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68" r:id="rId2"/>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003969"/>
    <a:srgbClr val="65AA00"/>
    <a:srgbClr val="0092F7"/>
    <a:srgbClr val="AA0065"/>
    <a:srgbClr val="960059"/>
    <a:srgbClr val="860050"/>
    <a:srgbClr val="DA0082"/>
    <a:srgbClr val="920057"/>
    <a:srgbClr val="8A0052"/>
    <a:srgbClr val="004277"/>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E98E77CF-AC67-4B9C-B728-4F7A58B12203}" v="2" dt="2024-03-18T14:59:30.935"/>
  </p1510:revLst>
</p1510:revInfo>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9559" autoAdjust="0"/>
    <p:restoredTop sz="94660"/>
  </p:normalViewPr>
  <p:slideViewPr>
    <p:cSldViewPr snapToGrid="0">
      <p:cViewPr varScale="1">
        <p:scale>
          <a:sx n="82" d="100"/>
          <a:sy n="82" d="100"/>
        </p:scale>
        <p:origin x="893" y="62"/>
      </p:cViewPr>
      <p:guideLst/>
    </p:cSldViewPr>
  </p:slideViewPr>
  <p:notesTextViewPr>
    <p:cViewPr>
      <p:scale>
        <a:sx n="1" d="1"/>
        <a:sy n="1" d="1"/>
      </p:scale>
      <p:origin x="0" y="0"/>
    </p:cViewPr>
  </p:notesTextViewPr>
  <p:sorterViewPr>
    <p:cViewPr>
      <p:scale>
        <a:sx n="100" d="100"/>
        <a:sy n="100" d="100"/>
      </p:scale>
      <p:origin x="0" y="0"/>
    </p:cViewPr>
  </p:sorter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7" Type="http://schemas.microsoft.com/office/2015/10/relationships/revisionInfo" Target="revisionInfo.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2" Type="http://schemas.openxmlformats.org/officeDocument/2006/relationships/image" Target="../media/image1.jpeg"/><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2" Type="http://schemas.openxmlformats.org/officeDocument/2006/relationships/image" Target="../media/image1.jpeg"/><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2" Type="http://schemas.openxmlformats.org/officeDocument/2006/relationships/image" Target="../media/image1.jpeg"/><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2" Type="http://schemas.openxmlformats.org/officeDocument/2006/relationships/image" Target="../media/image1.jpeg"/><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preserve="1" userDrawn="1">
  <p:cSld name="Original Article">
    <p:spTree>
      <p:nvGrpSpPr>
        <p:cNvPr id="1" name=""/>
        <p:cNvGrpSpPr/>
        <p:nvPr/>
      </p:nvGrpSpPr>
      <p:grpSpPr>
        <a:xfrm>
          <a:off x="0" y="0"/>
          <a:ext cx="0" cy="0"/>
          <a:chOff x="0" y="0"/>
          <a:chExt cx="0" cy="0"/>
        </a:xfrm>
      </p:grpSpPr>
      <p:sp>
        <p:nvSpPr>
          <p:cNvPr id="16" name="Flowchart: Stored Data 4">
            <a:extLst>
              <a:ext uri="{FF2B5EF4-FFF2-40B4-BE49-F238E27FC236}">
                <a16:creationId xmlns:a16="http://schemas.microsoft.com/office/drawing/2014/main" id="{6750A1AE-34CF-C798-885B-4AD2785F8297}"/>
              </a:ext>
            </a:extLst>
          </p:cNvPr>
          <p:cNvSpPr/>
          <p:nvPr userDrawn="1"/>
        </p:nvSpPr>
        <p:spPr>
          <a:xfrm rot="5400000">
            <a:off x="5288230" y="-4790379"/>
            <a:ext cx="1614236" cy="12203777"/>
          </a:xfrm>
          <a:custGeom>
            <a:avLst/>
            <a:gdLst>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89795 h 103750"/>
              <a:gd name="connsiteX1" fmla="*/ 8293 w 10000"/>
              <a:gd name="connsiteY1" fmla="*/ 0 h 103750"/>
              <a:gd name="connsiteX2" fmla="*/ 8333 w 10000"/>
              <a:gd name="connsiteY2" fmla="*/ 94795 h 103750"/>
              <a:gd name="connsiteX3" fmla="*/ 10000 w 10000"/>
              <a:gd name="connsiteY3" fmla="*/ 99795 h 103750"/>
              <a:gd name="connsiteX4" fmla="*/ 1667 w 10000"/>
              <a:gd name="connsiteY4" fmla="*/ 99795 h 103750"/>
              <a:gd name="connsiteX5" fmla="*/ 0 w 10000"/>
              <a:gd name="connsiteY5" fmla="*/ 94795 h 103750"/>
              <a:gd name="connsiteX6" fmla="*/ 1667 w 10000"/>
              <a:gd name="connsiteY6" fmla="*/ 89795 h 10375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5639 w 10161"/>
              <a:gd name="connsiteY0" fmla="*/ 18392 h 112308"/>
              <a:gd name="connsiteX1" fmla="*/ 8672 w 10161"/>
              <a:gd name="connsiteY1" fmla="*/ 5059 h 112308"/>
              <a:gd name="connsiteX2" fmla="*/ 8494 w 10161"/>
              <a:gd name="connsiteY2" fmla="*/ 103121 h 112308"/>
              <a:gd name="connsiteX3" fmla="*/ 10161 w 10161"/>
              <a:gd name="connsiteY3" fmla="*/ 108121 h 112308"/>
              <a:gd name="connsiteX4" fmla="*/ 1828 w 10161"/>
              <a:gd name="connsiteY4" fmla="*/ 108121 h 112308"/>
              <a:gd name="connsiteX5" fmla="*/ 161 w 10161"/>
              <a:gd name="connsiteY5" fmla="*/ 103121 h 112308"/>
              <a:gd name="connsiteX6" fmla="*/ 5639 w 10161"/>
              <a:gd name="connsiteY6" fmla="*/ 18392 h 112308"/>
              <a:gd name="connsiteX0" fmla="*/ 5639 w 10161"/>
              <a:gd name="connsiteY0" fmla="*/ 48998 h 145481"/>
              <a:gd name="connsiteX1" fmla="*/ 8354 w 10161"/>
              <a:gd name="connsiteY1" fmla="*/ 0 h 145481"/>
              <a:gd name="connsiteX2" fmla="*/ 8494 w 10161"/>
              <a:gd name="connsiteY2" fmla="*/ 133727 h 145481"/>
              <a:gd name="connsiteX3" fmla="*/ 10161 w 10161"/>
              <a:gd name="connsiteY3" fmla="*/ 138727 h 145481"/>
              <a:gd name="connsiteX4" fmla="*/ 1828 w 10161"/>
              <a:gd name="connsiteY4" fmla="*/ 138727 h 145481"/>
              <a:gd name="connsiteX5" fmla="*/ 161 w 10161"/>
              <a:gd name="connsiteY5" fmla="*/ 133727 h 145481"/>
              <a:gd name="connsiteX6" fmla="*/ 5639 w 10161"/>
              <a:gd name="connsiteY6" fmla="*/ 48998 h 145481"/>
              <a:gd name="connsiteX0" fmla="*/ 4738 w 10113"/>
              <a:gd name="connsiteY0" fmla="*/ 13812 h 159292"/>
              <a:gd name="connsiteX1" fmla="*/ 8306 w 10113"/>
              <a:gd name="connsiteY1" fmla="*/ 13811 h 159292"/>
              <a:gd name="connsiteX2" fmla="*/ 8446 w 10113"/>
              <a:gd name="connsiteY2" fmla="*/ 147538 h 159292"/>
              <a:gd name="connsiteX3" fmla="*/ 10113 w 10113"/>
              <a:gd name="connsiteY3" fmla="*/ 152538 h 159292"/>
              <a:gd name="connsiteX4" fmla="*/ 1780 w 10113"/>
              <a:gd name="connsiteY4" fmla="*/ 152538 h 159292"/>
              <a:gd name="connsiteX5" fmla="*/ 113 w 10113"/>
              <a:gd name="connsiteY5" fmla="*/ 147538 h 159292"/>
              <a:gd name="connsiteX6" fmla="*/ 4738 w 10113"/>
              <a:gd name="connsiteY6" fmla="*/ 13812 h 159292"/>
              <a:gd name="connsiteX0" fmla="*/ 4738 w 10113"/>
              <a:gd name="connsiteY0" fmla="*/ 2870 h 148350"/>
              <a:gd name="connsiteX1" fmla="*/ 8306 w 10113"/>
              <a:gd name="connsiteY1" fmla="*/ 2869 h 148350"/>
              <a:gd name="connsiteX2" fmla="*/ 8446 w 10113"/>
              <a:gd name="connsiteY2" fmla="*/ 136596 h 148350"/>
              <a:gd name="connsiteX3" fmla="*/ 10113 w 10113"/>
              <a:gd name="connsiteY3" fmla="*/ 141596 h 148350"/>
              <a:gd name="connsiteX4" fmla="*/ 1780 w 10113"/>
              <a:gd name="connsiteY4" fmla="*/ 141596 h 148350"/>
              <a:gd name="connsiteX5" fmla="*/ 113 w 10113"/>
              <a:gd name="connsiteY5" fmla="*/ 136596 h 148350"/>
              <a:gd name="connsiteX6" fmla="*/ 4738 w 10113"/>
              <a:gd name="connsiteY6" fmla="*/ 2870 h 148350"/>
              <a:gd name="connsiteX0" fmla="*/ 4738 w 10113"/>
              <a:gd name="connsiteY0" fmla="*/ 51 h 145531"/>
              <a:gd name="connsiteX1" fmla="*/ 8306 w 10113"/>
              <a:gd name="connsiteY1" fmla="*/ 50 h 145531"/>
              <a:gd name="connsiteX2" fmla="*/ 8446 w 10113"/>
              <a:gd name="connsiteY2" fmla="*/ 133777 h 145531"/>
              <a:gd name="connsiteX3" fmla="*/ 10113 w 10113"/>
              <a:gd name="connsiteY3" fmla="*/ 138777 h 145531"/>
              <a:gd name="connsiteX4" fmla="*/ 1780 w 10113"/>
              <a:gd name="connsiteY4" fmla="*/ 138777 h 145531"/>
              <a:gd name="connsiteX5" fmla="*/ 113 w 10113"/>
              <a:gd name="connsiteY5" fmla="*/ 133777 h 145531"/>
              <a:gd name="connsiteX6" fmla="*/ 4738 w 10113"/>
              <a:gd name="connsiteY6" fmla="*/ 51 h 145531"/>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674 w 10109"/>
              <a:gd name="connsiteY0" fmla="*/ 170 h 145517"/>
              <a:gd name="connsiteX1" fmla="*/ 8302 w 10109"/>
              <a:gd name="connsiteY1" fmla="*/ 36 h 145517"/>
              <a:gd name="connsiteX2" fmla="*/ 8442 w 10109"/>
              <a:gd name="connsiteY2" fmla="*/ 133763 h 145517"/>
              <a:gd name="connsiteX3" fmla="*/ 10109 w 10109"/>
              <a:gd name="connsiteY3" fmla="*/ 138763 h 145517"/>
              <a:gd name="connsiteX4" fmla="*/ 1776 w 10109"/>
              <a:gd name="connsiteY4" fmla="*/ 138763 h 145517"/>
              <a:gd name="connsiteX5" fmla="*/ 109 w 10109"/>
              <a:gd name="connsiteY5" fmla="*/ 133763 h 145517"/>
              <a:gd name="connsiteX6" fmla="*/ 4674 w 10109"/>
              <a:gd name="connsiteY6" fmla="*/ 170 h 145517"/>
              <a:gd name="connsiteX0" fmla="*/ 3080 w 8515"/>
              <a:gd name="connsiteY0" fmla="*/ 170 h 145517"/>
              <a:gd name="connsiteX1" fmla="*/ 6708 w 8515"/>
              <a:gd name="connsiteY1" fmla="*/ 36 h 145517"/>
              <a:gd name="connsiteX2" fmla="*/ 6848 w 8515"/>
              <a:gd name="connsiteY2" fmla="*/ 133763 h 145517"/>
              <a:gd name="connsiteX3" fmla="*/ 8515 w 8515"/>
              <a:gd name="connsiteY3" fmla="*/ 138763 h 145517"/>
              <a:gd name="connsiteX4" fmla="*/ 182 w 8515"/>
              <a:gd name="connsiteY4" fmla="*/ 138763 h 145517"/>
              <a:gd name="connsiteX5" fmla="*/ 3080 w 8515"/>
              <a:gd name="connsiteY5" fmla="*/ 170 h 145517"/>
              <a:gd name="connsiteX0" fmla="*/ 3617 w 10000"/>
              <a:gd name="connsiteY0" fmla="*/ 12 h 9536"/>
              <a:gd name="connsiteX1" fmla="*/ 7878 w 10000"/>
              <a:gd name="connsiteY1" fmla="*/ 2 h 9536"/>
              <a:gd name="connsiteX2" fmla="*/ 8042 w 10000"/>
              <a:gd name="connsiteY2" fmla="*/ 9192 h 9536"/>
              <a:gd name="connsiteX3" fmla="*/ 10000 w 10000"/>
              <a:gd name="connsiteY3" fmla="*/ 9536 h 9536"/>
              <a:gd name="connsiteX4" fmla="*/ 214 w 10000"/>
              <a:gd name="connsiteY4" fmla="*/ 9536 h 9536"/>
              <a:gd name="connsiteX5" fmla="*/ 3617 w 10000"/>
              <a:gd name="connsiteY5" fmla="*/ 12 h 9536"/>
              <a:gd name="connsiteX0" fmla="*/ 3403 w 9786"/>
              <a:gd name="connsiteY0" fmla="*/ 13 h 10000"/>
              <a:gd name="connsiteX1" fmla="*/ 7664 w 9786"/>
              <a:gd name="connsiteY1" fmla="*/ 2 h 10000"/>
              <a:gd name="connsiteX2" fmla="*/ 7828 w 9786"/>
              <a:gd name="connsiteY2" fmla="*/ 9639 h 10000"/>
              <a:gd name="connsiteX3" fmla="*/ 9786 w 9786"/>
              <a:gd name="connsiteY3" fmla="*/ 10000 h 10000"/>
              <a:gd name="connsiteX4" fmla="*/ 0 w 9786"/>
              <a:gd name="connsiteY4" fmla="*/ 10000 h 10000"/>
              <a:gd name="connsiteX5" fmla="*/ 3403 w 9786"/>
              <a:gd name="connsiteY5" fmla="*/ 13 h 10000"/>
              <a:gd name="connsiteX0" fmla="*/ 494 w 7017"/>
              <a:gd name="connsiteY0" fmla="*/ 743 h 10730"/>
              <a:gd name="connsiteX1" fmla="*/ 4849 w 7017"/>
              <a:gd name="connsiteY1" fmla="*/ 732 h 10730"/>
              <a:gd name="connsiteX2" fmla="*/ 5016 w 7017"/>
              <a:gd name="connsiteY2" fmla="*/ 10369 h 10730"/>
              <a:gd name="connsiteX3" fmla="*/ 7017 w 7017"/>
              <a:gd name="connsiteY3" fmla="*/ 10730 h 10730"/>
              <a:gd name="connsiteX4" fmla="*/ 45 w 7017"/>
              <a:gd name="connsiteY4" fmla="*/ 10709 h 10730"/>
              <a:gd name="connsiteX5" fmla="*/ 494 w 7017"/>
              <a:gd name="connsiteY5" fmla="*/ 743 h 10730"/>
              <a:gd name="connsiteX0" fmla="*/ 521 w 9817"/>
              <a:gd name="connsiteY0" fmla="*/ 692 h 10000"/>
              <a:gd name="connsiteX1" fmla="*/ 6727 w 9817"/>
              <a:gd name="connsiteY1" fmla="*/ 682 h 10000"/>
              <a:gd name="connsiteX2" fmla="*/ 6965 w 9817"/>
              <a:gd name="connsiteY2" fmla="*/ 9664 h 10000"/>
              <a:gd name="connsiteX3" fmla="*/ 9817 w 9817"/>
              <a:gd name="connsiteY3" fmla="*/ 10000 h 10000"/>
              <a:gd name="connsiteX4" fmla="*/ 273 w 9817"/>
              <a:gd name="connsiteY4" fmla="*/ 9980 h 10000"/>
              <a:gd name="connsiteX5" fmla="*/ 521 w 9817"/>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70 w 10039"/>
              <a:gd name="connsiteY0" fmla="*/ 695 h 10015"/>
              <a:gd name="connsiteX1" fmla="*/ 6891 w 10039"/>
              <a:gd name="connsiteY1" fmla="*/ 685 h 10015"/>
              <a:gd name="connsiteX2" fmla="*/ 7134 w 10039"/>
              <a:gd name="connsiteY2" fmla="*/ 9667 h 10015"/>
              <a:gd name="connsiteX3" fmla="*/ 10039 w 10039"/>
              <a:gd name="connsiteY3" fmla="*/ 10003 h 10015"/>
              <a:gd name="connsiteX4" fmla="*/ 217 w 10039"/>
              <a:gd name="connsiteY4" fmla="*/ 10015 h 10015"/>
              <a:gd name="connsiteX5" fmla="*/ 570 w 10039"/>
              <a:gd name="connsiteY5" fmla="*/ 695 h 10015"/>
              <a:gd name="connsiteX0" fmla="*/ 615 w 10084"/>
              <a:gd name="connsiteY0" fmla="*/ 695 h 10015"/>
              <a:gd name="connsiteX1" fmla="*/ 6936 w 10084"/>
              <a:gd name="connsiteY1" fmla="*/ 685 h 10015"/>
              <a:gd name="connsiteX2" fmla="*/ 7179 w 10084"/>
              <a:gd name="connsiteY2" fmla="*/ 9667 h 10015"/>
              <a:gd name="connsiteX3" fmla="*/ 10084 w 10084"/>
              <a:gd name="connsiteY3" fmla="*/ 10003 h 10015"/>
              <a:gd name="connsiteX4" fmla="*/ 262 w 10084"/>
              <a:gd name="connsiteY4" fmla="*/ 10015 h 10015"/>
              <a:gd name="connsiteX5" fmla="*/ 615 w 10084"/>
              <a:gd name="connsiteY5" fmla="*/ 695 h 10015"/>
              <a:gd name="connsiteX0" fmla="*/ 356 w 9825"/>
              <a:gd name="connsiteY0" fmla="*/ 695 h 10015"/>
              <a:gd name="connsiteX1" fmla="*/ 6677 w 9825"/>
              <a:gd name="connsiteY1" fmla="*/ 685 h 10015"/>
              <a:gd name="connsiteX2" fmla="*/ 6920 w 9825"/>
              <a:gd name="connsiteY2" fmla="*/ 9667 h 10015"/>
              <a:gd name="connsiteX3" fmla="*/ 9825 w 9825"/>
              <a:gd name="connsiteY3" fmla="*/ 10003 h 10015"/>
              <a:gd name="connsiteX4" fmla="*/ 3 w 9825"/>
              <a:gd name="connsiteY4" fmla="*/ 10015 h 10015"/>
              <a:gd name="connsiteX5" fmla="*/ 356 w 9825"/>
              <a:gd name="connsiteY5" fmla="*/ 695 h 10015"/>
              <a:gd name="connsiteX0" fmla="*/ 362 w 10000"/>
              <a:gd name="connsiteY0" fmla="*/ 10 h 9316"/>
              <a:gd name="connsiteX1" fmla="*/ 6796 w 10000"/>
              <a:gd name="connsiteY1" fmla="*/ 0 h 9316"/>
              <a:gd name="connsiteX2" fmla="*/ 7043 w 10000"/>
              <a:gd name="connsiteY2" fmla="*/ 8969 h 9316"/>
              <a:gd name="connsiteX3" fmla="*/ 10000 w 10000"/>
              <a:gd name="connsiteY3" fmla="*/ 9304 h 9316"/>
              <a:gd name="connsiteX4" fmla="*/ 3 w 10000"/>
              <a:gd name="connsiteY4" fmla="*/ 9316 h 9316"/>
              <a:gd name="connsiteX5" fmla="*/ 362 w 10000"/>
              <a:gd name="connsiteY5" fmla="*/ 10 h 9316"/>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0 w 9998"/>
              <a:gd name="connsiteY0" fmla="*/ 11 h 10000"/>
              <a:gd name="connsiteX1" fmla="*/ 7099 w 9998"/>
              <a:gd name="connsiteY1" fmla="*/ 0 h 10000"/>
              <a:gd name="connsiteX2" fmla="*/ 7041 w 9998"/>
              <a:gd name="connsiteY2" fmla="*/ 9628 h 10000"/>
              <a:gd name="connsiteX3" fmla="*/ 9998 w 9998"/>
              <a:gd name="connsiteY3" fmla="*/ 9987 h 10000"/>
              <a:gd name="connsiteX4" fmla="*/ 1 w 9998"/>
              <a:gd name="connsiteY4" fmla="*/ 10000 h 10000"/>
              <a:gd name="connsiteX5" fmla="*/ 360 w 9998"/>
              <a:gd name="connsiteY5" fmla="*/ 11 h 10000"/>
              <a:gd name="connsiteX0" fmla="*/ 0 w 9640"/>
              <a:gd name="connsiteY0" fmla="*/ 11 h 10000"/>
              <a:gd name="connsiteX1" fmla="*/ 6740 w 9640"/>
              <a:gd name="connsiteY1" fmla="*/ 0 h 10000"/>
              <a:gd name="connsiteX2" fmla="*/ 6682 w 9640"/>
              <a:gd name="connsiteY2" fmla="*/ 9628 h 10000"/>
              <a:gd name="connsiteX3" fmla="*/ 9640 w 9640"/>
              <a:gd name="connsiteY3" fmla="*/ 9987 h 10000"/>
              <a:gd name="connsiteX4" fmla="*/ 302 w 9640"/>
              <a:gd name="connsiteY4" fmla="*/ 10000 h 10000"/>
              <a:gd name="connsiteX5" fmla="*/ 0 w 964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9991"/>
              <a:gd name="connsiteX1" fmla="*/ 7048 w 10056"/>
              <a:gd name="connsiteY1" fmla="*/ 0 h 9991"/>
              <a:gd name="connsiteX2" fmla="*/ 6988 w 10056"/>
              <a:gd name="connsiteY2" fmla="*/ 9628 h 9991"/>
              <a:gd name="connsiteX3" fmla="*/ 10056 w 10056"/>
              <a:gd name="connsiteY3" fmla="*/ 9987 h 9991"/>
              <a:gd name="connsiteX4" fmla="*/ 129 w 10056"/>
              <a:gd name="connsiteY4" fmla="*/ 9991 h 9991"/>
              <a:gd name="connsiteX5" fmla="*/ 0 w 10056"/>
              <a:gd name="connsiteY5" fmla="*/ 4 h 9991"/>
              <a:gd name="connsiteX0" fmla="*/ 0 w 10000"/>
              <a:gd name="connsiteY0" fmla="*/ 4 h 9996"/>
              <a:gd name="connsiteX1" fmla="*/ 7009 w 10000"/>
              <a:gd name="connsiteY1" fmla="*/ 0 h 9996"/>
              <a:gd name="connsiteX2" fmla="*/ 6949 w 10000"/>
              <a:gd name="connsiteY2" fmla="*/ 9637 h 9996"/>
              <a:gd name="connsiteX3" fmla="*/ 10000 w 10000"/>
              <a:gd name="connsiteY3" fmla="*/ 9996 h 9996"/>
              <a:gd name="connsiteX4" fmla="*/ 128 w 10000"/>
              <a:gd name="connsiteY4" fmla="*/ 9992 h 9996"/>
              <a:gd name="connsiteX5" fmla="*/ 0 w 10000"/>
              <a:gd name="connsiteY5" fmla="*/ 4 h 9996"/>
              <a:gd name="connsiteX0" fmla="*/ 0 w 10000"/>
              <a:gd name="connsiteY0" fmla="*/ 4 h 10000"/>
              <a:gd name="connsiteX1" fmla="*/ 7009 w 10000"/>
              <a:gd name="connsiteY1" fmla="*/ 0 h 10000"/>
              <a:gd name="connsiteX2" fmla="*/ 6949 w 10000"/>
              <a:gd name="connsiteY2" fmla="*/ 9641 h 10000"/>
              <a:gd name="connsiteX3" fmla="*/ 10000 w 10000"/>
              <a:gd name="connsiteY3" fmla="*/ 10000 h 10000"/>
              <a:gd name="connsiteX4" fmla="*/ 128 w 10000"/>
              <a:gd name="connsiteY4" fmla="*/ 9996 h 10000"/>
              <a:gd name="connsiteX5" fmla="*/ 0 w 10000"/>
              <a:gd name="connsiteY5" fmla="*/ 4 h 10000"/>
              <a:gd name="connsiteX0" fmla="*/ 0 w 10000"/>
              <a:gd name="connsiteY0" fmla="*/ 4 h 10000"/>
              <a:gd name="connsiteX1" fmla="*/ 7009 w 10000"/>
              <a:gd name="connsiteY1" fmla="*/ 0 h 10000"/>
              <a:gd name="connsiteX2" fmla="*/ 6949 w 10000"/>
              <a:gd name="connsiteY2" fmla="*/ 9641 h 10000"/>
              <a:gd name="connsiteX3" fmla="*/ 10000 w 10000"/>
              <a:gd name="connsiteY3" fmla="*/ 10000 h 10000"/>
              <a:gd name="connsiteX4" fmla="*/ 128 w 10000"/>
              <a:gd name="connsiteY4" fmla="*/ 9996 h 10000"/>
              <a:gd name="connsiteX5" fmla="*/ 0 w 10000"/>
              <a:gd name="connsiteY5" fmla="*/ 4 h 10000"/>
              <a:gd name="connsiteX0" fmla="*/ 0 w 10000"/>
              <a:gd name="connsiteY0" fmla="*/ 4 h 10000"/>
              <a:gd name="connsiteX1" fmla="*/ 7009 w 10000"/>
              <a:gd name="connsiteY1" fmla="*/ 0 h 10000"/>
              <a:gd name="connsiteX2" fmla="*/ 6949 w 10000"/>
              <a:gd name="connsiteY2" fmla="*/ 9641 h 10000"/>
              <a:gd name="connsiteX3" fmla="*/ 10000 w 10000"/>
              <a:gd name="connsiteY3" fmla="*/ 10000 h 10000"/>
              <a:gd name="connsiteX4" fmla="*/ 128 w 10000"/>
              <a:gd name="connsiteY4" fmla="*/ 9996 h 10000"/>
              <a:gd name="connsiteX5" fmla="*/ 0 w 10000"/>
              <a:gd name="connsiteY5" fmla="*/ 4 h 10000"/>
              <a:gd name="connsiteX0" fmla="*/ 0 w 10000"/>
              <a:gd name="connsiteY0" fmla="*/ 4 h 10004"/>
              <a:gd name="connsiteX1" fmla="*/ 7009 w 10000"/>
              <a:gd name="connsiteY1" fmla="*/ 0 h 10004"/>
              <a:gd name="connsiteX2" fmla="*/ 6949 w 10000"/>
              <a:gd name="connsiteY2" fmla="*/ 9641 h 10004"/>
              <a:gd name="connsiteX3" fmla="*/ 10000 w 10000"/>
              <a:gd name="connsiteY3" fmla="*/ 10000 h 10004"/>
              <a:gd name="connsiteX4" fmla="*/ 128 w 10000"/>
              <a:gd name="connsiteY4" fmla="*/ 10004 h 10004"/>
              <a:gd name="connsiteX5" fmla="*/ 0 w 10000"/>
              <a:gd name="connsiteY5" fmla="*/ 4 h 10004"/>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0000" h="10004">
                <a:moveTo>
                  <a:pt x="0" y="4"/>
                </a:moveTo>
                <a:lnTo>
                  <a:pt x="7009" y="0"/>
                </a:lnTo>
                <a:cubicBezTo>
                  <a:pt x="6847" y="1556"/>
                  <a:pt x="6821" y="9283"/>
                  <a:pt x="6949" y="9641"/>
                </a:cubicBezTo>
                <a:cubicBezTo>
                  <a:pt x="6923" y="9843"/>
                  <a:pt x="8314" y="10000"/>
                  <a:pt x="10000" y="10000"/>
                </a:cubicBezTo>
                <a:lnTo>
                  <a:pt x="128" y="10004"/>
                </a:lnTo>
                <a:cubicBezTo>
                  <a:pt x="97" y="8408"/>
                  <a:pt x="98" y="1073"/>
                  <a:pt x="0" y="4"/>
                </a:cubicBezTo>
                <a:close/>
              </a:path>
            </a:pathLst>
          </a:custGeom>
          <a:solidFill>
            <a:srgbClr val="0092F7"/>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sz="1050" dirty="0"/>
          </a:p>
        </p:txBody>
      </p:sp>
      <p:sp>
        <p:nvSpPr>
          <p:cNvPr id="5" name="Flowchart: Stored Data 4">
            <a:extLst>
              <a:ext uri="{FF2B5EF4-FFF2-40B4-BE49-F238E27FC236}">
                <a16:creationId xmlns:a16="http://schemas.microsoft.com/office/drawing/2014/main" id="{D150C2D2-09E4-F78B-7FA6-F42DD5FA59F4}"/>
              </a:ext>
            </a:extLst>
          </p:cNvPr>
          <p:cNvSpPr/>
          <p:nvPr userDrawn="1"/>
        </p:nvSpPr>
        <p:spPr>
          <a:xfrm rot="5400000">
            <a:off x="5283465" y="-5325515"/>
            <a:ext cx="1614236" cy="12214770"/>
          </a:xfrm>
          <a:custGeom>
            <a:avLst/>
            <a:gdLst>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89795 h 103750"/>
              <a:gd name="connsiteX1" fmla="*/ 8293 w 10000"/>
              <a:gd name="connsiteY1" fmla="*/ 0 h 103750"/>
              <a:gd name="connsiteX2" fmla="*/ 8333 w 10000"/>
              <a:gd name="connsiteY2" fmla="*/ 94795 h 103750"/>
              <a:gd name="connsiteX3" fmla="*/ 10000 w 10000"/>
              <a:gd name="connsiteY3" fmla="*/ 99795 h 103750"/>
              <a:gd name="connsiteX4" fmla="*/ 1667 w 10000"/>
              <a:gd name="connsiteY4" fmla="*/ 99795 h 103750"/>
              <a:gd name="connsiteX5" fmla="*/ 0 w 10000"/>
              <a:gd name="connsiteY5" fmla="*/ 94795 h 103750"/>
              <a:gd name="connsiteX6" fmla="*/ 1667 w 10000"/>
              <a:gd name="connsiteY6" fmla="*/ 89795 h 10375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5639 w 10161"/>
              <a:gd name="connsiteY0" fmla="*/ 18392 h 112308"/>
              <a:gd name="connsiteX1" fmla="*/ 8672 w 10161"/>
              <a:gd name="connsiteY1" fmla="*/ 5059 h 112308"/>
              <a:gd name="connsiteX2" fmla="*/ 8494 w 10161"/>
              <a:gd name="connsiteY2" fmla="*/ 103121 h 112308"/>
              <a:gd name="connsiteX3" fmla="*/ 10161 w 10161"/>
              <a:gd name="connsiteY3" fmla="*/ 108121 h 112308"/>
              <a:gd name="connsiteX4" fmla="*/ 1828 w 10161"/>
              <a:gd name="connsiteY4" fmla="*/ 108121 h 112308"/>
              <a:gd name="connsiteX5" fmla="*/ 161 w 10161"/>
              <a:gd name="connsiteY5" fmla="*/ 103121 h 112308"/>
              <a:gd name="connsiteX6" fmla="*/ 5639 w 10161"/>
              <a:gd name="connsiteY6" fmla="*/ 18392 h 112308"/>
              <a:gd name="connsiteX0" fmla="*/ 5639 w 10161"/>
              <a:gd name="connsiteY0" fmla="*/ 48998 h 145481"/>
              <a:gd name="connsiteX1" fmla="*/ 8354 w 10161"/>
              <a:gd name="connsiteY1" fmla="*/ 0 h 145481"/>
              <a:gd name="connsiteX2" fmla="*/ 8494 w 10161"/>
              <a:gd name="connsiteY2" fmla="*/ 133727 h 145481"/>
              <a:gd name="connsiteX3" fmla="*/ 10161 w 10161"/>
              <a:gd name="connsiteY3" fmla="*/ 138727 h 145481"/>
              <a:gd name="connsiteX4" fmla="*/ 1828 w 10161"/>
              <a:gd name="connsiteY4" fmla="*/ 138727 h 145481"/>
              <a:gd name="connsiteX5" fmla="*/ 161 w 10161"/>
              <a:gd name="connsiteY5" fmla="*/ 133727 h 145481"/>
              <a:gd name="connsiteX6" fmla="*/ 5639 w 10161"/>
              <a:gd name="connsiteY6" fmla="*/ 48998 h 145481"/>
              <a:gd name="connsiteX0" fmla="*/ 4738 w 10113"/>
              <a:gd name="connsiteY0" fmla="*/ 13812 h 159292"/>
              <a:gd name="connsiteX1" fmla="*/ 8306 w 10113"/>
              <a:gd name="connsiteY1" fmla="*/ 13811 h 159292"/>
              <a:gd name="connsiteX2" fmla="*/ 8446 w 10113"/>
              <a:gd name="connsiteY2" fmla="*/ 147538 h 159292"/>
              <a:gd name="connsiteX3" fmla="*/ 10113 w 10113"/>
              <a:gd name="connsiteY3" fmla="*/ 152538 h 159292"/>
              <a:gd name="connsiteX4" fmla="*/ 1780 w 10113"/>
              <a:gd name="connsiteY4" fmla="*/ 152538 h 159292"/>
              <a:gd name="connsiteX5" fmla="*/ 113 w 10113"/>
              <a:gd name="connsiteY5" fmla="*/ 147538 h 159292"/>
              <a:gd name="connsiteX6" fmla="*/ 4738 w 10113"/>
              <a:gd name="connsiteY6" fmla="*/ 13812 h 159292"/>
              <a:gd name="connsiteX0" fmla="*/ 4738 w 10113"/>
              <a:gd name="connsiteY0" fmla="*/ 2870 h 148350"/>
              <a:gd name="connsiteX1" fmla="*/ 8306 w 10113"/>
              <a:gd name="connsiteY1" fmla="*/ 2869 h 148350"/>
              <a:gd name="connsiteX2" fmla="*/ 8446 w 10113"/>
              <a:gd name="connsiteY2" fmla="*/ 136596 h 148350"/>
              <a:gd name="connsiteX3" fmla="*/ 10113 w 10113"/>
              <a:gd name="connsiteY3" fmla="*/ 141596 h 148350"/>
              <a:gd name="connsiteX4" fmla="*/ 1780 w 10113"/>
              <a:gd name="connsiteY4" fmla="*/ 141596 h 148350"/>
              <a:gd name="connsiteX5" fmla="*/ 113 w 10113"/>
              <a:gd name="connsiteY5" fmla="*/ 136596 h 148350"/>
              <a:gd name="connsiteX6" fmla="*/ 4738 w 10113"/>
              <a:gd name="connsiteY6" fmla="*/ 2870 h 148350"/>
              <a:gd name="connsiteX0" fmla="*/ 4738 w 10113"/>
              <a:gd name="connsiteY0" fmla="*/ 51 h 145531"/>
              <a:gd name="connsiteX1" fmla="*/ 8306 w 10113"/>
              <a:gd name="connsiteY1" fmla="*/ 50 h 145531"/>
              <a:gd name="connsiteX2" fmla="*/ 8446 w 10113"/>
              <a:gd name="connsiteY2" fmla="*/ 133777 h 145531"/>
              <a:gd name="connsiteX3" fmla="*/ 10113 w 10113"/>
              <a:gd name="connsiteY3" fmla="*/ 138777 h 145531"/>
              <a:gd name="connsiteX4" fmla="*/ 1780 w 10113"/>
              <a:gd name="connsiteY4" fmla="*/ 138777 h 145531"/>
              <a:gd name="connsiteX5" fmla="*/ 113 w 10113"/>
              <a:gd name="connsiteY5" fmla="*/ 133777 h 145531"/>
              <a:gd name="connsiteX6" fmla="*/ 4738 w 10113"/>
              <a:gd name="connsiteY6" fmla="*/ 51 h 145531"/>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674 w 10109"/>
              <a:gd name="connsiteY0" fmla="*/ 170 h 145517"/>
              <a:gd name="connsiteX1" fmla="*/ 8302 w 10109"/>
              <a:gd name="connsiteY1" fmla="*/ 36 h 145517"/>
              <a:gd name="connsiteX2" fmla="*/ 8442 w 10109"/>
              <a:gd name="connsiteY2" fmla="*/ 133763 h 145517"/>
              <a:gd name="connsiteX3" fmla="*/ 10109 w 10109"/>
              <a:gd name="connsiteY3" fmla="*/ 138763 h 145517"/>
              <a:gd name="connsiteX4" fmla="*/ 1776 w 10109"/>
              <a:gd name="connsiteY4" fmla="*/ 138763 h 145517"/>
              <a:gd name="connsiteX5" fmla="*/ 109 w 10109"/>
              <a:gd name="connsiteY5" fmla="*/ 133763 h 145517"/>
              <a:gd name="connsiteX6" fmla="*/ 4674 w 10109"/>
              <a:gd name="connsiteY6" fmla="*/ 170 h 145517"/>
              <a:gd name="connsiteX0" fmla="*/ 3080 w 8515"/>
              <a:gd name="connsiteY0" fmla="*/ 170 h 145517"/>
              <a:gd name="connsiteX1" fmla="*/ 6708 w 8515"/>
              <a:gd name="connsiteY1" fmla="*/ 36 h 145517"/>
              <a:gd name="connsiteX2" fmla="*/ 6848 w 8515"/>
              <a:gd name="connsiteY2" fmla="*/ 133763 h 145517"/>
              <a:gd name="connsiteX3" fmla="*/ 8515 w 8515"/>
              <a:gd name="connsiteY3" fmla="*/ 138763 h 145517"/>
              <a:gd name="connsiteX4" fmla="*/ 182 w 8515"/>
              <a:gd name="connsiteY4" fmla="*/ 138763 h 145517"/>
              <a:gd name="connsiteX5" fmla="*/ 3080 w 8515"/>
              <a:gd name="connsiteY5" fmla="*/ 170 h 145517"/>
              <a:gd name="connsiteX0" fmla="*/ 3617 w 10000"/>
              <a:gd name="connsiteY0" fmla="*/ 12 h 9536"/>
              <a:gd name="connsiteX1" fmla="*/ 7878 w 10000"/>
              <a:gd name="connsiteY1" fmla="*/ 2 h 9536"/>
              <a:gd name="connsiteX2" fmla="*/ 8042 w 10000"/>
              <a:gd name="connsiteY2" fmla="*/ 9192 h 9536"/>
              <a:gd name="connsiteX3" fmla="*/ 10000 w 10000"/>
              <a:gd name="connsiteY3" fmla="*/ 9536 h 9536"/>
              <a:gd name="connsiteX4" fmla="*/ 214 w 10000"/>
              <a:gd name="connsiteY4" fmla="*/ 9536 h 9536"/>
              <a:gd name="connsiteX5" fmla="*/ 3617 w 10000"/>
              <a:gd name="connsiteY5" fmla="*/ 12 h 9536"/>
              <a:gd name="connsiteX0" fmla="*/ 3403 w 9786"/>
              <a:gd name="connsiteY0" fmla="*/ 13 h 10000"/>
              <a:gd name="connsiteX1" fmla="*/ 7664 w 9786"/>
              <a:gd name="connsiteY1" fmla="*/ 2 h 10000"/>
              <a:gd name="connsiteX2" fmla="*/ 7828 w 9786"/>
              <a:gd name="connsiteY2" fmla="*/ 9639 h 10000"/>
              <a:gd name="connsiteX3" fmla="*/ 9786 w 9786"/>
              <a:gd name="connsiteY3" fmla="*/ 10000 h 10000"/>
              <a:gd name="connsiteX4" fmla="*/ 0 w 9786"/>
              <a:gd name="connsiteY4" fmla="*/ 10000 h 10000"/>
              <a:gd name="connsiteX5" fmla="*/ 3403 w 9786"/>
              <a:gd name="connsiteY5" fmla="*/ 13 h 10000"/>
              <a:gd name="connsiteX0" fmla="*/ 494 w 7017"/>
              <a:gd name="connsiteY0" fmla="*/ 743 h 10730"/>
              <a:gd name="connsiteX1" fmla="*/ 4849 w 7017"/>
              <a:gd name="connsiteY1" fmla="*/ 732 h 10730"/>
              <a:gd name="connsiteX2" fmla="*/ 5016 w 7017"/>
              <a:gd name="connsiteY2" fmla="*/ 10369 h 10730"/>
              <a:gd name="connsiteX3" fmla="*/ 7017 w 7017"/>
              <a:gd name="connsiteY3" fmla="*/ 10730 h 10730"/>
              <a:gd name="connsiteX4" fmla="*/ 45 w 7017"/>
              <a:gd name="connsiteY4" fmla="*/ 10709 h 10730"/>
              <a:gd name="connsiteX5" fmla="*/ 494 w 7017"/>
              <a:gd name="connsiteY5" fmla="*/ 743 h 10730"/>
              <a:gd name="connsiteX0" fmla="*/ 521 w 9817"/>
              <a:gd name="connsiteY0" fmla="*/ 692 h 10000"/>
              <a:gd name="connsiteX1" fmla="*/ 6727 w 9817"/>
              <a:gd name="connsiteY1" fmla="*/ 682 h 10000"/>
              <a:gd name="connsiteX2" fmla="*/ 6965 w 9817"/>
              <a:gd name="connsiteY2" fmla="*/ 9664 h 10000"/>
              <a:gd name="connsiteX3" fmla="*/ 9817 w 9817"/>
              <a:gd name="connsiteY3" fmla="*/ 10000 h 10000"/>
              <a:gd name="connsiteX4" fmla="*/ 273 w 9817"/>
              <a:gd name="connsiteY4" fmla="*/ 9980 h 10000"/>
              <a:gd name="connsiteX5" fmla="*/ 521 w 9817"/>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70 w 10039"/>
              <a:gd name="connsiteY0" fmla="*/ 695 h 10015"/>
              <a:gd name="connsiteX1" fmla="*/ 6891 w 10039"/>
              <a:gd name="connsiteY1" fmla="*/ 685 h 10015"/>
              <a:gd name="connsiteX2" fmla="*/ 7134 w 10039"/>
              <a:gd name="connsiteY2" fmla="*/ 9667 h 10015"/>
              <a:gd name="connsiteX3" fmla="*/ 10039 w 10039"/>
              <a:gd name="connsiteY3" fmla="*/ 10003 h 10015"/>
              <a:gd name="connsiteX4" fmla="*/ 217 w 10039"/>
              <a:gd name="connsiteY4" fmla="*/ 10015 h 10015"/>
              <a:gd name="connsiteX5" fmla="*/ 570 w 10039"/>
              <a:gd name="connsiteY5" fmla="*/ 695 h 10015"/>
              <a:gd name="connsiteX0" fmla="*/ 615 w 10084"/>
              <a:gd name="connsiteY0" fmla="*/ 695 h 10015"/>
              <a:gd name="connsiteX1" fmla="*/ 6936 w 10084"/>
              <a:gd name="connsiteY1" fmla="*/ 685 h 10015"/>
              <a:gd name="connsiteX2" fmla="*/ 7179 w 10084"/>
              <a:gd name="connsiteY2" fmla="*/ 9667 h 10015"/>
              <a:gd name="connsiteX3" fmla="*/ 10084 w 10084"/>
              <a:gd name="connsiteY3" fmla="*/ 10003 h 10015"/>
              <a:gd name="connsiteX4" fmla="*/ 262 w 10084"/>
              <a:gd name="connsiteY4" fmla="*/ 10015 h 10015"/>
              <a:gd name="connsiteX5" fmla="*/ 615 w 10084"/>
              <a:gd name="connsiteY5" fmla="*/ 695 h 10015"/>
              <a:gd name="connsiteX0" fmla="*/ 356 w 9825"/>
              <a:gd name="connsiteY0" fmla="*/ 695 h 10015"/>
              <a:gd name="connsiteX1" fmla="*/ 6677 w 9825"/>
              <a:gd name="connsiteY1" fmla="*/ 685 h 10015"/>
              <a:gd name="connsiteX2" fmla="*/ 6920 w 9825"/>
              <a:gd name="connsiteY2" fmla="*/ 9667 h 10015"/>
              <a:gd name="connsiteX3" fmla="*/ 9825 w 9825"/>
              <a:gd name="connsiteY3" fmla="*/ 10003 h 10015"/>
              <a:gd name="connsiteX4" fmla="*/ 3 w 9825"/>
              <a:gd name="connsiteY4" fmla="*/ 10015 h 10015"/>
              <a:gd name="connsiteX5" fmla="*/ 356 w 9825"/>
              <a:gd name="connsiteY5" fmla="*/ 695 h 10015"/>
              <a:gd name="connsiteX0" fmla="*/ 362 w 10000"/>
              <a:gd name="connsiteY0" fmla="*/ 10 h 9316"/>
              <a:gd name="connsiteX1" fmla="*/ 6796 w 10000"/>
              <a:gd name="connsiteY1" fmla="*/ 0 h 9316"/>
              <a:gd name="connsiteX2" fmla="*/ 7043 w 10000"/>
              <a:gd name="connsiteY2" fmla="*/ 8969 h 9316"/>
              <a:gd name="connsiteX3" fmla="*/ 10000 w 10000"/>
              <a:gd name="connsiteY3" fmla="*/ 9304 h 9316"/>
              <a:gd name="connsiteX4" fmla="*/ 3 w 10000"/>
              <a:gd name="connsiteY4" fmla="*/ 9316 h 9316"/>
              <a:gd name="connsiteX5" fmla="*/ 362 w 10000"/>
              <a:gd name="connsiteY5" fmla="*/ 10 h 9316"/>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0 w 9998"/>
              <a:gd name="connsiteY0" fmla="*/ 11 h 10000"/>
              <a:gd name="connsiteX1" fmla="*/ 7099 w 9998"/>
              <a:gd name="connsiteY1" fmla="*/ 0 h 10000"/>
              <a:gd name="connsiteX2" fmla="*/ 7041 w 9998"/>
              <a:gd name="connsiteY2" fmla="*/ 9628 h 10000"/>
              <a:gd name="connsiteX3" fmla="*/ 9998 w 9998"/>
              <a:gd name="connsiteY3" fmla="*/ 9987 h 10000"/>
              <a:gd name="connsiteX4" fmla="*/ 1 w 9998"/>
              <a:gd name="connsiteY4" fmla="*/ 10000 h 10000"/>
              <a:gd name="connsiteX5" fmla="*/ 360 w 9998"/>
              <a:gd name="connsiteY5" fmla="*/ 11 h 10000"/>
              <a:gd name="connsiteX0" fmla="*/ 0 w 9640"/>
              <a:gd name="connsiteY0" fmla="*/ 11 h 10000"/>
              <a:gd name="connsiteX1" fmla="*/ 6740 w 9640"/>
              <a:gd name="connsiteY1" fmla="*/ 0 h 10000"/>
              <a:gd name="connsiteX2" fmla="*/ 6682 w 9640"/>
              <a:gd name="connsiteY2" fmla="*/ 9628 h 10000"/>
              <a:gd name="connsiteX3" fmla="*/ 9640 w 9640"/>
              <a:gd name="connsiteY3" fmla="*/ 9987 h 10000"/>
              <a:gd name="connsiteX4" fmla="*/ 302 w 9640"/>
              <a:gd name="connsiteY4" fmla="*/ 10000 h 10000"/>
              <a:gd name="connsiteX5" fmla="*/ 0 w 964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0 h 9996"/>
              <a:gd name="connsiteX1" fmla="*/ 7001 w 10056"/>
              <a:gd name="connsiteY1" fmla="*/ 1 h 9996"/>
              <a:gd name="connsiteX2" fmla="*/ 6988 w 10056"/>
              <a:gd name="connsiteY2" fmla="*/ 9624 h 9996"/>
              <a:gd name="connsiteX3" fmla="*/ 10056 w 10056"/>
              <a:gd name="connsiteY3" fmla="*/ 9983 h 9996"/>
              <a:gd name="connsiteX4" fmla="*/ 62 w 10056"/>
              <a:gd name="connsiteY4" fmla="*/ 9996 h 9996"/>
              <a:gd name="connsiteX5" fmla="*/ 0 w 10056"/>
              <a:gd name="connsiteY5" fmla="*/ 0 h 9996"/>
              <a:gd name="connsiteX0" fmla="*/ 0 w 10000"/>
              <a:gd name="connsiteY0" fmla="*/ 2 h 10002"/>
              <a:gd name="connsiteX1" fmla="*/ 6962 w 10000"/>
              <a:gd name="connsiteY1" fmla="*/ 0 h 10002"/>
              <a:gd name="connsiteX2" fmla="*/ 6949 w 10000"/>
              <a:gd name="connsiteY2" fmla="*/ 9630 h 10002"/>
              <a:gd name="connsiteX3" fmla="*/ 10000 w 10000"/>
              <a:gd name="connsiteY3" fmla="*/ 9989 h 10002"/>
              <a:gd name="connsiteX4" fmla="*/ 62 w 10000"/>
              <a:gd name="connsiteY4" fmla="*/ 10002 h 10002"/>
              <a:gd name="connsiteX5" fmla="*/ 0 w 10000"/>
              <a:gd name="connsiteY5" fmla="*/ 2 h 10002"/>
              <a:gd name="connsiteX0" fmla="*/ 0 w 10000"/>
              <a:gd name="connsiteY0" fmla="*/ 4 h 10004"/>
              <a:gd name="connsiteX1" fmla="*/ 6927 w 10000"/>
              <a:gd name="connsiteY1" fmla="*/ 0 h 10004"/>
              <a:gd name="connsiteX2" fmla="*/ 6949 w 10000"/>
              <a:gd name="connsiteY2" fmla="*/ 9632 h 10004"/>
              <a:gd name="connsiteX3" fmla="*/ 10000 w 10000"/>
              <a:gd name="connsiteY3" fmla="*/ 9991 h 10004"/>
              <a:gd name="connsiteX4" fmla="*/ 62 w 10000"/>
              <a:gd name="connsiteY4" fmla="*/ 10004 h 10004"/>
              <a:gd name="connsiteX5" fmla="*/ 0 w 10000"/>
              <a:gd name="connsiteY5" fmla="*/ 4 h 10004"/>
              <a:gd name="connsiteX0" fmla="*/ 0 w 10000"/>
              <a:gd name="connsiteY0" fmla="*/ 4 h 10004"/>
              <a:gd name="connsiteX1" fmla="*/ 6927 w 10000"/>
              <a:gd name="connsiteY1" fmla="*/ 0 h 10004"/>
              <a:gd name="connsiteX2" fmla="*/ 6949 w 10000"/>
              <a:gd name="connsiteY2" fmla="*/ 9632 h 10004"/>
              <a:gd name="connsiteX3" fmla="*/ 10000 w 10000"/>
              <a:gd name="connsiteY3" fmla="*/ 9991 h 10004"/>
              <a:gd name="connsiteX4" fmla="*/ 62 w 10000"/>
              <a:gd name="connsiteY4" fmla="*/ 10004 h 10004"/>
              <a:gd name="connsiteX5" fmla="*/ 0 w 10000"/>
              <a:gd name="connsiteY5" fmla="*/ 4 h 10004"/>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0000" h="10004">
                <a:moveTo>
                  <a:pt x="0" y="4"/>
                </a:moveTo>
                <a:lnTo>
                  <a:pt x="6927" y="0"/>
                </a:lnTo>
                <a:cubicBezTo>
                  <a:pt x="6894" y="1547"/>
                  <a:pt x="6891" y="9283"/>
                  <a:pt x="6949" y="9632"/>
                </a:cubicBezTo>
                <a:cubicBezTo>
                  <a:pt x="6923" y="9834"/>
                  <a:pt x="8645" y="9997"/>
                  <a:pt x="10000" y="9991"/>
                </a:cubicBezTo>
                <a:lnTo>
                  <a:pt x="62" y="10004"/>
                </a:lnTo>
                <a:cubicBezTo>
                  <a:pt x="31" y="8409"/>
                  <a:pt x="98" y="1072"/>
                  <a:pt x="0" y="4"/>
                </a:cubicBezTo>
                <a:close/>
              </a:path>
            </a:pathLst>
          </a:custGeom>
          <a:solidFill>
            <a:srgbClr val="003969"/>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dirty="0"/>
          </a:p>
        </p:txBody>
      </p:sp>
      <p:sp>
        <p:nvSpPr>
          <p:cNvPr id="12" name="Rectangle 11"/>
          <p:cNvSpPr/>
          <p:nvPr userDrawn="1"/>
        </p:nvSpPr>
        <p:spPr>
          <a:xfrm>
            <a:off x="7489445" y="5672093"/>
            <a:ext cx="4708523" cy="421061"/>
          </a:xfrm>
          <a:prstGeom prst="rect">
            <a:avLst/>
          </a:prstGeom>
          <a:gradFill flip="none" rotWithShape="1">
            <a:gsLst>
              <a:gs pos="0">
                <a:srgbClr val="AA0065">
                  <a:shade val="30000"/>
                  <a:satMod val="115000"/>
                </a:srgbClr>
              </a:gs>
              <a:gs pos="50000">
                <a:srgbClr val="AA0065">
                  <a:shade val="67500"/>
                  <a:satMod val="115000"/>
                </a:srgbClr>
              </a:gs>
              <a:gs pos="100000">
                <a:srgbClr val="AA0065">
                  <a:shade val="100000"/>
                  <a:satMod val="115000"/>
                </a:srgbClr>
              </a:gs>
            </a:gsLst>
            <a:lin ang="13500000" scaled="1"/>
            <a:tileRect/>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900"/>
          </a:p>
        </p:txBody>
      </p:sp>
      <p:grpSp>
        <p:nvGrpSpPr>
          <p:cNvPr id="13" name="Group 12"/>
          <p:cNvGrpSpPr/>
          <p:nvPr userDrawn="1"/>
        </p:nvGrpSpPr>
        <p:grpSpPr>
          <a:xfrm>
            <a:off x="7637330" y="6112457"/>
            <a:ext cx="4174624" cy="723275"/>
            <a:chOff x="7646796" y="6098813"/>
            <a:chExt cx="4174624" cy="723275"/>
          </a:xfrm>
        </p:grpSpPr>
        <p:pic>
          <p:nvPicPr>
            <p:cNvPr id="14" name="Picture 10" descr="LOGO_IPNA_Blue"/>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7646796" y="6186597"/>
              <a:ext cx="581637" cy="581637"/>
            </a:xfrm>
            <a:prstGeom prst="rect">
              <a:avLst/>
            </a:prstGeom>
            <a:noFill/>
            <a:extLst>
              <a:ext uri="{909E8E84-426E-40DD-AFC4-6F175D3DCCD1}">
                <a14:hiddenFill xmlns:a14="http://schemas.microsoft.com/office/drawing/2010/main">
                  <a:solidFill>
                    <a:srgbClr val="FFFFFF"/>
                  </a:solidFill>
                </a14:hiddenFill>
              </a:ext>
            </a:extLst>
          </p:spPr>
        </p:pic>
        <p:sp>
          <p:nvSpPr>
            <p:cNvPr id="15" name="Rectangle 12"/>
            <p:cNvSpPr>
              <a:spLocks noChangeArrowheads="1"/>
            </p:cNvSpPr>
            <p:nvPr/>
          </p:nvSpPr>
          <p:spPr bwMode="auto">
            <a:xfrm>
              <a:off x="8208157" y="6098813"/>
              <a:ext cx="3613263" cy="72327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GB" altLang="en-US" b="1" i="0" u="none" strike="noStrike" cap="none" normalizeH="0" baseline="0" dirty="0">
                  <a:ln>
                    <a:noFill/>
                  </a:ln>
                  <a:solidFill>
                    <a:srgbClr val="296DC0"/>
                  </a:solidFill>
                  <a:effectLst/>
                  <a:latin typeface="Arial" panose="020B0604020202020204" pitchFamily="34" charset="0"/>
                  <a:ea typeface="Calibri" panose="020F0502020204030204" pitchFamily="34" charset="0"/>
                  <a:cs typeface="Calibri" panose="020F0502020204030204" pitchFamily="34" charset="0"/>
                </a:rPr>
                <a:t>Pediatric Nephrology</a:t>
              </a:r>
              <a:endParaRPr kumimoji="0" lang="en-GB" altLang="en-US" sz="500" b="0" i="0" u="none" strike="noStrike" cap="none" normalizeH="0" baseline="0" dirty="0">
                <a:ln>
                  <a:noFill/>
                </a:ln>
                <a:solidFill>
                  <a:schemeClr val="tx1"/>
                </a:solidFill>
                <a:effectLst/>
                <a:latin typeface="Arial" panose="020B0604020202020204" pitchFamily="34" charset="0"/>
              </a:endParaRPr>
            </a:p>
            <a:p>
              <a:pPr marL="0" marR="0" lvl="0" indent="0" algn="l" defTabSz="914400" rtl="0" eaLnBrk="0" fontAlgn="base" latinLnBrk="0" hangingPunct="0">
                <a:lnSpc>
                  <a:spcPct val="100000"/>
                </a:lnSpc>
                <a:spcBef>
                  <a:spcPct val="0"/>
                </a:spcBef>
                <a:spcAft>
                  <a:spcPct val="0"/>
                </a:spcAft>
                <a:buClrTx/>
                <a:buSzTx/>
                <a:buFontTx/>
                <a:buNone/>
                <a:tabLst/>
              </a:pPr>
              <a:r>
                <a:rPr kumimoji="0" lang="en-GB" altLang="en-US" sz="11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t>Journal of the </a:t>
              </a:r>
              <a:br>
                <a:rPr kumimoji="0" lang="en-GB" altLang="en-US" sz="11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br>
              <a:r>
                <a:rPr kumimoji="0" lang="en-GB" altLang="en-US" sz="12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t>International Pediatric Nephrology Association</a:t>
              </a:r>
              <a:endParaRPr kumimoji="0" lang="en-GB" altLang="en-US" sz="1200" b="0" i="0" u="none" strike="noStrike" cap="none" normalizeH="0" baseline="0" dirty="0">
                <a:ln>
                  <a:noFill/>
                </a:ln>
                <a:solidFill>
                  <a:schemeClr val="tx1"/>
                </a:solidFill>
                <a:effectLst/>
                <a:latin typeface="Arial" panose="020B0604020202020204" pitchFamily="34" charset="0"/>
              </a:endParaRPr>
            </a:p>
          </p:txBody>
        </p:sp>
      </p:grpSp>
      <p:sp>
        <p:nvSpPr>
          <p:cNvPr id="37" name="Rectangle 36">
            <a:extLst>
              <a:ext uri="{FF2B5EF4-FFF2-40B4-BE49-F238E27FC236}">
                <a16:creationId xmlns:a16="http://schemas.microsoft.com/office/drawing/2014/main" id="{FB861B61-643E-7D14-D771-2A7BF1205723}"/>
              </a:ext>
            </a:extLst>
          </p:cNvPr>
          <p:cNvSpPr/>
          <p:nvPr userDrawn="1"/>
        </p:nvSpPr>
        <p:spPr>
          <a:xfrm>
            <a:off x="10265756" y="-25248"/>
            <a:ext cx="1935480" cy="1116814"/>
          </a:xfrm>
          <a:prstGeom prst="rect">
            <a:avLst/>
          </a:prstGeom>
          <a:solidFill>
            <a:srgbClr val="65AA00"/>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p>
        </p:txBody>
      </p:sp>
      <p:grpSp>
        <p:nvGrpSpPr>
          <p:cNvPr id="34" name="Group 33">
            <a:extLst>
              <a:ext uri="{FF2B5EF4-FFF2-40B4-BE49-F238E27FC236}">
                <a16:creationId xmlns:a16="http://schemas.microsoft.com/office/drawing/2014/main" id="{49043F73-8834-4114-AD27-24C1BD0B05A6}"/>
              </a:ext>
            </a:extLst>
          </p:cNvPr>
          <p:cNvGrpSpPr/>
          <p:nvPr userDrawn="1"/>
        </p:nvGrpSpPr>
        <p:grpSpPr>
          <a:xfrm>
            <a:off x="10507067" y="138710"/>
            <a:ext cx="1613769" cy="780217"/>
            <a:chOff x="10446107" y="176810"/>
            <a:chExt cx="1613769" cy="780217"/>
          </a:xfrm>
        </p:grpSpPr>
        <p:sp>
          <p:nvSpPr>
            <p:cNvPr id="19" name="TextBox 18"/>
            <p:cNvSpPr txBox="1"/>
            <p:nvPr/>
          </p:nvSpPr>
          <p:spPr>
            <a:xfrm>
              <a:off x="10618401" y="433807"/>
              <a:ext cx="1441475" cy="523220"/>
            </a:xfrm>
            <a:prstGeom prst="rect">
              <a:avLst/>
            </a:prstGeom>
            <a:noFill/>
          </p:spPr>
          <p:txBody>
            <a:bodyPr wrap="square" rtlCol="0">
              <a:spAutoFit/>
            </a:bodyPr>
            <a:lstStyle/>
            <a:p>
              <a:r>
                <a:rPr lang="en-GB" sz="2800" dirty="0">
                  <a:solidFill>
                    <a:schemeClr val="bg1"/>
                  </a:solidFill>
                </a:rPr>
                <a:t>Article</a:t>
              </a:r>
            </a:p>
          </p:txBody>
        </p:sp>
        <p:sp>
          <p:nvSpPr>
            <p:cNvPr id="18" name="TextBox 17"/>
            <p:cNvSpPr txBox="1"/>
            <p:nvPr/>
          </p:nvSpPr>
          <p:spPr>
            <a:xfrm>
              <a:off x="10446107" y="176810"/>
              <a:ext cx="1593052" cy="523220"/>
            </a:xfrm>
            <a:prstGeom prst="rect">
              <a:avLst/>
            </a:prstGeom>
            <a:noFill/>
          </p:spPr>
          <p:txBody>
            <a:bodyPr wrap="square" rtlCol="0">
              <a:spAutoFit/>
            </a:bodyPr>
            <a:lstStyle/>
            <a:p>
              <a:r>
                <a:rPr lang="en-GB" sz="2800" dirty="0">
                  <a:solidFill>
                    <a:schemeClr val="bg1"/>
                  </a:solidFill>
                </a:rPr>
                <a:t>Original</a:t>
              </a:r>
            </a:p>
          </p:txBody>
        </p:sp>
      </p:grpSp>
      <p:sp>
        <p:nvSpPr>
          <p:cNvPr id="29" name="Flowchart: Stored Data 4">
            <a:extLst>
              <a:ext uri="{FF2B5EF4-FFF2-40B4-BE49-F238E27FC236}">
                <a16:creationId xmlns:a16="http://schemas.microsoft.com/office/drawing/2014/main" id="{17034CCF-1EDD-D498-AB89-09358AFA3492}"/>
              </a:ext>
            </a:extLst>
          </p:cNvPr>
          <p:cNvSpPr/>
          <p:nvPr userDrawn="1"/>
        </p:nvSpPr>
        <p:spPr>
          <a:xfrm rot="16200000" flipV="1">
            <a:off x="2885446" y="2269341"/>
            <a:ext cx="1695596" cy="7512401"/>
          </a:xfrm>
          <a:custGeom>
            <a:avLst/>
            <a:gdLst>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89795 h 103750"/>
              <a:gd name="connsiteX1" fmla="*/ 8293 w 10000"/>
              <a:gd name="connsiteY1" fmla="*/ 0 h 103750"/>
              <a:gd name="connsiteX2" fmla="*/ 8333 w 10000"/>
              <a:gd name="connsiteY2" fmla="*/ 94795 h 103750"/>
              <a:gd name="connsiteX3" fmla="*/ 10000 w 10000"/>
              <a:gd name="connsiteY3" fmla="*/ 99795 h 103750"/>
              <a:gd name="connsiteX4" fmla="*/ 1667 w 10000"/>
              <a:gd name="connsiteY4" fmla="*/ 99795 h 103750"/>
              <a:gd name="connsiteX5" fmla="*/ 0 w 10000"/>
              <a:gd name="connsiteY5" fmla="*/ 94795 h 103750"/>
              <a:gd name="connsiteX6" fmla="*/ 1667 w 10000"/>
              <a:gd name="connsiteY6" fmla="*/ 89795 h 10375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5639 w 10161"/>
              <a:gd name="connsiteY0" fmla="*/ 18392 h 112308"/>
              <a:gd name="connsiteX1" fmla="*/ 8672 w 10161"/>
              <a:gd name="connsiteY1" fmla="*/ 5059 h 112308"/>
              <a:gd name="connsiteX2" fmla="*/ 8494 w 10161"/>
              <a:gd name="connsiteY2" fmla="*/ 103121 h 112308"/>
              <a:gd name="connsiteX3" fmla="*/ 10161 w 10161"/>
              <a:gd name="connsiteY3" fmla="*/ 108121 h 112308"/>
              <a:gd name="connsiteX4" fmla="*/ 1828 w 10161"/>
              <a:gd name="connsiteY4" fmla="*/ 108121 h 112308"/>
              <a:gd name="connsiteX5" fmla="*/ 161 w 10161"/>
              <a:gd name="connsiteY5" fmla="*/ 103121 h 112308"/>
              <a:gd name="connsiteX6" fmla="*/ 5639 w 10161"/>
              <a:gd name="connsiteY6" fmla="*/ 18392 h 112308"/>
              <a:gd name="connsiteX0" fmla="*/ 5639 w 10161"/>
              <a:gd name="connsiteY0" fmla="*/ 48998 h 145481"/>
              <a:gd name="connsiteX1" fmla="*/ 8354 w 10161"/>
              <a:gd name="connsiteY1" fmla="*/ 0 h 145481"/>
              <a:gd name="connsiteX2" fmla="*/ 8494 w 10161"/>
              <a:gd name="connsiteY2" fmla="*/ 133727 h 145481"/>
              <a:gd name="connsiteX3" fmla="*/ 10161 w 10161"/>
              <a:gd name="connsiteY3" fmla="*/ 138727 h 145481"/>
              <a:gd name="connsiteX4" fmla="*/ 1828 w 10161"/>
              <a:gd name="connsiteY4" fmla="*/ 138727 h 145481"/>
              <a:gd name="connsiteX5" fmla="*/ 161 w 10161"/>
              <a:gd name="connsiteY5" fmla="*/ 133727 h 145481"/>
              <a:gd name="connsiteX6" fmla="*/ 5639 w 10161"/>
              <a:gd name="connsiteY6" fmla="*/ 48998 h 145481"/>
              <a:gd name="connsiteX0" fmla="*/ 4738 w 10113"/>
              <a:gd name="connsiteY0" fmla="*/ 13812 h 159292"/>
              <a:gd name="connsiteX1" fmla="*/ 8306 w 10113"/>
              <a:gd name="connsiteY1" fmla="*/ 13811 h 159292"/>
              <a:gd name="connsiteX2" fmla="*/ 8446 w 10113"/>
              <a:gd name="connsiteY2" fmla="*/ 147538 h 159292"/>
              <a:gd name="connsiteX3" fmla="*/ 10113 w 10113"/>
              <a:gd name="connsiteY3" fmla="*/ 152538 h 159292"/>
              <a:gd name="connsiteX4" fmla="*/ 1780 w 10113"/>
              <a:gd name="connsiteY4" fmla="*/ 152538 h 159292"/>
              <a:gd name="connsiteX5" fmla="*/ 113 w 10113"/>
              <a:gd name="connsiteY5" fmla="*/ 147538 h 159292"/>
              <a:gd name="connsiteX6" fmla="*/ 4738 w 10113"/>
              <a:gd name="connsiteY6" fmla="*/ 13812 h 159292"/>
              <a:gd name="connsiteX0" fmla="*/ 4738 w 10113"/>
              <a:gd name="connsiteY0" fmla="*/ 2870 h 148350"/>
              <a:gd name="connsiteX1" fmla="*/ 8306 w 10113"/>
              <a:gd name="connsiteY1" fmla="*/ 2869 h 148350"/>
              <a:gd name="connsiteX2" fmla="*/ 8446 w 10113"/>
              <a:gd name="connsiteY2" fmla="*/ 136596 h 148350"/>
              <a:gd name="connsiteX3" fmla="*/ 10113 w 10113"/>
              <a:gd name="connsiteY3" fmla="*/ 141596 h 148350"/>
              <a:gd name="connsiteX4" fmla="*/ 1780 w 10113"/>
              <a:gd name="connsiteY4" fmla="*/ 141596 h 148350"/>
              <a:gd name="connsiteX5" fmla="*/ 113 w 10113"/>
              <a:gd name="connsiteY5" fmla="*/ 136596 h 148350"/>
              <a:gd name="connsiteX6" fmla="*/ 4738 w 10113"/>
              <a:gd name="connsiteY6" fmla="*/ 2870 h 148350"/>
              <a:gd name="connsiteX0" fmla="*/ 4738 w 10113"/>
              <a:gd name="connsiteY0" fmla="*/ 51 h 145531"/>
              <a:gd name="connsiteX1" fmla="*/ 8306 w 10113"/>
              <a:gd name="connsiteY1" fmla="*/ 50 h 145531"/>
              <a:gd name="connsiteX2" fmla="*/ 8446 w 10113"/>
              <a:gd name="connsiteY2" fmla="*/ 133777 h 145531"/>
              <a:gd name="connsiteX3" fmla="*/ 10113 w 10113"/>
              <a:gd name="connsiteY3" fmla="*/ 138777 h 145531"/>
              <a:gd name="connsiteX4" fmla="*/ 1780 w 10113"/>
              <a:gd name="connsiteY4" fmla="*/ 138777 h 145531"/>
              <a:gd name="connsiteX5" fmla="*/ 113 w 10113"/>
              <a:gd name="connsiteY5" fmla="*/ 133777 h 145531"/>
              <a:gd name="connsiteX6" fmla="*/ 4738 w 10113"/>
              <a:gd name="connsiteY6" fmla="*/ 51 h 145531"/>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674 w 10109"/>
              <a:gd name="connsiteY0" fmla="*/ 170 h 145517"/>
              <a:gd name="connsiteX1" fmla="*/ 8302 w 10109"/>
              <a:gd name="connsiteY1" fmla="*/ 36 h 145517"/>
              <a:gd name="connsiteX2" fmla="*/ 8442 w 10109"/>
              <a:gd name="connsiteY2" fmla="*/ 133763 h 145517"/>
              <a:gd name="connsiteX3" fmla="*/ 10109 w 10109"/>
              <a:gd name="connsiteY3" fmla="*/ 138763 h 145517"/>
              <a:gd name="connsiteX4" fmla="*/ 1776 w 10109"/>
              <a:gd name="connsiteY4" fmla="*/ 138763 h 145517"/>
              <a:gd name="connsiteX5" fmla="*/ 109 w 10109"/>
              <a:gd name="connsiteY5" fmla="*/ 133763 h 145517"/>
              <a:gd name="connsiteX6" fmla="*/ 4674 w 10109"/>
              <a:gd name="connsiteY6" fmla="*/ 170 h 145517"/>
              <a:gd name="connsiteX0" fmla="*/ 3080 w 8515"/>
              <a:gd name="connsiteY0" fmla="*/ 170 h 145517"/>
              <a:gd name="connsiteX1" fmla="*/ 6708 w 8515"/>
              <a:gd name="connsiteY1" fmla="*/ 36 h 145517"/>
              <a:gd name="connsiteX2" fmla="*/ 6848 w 8515"/>
              <a:gd name="connsiteY2" fmla="*/ 133763 h 145517"/>
              <a:gd name="connsiteX3" fmla="*/ 8515 w 8515"/>
              <a:gd name="connsiteY3" fmla="*/ 138763 h 145517"/>
              <a:gd name="connsiteX4" fmla="*/ 182 w 8515"/>
              <a:gd name="connsiteY4" fmla="*/ 138763 h 145517"/>
              <a:gd name="connsiteX5" fmla="*/ 3080 w 8515"/>
              <a:gd name="connsiteY5" fmla="*/ 170 h 145517"/>
              <a:gd name="connsiteX0" fmla="*/ 3617 w 10000"/>
              <a:gd name="connsiteY0" fmla="*/ 12 h 9536"/>
              <a:gd name="connsiteX1" fmla="*/ 7878 w 10000"/>
              <a:gd name="connsiteY1" fmla="*/ 2 h 9536"/>
              <a:gd name="connsiteX2" fmla="*/ 8042 w 10000"/>
              <a:gd name="connsiteY2" fmla="*/ 9192 h 9536"/>
              <a:gd name="connsiteX3" fmla="*/ 10000 w 10000"/>
              <a:gd name="connsiteY3" fmla="*/ 9536 h 9536"/>
              <a:gd name="connsiteX4" fmla="*/ 214 w 10000"/>
              <a:gd name="connsiteY4" fmla="*/ 9536 h 9536"/>
              <a:gd name="connsiteX5" fmla="*/ 3617 w 10000"/>
              <a:gd name="connsiteY5" fmla="*/ 12 h 9536"/>
              <a:gd name="connsiteX0" fmla="*/ 3403 w 9786"/>
              <a:gd name="connsiteY0" fmla="*/ 13 h 10000"/>
              <a:gd name="connsiteX1" fmla="*/ 7664 w 9786"/>
              <a:gd name="connsiteY1" fmla="*/ 2 h 10000"/>
              <a:gd name="connsiteX2" fmla="*/ 7828 w 9786"/>
              <a:gd name="connsiteY2" fmla="*/ 9639 h 10000"/>
              <a:gd name="connsiteX3" fmla="*/ 9786 w 9786"/>
              <a:gd name="connsiteY3" fmla="*/ 10000 h 10000"/>
              <a:gd name="connsiteX4" fmla="*/ 0 w 9786"/>
              <a:gd name="connsiteY4" fmla="*/ 10000 h 10000"/>
              <a:gd name="connsiteX5" fmla="*/ 3403 w 9786"/>
              <a:gd name="connsiteY5" fmla="*/ 13 h 10000"/>
              <a:gd name="connsiteX0" fmla="*/ 494 w 7017"/>
              <a:gd name="connsiteY0" fmla="*/ 743 h 10730"/>
              <a:gd name="connsiteX1" fmla="*/ 4849 w 7017"/>
              <a:gd name="connsiteY1" fmla="*/ 732 h 10730"/>
              <a:gd name="connsiteX2" fmla="*/ 5016 w 7017"/>
              <a:gd name="connsiteY2" fmla="*/ 10369 h 10730"/>
              <a:gd name="connsiteX3" fmla="*/ 7017 w 7017"/>
              <a:gd name="connsiteY3" fmla="*/ 10730 h 10730"/>
              <a:gd name="connsiteX4" fmla="*/ 45 w 7017"/>
              <a:gd name="connsiteY4" fmla="*/ 10709 h 10730"/>
              <a:gd name="connsiteX5" fmla="*/ 494 w 7017"/>
              <a:gd name="connsiteY5" fmla="*/ 743 h 10730"/>
              <a:gd name="connsiteX0" fmla="*/ 521 w 9817"/>
              <a:gd name="connsiteY0" fmla="*/ 692 h 10000"/>
              <a:gd name="connsiteX1" fmla="*/ 6727 w 9817"/>
              <a:gd name="connsiteY1" fmla="*/ 682 h 10000"/>
              <a:gd name="connsiteX2" fmla="*/ 6965 w 9817"/>
              <a:gd name="connsiteY2" fmla="*/ 9664 h 10000"/>
              <a:gd name="connsiteX3" fmla="*/ 9817 w 9817"/>
              <a:gd name="connsiteY3" fmla="*/ 10000 h 10000"/>
              <a:gd name="connsiteX4" fmla="*/ 273 w 9817"/>
              <a:gd name="connsiteY4" fmla="*/ 9980 h 10000"/>
              <a:gd name="connsiteX5" fmla="*/ 521 w 9817"/>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70 w 10039"/>
              <a:gd name="connsiteY0" fmla="*/ 695 h 10015"/>
              <a:gd name="connsiteX1" fmla="*/ 6891 w 10039"/>
              <a:gd name="connsiteY1" fmla="*/ 685 h 10015"/>
              <a:gd name="connsiteX2" fmla="*/ 7134 w 10039"/>
              <a:gd name="connsiteY2" fmla="*/ 9667 h 10015"/>
              <a:gd name="connsiteX3" fmla="*/ 10039 w 10039"/>
              <a:gd name="connsiteY3" fmla="*/ 10003 h 10015"/>
              <a:gd name="connsiteX4" fmla="*/ 217 w 10039"/>
              <a:gd name="connsiteY4" fmla="*/ 10015 h 10015"/>
              <a:gd name="connsiteX5" fmla="*/ 570 w 10039"/>
              <a:gd name="connsiteY5" fmla="*/ 695 h 10015"/>
              <a:gd name="connsiteX0" fmla="*/ 615 w 10084"/>
              <a:gd name="connsiteY0" fmla="*/ 695 h 10015"/>
              <a:gd name="connsiteX1" fmla="*/ 6936 w 10084"/>
              <a:gd name="connsiteY1" fmla="*/ 685 h 10015"/>
              <a:gd name="connsiteX2" fmla="*/ 7179 w 10084"/>
              <a:gd name="connsiteY2" fmla="*/ 9667 h 10015"/>
              <a:gd name="connsiteX3" fmla="*/ 10084 w 10084"/>
              <a:gd name="connsiteY3" fmla="*/ 10003 h 10015"/>
              <a:gd name="connsiteX4" fmla="*/ 262 w 10084"/>
              <a:gd name="connsiteY4" fmla="*/ 10015 h 10015"/>
              <a:gd name="connsiteX5" fmla="*/ 615 w 10084"/>
              <a:gd name="connsiteY5" fmla="*/ 695 h 10015"/>
              <a:gd name="connsiteX0" fmla="*/ 356 w 9825"/>
              <a:gd name="connsiteY0" fmla="*/ 695 h 10015"/>
              <a:gd name="connsiteX1" fmla="*/ 6677 w 9825"/>
              <a:gd name="connsiteY1" fmla="*/ 685 h 10015"/>
              <a:gd name="connsiteX2" fmla="*/ 6920 w 9825"/>
              <a:gd name="connsiteY2" fmla="*/ 9667 h 10015"/>
              <a:gd name="connsiteX3" fmla="*/ 9825 w 9825"/>
              <a:gd name="connsiteY3" fmla="*/ 10003 h 10015"/>
              <a:gd name="connsiteX4" fmla="*/ 3 w 9825"/>
              <a:gd name="connsiteY4" fmla="*/ 10015 h 10015"/>
              <a:gd name="connsiteX5" fmla="*/ 356 w 9825"/>
              <a:gd name="connsiteY5" fmla="*/ 695 h 10015"/>
              <a:gd name="connsiteX0" fmla="*/ 362 w 10000"/>
              <a:gd name="connsiteY0" fmla="*/ 10 h 9316"/>
              <a:gd name="connsiteX1" fmla="*/ 6796 w 10000"/>
              <a:gd name="connsiteY1" fmla="*/ 0 h 9316"/>
              <a:gd name="connsiteX2" fmla="*/ 7043 w 10000"/>
              <a:gd name="connsiteY2" fmla="*/ 8969 h 9316"/>
              <a:gd name="connsiteX3" fmla="*/ 10000 w 10000"/>
              <a:gd name="connsiteY3" fmla="*/ 9304 h 9316"/>
              <a:gd name="connsiteX4" fmla="*/ 3 w 10000"/>
              <a:gd name="connsiteY4" fmla="*/ 9316 h 9316"/>
              <a:gd name="connsiteX5" fmla="*/ 362 w 10000"/>
              <a:gd name="connsiteY5" fmla="*/ 10 h 9316"/>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0 w 9998"/>
              <a:gd name="connsiteY0" fmla="*/ 11 h 10000"/>
              <a:gd name="connsiteX1" fmla="*/ 7099 w 9998"/>
              <a:gd name="connsiteY1" fmla="*/ 0 h 10000"/>
              <a:gd name="connsiteX2" fmla="*/ 7041 w 9998"/>
              <a:gd name="connsiteY2" fmla="*/ 9628 h 10000"/>
              <a:gd name="connsiteX3" fmla="*/ 9998 w 9998"/>
              <a:gd name="connsiteY3" fmla="*/ 9987 h 10000"/>
              <a:gd name="connsiteX4" fmla="*/ 1 w 9998"/>
              <a:gd name="connsiteY4" fmla="*/ 10000 h 10000"/>
              <a:gd name="connsiteX5" fmla="*/ 360 w 9998"/>
              <a:gd name="connsiteY5" fmla="*/ 11 h 10000"/>
              <a:gd name="connsiteX0" fmla="*/ 0 w 9640"/>
              <a:gd name="connsiteY0" fmla="*/ 11 h 10000"/>
              <a:gd name="connsiteX1" fmla="*/ 6740 w 9640"/>
              <a:gd name="connsiteY1" fmla="*/ 0 h 10000"/>
              <a:gd name="connsiteX2" fmla="*/ 6682 w 9640"/>
              <a:gd name="connsiteY2" fmla="*/ 9628 h 10000"/>
              <a:gd name="connsiteX3" fmla="*/ 9640 w 9640"/>
              <a:gd name="connsiteY3" fmla="*/ 9987 h 10000"/>
              <a:gd name="connsiteX4" fmla="*/ 302 w 9640"/>
              <a:gd name="connsiteY4" fmla="*/ 10000 h 10000"/>
              <a:gd name="connsiteX5" fmla="*/ 0 w 964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9991"/>
              <a:gd name="connsiteX1" fmla="*/ 7048 w 10056"/>
              <a:gd name="connsiteY1" fmla="*/ 0 h 9991"/>
              <a:gd name="connsiteX2" fmla="*/ 6988 w 10056"/>
              <a:gd name="connsiteY2" fmla="*/ 9628 h 9991"/>
              <a:gd name="connsiteX3" fmla="*/ 10056 w 10056"/>
              <a:gd name="connsiteY3" fmla="*/ 9987 h 9991"/>
              <a:gd name="connsiteX4" fmla="*/ 129 w 10056"/>
              <a:gd name="connsiteY4" fmla="*/ 9991 h 9991"/>
              <a:gd name="connsiteX5" fmla="*/ 0 w 10056"/>
              <a:gd name="connsiteY5" fmla="*/ 4 h 9991"/>
              <a:gd name="connsiteX0" fmla="*/ 0 w 10000"/>
              <a:gd name="connsiteY0" fmla="*/ 0 h 9996"/>
              <a:gd name="connsiteX1" fmla="*/ 6799 w 10000"/>
              <a:gd name="connsiteY1" fmla="*/ 3842 h 9996"/>
              <a:gd name="connsiteX2" fmla="*/ 6949 w 10000"/>
              <a:gd name="connsiteY2" fmla="*/ 9633 h 9996"/>
              <a:gd name="connsiteX3" fmla="*/ 10000 w 10000"/>
              <a:gd name="connsiteY3" fmla="*/ 9992 h 9996"/>
              <a:gd name="connsiteX4" fmla="*/ 128 w 10000"/>
              <a:gd name="connsiteY4" fmla="*/ 9996 h 9996"/>
              <a:gd name="connsiteX5" fmla="*/ 0 w 10000"/>
              <a:gd name="connsiteY5" fmla="*/ 0 h 9996"/>
              <a:gd name="connsiteX0" fmla="*/ 0 w 9895"/>
              <a:gd name="connsiteY0" fmla="*/ 11 h 6156"/>
              <a:gd name="connsiteX1" fmla="*/ 6694 w 9895"/>
              <a:gd name="connsiteY1" fmla="*/ 0 h 6156"/>
              <a:gd name="connsiteX2" fmla="*/ 6844 w 9895"/>
              <a:gd name="connsiteY2" fmla="*/ 5793 h 6156"/>
              <a:gd name="connsiteX3" fmla="*/ 9895 w 9895"/>
              <a:gd name="connsiteY3" fmla="*/ 6152 h 6156"/>
              <a:gd name="connsiteX4" fmla="*/ 23 w 9895"/>
              <a:gd name="connsiteY4" fmla="*/ 6156 h 6156"/>
              <a:gd name="connsiteX5" fmla="*/ 0 w 9895"/>
              <a:gd name="connsiteY5" fmla="*/ 11 h 6156"/>
              <a:gd name="connsiteX0" fmla="*/ 0 w 11007"/>
              <a:gd name="connsiteY0" fmla="*/ 7 h 10000"/>
              <a:gd name="connsiteX1" fmla="*/ 7772 w 11007"/>
              <a:gd name="connsiteY1" fmla="*/ 0 h 10000"/>
              <a:gd name="connsiteX2" fmla="*/ 7924 w 11007"/>
              <a:gd name="connsiteY2" fmla="*/ 9410 h 10000"/>
              <a:gd name="connsiteX3" fmla="*/ 11007 w 11007"/>
              <a:gd name="connsiteY3" fmla="*/ 9994 h 10000"/>
              <a:gd name="connsiteX4" fmla="*/ 1030 w 11007"/>
              <a:gd name="connsiteY4" fmla="*/ 10000 h 10000"/>
              <a:gd name="connsiteX5" fmla="*/ 0 w 11007"/>
              <a:gd name="connsiteY5" fmla="*/ 7 h 10000"/>
              <a:gd name="connsiteX0" fmla="*/ 0 w 11007"/>
              <a:gd name="connsiteY0" fmla="*/ 7 h 10000"/>
              <a:gd name="connsiteX1" fmla="*/ 7772 w 11007"/>
              <a:gd name="connsiteY1" fmla="*/ 0 h 10000"/>
              <a:gd name="connsiteX2" fmla="*/ 7924 w 11007"/>
              <a:gd name="connsiteY2" fmla="*/ 9410 h 10000"/>
              <a:gd name="connsiteX3" fmla="*/ 11007 w 11007"/>
              <a:gd name="connsiteY3" fmla="*/ 9994 h 10000"/>
              <a:gd name="connsiteX4" fmla="*/ 23 w 11007"/>
              <a:gd name="connsiteY4" fmla="*/ 10000 h 10000"/>
              <a:gd name="connsiteX5" fmla="*/ 0 w 11007"/>
              <a:gd name="connsiteY5" fmla="*/ 7 h 10000"/>
              <a:gd name="connsiteX0" fmla="*/ 76 w 10988"/>
              <a:gd name="connsiteY0" fmla="*/ 45 h 10000"/>
              <a:gd name="connsiteX1" fmla="*/ 7753 w 10988"/>
              <a:gd name="connsiteY1" fmla="*/ 0 h 10000"/>
              <a:gd name="connsiteX2" fmla="*/ 7905 w 10988"/>
              <a:gd name="connsiteY2" fmla="*/ 9410 h 10000"/>
              <a:gd name="connsiteX3" fmla="*/ 10988 w 10988"/>
              <a:gd name="connsiteY3" fmla="*/ 9994 h 10000"/>
              <a:gd name="connsiteX4" fmla="*/ 4 w 10988"/>
              <a:gd name="connsiteY4" fmla="*/ 10000 h 10000"/>
              <a:gd name="connsiteX5" fmla="*/ 76 w 10988"/>
              <a:gd name="connsiteY5" fmla="*/ 45 h 10000"/>
              <a:gd name="connsiteX0" fmla="*/ 16 w 10988"/>
              <a:gd name="connsiteY0" fmla="*/ 20 h 10000"/>
              <a:gd name="connsiteX1" fmla="*/ 7753 w 10988"/>
              <a:gd name="connsiteY1" fmla="*/ 0 h 10000"/>
              <a:gd name="connsiteX2" fmla="*/ 7905 w 10988"/>
              <a:gd name="connsiteY2" fmla="*/ 9410 h 10000"/>
              <a:gd name="connsiteX3" fmla="*/ 10988 w 10988"/>
              <a:gd name="connsiteY3" fmla="*/ 9994 h 10000"/>
              <a:gd name="connsiteX4" fmla="*/ 4 w 10988"/>
              <a:gd name="connsiteY4" fmla="*/ 10000 h 10000"/>
              <a:gd name="connsiteX5" fmla="*/ 16 w 10988"/>
              <a:gd name="connsiteY5" fmla="*/ 20 h 10000"/>
              <a:gd name="connsiteX0" fmla="*/ 16 w 10988"/>
              <a:gd name="connsiteY0" fmla="*/ 0 h 9980"/>
              <a:gd name="connsiteX1" fmla="*/ 7753 w 10988"/>
              <a:gd name="connsiteY1" fmla="*/ 0 h 9980"/>
              <a:gd name="connsiteX2" fmla="*/ 7905 w 10988"/>
              <a:gd name="connsiteY2" fmla="*/ 9390 h 9980"/>
              <a:gd name="connsiteX3" fmla="*/ 10988 w 10988"/>
              <a:gd name="connsiteY3" fmla="*/ 9974 h 9980"/>
              <a:gd name="connsiteX4" fmla="*/ 4 w 10988"/>
              <a:gd name="connsiteY4" fmla="*/ 9980 h 9980"/>
              <a:gd name="connsiteX5" fmla="*/ 16 w 10988"/>
              <a:gd name="connsiteY5" fmla="*/ 0 h 9980"/>
              <a:gd name="connsiteX0" fmla="*/ 0 w 9985"/>
              <a:gd name="connsiteY0" fmla="*/ 0 h 9994"/>
              <a:gd name="connsiteX1" fmla="*/ 7041 w 9985"/>
              <a:gd name="connsiteY1" fmla="*/ 0 h 9994"/>
              <a:gd name="connsiteX2" fmla="*/ 7179 w 9985"/>
              <a:gd name="connsiteY2" fmla="*/ 9409 h 9994"/>
              <a:gd name="connsiteX3" fmla="*/ 9985 w 9985"/>
              <a:gd name="connsiteY3" fmla="*/ 9994 h 9994"/>
              <a:gd name="connsiteX4" fmla="*/ 11 w 9985"/>
              <a:gd name="connsiteY4" fmla="*/ 9987 h 9994"/>
              <a:gd name="connsiteX5" fmla="*/ 0 w 9985"/>
              <a:gd name="connsiteY5" fmla="*/ 0 h 9994"/>
              <a:gd name="connsiteX0" fmla="*/ 0 w 10000"/>
              <a:gd name="connsiteY0" fmla="*/ 0 h 10000"/>
              <a:gd name="connsiteX1" fmla="*/ 7052 w 10000"/>
              <a:gd name="connsiteY1" fmla="*/ 0 h 10000"/>
              <a:gd name="connsiteX2" fmla="*/ 7190 w 10000"/>
              <a:gd name="connsiteY2" fmla="*/ 9415 h 10000"/>
              <a:gd name="connsiteX3" fmla="*/ 10000 w 10000"/>
              <a:gd name="connsiteY3" fmla="*/ 10000 h 10000"/>
              <a:gd name="connsiteX4" fmla="*/ 11 w 10000"/>
              <a:gd name="connsiteY4" fmla="*/ 9996 h 10000"/>
              <a:gd name="connsiteX5" fmla="*/ 0 w 10000"/>
              <a:gd name="connsiteY5" fmla="*/ 0 h 10000"/>
              <a:gd name="connsiteX0" fmla="*/ 35 w 10035"/>
              <a:gd name="connsiteY0" fmla="*/ 0 h 10009"/>
              <a:gd name="connsiteX1" fmla="*/ 7087 w 10035"/>
              <a:gd name="connsiteY1" fmla="*/ 0 h 10009"/>
              <a:gd name="connsiteX2" fmla="*/ 7225 w 10035"/>
              <a:gd name="connsiteY2" fmla="*/ 9415 h 10009"/>
              <a:gd name="connsiteX3" fmla="*/ 10035 w 10035"/>
              <a:gd name="connsiteY3" fmla="*/ 10000 h 10009"/>
              <a:gd name="connsiteX4" fmla="*/ 3 w 10035"/>
              <a:gd name="connsiteY4" fmla="*/ 10009 h 10009"/>
              <a:gd name="connsiteX5" fmla="*/ 35 w 10035"/>
              <a:gd name="connsiteY5" fmla="*/ 0 h 10009"/>
              <a:gd name="connsiteX0" fmla="*/ 0 w 10000"/>
              <a:gd name="connsiteY0" fmla="*/ 0 h 10000"/>
              <a:gd name="connsiteX1" fmla="*/ 7052 w 10000"/>
              <a:gd name="connsiteY1" fmla="*/ 0 h 10000"/>
              <a:gd name="connsiteX2" fmla="*/ 7190 w 10000"/>
              <a:gd name="connsiteY2" fmla="*/ 9415 h 10000"/>
              <a:gd name="connsiteX3" fmla="*/ 10000 w 10000"/>
              <a:gd name="connsiteY3" fmla="*/ 10000 h 10000"/>
              <a:gd name="connsiteX4" fmla="*/ 66 w 10000"/>
              <a:gd name="connsiteY4" fmla="*/ 9989 h 10000"/>
              <a:gd name="connsiteX5" fmla="*/ 0 w 10000"/>
              <a:gd name="connsiteY5" fmla="*/ 0 h 10000"/>
              <a:gd name="connsiteX0" fmla="*/ 0 w 10000"/>
              <a:gd name="connsiteY0" fmla="*/ 0 h 10002"/>
              <a:gd name="connsiteX1" fmla="*/ 7052 w 10000"/>
              <a:gd name="connsiteY1" fmla="*/ 0 h 10002"/>
              <a:gd name="connsiteX2" fmla="*/ 7190 w 10000"/>
              <a:gd name="connsiteY2" fmla="*/ 9415 h 10002"/>
              <a:gd name="connsiteX3" fmla="*/ 10000 w 10000"/>
              <a:gd name="connsiteY3" fmla="*/ 10000 h 10002"/>
              <a:gd name="connsiteX4" fmla="*/ 23 w 10000"/>
              <a:gd name="connsiteY4" fmla="*/ 10002 h 10002"/>
              <a:gd name="connsiteX5" fmla="*/ 0 w 10000"/>
              <a:gd name="connsiteY5" fmla="*/ 0 h 10002"/>
              <a:gd name="connsiteX0" fmla="*/ 164 w 10164"/>
              <a:gd name="connsiteY0" fmla="*/ 0 h 10000"/>
              <a:gd name="connsiteX1" fmla="*/ 7216 w 10164"/>
              <a:gd name="connsiteY1" fmla="*/ 0 h 10000"/>
              <a:gd name="connsiteX2" fmla="*/ 7354 w 10164"/>
              <a:gd name="connsiteY2" fmla="*/ 9415 h 10000"/>
              <a:gd name="connsiteX3" fmla="*/ 10164 w 10164"/>
              <a:gd name="connsiteY3" fmla="*/ 10000 h 10000"/>
              <a:gd name="connsiteX4" fmla="*/ 2 w 10164"/>
              <a:gd name="connsiteY4" fmla="*/ 9999 h 10000"/>
              <a:gd name="connsiteX5" fmla="*/ 164 w 10164"/>
              <a:gd name="connsiteY5" fmla="*/ 0 h 10000"/>
              <a:gd name="connsiteX0" fmla="*/ 163 w 10163"/>
              <a:gd name="connsiteY0" fmla="*/ 0 h 10000"/>
              <a:gd name="connsiteX1" fmla="*/ 7215 w 10163"/>
              <a:gd name="connsiteY1" fmla="*/ 0 h 10000"/>
              <a:gd name="connsiteX2" fmla="*/ 7353 w 10163"/>
              <a:gd name="connsiteY2" fmla="*/ 9415 h 10000"/>
              <a:gd name="connsiteX3" fmla="*/ 10163 w 10163"/>
              <a:gd name="connsiteY3" fmla="*/ 10000 h 10000"/>
              <a:gd name="connsiteX4" fmla="*/ 1 w 10163"/>
              <a:gd name="connsiteY4" fmla="*/ 9999 h 10000"/>
              <a:gd name="connsiteX5" fmla="*/ 163 w 10163"/>
              <a:gd name="connsiteY5" fmla="*/ 0 h 10000"/>
              <a:gd name="connsiteX0" fmla="*/ 0 w 10174"/>
              <a:gd name="connsiteY0" fmla="*/ 0 h 10000"/>
              <a:gd name="connsiteX1" fmla="*/ 7226 w 10174"/>
              <a:gd name="connsiteY1" fmla="*/ 0 h 10000"/>
              <a:gd name="connsiteX2" fmla="*/ 7364 w 10174"/>
              <a:gd name="connsiteY2" fmla="*/ 9415 h 10000"/>
              <a:gd name="connsiteX3" fmla="*/ 10174 w 10174"/>
              <a:gd name="connsiteY3" fmla="*/ 10000 h 10000"/>
              <a:gd name="connsiteX4" fmla="*/ 12 w 10174"/>
              <a:gd name="connsiteY4" fmla="*/ 9999 h 10000"/>
              <a:gd name="connsiteX5" fmla="*/ 0 w 10174"/>
              <a:gd name="connsiteY5" fmla="*/ 0 h 10000"/>
              <a:gd name="connsiteX0" fmla="*/ 0 w 10174"/>
              <a:gd name="connsiteY0" fmla="*/ 0 h 10000"/>
              <a:gd name="connsiteX1" fmla="*/ 7226 w 10174"/>
              <a:gd name="connsiteY1" fmla="*/ 0 h 10000"/>
              <a:gd name="connsiteX2" fmla="*/ 7364 w 10174"/>
              <a:gd name="connsiteY2" fmla="*/ 9415 h 10000"/>
              <a:gd name="connsiteX3" fmla="*/ 10174 w 10174"/>
              <a:gd name="connsiteY3" fmla="*/ 10000 h 10000"/>
              <a:gd name="connsiteX4" fmla="*/ 12 w 10174"/>
              <a:gd name="connsiteY4" fmla="*/ 9999 h 10000"/>
              <a:gd name="connsiteX5" fmla="*/ 0 w 10174"/>
              <a:gd name="connsiteY5" fmla="*/ 0 h 10000"/>
              <a:gd name="connsiteX0" fmla="*/ 0 w 10174"/>
              <a:gd name="connsiteY0" fmla="*/ 3 h 10003"/>
              <a:gd name="connsiteX1" fmla="*/ 7335 w 10174"/>
              <a:gd name="connsiteY1" fmla="*/ 0 h 10003"/>
              <a:gd name="connsiteX2" fmla="*/ 7364 w 10174"/>
              <a:gd name="connsiteY2" fmla="*/ 9418 h 10003"/>
              <a:gd name="connsiteX3" fmla="*/ 10174 w 10174"/>
              <a:gd name="connsiteY3" fmla="*/ 10003 h 10003"/>
              <a:gd name="connsiteX4" fmla="*/ 12 w 10174"/>
              <a:gd name="connsiteY4" fmla="*/ 10002 h 10003"/>
              <a:gd name="connsiteX5" fmla="*/ 0 w 10174"/>
              <a:gd name="connsiteY5" fmla="*/ 3 h 10003"/>
              <a:gd name="connsiteX0" fmla="*/ 0 w 10174"/>
              <a:gd name="connsiteY0" fmla="*/ 6 h 10006"/>
              <a:gd name="connsiteX1" fmla="*/ 7346 w 10174"/>
              <a:gd name="connsiteY1" fmla="*/ 0 h 10006"/>
              <a:gd name="connsiteX2" fmla="*/ 7364 w 10174"/>
              <a:gd name="connsiteY2" fmla="*/ 9421 h 10006"/>
              <a:gd name="connsiteX3" fmla="*/ 10174 w 10174"/>
              <a:gd name="connsiteY3" fmla="*/ 10006 h 10006"/>
              <a:gd name="connsiteX4" fmla="*/ 12 w 10174"/>
              <a:gd name="connsiteY4" fmla="*/ 10005 h 10006"/>
              <a:gd name="connsiteX5" fmla="*/ 0 w 10174"/>
              <a:gd name="connsiteY5" fmla="*/ 6 h 10006"/>
              <a:gd name="connsiteX0" fmla="*/ 0 w 10174"/>
              <a:gd name="connsiteY0" fmla="*/ 6 h 10006"/>
              <a:gd name="connsiteX1" fmla="*/ 7346 w 10174"/>
              <a:gd name="connsiteY1" fmla="*/ 0 h 10006"/>
              <a:gd name="connsiteX2" fmla="*/ 7364 w 10174"/>
              <a:gd name="connsiteY2" fmla="*/ 9421 h 10006"/>
              <a:gd name="connsiteX3" fmla="*/ 10174 w 10174"/>
              <a:gd name="connsiteY3" fmla="*/ 10006 h 10006"/>
              <a:gd name="connsiteX4" fmla="*/ 12 w 10174"/>
              <a:gd name="connsiteY4" fmla="*/ 10005 h 10006"/>
              <a:gd name="connsiteX5" fmla="*/ 0 w 10174"/>
              <a:gd name="connsiteY5" fmla="*/ 6 h 10006"/>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0 w 9613"/>
              <a:gd name="connsiteY0" fmla="*/ 3 h 10009"/>
              <a:gd name="connsiteX1" fmla="*/ 6785 w 9613"/>
              <a:gd name="connsiteY1" fmla="*/ 0 h 10009"/>
              <a:gd name="connsiteX2" fmla="*/ 6803 w 9613"/>
              <a:gd name="connsiteY2" fmla="*/ 9424 h 10009"/>
              <a:gd name="connsiteX3" fmla="*/ 9613 w 9613"/>
              <a:gd name="connsiteY3" fmla="*/ 10009 h 10009"/>
              <a:gd name="connsiteX4" fmla="*/ 95 w 9613"/>
              <a:gd name="connsiteY4" fmla="*/ 9998 h 10009"/>
              <a:gd name="connsiteX5" fmla="*/ 0 w 9613"/>
              <a:gd name="connsiteY5" fmla="*/ 3 h 10009"/>
              <a:gd name="connsiteX0" fmla="*/ 0 w 10000"/>
              <a:gd name="connsiteY0" fmla="*/ 3 h 10000"/>
              <a:gd name="connsiteX1" fmla="*/ 7058 w 10000"/>
              <a:gd name="connsiteY1" fmla="*/ 0 h 10000"/>
              <a:gd name="connsiteX2" fmla="*/ 7077 w 10000"/>
              <a:gd name="connsiteY2" fmla="*/ 9416 h 10000"/>
              <a:gd name="connsiteX3" fmla="*/ 10000 w 10000"/>
              <a:gd name="connsiteY3" fmla="*/ 10000 h 10000"/>
              <a:gd name="connsiteX4" fmla="*/ 14 w 10000"/>
              <a:gd name="connsiteY4" fmla="*/ 9999 h 10000"/>
              <a:gd name="connsiteX5" fmla="*/ 0 w 10000"/>
              <a:gd name="connsiteY5" fmla="*/ 3 h 10000"/>
              <a:gd name="connsiteX0" fmla="*/ 51 w 10051"/>
              <a:gd name="connsiteY0" fmla="*/ 3 h 10028"/>
              <a:gd name="connsiteX1" fmla="*/ 7109 w 10051"/>
              <a:gd name="connsiteY1" fmla="*/ 0 h 10028"/>
              <a:gd name="connsiteX2" fmla="*/ 7128 w 10051"/>
              <a:gd name="connsiteY2" fmla="*/ 9416 h 10028"/>
              <a:gd name="connsiteX3" fmla="*/ 10051 w 10051"/>
              <a:gd name="connsiteY3" fmla="*/ 10000 h 10028"/>
              <a:gd name="connsiteX4" fmla="*/ 0 w 10051"/>
              <a:gd name="connsiteY4" fmla="*/ 10028 h 10028"/>
              <a:gd name="connsiteX5" fmla="*/ 51 w 10051"/>
              <a:gd name="connsiteY5" fmla="*/ 3 h 10028"/>
              <a:gd name="connsiteX0" fmla="*/ 0 w 10065"/>
              <a:gd name="connsiteY0" fmla="*/ 3 h 10028"/>
              <a:gd name="connsiteX1" fmla="*/ 7123 w 10065"/>
              <a:gd name="connsiteY1" fmla="*/ 0 h 10028"/>
              <a:gd name="connsiteX2" fmla="*/ 7142 w 10065"/>
              <a:gd name="connsiteY2" fmla="*/ 9416 h 10028"/>
              <a:gd name="connsiteX3" fmla="*/ 10065 w 10065"/>
              <a:gd name="connsiteY3" fmla="*/ 10000 h 10028"/>
              <a:gd name="connsiteX4" fmla="*/ 14 w 10065"/>
              <a:gd name="connsiteY4" fmla="*/ 10028 h 10028"/>
              <a:gd name="connsiteX5" fmla="*/ 0 w 10065"/>
              <a:gd name="connsiteY5" fmla="*/ 3 h 1002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0065" h="10028">
                <a:moveTo>
                  <a:pt x="0" y="3"/>
                </a:moveTo>
                <a:lnTo>
                  <a:pt x="7123" y="0"/>
                </a:lnTo>
                <a:cubicBezTo>
                  <a:pt x="7114" y="2528"/>
                  <a:pt x="7133" y="8825"/>
                  <a:pt x="7142" y="9416"/>
                </a:cubicBezTo>
                <a:cubicBezTo>
                  <a:pt x="7117" y="9743"/>
                  <a:pt x="8449" y="10000"/>
                  <a:pt x="10065" y="10000"/>
                </a:cubicBezTo>
                <a:lnTo>
                  <a:pt x="14" y="10028"/>
                </a:lnTo>
                <a:cubicBezTo>
                  <a:pt x="7" y="7430"/>
                  <a:pt x="15" y="1749"/>
                  <a:pt x="0" y="3"/>
                </a:cubicBezTo>
                <a:close/>
              </a:path>
            </a:pathLst>
          </a:custGeom>
          <a:solidFill>
            <a:srgbClr val="0092F7"/>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sz="1050"/>
          </a:p>
        </p:txBody>
      </p:sp>
    </p:spTree>
    <p:extLst>
      <p:ext uri="{BB962C8B-B14F-4D97-AF65-F5344CB8AC3E}">
        <p14:creationId xmlns:p14="http://schemas.microsoft.com/office/powerpoint/2010/main" val="365508860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preserve="1" userDrawn="1">
  <p:cSld name="Review">
    <p:spTree>
      <p:nvGrpSpPr>
        <p:cNvPr id="1" name=""/>
        <p:cNvGrpSpPr/>
        <p:nvPr/>
      </p:nvGrpSpPr>
      <p:grpSpPr>
        <a:xfrm>
          <a:off x="0" y="0"/>
          <a:ext cx="0" cy="0"/>
          <a:chOff x="0" y="0"/>
          <a:chExt cx="0" cy="0"/>
        </a:xfrm>
      </p:grpSpPr>
      <p:sp>
        <p:nvSpPr>
          <p:cNvPr id="5" name="Flowchart: Stored Data 4">
            <a:extLst>
              <a:ext uri="{FF2B5EF4-FFF2-40B4-BE49-F238E27FC236}">
                <a16:creationId xmlns:a16="http://schemas.microsoft.com/office/drawing/2014/main" id="{D150C2D2-09E4-F78B-7FA6-F42DD5FA59F4}"/>
              </a:ext>
            </a:extLst>
          </p:cNvPr>
          <p:cNvSpPr/>
          <p:nvPr userDrawn="1"/>
        </p:nvSpPr>
        <p:spPr>
          <a:xfrm rot="5400000">
            <a:off x="5283465" y="-5325515"/>
            <a:ext cx="1614236" cy="12214770"/>
          </a:xfrm>
          <a:custGeom>
            <a:avLst/>
            <a:gdLst>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89795 h 103750"/>
              <a:gd name="connsiteX1" fmla="*/ 8293 w 10000"/>
              <a:gd name="connsiteY1" fmla="*/ 0 h 103750"/>
              <a:gd name="connsiteX2" fmla="*/ 8333 w 10000"/>
              <a:gd name="connsiteY2" fmla="*/ 94795 h 103750"/>
              <a:gd name="connsiteX3" fmla="*/ 10000 w 10000"/>
              <a:gd name="connsiteY3" fmla="*/ 99795 h 103750"/>
              <a:gd name="connsiteX4" fmla="*/ 1667 w 10000"/>
              <a:gd name="connsiteY4" fmla="*/ 99795 h 103750"/>
              <a:gd name="connsiteX5" fmla="*/ 0 w 10000"/>
              <a:gd name="connsiteY5" fmla="*/ 94795 h 103750"/>
              <a:gd name="connsiteX6" fmla="*/ 1667 w 10000"/>
              <a:gd name="connsiteY6" fmla="*/ 89795 h 10375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5639 w 10161"/>
              <a:gd name="connsiteY0" fmla="*/ 18392 h 112308"/>
              <a:gd name="connsiteX1" fmla="*/ 8672 w 10161"/>
              <a:gd name="connsiteY1" fmla="*/ 5059 h 112308"/>
              <a:gd name="connsiteX2" fmla="*/ 8494 w 10161"/>
              <a:gd name="connsiteY2" fmla="*/ 103121 h 112308"/>
              <a:gd name="connsiteX3" fmla="*/ 10161 w 10161"/>
              <a:gd name="connsiteY3" fmla="*/ 108121 h 112308"/>
              <a:gd name="connsiteX4" fmla="*/ 1828 w 10161"/>
              <a:gd name="connsiteY4" fmla="*/ 108121 h 112308"/>
              <a:gd name="connsiteX5" fmla="*/ 161 w 10161"/>
              <a:gd name="connsiteY5" fmla="*/ 103121 h 112308"/>
              <a:gd name="connsiteX6" fmla="*/ 5639 w 10161"/>
              <a:gd name="connsiteY6" fmla="*/ 18392 h 112308"/>
              <a:gd name="connsiteX0" fmla="*/ 5639 w 10161"/>
              <a:gd name="connsiteY0" fmla="*/ 48998 h 145481"/>
              <a:gd name="connsiteX1" fmla="*/ 8354 w 10161"/>
              <a:gd name="connsiteY1" fmla="*/ 0 h 145481"/>
              <a:gd name="connsiteX2" fmla="*/ 8494 w 10161"/>
              <a:gd name="connsiteY2" fmla="*/ 133727 h 145481"/>
              <a:gd name="connsiteX3" fmla="*/ 10161 w 10161"/>
              <a:gd name="connsiteY3" fmla="*/ 138727 h 145481"/>
              <a:gd name="connsiteX4" fmla="*/ 1828 w 10161"/>
              <a:gd name="connsiteY4" fmla="*/ 138727 h 145481"/>
              <a:gd name="connsiteX5" fmla="*/ 161 w 10161"/>
              <a:gd name="connsiteY5" fmla="*/ 133727 h 145481"/>
              <a:gd name="connsiteX6" fmla="*/ 5639 w 10161"/>
              <a:gd name="connsiteY6" fmla="*/ 48998 h 145481"/>
              <a:gd name="connsiteX0" fmla="*/ 4738 w 10113"/>
              <a:gd name="connsiteY0" fmla="*/ 13812 h 159292"/>
              <a:gd name="connsiteX1" fmla="*/ 8306 w 10113"/>
              <a:gd name="connsiteY1" fmla="*/ 13811 h 159292"/>
              <a:gd name="connsiteX2" fmla="*/ 8446 w 10113"/>
              <a:gd name="connsiteY2" fmla="*/ 147538 h 159292"/>
              <a:gd name="connsiteX3" fmla="*/ 10113 w 10113"/>
              <a:gd name="connsiteY3" fmla="*/ 152538 h 159292"/>
              <a:gd name="connsiteX4" fmla="*/ 1780 w 10113"/>
              <a:gd name="connsiteY4" fmla="*/ 152538 h 159292"/>
              <a:gd name="connsiteX5" fmla="*/ 113 w 10113"/>
              <a:gd name="connsiteY5" fmla="*/ 147538 h 159292"/>
              <a:gd name="connsiteX6" fmla="*/ 4738 w 10113"/>
              <a:gd name="connsiteY6" fmla="*/ 13812 h 159292"/>
              <a:gd name="connsiteX0" fmla="*/ 4738 w 10113"/>
              <a:gd name="connsiteY0" fmla="*/ 2870 h 148350"/>
              <a:gd name="connsiteX1" fmla="*/ 8306 w 10113"/>
              <a:gd name="connsiteY1" fmla="*/ 2869 h 148350"/>
              <a:gd name="connsiteX2" fmla="*/ 8446 w 10113"/>
              <a:gd name="connsiteY2" fmla="*/ 136596 h 148350"/>
              <a:gd name="connsiteX3" fmla="*/ 10113 w 10113"/>
              <a:gd name="connsiteY3" fmla="*/ 141596 h 148350"/>
              <a:gd name="connsiteX4" fmla="*/ 1780 w 10113"/>
              <a:gd name="connsiteY4" fmla="*/ 141596 h 148350"/>
              <a:gd name="connsiteX5" fmla="*/ 113 w 10113"/>
              <a:gd name="connsiteY5" fmla="*/ 136596 h 148350"/>
              <a:gd name="connsiteX6" fmla="*/ 4738 w 10113"/>
              <a:gd name="connsiteY6" fmla="*/ 2870 h 148350"/>
              <a:gd name="connsiteX0" fmla="*/ 4738 w 10113"/>
              <a:gd name="connsiteY0" fmla="*/ 51 h 145531"/>
              <a:gd name="connsiteX1" fmla="*/ 8306 w 10113"/>
              <a:gd name="connsiteY1" fmla="*/ 50 h 145531"/>
              <a:gd name="connsiteX2" fmla="*/ 8446 w 10113"/>
              <a:gd name="connsiteY2" fmla="*/ 133777 h 145531"/>
              <a:gd name="connsiteX3" fmla="*/ 10113 w 10113"/>
              <a:gd name="connsiteY3" fmla="*/ 138777 h 145531"/>
              <a:gd name="connsiteX4" fmla="*/ 1780 w 10113"/>
              <a:gd name="connsiteY4" fmla="*/ 138777 h 145531"/>
              <a:gd name="connsiteX5" fmla="*/ 113 w 10113"/>
              <a:gd name="connsiteY5" fmla="*/ 133777 h 145531"/>
              <a:gd name="connsiteX6" fmla="*/ 4738 w 10113"/>
              <a:gd name="connsiteY6" fmla="*/ 51 h 145531"/>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674 w 10109"/>
              <a:gd name="connsiteY0" fmla="*/ 170 h 145517"/>
              <a:gd name="connsiteX1" fmla="*/ 8302 w 10109"/>
              <a:gd name="connsiteY1" fmla="*/ 36 h 145517"/>
              <a:gd name="connsiteX2" fmla="*/ 8442 w 10109"/>
              <a:gd name="connsiteY2" fmla="*/ 133763 h 145517"/>
              <a:gd name="connsiteX3" fmla="*/ 10109 w 10109"/>
              <a:gd name="connsiteY3" fmla="*/ 138763 h 145517"/>
              <a:gd name="connsiteX4" fmla="*/ 1776 w 10109"/>
              <a:gd name="connsiteY4" fmla="*/ 138763 h 145517"/>
              <a:gd name="connsiteX5" fmla="*/ 109 w 10109"/>
              <a:gd name="connsiteY5" fmla="*/ 133763 h 145517"/>
              <a:gd name="connsiteX6" fmla="*/ 4674 w 10109"/>
              <a:gd name="connsiteY6" fmla="*/ 170 h 145517"/>
              <a:gd name="connsiteX0" fmla="*/ 3080 w 8515"/>
              <a:gd name="connsiteY0" fmla="*/ 170 h 145517"/>
              <a:gd name="connsiteX1" fmla="*/ 6708 w 8515"/>
              <a:gd name="connsiteY1" fmla="*/ 36 h 145517"/>
              <a:gd name="connsiteX2" fmla="*/ 6848 w 8515"/>
              <a:gd name="connsiteY2" fmla="*/ 133763 h 145517"/>
              <a:gd name="connsiteX3" fmla="*/ 8515 w 8515"/>
              <a:gd name="connsiteY3" fmla="*/ 138763 h 145517"/>
              <a:gd name="connsiteX4" fmla="*/ 182 w 8515"/>
              <a:gd name="connsiteY4" fmla="*/ 138763 h 145517"/>
              <a:gd name="connsiteX5" fmla="*/ 3080 w 8515"/>
              <a:gd name="connsiteY5" fmla="*/ 170 h 145517"/>
              <a:gd name="connsiteX0" fmla="*/ 3617 w 10000"/>
              <a:gd name="connsiteY0" fmla="*/ 12 h 9536"/>
              <a:gd name="connsiteX1" fmla="*/ 7878 w 10000"/>
              <a:gd name="connsiteY1" fmla="*/ 2 h 9536"/>
              <a:gd name="connsiteX2" fmla="*/ 8042 w 10000"/>
              <a:gd name="connsiteY2" fmla="*/ 9192 h 9536"/>
              <a:gd name="connsiteX3" fmla="*/ 10000 w 10000"/>
              <a:gd name="connsiteY3" fmla="*/ 9536 h 9536"/>
              <a:gd name="connsiteX4" fmla="*/ 214 w 10000"/>
              <a:gd name="connsiteY4" fmla="*/ 9536 h 9536"/>
              <a:gd name="connsiteX5" fmla="*/ 3617 w 10000"/>
              <a:gd name="connsiteY5" fmla="*/ 12 h 9536"/>
              <a:gd name="connsiteX0" fmla="*/ 3403 w 9786"/>
              <a:gd name="connsiteY0" fmla="*/ 13 h 10000"/>
              <a:gd name="connsiteX1" fmla="*/ 7664 w 9786"/>
              <a:gd name="connsiteY1" fmla="*/ 2 h 10000"/>
              <a:gd name="connsiteX2" fmla="*/ 7828 w 9786"/>
              <a:gd name="connsiteY2" fmla="*/ 9639 h 10000"/>
              <a:gd name="connsiteX3" fmla="*/ 9786 w 9786"/>
              <a:gd name="connsiteY3" fmla="*/ 10000 h 10000"/>
              <a:gd name="connsiteX4" fmla="*/ 0 w 9786"/>
              <a:gd name="connsiteY4" fmla="*/ 10000 h 10000"/>
              <a:gd name="connsiteX5" fmla="*/ 3403 w 9786"/>
              <a:gd name="connsiteY5" fmla="*/ 13 h 10000"/>
              <a:gd name="connsiteX0" fmla="*/ 494 w 7017"/>
              <a:gd name="connsiteY0" fmla="*/ 743 h 10730"/>
              <a:gd name="connsiteX1" fmla="*/ 4849 w 7017"/>
              <a:gd name="connsiteY1" fmla="*/ 732 h 10730"/>
              <a:gd name="connsiteX2" fmla="*/ 5016 w 7017"/>
              <a:gd name="connsiteY2" fmla="*/ 10369 h 10730"/>
              <a:gd name="connsiteX3" fmla="*/ 7017 w 7017"/>
              <a:gd name="connsiteY3" fmla="*/ 10730 h 10730"/>
              <a:gd name="connsiteX4" fmla="*/ 45 w 7017"/>
              <a:gd name="connsiteY4" fmla="*/ 10709 h 10730"/>
              <a:gd name="connsiteX5" fmla="*/ 494 w 7017"/>
              <a:gd name="connsiteY5" fmla="*/ 743 h 10730"/>
              <a:gd name="connsiteX0" fmla="*/ 521 w 9817"/>
              <a:gd name="connsiteY0" fmla="*/ 692 h 10000"/>
              <a:gd name="connsiteX1" fmla="*/ 6727 w 9817"/>
              <a:gd name="connsiteY1" fmla="*/ 682 h 10000"/>
              <a:gd name="connsiteX2" fmla="*/ 6965 w 9817"/>
              <a:gd name="connsiteY2" fmla="*/ 9664 h 10000"/>
              <a:gd name="connsiteX3" fmla="*/ 9817 w 9817"/>
              <a:gd name="connsiteY3" fmla="*/ 10000 h 10000"/>
              <a:gd name="connsiteX4" fmla="*/ 273 w 9817"/>
              <a:gd name="connsiteY4" fmla="*/ 9980 h 10000"/>
              <a:gd name="connsiteX5" fmla="*/ 521 w 9817"/>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70 w 10039"/>
              <a:gd name="connsiteY0" fmla="*/ 695 h 10015"/>
              <a:gd name="connsiteX1" fmla="*/ 6891 w 10039"/>
              <a:gd name="connsiteY1" fmla="*/ 685 h 10015"/>
              <a:gd name="connsiteX2" fmla="*/ 7134 w 10039"/>
              <a:gd name="connsiteY2" fmla="*/ 9667 h 10015"/>
              <a:gd name="connsiteX3" fmla="*/ 10039 w 10039"/>
              <a:gd name="connsiteY3" fmla="*/ 10003 h 10015"/>
              <a:gd name="connsiteX4" fmla="*/ 217 w 10039"/>
              <a:gd name="connsiteY4" fmla="*/ 10015 h 10015"/>
              <a:gd name="connsiteX5" fmla="*/ 570 w 10039"/>
              <a:gd name="connsiteY5" fmla="*/ 695 h 10015"/>
              <a:gd name="connsiteX0" fmla="*/ 615 w 10084"/>
              <a:gd name="connsiteY0" fmla="*/ 695 h 10015"/>
              <a:gd name="connsiteX1" fmla="*/ 6936 w 10084"/>
              <a:gd name="connsiteY1" fmla="*/ 685 h 10015"/>
              <a:gd name="connsiteX2" fmla="*/ 7179 w 10084"/>
              <a:gd name="connsiteY2" fmla="*/ 9667 h 10015"/>
              <a:gd name="connsiteX3" fmla="*/ 10084 w 10084"/>
              <a:gd name="connsiteY3" fmla="*/ 10003 h 10015"/>
              <a:gd name="connsiteX4" fmla="*/ 262 w 10084"/>
              <a:gd name="connsiteY4" fmla="*/ 10015 h 10015"/>
              <a:gd name="connsiteX5" fmla="*/ 615 w 10084"/>
              <a:gd name="connsiteY5" fmla="*/ 695 h 10015"/>
              <a:gd name="connsiteX0" fmla="*/ 356 w 9825"/>
              <a:gd name="connsiteY0" fmla="*/ 695 h 10015"/>
              <a:gd name="connsiteX1" fmla="*/ 6677 w 9825"/>
              <a:gd name="connsiteY1" fmla="*/ 685 h 10015"/>
              <a:gd name="connsiteX2" fmla="*/ 6920 w 9825"/>
              <a:gd name="connsiteY2" fmla="*/ 9667 h 10015"/>
              <a:gd name="connsiteX3" fmla="*/ 9825 w 9825"/>
              <a:gd name="connsiteY3" fmla="*/ 10003 h 10015"/>
              <a:gd name="connsiteX4" fmla="*/ 3 w 9825"/>
              <a:gd name="connsiteY4" fmla="*/ 10015 h 10015"/>
              <a:gd name="connsiteX5" fmla="*/ 356 w 9825"/>
              <a:gd name="connsiteY5" fmla="*/ 695 h 10015"/>
              <a:gd name="connsiteX0" fmla="*/ 362 w 10000"/>
              <a:gd name="connsiteY0" fmla="*/ 10 h 9316"/>
              <a:gd name="connsiteX1" fmla="*/ 6796 w 10000"/>
              <a:gd name="connsiteY1" fmla="*/ 0 h 9316"/>
              <a:gd name="connsiteX2" fmla="*/ 7043 w 10000"/>
              <a:gd name="connsiteY2" fmla="*/ 8969 h 9316"/>
              <a:gd name="connsiteX3" fmla="*/ 10000 w 10000"/>
              <a:gd name="connsiteY3" fmla="*/ 9304 h 9316"/>
              <a:gd name="connsiteX4" fmla="*/ 3 w 10000"/>
              <a:gd name="connsiteY4" fmla="*/ 9316 h 9316"/>
              <a:gd name="connsiteX5" fmla="*/ 362 w 10000"/>
              <a:gd name="connsiteY5" fmla="*/ 10 h 9316"/>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0 w 9998"/>
              <a:gd name="connsiteY0" fmla="*/ 11 h 10000"/>
              <a:gd name="connsiteX1" fmla="*/ 7099 w 9998"/>
              <a:gd name="connsiteY1" fmla="*/ 0 h 10000"/>
              <a:gd name="connsiteX2" fmla="*/ 7041 w 9998"/>
              <a:gd name="connsiteY2" fmla="*/ 9628 h 10000"/>
              <a:gd name="connsiteX3" fmla="*/ 9998 w 9998"/>
              <a:gd name="connsiteY3" fmla="*/ 9987 h 10000"/>
              <a:gd name="connsiteX4" fmla="*/ 1 w 9998"/>
              <a:gd name="connsiteY4" fmla="*/ 10000 h 10000"/>
              <a:gd name="connsiteX5" fmla="*/ 360 w 9998"/>
              <a:gd name="connsiteY5" fmla="*/ 11 h 10000"/>
              <a:gd name="connsiteX0" fmla="*/ 0 w 9640"/>
              <a:gd name="connsiteY0" fmla="*/ 11 h 10000"/>
              <a:gd name="connsiteX1" fmla="*/ 6740 w 9640"/>
              <a:gd name="connsiteY1" fmla="*/ 0 h 10000"/>
              <a:gd name="connsiteX2" fmla="*/ 6682 w 9640"/>
              <a:gd name="connsiteY2" fmla="*/ 9628 h 10000"/>
              <a:gd name="connsiteX3" fmla="*/ 9640 w 9640"/>
              <a:gd name="connsiteY3" fmla="*/ 9987 h 10000"/>
              <a:gd name="connsiteX4" fmla="*/ 302 w 9640"/>
              <a:gd name="connsiteY4" fmla="*/ 10000 h 10000"/>
              <a:gd name="connsiteX5" fmla="*/ 0 w 964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0 h 9996"/>
              <a:gd name="connsiteX1" fmla="*/ 7001 w 10056"/>
              <a:gd name="connsiteY1" fmla="*/ 1 h 9996"/>
              <a:gd name="connsiteX2" fmla="*/ 6988 w 10056"/>
              <a:gd name="connsiteY2" fmla="*/ 9624 h 9996"/>
              <a:gd name="connsiteX3" fmla="*/ 10056 w 10056"/>
              <a:gd name="connsiteY3" fmla="*/ 9983 h 9996"/>
              <a:gd name="connsiteX4" fmla="*/ 62 w 10056"/>
              <a:gd name="connsiteY4" fmla="*/ 9996 h 9996"/>
              <a:gd name="connsiteX5" fmla="*/ 0 w 10056"/>
              <a:gd name="connsiteY5" fmla="*/ 0 h 9996"/>
              <a:gd name="connsiteX0" fmla="*/ 0 w 10000"/>
              <a:gd name="connsiteY0" fmla="*/ 2 h 10002"/>
              <a:gd name="connsiteX1" fmla="*/ 6962 w 10000"/>
              <a:gd name="connsiteY1" fmla="*/ 0 h 10002"/>
              <a:gd name="connsiteX2" fmla="*/ 6949 w 10000"/>
              <a:gd name="connsiteY2" fmla="*/ 9630 h 10002"/>
              <a:gd name="connsiteX3" fmla="*/ 10000 w 10000"/>
              <a:gd name="connsiteY3" fmla="*/ 9989 h 10002"/>
              <a:gd name="connsiteX4" fmla="*/ 62 w 10000"/>
              <a:gd name="connsiteY4" fmla="*/ 10002 h 10002"/>
              <a:gd name="connsiteX5" fmla="*/ 0 w 10000"/>
              <a:gd name="connsiteY5" fmla="*/ 2 h 10002"/>
              <a:gd name="connsiteX0" fmla="*/ 0 w 10000"/>
              <a:gd name="connsiteY0" fmla="*/ 4 h 10004"/>
              <a:gd name="connsiteX1" fmla="*/ 6927 w 10000"/>
              <a:gd name="connsiteY1" fmla="*/ 0 h 10004"/>
              <a:gd name="connsiteX2" fmla="*/ 6949 w 10000"/>
              <a:gd name="connsiteY2" fmla="*/ 9632 h 10004"/>
              <a:gd name="connsiteX3" fmla="*/ 10000 w 10000"/>
              <a:gd name="connsiteY3" fmla="*/ 9991 h 10004"/>
              <a:gd name="connsiteX4" fmla="*/ 62 w 10000"/>
              <a:gd name="connsiteY4" fmla="*/ 10004 h 10004"/>
              <a:gd name="connsiteX5" fmla="*/ 0 w 10000"/>
              <a:gd name="connsiteY5" fmla="*/ 4 h 10004"/>
              <a:gd name="connsiteX0" fmla="*/ 0 w 10000"/>
              <a:gd name="connsiteY0" fmla="*/ 4 h 10004"/>
              <a:gd name="connsiteX1" fmla="*/ 6927 w 10000"/>
              <a:gd name="connsiteY1" fmla="*/ 0 h 10004"/>
              <a:gd name="connsiteX2" fmla="*/ 6949 w 10000"/>
              <a:gd name="connsiteY2" fmla="*/ 9632 h 10004"/>
              <a:gd name="connsiteX3" fmla="*/ 10000 w 10000"/>
              <a:gd name="connsiteY3" fmla="*/ 9991 h 10004"/>
              <a:gd name="connsiteX4" fmla="*/ 62 w 10000"/>
              <a:gd name="connsiteY4" fmla="*/ 10004 h 10004"/>
              <a:gd name="connsiteX5" fmla="*/ 0 w 10000"/>
              <a:gd name="connsiteY5" fmla="*/ 4 h 10004"/>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0000" h="10004">
                <a:moveTo>
                  <a:pt x="0" y="4"/>
                </a:moveTo>
                <a:lnTo>
                  <a:pt x="6927" y="0"/>
                </a:lnTo>
                <a:cubicBezTo>
                  <a:pt x="6894" y="1547"/>
                  <a:pt x="6891" y="9283"/>
                  <a:pt x="6949" y="9632"/>
                </a:cubicBezTo>
                <a:cubicBezTo>
                  <a:pt x="6923" y="9834"/>
                  <a:pt x="8645" y="9997"/>
                  <a:pt x="10000" y="9991"/>
                </a:cubicBezTo>
                <a:lnTo>
                  <a:pt x="62" y="10004"/>
                </a:lnTo>
                <a:cubicBezTo>
                  <a:pt x="31" y="8409"/>
                  <a:pt x="98" y="1072"/>
                  <a:pt x="0" y="4"/>
                </a:cubicBezTo>
                <a:close/>
              </a:path>
            </a:pathLst>
          </a:custGeom>
          <a:solidFill>
            <a:srgbClr val="65AA00"/>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dirty="0"/>
          </a:p>
        </p:txBody>
      </p:sp>
      <p:sp>
        <p:nvSpPr>
          <p:cNvPr id="12" name="Rectangle 11"/>
          <p:cNvSpPr/>
          <p:nvPr userDrawn="1"/>
        </p:nvSpPr>
        <p:spPr>
          <a:xfrm>
            <a:off x="7490690" y="5672093"/>
            <a:ext cx="4702823" cy="421061"/>
          </a:xfrm>
          <a:prstGeom prst="rect">
            <a:avLst/>
          </a:prstGeom>
          <a:solidFill>
            <a:srgbClr val="0092F7"/>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900"/>
          </a:p>
        </p:txBody>
      </p:sp>
      <p:grpSp>
        <p:nvGrpSpPr>
          <p:cNvPr id="13" name="Group 12"/>
          <p:cNvGrpSpPr/>
          <p:nvPr userDrawn="1"/>
        </p:nvGrpSpPr>
        <p:grpSpPr>
          <a:xfrm>
            <a:off x="7637330" y="6112457"/>
            <a:ext cx="4174624" cy="723275"/>
            <a:chOff x="7646796" y="6098813"/>
            <a:chExt cx="4174624" cy="723275"/>
          </a:xfrm>
        </p:grpSpPr>
        <p:pic>
          <p:nvPicPr>
            <p:cNvPr id="14" name="Picture 10" descr="LOGO_IPNA_Blue"/>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7646796" y="6186597"/>
              <a:ext cx="581637" cy="581637"/>
            </a:xfrm>
            <a:prstGeom prst="rect">
              <a:avLst/>
            </a:prstGeom>
            <a:noFill/>
            <a:extLst>
              <a:ext uri="{909E8E84-426E-40DD-AFC4-6F175D3DCCD1}">
                <a14:hiddenFill xmlns:a14="http://schemas.microsoft.com/office/drawing/2010/main">
                  <a:solidFill>
                    <a:srgbClr val="FFFFFF"/>
                  </a:solidFill>
                </a14:hiddenFill>
              </a:ext>
            </a:extLst>
          </p:spPr>
        </p:pic>
        <p:sp>
          <p:nvSpPr>
            <p:cNvPr id="15" name="Rectangle 12"/>
            <p:cNvSpPr>
              <a:spLocks noChangeArrowheads="1"/>
            </p:cNvSpPr>
            <p:nvPr/>
          </p:nvSpPr>
          <p:spPr bwMode="auto">
            <a:xfrm>
              <a:off x="8208157" y="6098813"/>
              <a:ext cx="3613263" cy="72327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GB" altLang="en-US" b="1" i="0" u="none" strike="noStrike" cap="none" normalizeH="0" baseline="0" dirty="0">
                  <a:ln>
                    <a:noFill/>
                  </a:ln>
                  <a:solidFill>
                    <a:srgbClr val="296DC0"/>
                  </a:solidFill>
                  <a:effectLst/>
                  <a:latin typeface="Arial" panose="020B0604020202020204" pitchFamily="34" charset="0"/>
                  <a:ea typeface="Calibri" panose="020F0502020204030204" pitchFamily="34" charset="0"/>
                  <a:cs typeface="Calibri" panose="020F0502020204030204" pitchFamily="34" charset="0"/>
                </a:rPr>
                <a:t>Pediatric Nephrology</a:t>
              </a:r>
              <a:endParaRPr kumimoji="0" lang="en-GB" altLang="en-US" sz="500" b="0" i="0" u="none" strike="noStrike" cap="none" normalizeH="0" baseline="0" dirty="0">
                <a:ln>
                  <a:noFill/>
                </a:ln>
                <a:solidFill>
                  <a:schemeClr val="tx1"/>
                </a:solidFill>
                <a:effectLst/>
                <a:latin typeface="Arial" panose="020B0604020202020204" pitchFamily="34" charset="0"/>
              </a:endParaRPr>
            </a:p>
            <a:p>
              <a:pPr marL="0" marR="0" lvl="0" indent="0" algn="l" defTabSz="914400" rtl="0" eaLnBrk="0" fontAlgn="base" latinLnBrk="0" hangingPunct="0">
                <a:lnSpc>
                  <a:spcPct val="100000"/>
                </a:lnSpc>
                <a:spcBef>
                  <a:spcPct val="0"/>
                </a:spcBef>
                <a:spcAft>
                  <a:spcPct val="0"/>
                </a:spcAft>
                <a:buClrTx/>
                <a:buSzTx/>
                <a:buFontTx/>
                <a:buNone/>
                <a:tabLst/>
              </a:pPr>
              <a:r>
                <a:rPr kumimoji="0" lang="en-GB" altLang="en-US" sz="11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t>Journal of the </a:t>
              </a:r>
              <a:br>
                <a:rPr kumimoji="0" lang="en-GB" altLang="en-US" sz="11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br>
              <a:r>
                <a:rPr kumimoji="0" lang="en-GB" altLang="en-US" sz="12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t>International Pediatric Nephrology Association</a:t>
              </a:r>
              <a:endParaRPr kumimoji="0" lang="en-GB" altLang="en-US" sz="1200" b="0" i="0" u="none" strike="noStrike" cap="none" normalizeH="0" baseline="0" dirty="0">
                <a:ln>
                  <a:noFill/>
                </a:ln>
                <a:solidFill>
                  <a:schemeClr val="tx1"/>
                </a:solidFill>
                <a:effectLst/>
                <a:latin typeface="Arial" panose="020B0604020202020204" pitchFamily="34" charset="0"/>
              </a:endParaRPr>
            </a:p>
          </p:txBody>
        </p:sp>
      </p:grpSp>
      <p:sp>
        <p:nvSpPr>
          <p:cNvPr id="37" name="Rectangle 36">
            <a:extLst>
              <a:ext uri="{FF2B5EF4-FFF2-40B4-BE49-F238E27FC236}">
                <a16:creationId xmlns:a16="http://schemas.microsoft.com/office/drawing/2014/main" id="{FB861B61-643E-7D14-D771-2A7BF1205723}"/>
              </a:ext>
            </a:extLst>
          </p:cNvPr>
          <p:cNvSpPr/>
          <p:nvPr userDrawn="1"/>
        </p:nvSpPr>
        <p:spPr>
          <a:xfrm>
            <a:off x="10209747" y="-31269"/>
            <a:ext cx="1992085" cy="1120316"/>
          </a:xfrm>
          <a:prstGeom prst="rect">
            <a:avLst/>
          </a:prstGeom>
          <a:solidFill>
            <a:srgbClr val="003969"/>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19" name="TextBox 18"/>
          <p:cNvSpPr txBox="1"/>
          <p:nvPr/>
        </p:nvSpPr>
        <p:spPr>
          <a:xfrm>
            <a:off x="10624932" y="241626"/>
            <a:ext cx="1441475" cy="523220"/>
          </a:xfrm>
          <a:prstGeom prst="rect">
            <a:avLst/>
          </a:prstGeom>
          <a:noFill/>
        </p:spPr>
        <p:txBody>
          <a:bodyPr wrap="square" rtlCol="0">
            <a:spAutoFit/>
          </a:bodyPr>
          <a:lstStyle/>
          <a:p>
            <a:r>
              <a:rPr lang="en-GB" sz="2800" dirty="0">
                <a:solidFill>
                  <a:schemeClr val="bg1"/>
                </a:solidFill>
              </a:rPr>
              <a:t>Review</a:t>
            </a:r>
          </a:p>
        </p:txBody>
      </p:sp>
      <p:sp>
        <p:nvSpPr>
          <p:cNvPr id="29" name="Flowchart: Stored Data 4">
            <a:extLst>
              <a:ext uri="{FF2B5EF4-FFF2-40B4-BE49-F238E27FC236}">
                <a16:creationId xmlns:a16="http://schemas.microsoft.com/office/drawing/2014/main" id="{17034CCF-1EDD-D498-AB89-09358AFA3492}"/>
              </a:ext>
            </a:extLst>
          </p:cNvPr>
          <p:cNvSpPr/>
          <p:nvPr userDrawn="1"/>
        </p:nvSpPr>
        <p:spPr>
          <a:xfrm rot="16200000" flipV="1">
            <a:off x="2901409" y="2274353"/>
            <a:ext cx="1684645" cy="7491425"/>
          </a:xfrm>
          <a:custGeom>
            <a:avLst/>
            <a:gdLst>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89795 h 103750"/>
              <a:gd name="connsiteX1" fmla="*/ 8293 w 10000"/>
              <a:gd name="connsiteY1" fmla="*/ 0 h 103750"/>
              <a:gd name="connsiteX2" fmla="*/ 8333 w 10000"/>
              <a:gd name="connsiteY2" fmla="*/ 94795 h 103750"/>
              <a:gd name="connsiteX3" fmla="*/ 10000 w 10000"/>
              <a:gd name="connsiteY3" fmla="*/ 99795 h 103750"/>
              <a:gd name="connsiteX4" fmla="*/ 1667 w 10000"/>
              <a:gd name="connsiteY4" fmla="*/ 99795 h 103750"/>
              <a:gd name="connsiteX5" fmla="*/ 0 w 10000"/>
              <a:gd name="connsiteY5" fmla="*/ 94795 h 103750"/>
              <a:gd name="connsiteX6" fmla="*/ 1667 w 10000"/>
              <a:gd name="connsiteY6" fmla="*/ 89795 h 10375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5639 w 10161"/>
              <a:gd name="connsiteY0" fmla="*/ 18392 h 112308"/>
              <a:gd name="connsiteX1" fmla="*/ 8672 w 10161"/>
              <a:gd name="connsiteY1" fmla="*/ 5059 h 112308"/>
              <a:gd name="connsiteX2" fmla="*/ 8494 w 10161"/>
              <a:gd name="connsiteY2" fmla="*/ 103121 h 112308"/>
              <a:gd name="connsiteX3" fmla="*/ 10161 w 10161"/>
              <a:gd name="connsiteY3" fmla="*/ 108121 h 112308"/>
              <a:gd name="connsiteX4" fmla="*/ 1828 w 10161"/>
              <a:gd name="connsiteY4" fmla="*/ 108121 h 112308"/>
              <a:gd name="connsiteX5" fmla="*/ 161 w 10161"/>
              <a:gd name="connsiteY5" fmla="*/ 103121 h 112308"/>
              <a:gd name="connsiteX6" fmla="*/ 5639 w 10161"/>
              <a:gd name="connsiteY6" fmla="*/ 18392 h 112308"/>
              <a:gd name="connsiteX0" fmla="*/ 5639 w 10161"/>
              <a:gd name="connsiteY0" fmla="*/ 48998 h 145481"/>
              <a:gd name="connsiteX1" fmla="*/ 8354 w 10161"/>
              <a:gd name="connsiteY1" fmla="*/ 0 h 145481"/>
              <a:gd name="connsiteX2" fmla="*/ 8494 w 10161"/>
              <a:gd name="connsiteY2" fmla="*/ 133727 h 145481"/>
              <a:gd name="connsiteX3" fmla="*/ 10161 w 10161"/>
              <a:gd name="connsiteY3" fmla="*/ 138727 h 145481"/>
              <a:gd name="connsiteX4" fmla="*/ 1828 w 10161"/>
              <a:gd name="connsiteY4" fmla="*/ 138727 h 145481"/>
              <a:gd name="connsiteX5" fmla="*/ 161 w 10161"/>
              <a:gd name="connsiteY5" fmla="*/ 133727 h 145481"/>
              <a:gd name="connsiteX6" fmla="*/ 5639 w 10161"/>
              <a:gd name="connsiteY6" fmla="*/ 48998 h 145481"/>
              <a:gd name="connsiteX0" fmla="*/ 4738 w 10113"/>
              <a:gd name="connsiteY0" fmla="*/ 13812 h 159292"/>
              <a:gd name="connsiteX1" fmla="*/ 8306 w 10113"/>
              <a:gd name="connsiteY1" fmla="*/ 13811 h 159292"/>
              <a:gd name="connsiteX2" fmla="*/ 8446 w 10113"/>
              <a:gd name="connsiteY2" fmla="*/ 147538 h 159292"/>
              <a:gd name="connsiteX3" fmla="*/ 10113 w 10113"/>
              <a:gd name="connsiteY3" fmla="*/ 152538 h 159292"/>
              <a:gd name="connsiteX4" fmla="*/ 1780 w 10113"/>
              <a:gd name="connsiteY4" fmla="*/ 152538 h 159292"/>
              <a:gd name="connsiteX5" fmla="*/ 113 w 10113"/>
              <a:gd name="connsiteY5" fmla="*/ 147538 h 159292"/>
              <a:gd name="connsiteX6" fmla="*/ 4738 w 10113"/>
              <a:gd name="connsiteY6" fmla="*/ 13812 h 159292"/>
              <a:gd name="connsiteX0" fmla="*/ 4738 w 10113"/>
              <a:gd name="connsiteY0" fmla="*/ 2870 h 148350"/>
              <a:gd name="connsiteX1" fmla="*/ 8306 w 10113"/>
              <a:gd name="connsiteY1" fmla="*/ 2869 h 148350"/>
              <a:gd name="connsiteX2" fmla="*/ 8446 w 10113"/>
              <a:gd name="connsiteY2" fmla="*/ 136596 h 148350"/>
              <a:gd name="connsiteX3" fmla="*/ 10113 w 10113"/>
              <a:gd name="connsiteY3" fmla="*/ 141596 h 148350"/>
              <a:gd name="connsiteX4" fmla="*/ 1780 w 10113"/>
              <a:gd name="connsiteY4" fmla="*/ 141596 h 148350"/>
              <a:gd name="connsiteX5" fmla="*/ 113 w 10113"/>
              <a:gd name="connsiteY5" fmla="*/ 136596 h 148350"/>
              <a:gd name="connsiteX6" fmla="*/ 4738 w 10113"/>
              <a:gd name="connsiteY6" fmla="*/ 2870 h 148350"/>
              <a:gd name="connsiteX0" fmla="*/ 4738 w 10113"/>
              <a:gd name="connsiteY0" fmla="*/ 51 h 145531"/>
              <a:gd name="connsiteX1" fmla="*/ 8306 w 10113"/>
              <a:gd name="connsiteY1" fmla="*/ 50 h 145531"/>
              <a:gd name="connsiteX2" fmla="*/ 8446 w 10113"/>
              <a:gd name="connsiteY2" fmla="*/ 133777 h 145531"/>
              <a:gd name="connsiteX3" fmla="*/ 10113 w 10113"/>
              <a:gd name="connsiteY3" fmla="*/ 138777 h 145531"/>
              <a:gd name="connsiteX4" fmla="*/ 1780 w 10113"/>
              <a:gd name="connsiteY4" fmla="*/ 138777 h 145531"/>
              <a:gd name="connsiteX5" fmla="*/ 113 w 10113"/>
              <a:gd name="connsiteY5" fmla="*/ 133777 h 145531"/>
              <a:gd name="connsiteX6" fmla="*/ 4738 w 10113"/>
              <a:gd name="connsiteY6" fmla="*/ 51 h 145531"/>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674 w 10109"/>
              <a:gd name="connsiteY0" fmla="*/ 170 h 145517"/>
              <a:gd name="connsiteX1" fmla="*/ 8302 w 10109"/>
              <a:gd name="connsiteY1" fmla="*/ 36 h 145517"/>
              <a:gd name="connsiteX2" fmla="*/ 8442 w 10109"/>
              <a:gd name="connsiteY2" fmla="*/ 133763 h 145517"/>
              <a:gd name="connsiteX3" fmla="*/ 10109 w 10109"/>
              <a:gd name="connsiteY3" fmla="*/ 138763 h 145517"/>
              <a:gd name="connsiteX4" fmla="*/ 1776 w 10109"/>
              <a:gd name="connsiteY4" fmla="*/ 138763 h 145517"/>
              <a:gd name="connsiteX5" fmla="*/ 109 w 10109"/>
              <a:gd name="connsiteY5" fmla="*/ 133763 h 145517"/>
              <a:gd name="connsiteX6" fmla="*/ 4674 w 10109"/>
              <a:gd name="connsiteY6" fmla="*/ 170 h 145517"/>
              <a:gd name="connsiteX0" fmla="*/ 3080 w 8515"/>
              <a:gd name="connsiteY0" fmla="*/ 170 h 145517"/>
              <a:gd name="connsiteX1" fmla="*/ 6708 w 8515"/>
              <a:gd name="connsiteY1" fmla="*/ 36 h 145517"/>
              <a:gd name="connsiteX2" fmla="*/ 6848 w 8515"/>
              <a:gd name="connsiteY2" fmla="*/ 133763 h 145517"/>
              <a:gd name="connsiteX3" fmla="*/ 8515 w 8515"/>
              <a:gd name="connsiteY3" fmla="*/ 138763 h 145517"/>
              <a:gd name="connsiteX4" fmla="*/ 182 w 8515"/>
              <a:gd name="connsiteY4" fmla="*/ 138763 h 145517"/>
              <a:gd name="connsiteX5" fmla="*/ 3080 w 8515"/>
              <a:gd name="connsiteY5" fmla="*/ 170 h 145517"/>
              <a:gd name="connsiteX0" fmla="*/ 3617 w 10000"/>
              <a:gd name="connsiteY0" fmla="*/ 12 h 9536"/>
              <a:gd name="connsiteX1" fmla="*/ 7878 w 10000"/>
              <a:gd name="connsiteY1" fmla="*/ 2 h 9536"/>
              <a:gd name="connsiteX2" fmla="*/ 8042 w 10000"/>
              <a:gd name="connsiteY2" fmla="*/ 9192 h 9536"/>
              <a:gd name="connsiteX3" fmla="*/ 10000 w 10000"/>
              <a:gd name="connsiteY3" fmla="*/ 9536 h 9536"/>
              <a:gd name="connsiteX4" fmla="*/ 214 w 10000"/>
              <a:gd name="connsiteY4" fmla="*/ 9536 h 9536"/>
              <a:gd name="connsiteX5" fmla="*/ 3617 w 10000"/>
              <a:gd name="connsiteY5" fmla="*/ 12 h 9536"/>
              <a:gd name="connsiteX0" fmla="*/ 3403 w 9786"/>
              <a:gd name="connsiteY0" fmla="*/ 13 h 10000"/>
              <a:gd name="connsiteX1" fmla="*/ 7664 w 9786"/>
              <a:gd name="connsiteY1" fmla="*/ 2 h 10000"/>
              <a:gd name="connsiteX2" fmla="*/ 7828 w 9786"/>
              <a:gd name="connsiteY2" fmla="*/ 9639 h 10000"/>
              <a:gd name="connsiteX3" fmla="*/ 9786 w 9786"/>
              <a:gd name="connsiteY3" fmla="*/ 10000 h 10000"/>
              <a:gd name="connsiteX4" fmla="*/ 0 w 9786"/>
              <a:gd name="connsiteY4" fmla="*/ 10000 h 10000"/>
              <a:gd name="connsiteX5" fmla="*/ 3403 w 9786"/>
              <a:gd name="connsiteY5" fmla="*/ 13 h 10000"/>
              <a:gd name="connsiteX0" fmla="*/ 494 w 7017"/>
              <a:gd name="connsiteY0" fmla="*/ 743 h 10730"/>
              <a:gd name="connsiteX1" fmla="*/ 4849 w 7017"/>
              <a:gd name="connsiteY1" fmla="*/ 732 h 10730"/>
              <a:gd name="connsiteX2" fmla="*/ 5016 w 7017"/>
              <a:gd name="connsiteY2" fmla="*/ 10369 h 10730"/>
              <a:gd name="connsiteX3" fmla="*/ 7017 w 7017"/>
              <a:gd name="connsiteY3" fmla="*/ 10730 h 10730"/>
              <a:gd name="connsiteX4" fmla="*/ 45 w 7017"/>
              <a:gd name="connsiteY4" fmla="*/ 10709 h 10730"/>
              <a:gd name="connsiteX5" fmla="*/ 494 w 7017"/>
              <a:gd name="connsiteY5" fmla="*/ 743 h 10730"/>
              <a:gd name="connsiteX0" fmla="*/ 521 w 9817"/>
              <a:gd name="connsiteY0" fmla="*/ 692 h 10000"/>
              <a:gd name="connsiteX1" fmla="*/ 6727 w 9817"/>
              <a:gd name="connsiteY1" fmla="*/ 682 h 10000"/>
              <a:gd name="connsiteX2" fmla="*/ 6965 w 9817"/>
              <a:gd name="connsiteY2" fmla="*/ 9664 h 10000"/>
              <a:gd name="connsiteX3" fmla="*/ 9817 w 9817"/>
              <a:gd name="connsiteY3" fmla="*/ 10000 h 10000"/>
              <a:gd name="connsiteX4" fmla="*/ 273 w 9817"/>
              <a:gd name="connsiteY4" fmla="*/ 9980 h 10000"/>
              <a:gd name="connsiteX5" fmla="*/ 521 w 9817"/>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70 w 10039"/>
              <a:gd name="connsiteY0" fmla="*/ 695 h 10015"/>
              <a:gd name="connsiteX1" fmla="*/ 6891 w 10039"/>
              <a:gd name="connsiteY1" fmla="*/ 685 h 10015"/>
              <a:gd name="connsiteX2" fmla="*/ 7134 w 10039"/>
              <a:gd name="connsiteY2" fmla="*/ 9667 h 10015"/>
              <a:gd name="connsiteX3" fmla="*/ 10039 w 10039"/>
              <a:gd name="connsiteY3" fmla="*/ 10003 h 10015"/>
              <a:gd name="connsiteX4" fmla="*/ 217 w 10039"/>
              <a:gd name="connsiteY4" fmla="*/ 10015 h 10015"/>
              <a:gd name="connsiteX5" fmla="*/ 570 w 10039"/>
              <a:gd name="connsiteY5" fmla="*/ 695 h 10015"/>
              <a:gd name="connsiteX0" fmla="*/ 615 w 10084"/>
              <a:gd name="connsiteY0" fmla="*/ 695 h 10015"/>
              <a:gd name="connsiteX1" fmla="*/ 6936 w 10084"/>
              <a:gd name="connsiteY1" fmla="*/ 685 h 10015"/>
              <a:gd name="connsiteX2" fmla="*/ 7179 w 10084"/>
              <a:gd name="connsiteY2" fmla="*/ 9667 h 10015"/>
              <a:gd name="connsiteX3" fmla="*/ 10084 w 10084"/>
              <a:gd name="connsiteY3" fmla="*/ 10003 h 10015"/>
              <a:gd name="connsiteX4" fmla="*/ 262 w 10084"/>
              <a:gd name="connsiteY4" fmla="*/ 10015 h 10015"/>
              <a:gd name="connsiteX5" fmla="*/ 615 w 10084"/>
              <a:gd name="connsiteY5" fmla="*/ 695 h 10015"/>
              <a:gd name="connsiteX0" fmla="*/ 356 w 9825"/>
              <a:gd name="connsiteY0" fmla="*/ 695 h 10015"/>
              <a:gd name="connsiteX1" fmla="*/ 6677 w 9825"/>
              <a:gd name="connsiteY1" fmla="*/ 685 h 10015"/>
              <a:gd name="connsiteX2" fmla="*/ 6920 w 9825"/>
              <a:gd name="connsiteY2" fmla="*/ 9667 h 10015"/>
              <a:gd name="connsiteX3" fmla="*/ 9825 w 9825"/>
              <a:gd name="connsiteY3" fmla="*/ 10003 h 10015"/>
              <a:gd name="connsiteX4" fmla="*/ 3 w 9825"/>
              <a:gd name="connsiteY4" fmla="*/ 10015 h 10015"/>
              <a:gd name="connsiteX5" fmla="*/ 356 w 9825"/>
              <a:gd name="connsiteY5" fmla="*/ 695 h 10015"/>
              <a:gd name="connsiteX0" fmla="*/ 362 w 10000"/>
              <a:gd name="connsiteY0" fmla="*/ 10 h 9316"/>
              <a:gd name="connsiteX1" fmla="*/ 6796 w 10000"/>
              <a:gd name="connsiteY1" fmla="*/ 0 h 9316"/>
              <a:gd name="connsiteX2" fmla="*/ 7043 w 10000"/>
              <a:gd name="connsiteY2" fmla="*/ 8969 h 9316"/>
              <a:gd name="connsiteX3" fmla="*/ 10000 w 10000"/>
              <a:gd name="connsiteY3" fmla="*/ 9304 h 9316"/>
              <a:gd name="connsiteX4" fmla="*/ 3 w 10000"/>
              <a:gd name="connsiteY4" fmla="*/ 9316 h 9316"/>
              <a:gd name="connsiteX5" fmla="*/ 362 w 10000"/>
              <a:gd name="connsiteY5" fmla="*/ 10 h 9316"/>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0 w 9998"/>
              <a:gd name="connsiteY0" fmla="*/ 11 h 10000"/>
              <a:gd name="connsiteX1" fmla="*/ 7099 w 9998"/>
              <a:gd name="connsiteY1" fmla="*/ 0 h 10000"/>
              <a:gd name="connsiteX2" fmla="*/ 7041 w 9998"/>
              <a:gd name="connsiteY2" fmla="*/ 9628 h 10000"/>
              <a:gd name="connsiteX3" fmla="*/ 9998 w 9998"/>
              <a:gd name="connsiteY3" fmla="*/ 9987 h 10000"/>
              <a:gd name="connsiteX4" fmla="*/ 1 w 9998"/>
              <a:gd name="connsiteY4" fmla="*/ 10000 h 10000"/>
              <a:gd name="connsiteX5" fmla="*/ 360 w 9998"/>
              <a:gd name="connsiteY5" fmla="*/ 11 h 10000"/>
              <a:gd name="connsiteX0" fmla="*/ 0 w 9640"/>
              <a:gd name="connsiteY0" fmla="*/ 11 h 10000"/>
              <a:gd name="connsiteX1" fmla="*/ 6740 w 9640"/>
              <a:gd name="connsiteY1" fmla="*/ 0 h 10000"/>
              <a:gd name="connsiteX2" fmla="*/ 6682 w 9640"/>
              <a:gd name="connsiteY2" fmla="*/ 9628 h 10000"/>
              <a:gd name="connsiteX3" fmla="*/ 9640 w 9640"/>
              <a:gd name="connsiteY3" fmla="*/ 9987 h 10000"/>
              <a:gd name="connsiteX4" fmla="*/ 302 w 9640"/>
              <a:gd name="connsiteY4" fmla="*/ 10000 h 10000"/>
              <a:gd name="connsiteX5" fmla="*/ 0 w 964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9991"/>
              <a:gd name="connsiteX1" fmla="*/ 7048 w 10056"/>
              <a:gd name="connsiteY1" fmla="*/ 0 h 9991"/>
              <a:gd name="connsiteX2" fmla="*/ 6988 w 10056"/>
              <a:gd name="connsiteY2" fmla="*/ 9628 h 9991"/>
              <a:gd name="connsiteX3" fmla="*/ 10056 w 10056"/>
              <a:gd name="connsiteY3" fmla="*/ 9987 h 9991"/>
              <a:gd name="connsiteX4" fmla="*/ 129 w 10056"/>
              <a:gd name="connsiteY4" fmla="*/ 9991 h 9991"/>
              <a:gd name="connsiteX5" fmla="*/ 0 w 10056"/>
              <a:gd name="connsiteY5" fmla="*/ 4 h 9991"/>
              <a:gd name="connsiteX0" fmla="*/ 0 w 10000"/>
              <a:gd name="connsiteY0" fmla="*/ 0 h 9996"/>
              <a:gd name="connsiteX1" fmla="*/ 6799 w 10000"/>
              <a:gd name="connsiteY1" fmla="*/ 3842 h 9996"/>
              <a:gd name="connsiteX2" fmla="*/ 6949 w 10000"/>
              <a:gd name="connsiteY2" fmla="*/ 9633 h 9996"/>
              <a:gd name="connsiteX3" fmla="*/ 10000 w 10000"/>
              <a:gd name="connsiteY3" fmla="*/ 9992 h 9996"/>
              <a:gd name="connsiteX4" fmla="*/ 128 w 10000"/>
              <a:gd name="connsiteY4" fmla="*/ 9996 h 9996"/>
              <a:gd name="connsiteX5" fmla="*/ 0 w 10000"/>
              <a:gd name="connsiteY5" fmla="*/ 0 h 9996"/>
              <a:gd name="connsiteX0" fmla="*/ 0 w 9895"/>
              <a:gd name="connsiteY0" fmla="*/ 11 h 6156"/>
              <a:gd name="connsiteX1" fmla="*/ 6694 w 9895"/>
              <a:gd name="connsiteY1" fmla="*/ 0 h 6156"/>
              <a:gd name="connsiteX2" fmla="*/ 6844 w 9895"/>
              <a:gd name="connsiteY2" fmla="*/ 5793 h 6156"/>
              <a:gd name="connsiteX3" fmla="*/ 9895 w 9895"/>
              <a:gd name="connsiteY3" fmla="*/ 6152 h 6156"/>
              <a:gd name="connsiteX4" fmla="*/ 23 w 9895"/>
              <a:gd name="connsiteY4" fmla="*/ 6156 h 6156"/>
              <a:gd name="connsiteX5" fmla="*/ 0 w 9895"/>
              <a:gd name="connsiteY5" fmla="*/ 11 h 6156"/>
              <a:gd name="connsiteX0" fmla="*/ 0 w 11007"/>
              <a:gd name="connsiteY0" fmla="*/ 7 h 10000"/>
              <a:gd name="connsiteX1" fmla="*/ 7772 w 11007"/>
              <a:gd name="connsiteY1" fmla="*/ 0 h 10000"/>
              <a:gd name="connsiteX2" fmla="*/ 7924 w 11007"/>
              <a:gd name="connsiteY2" fmla="*/ 9410 h 10000"/>
              <a:gd name="connsiteX3" fmla="*/ 11007 w 11007"/>
              <a:gd name="connsiteY3" fmla="*/ 9994 h 10000"/>
              <a:gd name="connsiteX4" fmla="*/ 1030 w 11007"/>
              <a:gd name="connsiteY4" fmla="*/ 10000 h 10000"/>
              <a:gd name="connsiteX5" fmla="*/ 0 w 11007"/>
              <a:gd name="connsiteY5" fmla="*/ 7 h 10000"/>
              <a:gd name="connsiteX0" fmla="*/ 0 w 11007"/>
              <a:gd name="connsiteY0" fmla="*/ 7 h 10000"/>
              <a:gd name="connsiteX1" fmla="*/ 7772 w 11007"/>
              <a:gd name="connsiteY1" fmla="*/ 0 h 10000"/>
              <a:gd name="connsiteX2" fmla="*/ 7924 w 11007"/>
              <a:gd name="connsiteY2" fmla="*/ 9410 h 10000"/>
              <a:gd name="connsiteX3" fmla="*/ 11007 w 11007"/>
              <a:gd name="connsiteY3" fmla="*/ 9994 h 10000"/>
              <a:gd name="connsiteX4" fmla="*/ 23 w 11007"/>
              <a:gd name="connsiteY4" fmla="*/ 10000 h 10000"/>
              <a:gd name="connsiteX5" fmla="*/ 0 w 11007"/>
              <a:gd name="connsiteY5" fmla="*/ 7 h 10000"/>
              <a:gd name="connsiteX0" fmla="*/ 76 w 10988"/>
              <a:gd name="connsiteY0" fmla="*/ 45 h 10000"/>
              <a:gd name="connsiteX1" fmla="*/ 7753 w 10988"/>
              <a:gd name="connsiteY1" fmla="*/ 0 h 10000"/>
              <a:gd name="connsiteX2" fmla="*/ 7905 w 10988"/>
              <a:gd name="connsiteY2" fmla="*/ 9410 h 10000"/>
              <a:gd name="connsiteX3" fmla="*/ 10988 w 10988"/>
              <a:gd name="connsiteY3" fmla="*/ 9994 h 10000"/>
              <a:gd name="connsiteX4" fmla="*/ 4 w 10988"/>
              <a:gd name="connsiteY4" fmla="*/ 10000 h 10000"/>
              <a:gd name="connsiteX5" fmla="*/ 76 w 10988"/>
              <a:gd name="connsiteY5" fmla="*/ 45 h 10000"/>
              <a:gd name="connsiteX0" fmla="*/ 16 w 10988"/>
              <a:gd name="connsiteY0" fmla="*/ 20 h 10000"/>
              <a:gd name="connsiteX1" fmla="*/ 7753 w 10988"/>
              <a:gd name="connsiteY1" fmla="*/ 0 h 10000"/>
              <a:gd name="connsiteX2" fmla="*/ 7905 w 10988"/>
              <a:gd name="connsiteY2" fmla="*/ 9410 h 10000"/>
              <a:gd name="connsiteX3" fmla="*/ 10988 w 10988"/>
              <a:gd name="connsiteY3" fmla="*/ 9994 h 10000"/>
              <a:gd name="connsiteX4" fmla="*/ 4 w 10988"/>
              <a:gd name="connsiteY4" fmla="*/ 10000 h 10000"/>
              <a:gd name="connsiteX5" fmla="*/ 16 w 10988"/>
              <a:gd name="connsiteY5" fmla="*/ 20 h 10000"/>
              <a:gd name="connsiteX0" fmla="*/ 16 w 10988"/>
              <a:gd name="connsiteY0" fmla="*/ 0 h 9980"/>
              <a:gd name="connsiteX1" fmla="*/ 7753 w 10988"/>
              <a:gd name="connsiteY1" fmla="*/ 0 h 9980"/>
              <a:gd name="connsiteX2" fmla="*/ 7905 w 10988"/>
              <a:gd name="connsiteY2" fmla="*/ 9390 h 9980"/>
              <a:gd name="connsiteX3" fmla="*/ 10988 w 10988"/>
              <a:gd name="connsiteY3" fmla="*/ 9974 h 9980"/>
              <a:gd name="connsiteX4" fmla="*/ 4 w 10988"/>
              <a:gd name="connsiteY4" fmla="*/ 9980 h 9980"/>
              <a:gd name="connsiteX5" fmla="*/ 16 w 10988"/>
              <a:gd name="connsiteY5" fmla="*/ 0 h 9980"/>
              <a:gd name="connsiteX0" fmla="*/ 0 w 9985"/>
              <a:gd name="connsiteY0" fmla="*/ 0 h 9994"/>
              <a:gd name="connsiteX1" fmla="*/ 7041 w 9985"/>
              <a:gd name="connsiteY1" fmla="*/ 0 h 9994"/>
              <a:gd name="connsiteX2" fmla="*/ 7179 w 9985"/>
              <a:gd name="connsiteY2" fmla="*/ 9409 h 9994"/>
              <a:gd name="connsiteX3" fmla="*/ 9985 w 9985"/>
              <a:gd name="connsiteY3" fmla="*/ 9994 h 9994"/>
              <a:gd name="connsiteX4" fmla="*/ 11 w 9985"/>
              <a:gd name="connsiteY4" fmla="*/ 9987 h 9994"/>
              <a:gd name="connsiteX5" fmla="*/ 0 w 9985"/>
              <a:gd name="connsiteY5" fmla="*/ 0 h 9994"/>
              <a:gd name="connsiteX0" fmla="*/ 0 w 10000"/>
              <a:gd name="connsiteY0" fmla="*/ 0 h 10000"/>
              <a:gd name="connsiteX1" fmla="*/ 7052 w 10000"/>
              <a:gd name="connsiteY1" fmla="*/ 0 h 10000"/>
              <a:gd name="connsiteX2" fmla="*/ 7190 w 10000"/>
              <a:gd name="connsiteY2" fmla="*/ 9415 h 10000"/>
              <a:gd name="connsiteX3" fmla="*/ 10000 w 10000"/>
              <a:gd name="connsiteY3" fmla="*/ 10000 h 10000"/>
              <a:gd name="connsiteX4" fmla="*/ 11 w 10000"/>
              <a:gd name="connsiteY4" fmla="*/ 9996 h 10000"/>
              <a:gd name="connsiteX5" fmla="*/ 0 w 10000"/>
              <a:gd name="connsiteY5" fmla="*/ 0 h 10000"/>
              <a:gd name="connsiteX0" fmla="*/ 35 w 10035"/>
              <a:gd name="connsiteY0" fmla="*/ 0 h 10009"/>
              <a:gd name="connsiteX1" fmla="*/ 7087 w 10035"/>
              <a:gd name="connsiteY1" fmla="*/ 0 h 10009"/>
              <a:gd name="connsiteX2" fmla="*/ 7225 w 10035"/>
              <a:gd name="connsiteY2" fmla="*/ 9415 h 10009"/>
              <a:gd name="connsiteX3" fmla="*/ 10035 w 10035"/>
              <a:gd name="connsiteY3" fmla="*/ 10000 h 10009"/>
              <a:gd name="connsiteX4" fmla="*/ 3 w 10035"/>
              <a:gd name="connsiteY4" fmla="*/ 10009 h 10009"/>
              <a:gd name="connsiteX5" fmla="*/ 35 w 10035"/>
              <a:gd name="connsiteY5" fmla="*/ 0 h 10009"/>
              <a:gd name="connsiteX0" fmla="*/ 0 w 10000"/>
              <a:gd name="connsiteY0" fmla="*/ 0 h 10000"/>
              <a:gd name="connsiteX1" fmla="*/ 7052 w 10000"/>
              <a:gd name="connsiteY1" fmla="*/ 0 h 10000"/>
              <a:gd name="connsiteX2" fmla="*/ 7190 w 10000"/>
              <a:gd name="connsiteY2" fmla="*/ 9415 h 10000"/>
              <a:gd name="connsiteX3" fmla="*/ 10000 w 10000"/>
              <a:gd name="connsiteY3" fmla="*/ 10000 h 10000"/>
              <a:gd name="connsiteX4" fmla="*/ 66 w 10000"/>
              <a:gd name="connsiteY4" fmla="*/ 9989 h 10000"/>
              <a:gd name="connsiteX5" fmla="*/ 0 w 10000"/>
              <a:gd name="connsiteY5" fmla="*/ 0 h 10000"/>
              <a:gd name="connsiteX0" fmla="*/ 0 w 10000"/>
              <a:gd name="connsiteY0" fmla="*/ 0 h 10002"/>
              <a:gd name="connsiteX1" fmla="*/ 7052 w 10000"/>
              <a:gd name="connsiteY1" fmla="*/ 0 h 10002"/>
              <a:gd name="connsiteX2" fmla="*/ 7190 w 10000"/>
              <a:gd name="connsiteY2" fmla="*/ 9415 h 10002"/>
              <a:gd name="connsiteX3" fmla="*/ 10000 w 10000"/>
              <a:gd name="connsiteY3" fmla="*/ 10000 h 10002"/>
              <a:gd name="connsiteX4" fmla="*/ 23 w 10000"/>
              <a:gd name="connsiteY4" fmla="*/ 10002 h 10002"/>
              <a:gd name="connsiteX5" fmla="*/ 0 w 10000"/>
              <a:gd name="connsiteY5" fmla="*/ 0 h 10002"/>
              <a:gd name="connsiteX0" fmla="*/ 164 w 10164"/>
              <a:gd name="connsiteY0" fmla="*/ 0 h 10000"/>
              <a:gd name="connsiteX1" fmla="*/ 7216 w 10164"/>
              <a:gd name="connsiteY1" fmla="*/ 0 h 10000"/>
              <a:gd name="connsiteX2" fmla="*/ 7354 w 10164"/>
              <a:gd name="connsiteY2" fmla="*/ 9415 h 10000"/>
              <a:gd name="connsiteX3" fmla="*/ 10164 w 10164"/>
              <a:gd name="connsiteY3" fmla="*/ 10000 h 10000"/>
              <a:gd name="connsiteX4" fmla="*/ 2 w 10164"/>
              <a:gd name="connsiteY4" fmla="*/ 9999 h 10000"/>
              <a:gd name="connsiteX5" fmla="*/ 164 w 10164"/>
              <a:gd name="connsiteY5" fmla="*/ 0 h 10000"/>
              <a:gd name="connsiteX0" fmla="*/ 163 w 10163"/>
              <a:gd name="connsiteY0" fmla="*/ 0 h 10000"/>
              <a:gd name="connsiteX1" fmla="*/ 7215 w 10163"/>
              <a:gd name="connsiteY1" fmla="*/ 0 h 10000"/>
              <a:gd name="connsiteX2" fmla="*/ 7353 w 10163"/>
              <a:gd name="connsiteY2" fmla="*/ 9415 h 10000"/>
              <a:gd name="connsiteX3" fmla="*/ 10163 w 10163"/>
              <a:gd name="connsiteY3" fmla="*/ 10000 h 10000"/>
              <a:gd name="connsiteX4" fmla="*/ 1 w 10163"/>
              <a:gd name="connsiteY4" fmla="*/ 9999 h 10000"/>
              <a:gd name="connsiteX5" fmla="*/ 163 w 10163"/>
              <a:gd name="connsiteY5" fmla="*/ 0 h 10000"/>
              <a:gd name="connsiteX0" fmla="*/ 0 w 10174"/>
              <a:gd name="connsiteY0" fmla="*/ 0 h 10000"/>
              <a:gd name="connsiteX1" fmla="*/ 7226 w 10174"/>
              <a:gd name="connsiteY1" fmla="*/ 0 h 10000"/>
              <a:gd name="connsiteX2" fmla="*/ 7364 w 10174"/>
              <a:gd name="connsiteY2" fmla="*/ 9415 h 10000"/>
              <a:gd name="connsiteX3" fmla="*/ 10174 w 10174"/>
              <a:gd name="connsiteY3" fmla="*/ 10000 h 10000"/>
              <a:gd name="connsiteX4" fmla="*/ 12 w 10174"/>
              <a:gd name="connsiteY4" fmla="*/ 9999 h 10000"/>
              <a:gd name="connsiteX5" fmla="*/ 0 w 10174"/>
              <a:gd name="connsiteY5" fmla="*/ 0 h 10000"/>
              <a:gd name="connsiteX0" fmla="*/ 0 w 10174"/>
              <a:gd name="connsiteY0" fmla="*/ 0 h 10000"/>
              <a:gd name="connsiteX1" fmla="*/ 7226 w 10174"/>
              <a:gd name="connsiteY1" fmla="*/ 0 h 10000"/>
              <a:gd name="connsiteX2" fmla="*/ 7364 w 10174"/>
              <a:gd name="connsiteY2" fmla="*/ 9415 h 10000"/>
              <a:gd name="connsiteX3" fmla="*/ 10174 w 10174"/>
              <a:gd name="connsiteY3" fmla="*/ 10000 h 10000"/>
              <a:gd name="connsiteX4" fmla="*/ 12 w 10174"/>
              <a:gd name="connsiteY4" fmla="*/ 9999 h 10000"/>
              <a:gd name="connsiteX5" fmla="*/ 0 w 10174"/>
              <a:gd name="connsiteY5" fmla="*/ 0 h 10000"/>
              <a:gd name="connsiteX0" fmla="*/ 0 w 10174"/>
              <a:gd name="connsiteY0" fmla="*/ 3 h 10003"/>
              <a:gd name="connsiteX1" fmla="*/ 7335 w 10174"/>
              <a:gd name="connsiteY1" fmla="*/ 0 h 10003"/>
              <a:gd name="connsiteX2" fmla="*/ 7364 w 10174"/>
              <a:gd name="connsiteY2" fmla="*/ 9418 h 10003"/>
              <a:gd name="connsiteX3" fmla="*/ 10174 w 10174"/>
              <a:gd name="connsiteY3" fmla="*/ 10003 h 10003"/>
              <a:gd name="connsiteX4" fmla="*/ 12 w 10174"/>
              <a:gd name="connsiteY4" fmla="*/ 10002 h 10003"/>
              <a:gd name="connsiteX5" fmla="*/ 0 w 10174"/>
              <a:gd name="connsiteY5" fmla="*/ 3 h 10003"/>
              <a:gd name="connsiteX0" fmla="*/ 0 w 10174"/>
              <a:gd name="connsiteY0" fmla="*/ 6 h 10006"/>
              <a:gd name="connsiteX1" fmla="*/ 7346 w 10174"/>
              <a:gd name="connsiteY1" fmla="*/ 0 h 10006"/>
              <a:gd name="connsiteX2" fmla="*/ 7364 w 10174"/>
              <a:gd name="connsiteY2" fmla="*/ 9421 h 10006"/>
              <a:gd name="connsiteX3" fmla="*/ 10174 w 10174"/>
              <a:gd name="connsiteY3" fmla="*/ 10006 h 10006"/>
              <a:gd name="connsiteX4" fmla="*/ 12 w 10174"/>
              <a:gd name="connsiteY4" fmla="*/ 10005 h 10006"/>
              <a:gd name="connsiteX5" fmla="*/ 0 w 10174"/>
              <a:gd name="connsiteY5" fmla="*/ 6 h 10006"/>
              <a:gd name="connsiteX0" fmla="*/ 0 w 10174"/>
              <a:gd name="connsiteY0" fmla="*/ 6 h 10006"/>
              <a:gd name="connsiteX1" fmla="*/ 7346 w 10174"/>
              <a:gd name="connsiteY1" fmla="*/ 0 h 10006"/>
              <a:gd name="connsiteX2" fmla="*/ 7364 w 10174"/>
              <a:gd name="connsiteY2" fmla="*/ 9421 h 10006"/>
              <a:gd name="connsiteX3" fmla="*/ 10174 w 10174"/>
              <a:gd name="connsiteY3" fmla="*/ 10006 h 10006"/>
              <a:gd name="connsiteX4" fmla="*/ 12 w 10174"/>
              <a:gd name="connsiteY4" fmla="*/ 10005 h 10006"/>
              <a:gd name="connsiteX5" fmla="*/ 0 w 10174"/>
              <a:gd name="connsiteY5" fmla="*/ 6 h 10006"/>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0 w 9613"/>
              <a:gd name="connsiteY0" fmla="*/ 3 h 10009"/>
              <a:gd name="connsiteX1" fmla="*/ 6785 w 9613"/>
              <a:gd name="connsiteY1" fmla="*/ 0 h 10009"/>
              <a:gd name="connsiteX2" fmla="*/ 6803 w 9613"/>
              <a:gd name="connsiteY2" fmla="*/ 9424 h 10009"/>
              <a:gd name="connsiteX3" fmla="*/ 9613 w 9613"/>
              <a:gd name="connsiteY3" fmla="*/ 10009 h 10009"/>
              <a:gd name="connsiteX4" fmla="*/ 95 w 9613"/>
              <a:gd name="connsiteY4" fmla="*/ 9998 h 10009"/>
              <a:gd name="connsiteX5" fmla="*/ 0 w 9613"/>
              <a:gd name="connsiteY5" fmla="*/ 3 h 10009"/>
              <a:gd name="connsiteX0" fmla="*/ 0 w 10000"/>
              <a:gd name="connsiteY0" fmla="*/ 3 h 10000"/>
              <a:gd name="connsiteX1" fmla="*/ 7058 w 10000"/>
              <a:gd name="connsiteY1" fmla="*/ 0 h 10000"/>
              <a:gd name="connsiteX2" fmla="*/ 7077 w 10000"/>
              <a:gd name="connsiteY2" fmla="*/ 9416 h 10000"/>
              <a:gd name="connsiteX3" fmla="*/ 10000 w 10000"/>
              <a:gd name="connsiteY3" fmla="*/ 10000 h 10000"/>
              <a:gd name="connsiteX4" fmla="*/ 14 w 10000"/>
              <a:gd name="connsiteY4" fmla="*/ 9999 h 10000"/>
              <a:gd name="connsiteX5" fmla="*/ 0 w 10000"/>
              <a:gd name="connsiteY5" fmla="*/ 3 h 10000"/>
              <a:gd name="connsiteX0" fmla="*/ 0 w 10000"/>
              <a:gd name="connsiteY0" fmla="*/ 3 h 10000"/>
              <a:gd name="connsiteX1" fmla="*/ 7058 w 10000"/>
              <a:gd name="connsiteY1" fmla="*/ 0 h 10000"/>
              <a:gd name="connsiteX2" fmla="*/ 7077 w 10000"/>
              <a:gd name="connsiteY2" fmla="*/ 9416 h 10000"/>
              <a:gd name="connsiteX3" fmla="*/ 10000 w 10000"/>
              <a:gd name="connsiteY3" fmla="*/ 10000 h 10000"/>
              <a:gd name="connsiteX4" fmla="*/ 14 w 10000"/>
              <a:gd name="connsiteY4" fmla="*/ 9999 h 10000"/>
              <a:gd name="connsiteX5" fmla="*/ 0 w 10000"/>
              <a:gd name="connsiteY5" fmla="*/ 3 h 10000"/>
              <a:gd name="connsiteX0" fmla="*/ 0 w 10000"/>
              <a:gd name="connsiteY0" fmla="*/ 3 h 10000"/>
              <a:gd name="connsiteX1" fmla="*/ 7058 w 10000"/>
              <a:gd name="connsiteY1" fmla="*/ 0 h 10000"/>
              <a:gd name="connsiteX2" fmla="*/ 7077 w 10000"/>
              <a:gd name="connsiteY2" fmla="*/ 9416 h 10000"/>
              <a:gd name="connsiteX3" fmla="*/ 10000 w 10000"/>
              <a:gd name="connsiteY3" fmla="*/ 10000 h 10000"/>
              <a:gd name="connsiteX4" fmla="*/ 14 w 10000"/>
              <a:gd name="connsiteY4" fmla="*/ 9999 h 10000"/>
              <a:gd name="connsiteX5" fmla="*/ 0 w 10000"/>
              <a:gd name="connsiteY5" fmla="*/ 3 h 10000"/>
              <a:gd name="connsiteX0" fmla="*/ 0 w 10000"/>
              <a:gd name="connsiteY0" fmla="*/ 3 h 10000"/>
              <a:gd name="connsiteX1" fmla="*/ 7058 w 10000"/>
              <a:gd name="connsiteY1" fmla="*/ 0 h 10000"/>
              <a:gd name="connsiteX2" fmla="*/ 7077 w 10000"/>
              <a:gd name="connsiteY2" fmla="*/ 9416 h 10000"/>
              <a:gd name="connsiteX3" fmla="*/ 10000 w 10000"/>
              <a:gd name="connsiteY3" fmla="*/ 10000 h 10000"/>
              <a:gd name="connsiteX4" fmla="*/ 14 w 10000"/>
              <a:gd name="connsiteY4" fmla="*/ 9999 h 10000"/>
              <a:gd name="connsiteX5" fmla="*/ 0 w 10000"/>
              <a:gd name="connsiteY5" fmla="*/ 3 h 1000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0000" h="10000">
                <a:moveTo>
                  <a:pt x="0" y="3"/>
                </a:moveTo>
                <a:lnTo>
                  <a:pt x="7058" y="0"/>
                </a:lnTo>
                <a:cubicBezTo>
                  <a:pt x="7049" y="2528"/>
                  <a:pt x="7068" y="8825"/>
                  <a:pt x="7077" y="9416"/>
                </a:cubicBezTo>
                <a:cubicBezTo>
                  <a:pt x="7052" y="9743"/>
                  <a:pt x="8384" y="10000"/>
                  <a:pt x="10000" y="10000"/>
                </a:cubicBezTo>
                <a:lnTo>
                  <a:pt x="14" y="9999"/>
                </a:lnTo>
                <a:cubicBezTo>
                  <a:pt x="7" y="7401"/>
                  <a:pt x="15" y="1749"/>
                  <a:pt x="0" y="3"/>
                </a:cubicBezTo>
                <a:close/>
              </a:path>
            </a:pathLst>
          </a:custGeom>
          <a:solidFill>
            <a:srgbClr val="65AA00"/>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p>
        </p:txBody>
      </p:sp>
    </p:spTree>
    <p:extLst>
      <p:ext uri="{BB962C8B-B14F-4D97-AF65-F5344CB8AC3E}">
        <p14:creationId xmlns:p14="http://schemas.microsoft.com/office/powerpoint/2010/main" val="50610923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preserve="1" userDrawn="1">
  <p:cSld name="Educational Review">
    <p:spTree>
      <p:nvGrpSpPr>
        <p:cNvPr id="1" name=""/>
        <p:cNvGrpSpPr/>
        <p:nvPr/>
      </p:nvGrpSpPr>
      <p:grpSpPr>
        <a:xfrm>
          <a:off x="0" y="0"/>
          <a:ext cx="0" cy="0"/>
          <a:chOff x="0" y="0"/>
          <a:chExt cx="0" cy="0"/>
        </a:xfrm>
      </p:grpSpPr>
      <p:sp>
        <p:nvSpPr>
          <p:cNvPr id="5" name="Flowchart: Stored Data 4">
            <a:extLst>
              <a:ext uri="{FF2B5EF4-FFF2-40B4-BE49-F238E27FC236}">
                <a16:creationId xmlns:a16="http://schemas.microsoft.com/office/drawing/2014/main" id="{D150C2D2-09E4-F78B-7FA6-F42DD5FA59F4}"/>
              </a:ext>
            </a:extLst>
          </p:cNvPr>
          <p:cNvSpPr/>
          <p:nvPr userDrawn="1"/>
        </p:nvSpPr>
        <p:spPr>
          <a:xfrm rot="5400000">
            <a:off x="5283465" y="-5325515"/>
            <a:ext cx="1614236" cy="12214770"/>
          </a:xfrm>
          <a:custGeom>
            <a:avLst/>
            <a:gdLst>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89795 h 103750"/>
              <a:gd name="connsiteX1" fmla="*/ 8293 w 10000"/>
              <a:gd name="connsiteY1" fmla="*/ 0 h 103750"/>
              <a:gd name="connsiteX2" fmla="*/ 8333 w 10000"/>
              <a:gd name="connsiteY2" fmla="*/ 94795 h 103750"/>
              <a:gd name="connsiteX3" fmla="*/ 10000 w 10000"/>
              <a:gd name="connsiteY3" fmla="*/ 99795 h 103750"/>
              <a:gd name="connsiteX4" fmla="*/ 1667 w 10000"/>
              <a:gd name="connsiteY4" fmla="*/ 99795 h 103750"/>
              <a:gd name="connsiteX5" fmla="*/ 0 w 10000"/>
              <a:gd name="connsiteY5" fmla="*/ 94795 h 103750"/>
              <a:gd name="connsiteX6" fmla="*/ 1667 w 10000"/>
              <a:gd name="connsiteY6" fmla="*/ 89795 h 10375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5639 w 10161"/>
              <a:gd name="connsiteY0" fmla="*/ 18392 h 112308"/>
              <a:gd name="connsiteX1" fmla="*/ 8672 w 10161"/>
              <a:gd name="connsiteY1" fmla="*/ 5059 h 112308"/>
              <a:gd name="connsiteX2" fmla="*/ 8494 w 10161"/>
              <a:gd name="connsiteY2" fmla="*/ 103121 h 112308"/>
              <a:gd name="connsiteX3" fmla="*/ 10161 w 10161"/>
              <a:gd name="connsiteY3" fmla="*/ 108121 h 112308"/>
              <a:gd name="connsiteX4" fmla="*/ 1828 w 10161"/>
              <a:gd name="connsiteY4" fmla="*/ 108121 h 112308"/>
              <a:gd name="connsiteX5" fmla="*/ 161 w 10161"/>
              <a:gd name="connsiteY5" fmla="*/ 103121 h 112308"/>
              <a:gd name="connsiteX6" fmla="*/ 5639 w 10161"/>
              <a:gd name="connsiteY6" fmla="*/ 18392 h 112308"/>
              <a:gd name="connsiteX0" fmla="*/ 5639 w 10161"/>
              <a:gd name="connsiteY0" fmla="*/ 48998 h 145481"/>
              <a:gd name="connsiteX1" fmla="*/ 8354 w 10161"/>
              <a:gd name="connsiteY1" fmla="*/ 0 h 145481"/>
              <a:gd name="connsiteX2" fmla="*/ 8494 w 10161"/>
              <a:gd name="connsiteY2" fmla="*/ 133727 h 145481"/>
              <a:gd name="connsiteX3" fmla="*/ 10161 w 10161"/>
              <a:gd name="connsiteY3" fmla="*/ 138727 h 145481"/>
              <a:gd name="connsiteX4" fmla="*/ 1828 w 10161"/>
              <a:gd name="connsiteY4" fmla="*/ 138727 h 145481"/>
              <a:gd name="connsiteX5" fmla="*/ 161 w 10161"/>
              <a:gd name="connsiteY5" fmla="*/ 133727 h 145481"/>
              <a:gd name="connsiteX6" fmla="*/ 5639 w 10161"/>
              <a:gd name="connsiteY6" fmla="*/ 48998 h 145481"/>
              <a:gd name="connsiteX0" fmla="*/ 4738 w 10113"/>
              <a:gd name="connsiteY0" fmla="*/ 13812 h 159292"/>
              <a:gd name="connsiteX1" fmla="*/ 8306 w 10113"/>
              <a:gd name="connsiteY1" fmla="*/ 13811 h 159292"/>
              <a:gd name="connsiteX2" fmla="*/ 8446 w 10113"/>
              <a:gd name="connsiteY2" fmla="*/ 147538 h 159292"/>
              <a:gd name="connsiteX3" fmla="*/ 10113 w 10113"/>
              <a:gd name="connsiteY3" fmla="*/ 152538 h 159292"/>
              <a:gd name="connsiteX4" fmla="*/ 1780 w 10113"/>
              <a:gd name="connsiteY4" fmla="*/ 152538 h 159292"/>
              <a:gd name="connsiteX5" fmla="*/ 113 w 10113"/>
              <a:gd name="connsiteY5" fmla="*/ 147538 h 159292"/>
              <a:gd name="connsiteX6" fmla="*/ 4738 w 10113"/>
              <a:gd name="connsiteY6" fmla="*/ 13812 h 159292"/>
              <a:gd name="connsiteX0" fmla="*/ 4738 w 10113"/>
              <a:gd name="connsiteY0" fmla="*/ 2870 h 148350"/>
              <a:gd name="connsiteX1" fmla="*/ 8306 w 10113"/>
              <a:gd name="connsiteY1" fmla="*/ 2869 h 148350"/>
              <a:gd name="connsiteX2" fmla="*/ 8446 w 10113"/>
              <a:gd name="connsiteY2" fmla="*/ 136596 h 148350"/>
              <a:gd name="connsiteX3" fmla="*/ 10113 w 10113"/>
              <a:gd name="connsiteY3" fmla="*/ 141596 h 148350"/>
              <a:gd name="connsiteX4" fmla="*/ 1780 w 10113"/>
              <a:gd name="connsiteY4" fmla="*/ 141596 h 148350"/>
              <a:gd name="connsiteX5" fmla="*/ 113 w 10113"/>
              <a:gd name="connsiteY5" fmla="*/ 136596 h 148350"/>
              <a:gd name="connsiteX6" fmla="*/ 4738 w 10113"/>
              <a:gd name="connsiteY6" fmla="*/ 2870 h 148350"/>
              <a:gd name="connsiteX0" fmla="*/ 4738 w 10113"/>
              <a:gd name="connsiteY0" fmla="*/ 51 h 145531"/>
              <a:gd name="connsiteX1" fmla="*/ 8306 w 10113"/>
              <a:gd name="connsiteY1" fmla="*/ 50 h 145531"/>
              <a:gd name="connsiteX2" fmla="*/ 8446 w 10113"/>
              <a:gd name="connsiteY2" fmla="*/ 133777 h 145531"/>
              <a:gd name="connsiteX3" fmla="*/ 10113 w 10113"/>
              <a:gd name="connsiteY3" fmla="*/ 138777 h 145531"/>
              <a:gd name="connsiteX4" fmla="*/ 1780 w 10113"/>
              <a:gd name="connsiteY4" fmla="*/ 138777 h 145531"/>
              <a:gd name="connsiteX5" fmla="*/ 113 w 10113"/>
              <a:gd name="connsiteY5" fmla="*/ 133777 h 145531"/>
              <a:gd name="connsiteX6" fmla="*/ 4738 w 10113"/>
              <a:gd name="connsiteY6" fmla="*/ 51 h 145531"/>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674 w 10109"/>
              <a:gd name="connsiteY0" fmla="*/ 170 h 145517"/>
              <a:gd name="connsiteX1" fmla="*/ 8302 w 10109"/>
              <a:gd name="connsiteY1" fmla="*/ 36 h 145517"/>
              <a:gd name="connsiteX2" fmla="*/ 8442 w 10109"/>
              <a:gd name="connsiteY2" fmla="*/ 133763 h 145517"/>
              <a:gd name="connsiteX3" fmla="*/ 10109 w 10109"/>
              <a:gd name="connsiteY3" fmla="*/ 138763 h 145517"/>
              <a:gd name="connsiteX4" fmla="*/ 1776 w 10109"/>
              <a:gd name="connsiteY4" fmla="*/ 138763 h 145517"/>
              <a:gd name="connsiteX5" fmla="*/ 109 w 10109"/>
              <a:gd name="connsiteY5" fmla="*/ 133763 h 145517"/>
              <a:gd name="connsiteX6" fmla="*/ 4674 w 10109"/>
              <a:gd name="connsiteY6" fmla="*/ 170 h 145517"/>
              <a:gd name="connsiteX0" fmla="*/ 3080 w 8515"/>
              <a:gd name="connsiteY0" fmla="*/ 170 h 145517"/>
              <a:gd name="connsiteX1" fmla="*/ 6708 w 8515"/>
              <a:gd name="connsiteY1" fmla="*/ 36 h 145517"/>
              <a:gd name="connsiteX2" fmla="*/ 6848 w 8515"/>
              <a:gd name="connsiteY2" fmla="*/ 133763 h 145517"/>
              <a:gd name="connsiteX3" fmla="*/ 8515 w 8515"/>
              <a:gd name="connsiteY3" fmla="*/ 138763 h 145517"/>
              <a:gd name="connsiteX4" fmla="*/ 182 w 8515"/>
              <a:gd name="connsiteY4" fmla="*/ 138763 h 145517"/>
              <a:gd name="connsiteX5" fmla="*/ 3080 w 8515"/>
              <a:gd name="connsiteY5" fmla="*/ 170 h 145517"/>
              <a:gd name="connsiteX0" fmla="*/ 3617 w 10000"/>
              <a:gd name="connsiteY0" fmla="*/ 12 h 9536"/>
              <a:gd name="connsiteX1" fmla="*/ 7878 w 10000"/>
              <a:gd name="connsiteY1" fmla="*/ 2 h 9536"/>
              <a:gd name="connsiteX2" fmla="*/ 8042 w 10000"/>
              <a:gd name="connsiteY2" fmla="*/ 9192 h 9536"/>
              <a:gd name="connsiteX3" fmla="*/ 10000 w 10000"/>
              <a:gd name="connsiteY3" fmla="*/ 9536 h 9536"/>
              <a:gd name="connsiteX4" fmla="*/ 214 w 10000"/>
              <a:gd name="connsiteY4" fmla="*/ 9536 h 9536"/>
              <a:gd name="connsiteX5" fmla="*/ 3617 w 10000"/>
              <a:gd name="connsiteY5" fmla="*/ 12 h 9536"/>
              <a:gd name="connsiteX0" fmla="*/ 3403 w 9786"/>
              <a:gd name="connsiteY0" fmla="*/ 13 h 10000"/>
              <a:gd name="connsiteX1" fmla="*/ 7664 w 9786"/>
              <a:gd name="connsiteY1" fmla="*/ 2 h 10000"/>
              <a:gd name="connsiteX2" fmla="*/ 7828 w 9786"/>
              <a:gd name="connsiteY2" fmla="*/ 9639 h 10000"/>
              <a:gd name="connsiteX3" fmla="*/ 9786 w 9786"/>
              <a:gd name="connsiteY3" fmla="*/ 10000 h 10000"/>
              <a:gd name="connsiteX4" fmla="*/ 0 w 9786"/>
              <a:gd name="connsiteY4" fmla="*/ 10000 h 10000"/>
              <a:gd name="connsiteX5" fmla="*/ 3403 w 9786"/>
              <a:gd name="connsiteY5" fmla="*/ 13 h 10000"/>
              <a:gd name="connsiteX0" fmla="*/ 494 w 7017"/>
              <a:gd name="connsiteY0" fmla="*/ 743 h 10730"/>
              <a:gd name="connsiteX1" fmla="*/ 4849 w 7017"/>
              <a:gd name="connsiteY1" fmla="*/ 732 h 10730"/>
              <a:gd name="connsiteX2" fmla="*/ 5016 w 7017"/>
              <a:gd name="connsiteY2" fmla="*/ 10369 h 10730"/>
              <a:gd name="connsiteX3" fmla="*/ 7017 w 7017"/>
              <a:gd name="connsiteY3" fmla="*/ 10730 h 10730"/>
              <a:gd name="connsiteX4" fmla="*/ 45 w 7017"/>
              <a:gd name="connsiteY4" fmla="*/ 10709 h 10730"/>
              <a:gd name="connsiteX5" fmla="*/ 494 w 7017"/>
              <a:gd name="connsiteY5" fmla="*/ 743 h 10730"/>
              <a:gd name="connsiteX0" fmla="*/ 521 w 9817"/>
              <a:gd name="connsiteY0" fmla="*/ 692 h 10000"/>
              <a:gd name="connsiteX1" fmla="*/ 6727 w 9817"/>
              <a:gd name="connsiteY1" fmla="*/ 682 h 10000"/>
              <a:gd name="connsiteX2" fmla="*/ 6965 w 9817"/>
              <a:gd name="connsiteY2" fmla="*/ 9664 h 10000"/>
              <a:gd name="connsiteX3" fmla="*/ 9817 w 9817"/>
              <a:gd name="connsiteY3" fmla="*/ 10000 h 10000"/>
              <a:gd name="connsiteX4" fmla="*/ 273 w 9817"/>
              <a:gd name="connsiteY4" fmla="*/ 9980 h 10000"/>
              <a:gd name="connsiteX5" fmla="*/ 521 w 9817"/>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70 w 10039"/>
              <a:gd name="connsiteY0" fmla="*/ 695 h 10015"/>
              <a:gd name="connsiteX1" fmla="*/ 6891 w 10039"/>
              <a:gd name="connsiteY1" fmla="*/ 685 h 10015"/>
              <a:gd name="connsiteX2" fmla="*/ 7134 w 10039"/>
              <a:gd name="connsiteY2" fmla="*/ 9667 h 10015"/>
              <a:gd name="connsiteX3" fmla="*/ 10039 w 10039"/>
              <a:gd name="connsiteY3" fmla="*/ 10003 h 10015"/>
              <a:gd name="connsiteX4" fmla="*/ 217 w 10039"/>
              <a:gd name="connsiteY4" fmla="*/ 10015 h 10015"/>
              <a:gd name="connsiteX5" fmla="*/ 570 w 10039"/>
              <a:gd name="connsiteY5" fmla="*/ 695 h 10015"/>
              <a:gd name="connsiteX0" fmla="*/ 615 w 10084"/>
              <a:gd name="connsiteY0" fmla="*/ 695 h 10015"/>
              <a:gd name="connsiteX1" fmla="*/ 6936 w 10084"/>
              <a:gd name="connsiteY1" fmla="*/ 685 h 10015"/>
              <a:gd name="connsiteX2" fmla="*/ 7179 w 10084"/>
              <a:gd name="connsiteY2" fmla="*/ 9667 h 10015"/>
              <a:gd name="connsiteX3" fmla="*/ 10084 w 10084"/>
              <a:gd name="connsiteY3" fmla="*/ 10003 h 10015"/>
              <a:gd name="connsiteX4" fmla="*/ 262 w 10084"/>
              <a:gd name="connsiteY4" fmla="*/ 10015 h 10015"/>
              <a:gd name="connsiteX5" fmla="*/ 615 w 10084"/>
              <a:gd name="connsiteY5" fmla="*/ 695 h 10015"/>
              <a:gd name="connsiteX0" fmla="*/ 356 w 9825"/>
              <a:gd name="connsiteY0" fmla="*/ 695 h 10015"/>
              <a:gd name="connsiteX1" fmla="*/ 6677 w 9825"/>
              <a:gd name="connsiteY1" fmla="*/ 685 h 10015"/>
              <a:gd name="connsiteX2" fmla="*/ 6920 w 9825"/>
              <a:gd name="connsiteY2" fmla="*/ 9667 h 10015"/>
              <a:gd name="connsiteX3" fmla="*/ 9825 w 9825"/>
              <a:gd name="connsiteY3" fmla="*/ 10003 h 10015"/>
              <a:gd name="connsiteX4" fmla="*/ 3 w 9825"/>
              <a:gd name="connsiteY4" fmla="*/ 10015 h 10015"/>
              <a:gd name="connsiteX5" fmla="*/ 356 w 9825"/>
              <a:gd name="connsiteY5" fmla="*/ 695 h 10015"/>
              <a:gd name="connsiteX0" fmla="*/ 362 w 10000"/>
              <a:gd name="connsiteY0" fmla="*/ 10 h 9316"/>
              <a:gd name="connsiteX1" fmla="*/ 6796 w 10000"/>
              <a:gd name="connsiteY1" fmla="*/ 0 h 9316"/>
              <a:gd name="connsiteX2" fmla="*/ 7043 w 10000"/>
              <a:gd name="connsiteY2" fmla="*/ 8969 h 9316"/>
              <a:gd name="connsiteX3" fmla="*/ 10000 w 10000"/>
              <a:gd name="connsiteY3" fmla="*/ 9304 h 9316"/>
              <a:gd name="connsiteX4" fmla="*/ 3 w 10000"/>
              <a:gd name="connsiteY4" fmla="*/ 9316 h 9316"/>
              <a:gd name="connsiteX5" fmla="*/ 362 w 10000"/>
              <a:gd name="connsiteY5" fmla="*/ 10 h 9316"/>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0 w 9998"/>
              <a:gd name="connsiteY0" fmla="*/ 11 h 10000"/>
              <a:gd name="connsiteX1" fmla="*/ 7099 w 9998"/>
              <a:gd name="connsiteY1" fmla="*/ 0 h 10000"/>
              <a:gd name="connsiteX2" fmla="*/ 7041 w 9998"/>
              <a:gd name="connsiteY2" fmla="*/ 9628 h 10000"/>
              <a:gd name="connsiteX3" fmla="*/ 9998 w 9998"/>
              <a:gd name="connsiteY3" fmla="*/ 9987 h 10000"/>
              <a:gd name="connsiteX4" fmla="*/ 1 w 9998"/>
              <a:gd name="connsiteY4" fmla="*/ 10000 h 10000"/>
              <a:gd name="connsiteX5" fmla="*/ 360 w 9998"/>
              <a:gd name="connsiteY5" fmla="*/ 11 h 10000"/>
              <a:gd name="connsiteX0" fmla="*/ 0 w 9640"/>
              <a:gd name="connsiteY0" fmla="*/ 11 h 10000"/>
              <a:gd name="connsiteX1" fmla="*/ 6740 w 9640"/>
              <a:gd name="connsiteY1" fmla="*/ 0 h 10000"/>
              <a:gd name="connsiteX2" fmla="*/ 6682 w 9640"/>
              <a:gd name="connsiteY2" fmla="*/ 9628 h 10000"/>
              <a:gd name="connsiteX3" fmla="*/ 9640 w 9640"/>
              <a:gd name="connsiteY3" fmla="*/ 9987 h 10000"/>
              <a:gd name="connsiteX4" fmla="*/ 302 w 9640"/>
              <a:gd name="connsiteY4" fmla="*/ 10000 h 10000"/>
              <a:gd name="connsiteX5" fmla="*/ 0 w 964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0 h 9996"/>
              <a:gd name="connsiteX1" fmla="*/ 7001 w 10056"/>
              <a:gd name="connsiteY1" fmla="*/ 1 h 9996"/>
              <a:gd name="connsiteX2" fmla="*/ 6988 w 10056"/>
              <a:gd name="connsiteY2" fmla="*/ 9624 h 9996"/>
              <a:gd name="connsiteX3" fmla="*/ 10056 w 10056"/>
              <a:gd name="connsiteY3" fmla="*/ 9983 h 9996"/>
              <a:gd name="connsiteX4" fmla="*/ 62 w 10056"/>
              <a:gd name="connsiteY4" fmla="*/ 9996 h 9996"/>
              <a:gd name="connsiteX5" fmla="*/ 0 w 10056"/>
              <a:gd name="connsiteY5" fmla="*/ 0 h 9996"/>
              <a:gd name="connsiteX0" fmla="*/ 0 w 10000"/>
              <a:gd name="connsiteY0" fmla="*/ 2 h 10002"/>
              <a:gd name="connsiteX1" fmla="*/ 6962 w 10000"/>
              <a:gd name="connsiteY1" fmla="*/ 0 h 10002"/>
              <a:gd name="connsiteX2" fmla="*/ 6949 w 10000"/>
              <a:gd name="connsiteY2" fmla="*/ 9630 h 10002"/>
              <a:gd name="connsiteX3" fmla="*/ 10000 w 10000"/>
              <a:gd name="connsiteY3" fmla="*/ 9989 h 10002"/>
              <a:gd name="connsiteX4" fmla="*/ 62 w 10000"/>
              <a:gd name="connsiteY4" fmla="*/ 10002 h 10002"/>
              <a:gd name="connsiteX5" fmla="*/ 0 w 10000"/>
              <a:gd name="connsiteY5" fmla="*/ 2 h 10002"/>
              <a:gd name="connsiteX0" fmla="*/ 0 w 10000"/>
              <a:gd name="connsiteY0" fmla="*/ 4 h 10004"/>
              <a:gd name="connsiteX1" fmla="*/ 6927 w 10000"/>
              <a:gd name="connsiteY1" fmla="*/ 0 h 10004"/>
              <a:gd name="connsiteX2" fmla="*/ 6949 w 10000"/>
              <a:gd name="connsiteY2" fmla="*/ 9632 h 10004"/>
              <a:gd name="connsiteX3" fmla="*/ 10000 w 10000"/>
              <a:gd name="connsiteY3" fmla="*/ 9991 h 10004"/>
              <a:gd name="connsiteX4" fmla="*/ 62 w 10000"/>
              <a:gd name="connsiteY4" fmla="*/ 10004 h 10004"/>
              <a:gd name="connsiteX5" fmla="*/ 0 w 10000"/>
              <a:gd name="connsiteY5" fmla="*/ 4 h 10004"/>
              <a:gd name="connsiteX0" fmla="*/ 0 w 10000"/>
              <a:gd name="connsiteY0" fmla="*/ 4 h 10004"/>
              <a:gd name="connsiteX1" fmla="*/ 6927 w 10000"/>
              <a:gd name="connsiteY1" fmla="*/ 0 h 10004"/>
              <a:gd name="connsiteX2" fmla="*/ 6949 w 10000"/>
              <a:gd name="connsiteY2" fmla="*/ 9632 h 10004"/>
              <a:gd name="connsiteX3" fmla="*/ 10000 w 10000"/>
              <a:gd name="connsiteY3" fmla="*/ 9991 h 10004"/>
              <a:gd name="connsiteX4" fmla="*/ 62 w 10000"/>
              <a:gd name="connsiteY4" fmla="*/ 10004 h 10004"/>
              <a:gd name="connsiteX5" fmla="*/ 0 w 10000"/>
              <a:gd name="connsiteY5" fmla="*/ 4 h 10004"/>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0000" h="10004">
                <a:moveTo>
                  <a:pt x="0" y="4"/>
                </a:moveTo>
                <a:lnTo>
                  <a:pt x="6927" y="0"/>
                </a:lnTo>
                <a:cubicBezTo>
                  <a:pt x="6894" y="1547"/>
                  <a:pt x="6891" y="9283"/>
                  <a:pt x="6949" y="9632"/>
                </a:cubicBezTo>
                <a:cubicBezTo>
                  <a:pt x="6923" y="9834"/>
                  <a:pt x="8645" y="9997"/>
                  <a:pt x="10000" y="9991"/>
                </a:cubicBezTo>
                <a:lnTo>
                  <a:pt x="62" y="10004"/>
                </a:lnTo>
                <a:cubicBezTo>
                  <a:pt x="31" y="8409"/>
                  <a:pt x="98" y="1072"/>
                  <a:pt x="0" y="4"/>
                </a:cubicBezTo>
                <a:close/>
              </a:path>
            </a:pathLst>
          </a:custGeom>
          <a:solidFill>
            <a:srgbClr val="65AA00"/>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dirty="0"/>
          </a:p>
        </p:txBody>
      </p:sp>
      <p:sp>
        <p:nvSpPr>
          <p:cNvPr id="12" name="Rectangle 11"/>
          <p:cNvSpPr/>
          <p:nvPr userDrawn="1"/>
        </p:nvSpPr>
        <p:spPr>
          <a:xfrm>
            <a:off x="7490690" y="5672093"/>
            <a:ext cx="4702823" cy="421061"/>
          </a:xfrm>
          <a:prstGeom prst="rect">
            <a:avLst/>
          </a:prstGeom>
          <a:solidFill>
            <a:srgbClr val="003969"/>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900"/>
          </a:p>
        </p:txBody>
      </p:sp>
      <p:grpSp>
        <p:nvGrpSpPr>
          <p:cNvPr id="13" name="Group 12"/>
          <p:cNvGrpSpPr/>
          <p:nvPr userDrawn="1"/>
        </p:nvGrpSpPr>
        <p:grpSpPr>
          <a:xfrm>
            <a:off x="7637330" y="6112457"/>
            <a:ext cx="4174624" cy="723275"/>
            <a:chOff x="7646796" y="6098813"/>
            <a:chExt cx="4174624" cy="723275"/>
          </a:xfrm>
        </p:grpSpPr>
        <p:pic>
          <p:nvPicPr>
            <p:cNvPr id="14" name="Picture 10" descr="LOGO_IPNA_Blue"/>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7646796" y="6186597"/>
              <a:ext cx="581637" cy="581637"/>
            </a:xfrm>
            <a:prstGeom prst="rect">
              <a:avLst/>
            </a:prstGeom>
            <a:noFill/>
            <a:extLst>
              <a:ext uri="{909E8E84-426E-40DD-AFC4-6F175D3DCCD1}">
                <a14:hiddenFill xmlns:a14="http://schemas.microsoft.com/office/drawing/2010/main">
                  <a:solidFill>
                    <a:srgbClr val="FFFFFF"/>
                  </a:solidFill>
                </a14:hiddenFill>
              </a:ext>
            </a:extLst>
          </p:spPr>
        </p:pic>
        <p:sp>
          <p:nvSpPr>
            <p:cNvPr id="15" name="Rectangle 12"/>
            <p:cNvSpPr>
              <a:spLocks noChangeArrowheads="1"/>
            </p:cNvSpPr>
            <p:nvPr/>
          </p:nvSpPr>
          <p:spPr bwMode="auto">
            <a:xfrm>
              <a:off x="8208157" y="6098813"/>
              <a:ext cx="3613263" cy="72327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GB" altLang="en-US" b="1" i="0" u="none" strike="noStrike" cap="none" normalizeH="0" baseline="0" dirty="0">
                  <a:ln>
                    <a:noFill/>
                  </a:ln>
                  <a:solidFill>
                    <a:srgbClr val="296DC0"/>
                  </a:solidFill>
                  <a:effectLst/>
                  <a:latin typeface="Arial" panose="020B0604020202020204" pitchFamily="34" charset="0"/>
                  <a:ea typeface="Calibri" panose="020F0502020204030204" pitchFamily="34" charset="0"/>
                  <a:cs typeface="Calibri" panose="020F0502020204030204" pitchFamily="34" charset="0"/>
                </a:rPr>
                <a:t>Pediatric Nephrology</a:t>
              </a:r>
              <a:endParaRPr kumimoji="0" lang="en-GB" altLang="en-US" sz="500" b="0" i="0" u="none" strike="noStrike" cap="none" normalizeH="0" baseline="0" dirty="0">
                <a:ln>
                  <a:noFill/>
                </a:ln>
                <a:solidFill>
                  <a:schemeClr val="tx1"/>
                </a:solidFill>
                <a:effectLst/>
                <a:latin typeface="Arial" panose="020B0604020202020204" pitchFamily="34" charset="0"/>
              </a:endParaRPr>
            </a:p>
            <a:p>
              <a:pPr marL="0" marR="0" lvl="0" indent="0" algn="l" defTabSz="914400" rtl="0" eaLnBrk="0" fontAlgn="base" latinLnBrk="0" hangingPunct="0">
                <a:lnSpc>
                  <a:spcPct val="100000"/>
                </a:lnSpc>
                <a:spcBef>
                  <a:spcPct val="0"/>
                </a:spcBef>
                <a:spcAft>
                  <a:spcPct val="0"/>
                </a:spcAft>
                <a:buClrTx/>
                <a:buSzTx/>
                <a:buFontTx/>
                <a:buNone/>
                <a:tabLst/>
              </a:pPr>
              <a:r>
                <a:rPr kumimoji="0" lang="en-GB" altLang="en-US" sz="11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t>Journal of the </a:t>
              </a:r>
              <a:br>
                <a:rPr kumimoji="0" lang="en-GB" altLang="en-US" sz="11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br>
              <a:r>
                <a:rPr kumimoji="0" lang="en-GB" altLang="en-US" sz="12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t>International Pediatric Nephrology Association</a:t>
              </a:r>
              <a:endParaRPr kumimoji="0" lang="en-GB" altLang="en-US" sz="1200" b="0" i="0" u="none" strike="noStrike" cap="none" normalizeH="0" baseline="0" dirty="0">
                <a:ln>
                  <a:noFill/>
                </a:ln>
                <a:solidFill>
                  <a:schemeClr val="tx1"/>
                </a:solidFill>
                <a:effectLst/>
                <a:latin typeface="Arial" panose="020B0604020202020204" pitchFamily="34" charset="0"/>
              </a:endParaRPr>
            </a:p>
          </p:txBody>
        </p:sp>
      </p:grpSp>
      <p:sp>
        <p:nvSpPr>
          <p:cNvPr id="37" name="Rectangle 36">
            <a:extLst>
              <a:ext uri="{FF2B5EF4-FFF2-40B4-BE49-F238E27FC236}">
                <a16:creationId xmlns:a16="http://schemas.microsoft.com/office/drawing/2014/main" id="{FB861B61-643E-7D14-D771-2A7BF1205723}"/>
              </a:ext>
            </a:extLst>
          </p:cNvPr>
          <p:cNvSpPr/>
          <p:nvPr userDrawn="1"/>
        </p:nvSpPr>
        <p:spPr>
          <a:xfrm>
            <a:off x="10199915" y="-25248"/>
            <a:ext cx="2002971" cy="1115452"/>
          </a:xfrm>
          <a:prstGeom prst="rect">
            <a:avLst/>
          </a:prstGeom>
          <a:solidFill>
            <a:srgbClr val="AA0065"/>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p>
        </p:txBody>
      </p:sp>
      <p:grpSp>
        <p:nvGrpSpPr>
          <p:cNvPr id="34" name="Group 33">
            <a:extLst>
              <a:ext uri="{FF2B5EF4-FFF2-40B4-BE49-F238E27FC236}">
                <a16:creationId xmlns:a16="http://schemas.microsoft.com/office/drawing/2014/main" id="{49043F73-8834-4114-AD27-24C1BD0B05A6}"/>
              </a:ext>
            </a:extLst>
          </p:cNvPr>
          <p:cNvGrpSpPr/>
          <p:nvPr userDrawn="1"/>
        </p:nvGrpSpPr>
        <p:grpSpPr>
          <a:xfrm>
            <a:off x="10273494" y="138710"/>
            <a:ext cx="1935480" cy="780217"/>
            <a:chOff x="10212534" y="176810"/>
            <a:chExt cx="1935480" cy="780217"/>
          </a:xfrm>
        </p:grpSpPr>
        <p:sp>
          <p:nvSpPr>
            <p:cNvPr id="19" name="TextBox 18"/>
            <p:cNvSpPr txBox="1"/>
            <p:nvPr/>
          </p:nvSpPr>
          <p:spPr>
            <a:xfrm>
              <a:off x="10618401" y="433807"/>
              <a:ext cx="1441475" cy="523220"/>
            </a:xfrm>
            <a:prstGeom prst="rect">
              <a:avLst/>
            </a:prstGeom>
            <a:noFill/>
          </p:spPr>
          <p:txBody>
            <a:bodyPr wrap="square" rtlCol="0">
              <a:spAutoFit/>
            </a:bodyPr>
            <a:lstStyle/>
            <a:p>
              <a:r>
                <a:rPr lang="en-GB" sz="2800" dirty="0">
                  <a:solidFill>
                    <a:schemeClr val="bg1"/>
                  </a:solidFill>
                </a:rPr>
                <a:t>Review</a:t>
              </a:r>
            </a:p>
          </p:txBody>
        </p:sp>
        <p:sp>
          <p:nvSpPr>
            <p:cNvPr id="18" name="TextBox 17"/>
            <p:cNvSpPr txBox="1"/>
            <p:nvPr/>
          </p:nvSpPr>
          <p:spPr>
            <a:xfrm>
              <a:off x="10212534" y="176810"/>
              <a:ext cx="1935480" cy="523220"/>
            </a:xfrm>
            <a:prstGeom prst="rect">
              <a:avLst/>
            </a:prstGeom>
            <a:noFill/>
          </p:spPr>
          <p:txBody>
            <a:bodyPr wrap="square" rtlCol="0">
              <a:spAutoFit/>
            </a:bodyPr>
            <a:lstStyle/>
            <a:p>
              <a:r>
                <a:rPr lang="en-GB" sz="2800" dirty="0">
                  <a:solidFill>
                    <a:schemeClr val="bg1"/>
                  </a:solidFill>
                </a:rPr>
                <a:t>Educational</a:t>
              </a:r>
            </a:p>
          </p:txBody>
        </p:sp>
      </p:grpSp>
      <p:sp>
        <p:nvSpPr>
          <p:cNvPr id="29" name="Flowchart: Stored Data 4">
            <a:extLst>
              <a:ext uri="{FF2B5EF4-FFF2-40B4-BE49-F238E27FC236}">
                <a16:creationId xmlns:a16="http://schemas.microsoft.com/office/drawing/2014/main" id="{17034CCF-1EDD-D498-AB89-09358AFA3492}"/>
              </a:ext>
            </a:extLst>
          </p:cNvPr>
          <p:cNvSpPr/>
          <p:nvPr userDrawn="1"/>
        </p:nvSpPr>
        <p:spPr>
          <a:xfrm rot="16200000" flipV="1">
            <a:off x="2895934" y="2279828"/>
            <a:ext cx="1695595" cy="7491425"/>
          </a:xfrm>
          <a:custGeom>
            <a:avLst/>
            <a:gdLst>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89795 h 103750"/>
              <a:gd name="connsiteX1" fmla="*/ 8293 w 10000"/>
              <a:gd name="connsiteY1" fmla="*/ 0 h 103750"/>
              <a:gd name="connsiteX2" fmla="*/ 8333 w 10000"/>
              <a:gd name="connsiteY2" fmla="*/ 94795 h 103750"/>
              <a:gd name="connsiteX3" fmla="*/ 10000 w 10000"/>
              <a:gd name="connsiteY3" fmla="*/ 99795 h 103750"/>
              <a:gd name="connsiteX4" fmla="*/ 1667 w 10000"/>
              <a:gd name="connsiteY4" fmla="*/ 99795 h 103750"/>
              <a:gd name="connsiteX5" fmla="*/ 0 w 10000"/>
              <a:gd name="connsiteY5" fmla="*/ 94795 h 103750"/>
              <a:gd name="connsiteX6" fmla="*/ 1667 w 10000"/>
              <a:gd name="connsiteY6" fmla="*/ 89795 h 10375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5639 w 10161"/>
              <a:gd name="connsiteY0" fmla="*/ 18392 h 112308"/>
              <a:gd name="connsiteX1" fmla="*/ 8672 w 10161"/>
              <a:gd name="connsiteY1" fmla="*/ 5059 h 112308"/>
              <a:gd name="connsiteX2" fmla="*/ 8494 w 10161"/>
              <a:gd name="connsiteY2" fmla="*/ 103121 h 112308"/>
              <a:gd name="connsiteX3" fmla="*/ 10161 w 10161"/>
              <a:gd name="connsiteY3" fmla="*/ 108121 h 112308"/>
              <a:gd name="connsiteX4" fmla="*/ 1828 w 10161"/>
              <a:gd name="connsiteY4" fmla="*/ 108121 h 112308"/>
              <a:gd name="connsiteX5" fmla="*/ 161 w 10161"/>
              <a:gd name="connsiteY5" fmla="*/ 103121 h 112308"/>
              <a:gd name="connsiteX6" fmla="*/ 5639 w 10161"/>
              <a:gd name="connsiteY6" fmla="*/ 18392 h 112308"/>
              <a:gd name="connsiteX0" fmla="*/ 5639 w 10161"/>
              <a:gd name="connsiteY0" fmla="*/ 48998 h 145481"/>
              <a:gd name="connsiteX1" fmla="*/ 8354 w 10161"/>
              <a:gd name="connsiteY1" fmla="*/ 0 h 145481"/>
              <a:gd name="connsiteX2" fmla="*/ 8494 w 10161"/>
              <a:gd name="connsiteY2" fmla="*/ 133727 h 145481"/>
              <a:gd name="connsiteX3" fmla="*/ 10161 w 10161"/>
              <a:gd name="connsiteY3" fmla="*/ 138727 h 145481"/>
              <a:gd name="connsiteX4" fmla="*/ 1828 w 10161"/>
              <a:gd name="connsiteY4" fmla="*/ 138727 h 145481"/>
              <a:gd name="connsiteX5" fmla="*/ 161 w 10161"/>
              <a:gd name="connsiteY5" fmla="*/ 133727 h 145481"/>
              <a:gd name="connsiteX6" fmla="*/ 5639 w 10161"/>
              <a:gd name="connsiteY6" fmla="*/ 48998 h 145481"/>
              <a:gd name="connsiteX0" fmla="*/ 4738 w 10113"/>
              <a:gd name="connsiteY0" fmla="*/ 13812 h 159292"/>
              <a:gd name="connsiteX1" fmla="*/ 8306 w 10113"/>
              <a:gd name="connsiteY1" fmla="*/ 13811 h 159292"/>
              <a:gd name="connsiteX2" fmla="*/ 8446 w 10113"/>
              <a:gd name="connsiteY2" fmla="*/ 147538 h 159292"/>
              <a:gd name="connsiteX3" fmla="*/ 10113 w 10113"/>
              <a:gd name="connsiteY3" fmla="*/ 152538 h 159292"/>
              <a:gd name="connsiteX4" fmla="*/ 1780 w 10113"/>
              <a:gd name="connsiteY4" fmla="*/ 152538 h 159292"/>
              <a:gd name="connsiteX5" fmla="*/ 113 w 10113"/>
              <a:gd name="connsiteY5" fmla="*/ 147538 h 159292"/>
              <a:gd name="connsiteX6" fmla="*/ 4738 w 10113"/>
              <a:gd name="connsiteY6" fmla="*/ 13812 h 159292"/>
              <a:gd name="connsiteX0" fmla="*/ 4738 w 10113"/>
              <a:gd name="connsiteY0" fmla="*/ 2870 h 148350"/>
              <a:gd name="connsiteX1" fmla="*/ 8306 w 10113"/>
              <a:gd name="connsiteY1" fmla="*/ 2869 h 148350"/>
              <a:gd name="connsiteX2" fmla="*/ 8446 w 10113"/>
              <a:gd name="connsiteY2" fmla="*/ 136596 h 148350"/>
              <a:gd name="connsiteX3" fmla="*/ 10113 w 10113"/>
              <a:gd name="connsiteY3" fmla="*/ 141596 h 148350"/>
              <a:gd name="connsiteX4" fmla="*/ 1780 w 10113"/>
              <a:gd name="connsiteY4" fmla="*/ 141596 h 148350"/>
              <a:gd name="connsiteX5" fmla="*/ 113 w 10113"/>
              <a:gd name="connsiteY5" fmla="*/ 136596 h 148350"/>
              <a:gd name="connsiteX6" fmla="*/ 4738 w 10113"/>
              <a:gd name="connsiteY6" fmla="*/ 2870 h 148350"/>
              <a:gd name="connsiteX0" fmla="*/ 4738 w 10113"/>
              <a:gd name="connsiteY0" fmla="*/ 51 h 145531"/>
              <a:gd name="connsiteX1" fmla="*/ 8306 w 10113"/>
              <a:gd name="connsiteY1" fmla="*/ 50 h 145531"/>
              <a:gd name="connsiteX2" fmla="*/ 8446 w 10113"/>
              <a:gd name="connsiteY2" fmla="*/ 133777 h 145531"/>
              <a:gd name="connsiteX3" fmla="*/ 10113 w 10113"/>
              <a:gd name="connsiteY3" fmla="*/ 138777 h 145531"/>
              <a:gd name="connsiteX4" fmla="*/ 1780 w 10113"/>
              <a:gd name="connsiteY4" fmla="*/ 138777 h 145531"/>
              <a:gd name="connsiteX5" fmla="*/ 113 w 10113"/>
              <a:gd name="connsiteY5" fmla="*/ 133777 h 145531"/>
              <a:gd name="connsiteX6" fmla="*/ 4738 w 10113"/>
              <a:gd name="connsiteY6" fmla="*/ 51 h 145531"/>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674 w 10109"/>
              <a:gd name="connsiteY0" fmla="*/ 170 h 145517"/>
              <a:gd name="connsiteX1" fmla="*/ 8302 w 10109"/>
              <a:gd name="connsiteY1" fmla="*/ 36 h 145517"/>
              <a:gd name="connsiteX2" fmla="*/ 8442 w 10109"/>
              <a:gd name="connsiteY2" fmla="*/ 133763 h 145517"/>
              <a:gd name="connsiteX3" fmla="*/ 10109 w 10109"/>
              <a:gd name="connsiteY3" fmla="*/ 138763 h 145517"/>
              <a:gd name="connsiteX4" fmla="*/ 1776 w 10109"/>
              <a:gd name="connsiteY4" fmla="*/ 138763 h 145517"/>
              <a:gd name="connsiteX5" fmla="*/ 109 w 10109"/>
              <a:gd name="connsiteY5" fmla="*/ 133763 h 145517"/>
              <a:gd name="connsiteX6" fmla="*/ 4674 w 10109"/>
              <a:gd name="connsiteY6" fmla="*/ 170 h 145517"/>
              <a:gd name="connsiteX0" fmla="*/ 3080 w 8515"/>
              <a:gd name="connsiteY0" fmla="*/ 170 h 145517"/>
              <a:gd name="connsiteX1" fmla="*/ 6708 w 8515"/>
              <a:gd name="connsiteY1" fmla="*/ 36 h 145517"/>
              <a:gd name="connsiteX2" fmla="*/ 6848 w 8515"/>
              <a:gd name="connsiteY2" fmla="*/ 133763 h 145517"/>
              <a:gd name="connsiteX3" fmla="*/ 8515 w 8515"/>
              <a:gd name="connsiteY3" fmla="*/ 138763 h 145517"/>
              <a:gd name="connsiteX4" fmla="*/ 182 w 8515"/>
              <a:gd name="connsiteY4" fmla="*/ 138763 h 145517"/>
              <a:gd name="connsiteX5" fmla="*/ 3080 w 8515"/>
              <a:gd name="connsiteY5" fmla="*/ 170 h 145517"/>
              <a:gd name="connsiteX0" fmla="*/ 3617 w 10000"/>
              <a:gd name="connsiteY0" fmla="*/ 12 h 9536"/>
              <a:gd name="connsiteX1" fmla="*/ 7878 w 10000"/>
              <a:gd name="connsiteY1" fmla="*/ 2 h 9536"/>
              <a:gd name="connsiteX2" fmla="*/ 8042 w 10000"/>
              <a:gd name="connsiteY2" fmla="*/ 9192 h 9536"/>
              <a:gd name="connsiteX3" fmla="*/ 10000 w 10000"/>
              <a:gd name="connsiteY3" fmla="*/ 9536 h 9536"/>
              <a:gd name="connsiteX4" fmla="*/ 214 w 10000"/>
              <a:gd name="connsiteY4" fmla="*/ 9536 h 9536"/>
              <a:gd name="connsiteX5" fmla="*/ 3617 w 10000"/>
              <a:gd name="connsiteY5" fmla="*/ 12 h 9536"/>
              <a:gd name="connsiteX0" fmla="*/ 3403 w 9786"/>
              <a:gd name="connsiteY0" fmla="*/ 13 h 10000"/>
              <a:gd name="connsiteX1" fmla="*/ 7664 w 9786"/>
              <a:gd name="connsiteY1" fmla="*/ 2 h 10000"/>
              <a:gd name="connsiteX2" fmla="*/ 7828 w 9786"/>
              <a:gd name="connsiteY2" fmla="*/ 9639 h 10000"/>
              <a:gd name="connsiteX3" fmla="*/ 9786 w 9786"/>
              <a:gd name="connsiteY3" fmla="*/ 10000 h 10000"/>
              <a:gd name="connsiteX4" fmla="*/ 0 w 9786"/>
              <a:gd name="connsiteY4" fmla="*/ 10000 h 10000"/>
              <a:gd name="connsiteX5" fmla="*/ 3403 w 9786"/>
              <a:gd name="connsiteY5" fmla="*/ 13 h 10000"/>
              <a:gd name="connsiteX0" fmla="*/ 494 w 7017"/>
              <a:gd name="connsiteY0" fmla="*/ 743 h 10730"/>
              <a:gd name="connsiteX1" fmla="*/ 4849 w 7017"/>
              <a:gd name="connsiteY1" fmla="*/ 732 h 10730"/>
              <a:gd name="connsiteX2" fmla="*/ 5016 w 7017"/>
              <a:gd name="connsiteY2" fmla="*/ 10369 h 10730"/>
              <a:gd name="connsiteX3" fmla="*/ 7017 w 7017"/>
              <a:gd name="connsiteY3" fmla="*/ 10730 h 10730"/>
              <a:gd name="connsiteX4" fmla="*/ 45 w 7017"/>
              <a:gd name="connsiteY4" fmla="*/ 10709 h 10730"/>
              <a:gd name="connsiteX5" fmla="*/ 494 w 7017"/>
              <a:gd name="connsiteY5" fmla="*/ 743 h 10730"/>
              <a:gd name="connsiteX0" fmla="*/ 521 w 9817"/>
              <a:gd name="connsiteY0" fmla="*/ 692 h 10000"/>
              <a:gd name="connsiteX1" fmla="*/ 6727 w 9817"/>
              <a:gd name="connsiteY1" fmla="*/ 682 h 10000"/>
              <a:gd name="connsiteX2" fmla="*/ 6965 w 9817"/>
              <a:gd name="connsiteY2" fmla="*/ 9664 h 10000"/>
              <a:gd name="connsiteX3" fmla="*/ 9817 w 9817"/>
              <a:gd name="connsiteY3" fmla="*/ 10000 h 10000"/>
              <a:gd name="connsiteX4" fmla="*/ 273 w 9817"/>
              <a:gd name="connsiteY4" fmla="*/ 9980 h 10000"/>
              <a:gd name="connsiteX5" fmla="*/ 521 w 9817"/>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70 w 10039"/>
              <a:gd name="connsiteY0" fmla="*/ 695 h 10015"/>
              <a:gd name="connsiteX1" fmla="*/ 6891 w 10039"/>
              <a:gd name="connsiteY1" fmla="*/ 685 h 10015"/>
              <a:gd name="connsiteX2" fmla="*/ 7134 w 10039"/>
              <a:gd name="connsiteY2" fmla="*/ 9667 h 10015"/>
              <a:gd name="connsiteX3" fmla="*/ 10039 w 10039"/>
              <a:gd name="connsiteY3" fmla="*/ 10003 h 10015"/>
              <a:gd name="connsiteX4" fmla="*/ 217 w 10039"/>
              <a:gd name="connsiteY4" fmla="*/ 10015 h 10015"/>
              <a:gd name="connsiteX5" fmla="*/ 570 w 10039"/>
              <a:gd name="connsiteY5" fmla="*/ 695 h 10015"/>
              <a:gd name="connsiteX0" fmla="*/ 615 w 10084"/>
              <a:gd name="connsiteY0" fmla="*/ 695 h 10015"/>
              <a:gd name="connsiteX1" fmla="*/ 6936 w 10084"/>
              <a:gd name="connsiteY1" fmla="*/ 685 h 10015"/>
              <a:gd name="connsiteX2" fmla="*/ 7179 w 10084"/>
              <a:gd name="connsiteY2" fmla="*/ 9667 h 10015"/>
              <a:gd name="connsiteX3" fmla="*/ 10084 w 10084"/>
              <a:gd name="connsiteY3" fmla="*/ 10003 h 10015"/>
              <a:gd name="connsiteX4" fmla="*/ 262 w 10084"/>
              <a:gd name="connsiteY4" fmla="*/ 10015 h 10015"/>
              <a:gd name="connsiteX5" fmla="*/ 615 w 10084"/>
              <a:gd name="connsiteY5" fmla="*/ 695 h 10015"/>
              <a:gd name="connsiteX0" fmla="*/ 356 w 9825"/>
              <a:gd name="connsiteY0" fmla="*/ 695 h 10015"/>
              <a:gd name="connsiteX1" fmla="*/ 6677 w 9825"/>
              <a:gd name="connsiteY1" fmla="*/ 685 h 10015"/>
              <a:gd name="connsiteX2" fmla="*/ 6920 w 9825"/>
              <a:gd name="connsiteY2" fmla="*/ 9667 h 10015"/>
              <a:gd name="connsiteX3" fmla="*/ 9825 w 9825"/>
              <a:gd name="connsiteY3" fmla="*/ 10003 h 10015"/>
              <a:gd name="connsiteX4" fmla="*/ 3 w 9825"/>
              <a:gd name="connsiteY4" fmla="*/ 10015 h 10015"/>
              <a:gd name="connsiteX5" fmla="*/ 356 w 9825"/>
              <a:gd name="connsiteY5" fmla="*/ 695 h 10015"/>
              <a:gd name="connsiteX0" fmla="*/ 362 w 10000"/>
              <a:gd name="connsiteY0" fmla="*/ 10 h 9316"/>
              <a:gd name="connsiteX1" fmla="*/ 6796 w 10000"/>
              <a:gd name="connsiteY1" fmla="*/ 0 h 9316"/>
              <a:gd name="connsiteX2" fmla="*/ 7043 w 10000"/>
              <a:gd name="connsiteY2" fmla="*/ 8969 h 9316"/>
              <a:gd name="connsiteX3" fmla="*/ 10000 w 10000"/>
              <a:gd name="connsiteY3" fmla="*/ 9304 h 9316"/>
              <a:gd name="connsiteX4" fmla="*/ 3 w 10000"/>
              <a:gd name="connsiteY4" fmla="*/ 9316 h 9316"/>
              <a:gd name="connsiteX5" fmla="*/ 362 w 10000"/>
              <a:gd name="connsiteY5" fmla="*/ 10 h 9316"/>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0 w 9998"/>
              <a:gd name="connsiteY0" fmla="*/ 11 h 10000"/>
              <a:gd name="connsiteX1" fmla="*/ 7099 w 9998"/>
              <a:gd name="connsiteY1" fmla="*/ 0 h 10000"/>
              <a:gd name="connsiteX2" fmla="*/ 7041 w 9998"/>
              <a:gd name="connsiteY2" fmla="*/ 9628 h 10000"/>
              <a:gd name="connsiteX3" fmla="*/ 9998 w 9998"/>
              <a:gd name="connsiteY3" fmla="*/ 9987 h 10000"/>
              <a:gd name="connsiteX4" fmla="*/ 1 w 9998"/>
              <a:gd name="connsiteY4" fmla="*/ 10000 h 10000"/>
              <a:gd name="connsiteX5" fmla="*/ 360 w 9998"/>
              <a:gd name="connsiteY5" fmla="*/ 11 h 10000"/>
              <a:gd name="connsiteX0" fmla="*/ 0 w 9640"/>
              <a:gd name="connsiteY0" fmla="*/ 11 h 10000"/>
              <a:gd name="connsiteX1" fmla="*/ 6740 w 9640"/>
              <a:gd name="connsiteY1" fmla="*/ 0 h 10000"/>
              <a:gd name="connsiteX2" fmla="*/ 6682 w 9640"/>
              <a:gd name="connsiteY2" fmla="*/ 9628 h 10000"/>
              <a:gd name="connsiteX3" fmla="*/ 9640 w 9640"/>
              <a:gd name="connsiteY3" fmla="*/ 9987 h 10000"/>
              <a:gd name="connsiteX4" fmla="*/ 302 w 9640"/>
              <a:gd name="connsiteY4" fmla="*/ 10000 h 10000"/>
              <a:gd name="connsiteX5" fmla="*/ 0 w 964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9991"/>
              <a:gd name="connsiteX1" fmla="*/ 7048 w 10056"/>
              <a:gd name="connsiteY1" fmla="*/ 0 h 9991"/>
              <a:gd name="connsiteX2" fmla="*/ 6988 w 10056"/>
              <a:gd name="connsiteY2" fmla="*/ 9628 h 9991"/>
              <a:gd name="connsiteX3" fmla="*/ 10056 w 10056"/>
              <a:gd name="connsiteY3" fmla="*/ 9987 h 9991"/>
              <a:gd name="connsiteX4" fmla="*/ 129 w 10056"/>
              <a:gd name="connsiteY4" fmla="*/ 9991 h 9991"/>
              <a:gd name="connsiteX5" fmla="*/ 0 w 10056"/>
              <a:gd name="connsiteY5" fmla="*/ 4 h 9991"/>
              <a:gd name="connsiteX0" fmla="*/ 0 w 10000"/>
              <a:gd name="connsiteY0" fmla="*/ 0 h 9996"/>
              <a:gd name="connsiteX1" fmla="*/ 6799 w 10000"/>
              <a:gd name="connsiteY1" fmla="*/ 3842 h 9996"/>
              <a:gd name="connsiteX2" fmla="*/ 6949 w 10000"/>
              <a:gd name="connsiteY2" fmla="*/ 9633 h 9996"/>
              <a:gd name="connsiteX3" fmla="*/ 10000 w 10000"/>
              <a:gd name="connsiteY3" fmla="*/ 9992 h 9996"/>
              <a:gd name="connsiteX4" fmla="*/ 128 w 10000"/>
              <a:gd name="connsiteY4" fmla="*/ 9996 h 9996"/>
              <a:gd name="connsiteX5" fmla="*/ 0 w 10000"/>
              <a:gd name="connsiteY5" fmla="*/ 0 h 9996"/>
              <a:gd name="connsiteX0" fmla="*/ 0 w 9895"/>
              <a:gd name="connsiteY0" fmla="*/ 11 h 6156"/>
              <a:gd name="connsiteX1" fmla="*/ 6694 w 9895"/>
              <a:gd name="connsiteY1" fmla="*/ 0 h 6156"/>
              <a:gd name="connsiteX2" fmla="*/ 6844 w 9895"/>
              <a:gd name="connsiteY2" fmla="*/ 5793 h 6156"/>
              <a:gd name="connsiteX3" fmla="*/ 9895 w 9895"/>
              <a:gd name="connsiteY3" fmla="*/ 6152 h 6156"/>
              <a:gd name="connsiteX4" fmla="*/ 23 w 9895"/>
              <a:gd name="connsiteY4" fmla="*/ 6156 h 6156"/>
              <a:gd name="connsiteX5" fmla="*/ 0 w 9895"/>
              <a:gd name="connsiteY5" fmla="*/ 11 h 6156"/>
              <a:gd name="connsiteX0" fmla="*/ 0 w 11007"/>
              <a:gd name="connsiteY0" fmla="*/ 7 h 10000"/>
              <a:gd name="connsiteX1" fmla="*/ 7772 w 11007"/>
              <a:gd name="connsiteY1" fmla="*/ 0 h 10000"/>
              <a:gd name="connsiteX2" fmla="*/ 7924 w 11007"/>
              <a:gd name="connsiteY2" fmla="*/ 9410 h 10000"/>
              <a:gd name="connsiteX3" fmla="*/ 11007 w 11007"/>
              <a:gd name="connsiteY3" fmla="*/ 9994 h 10000"/>
              <a:gd name="connsiteX4" fmla="*/ 1030 w 11007"/>
              <a:gd name="connsiteY4" fmla="*/ 10000 h 10000"/>
              <a:gd name="connsiteX5" fmla="*/ 0 w 11007"/>
              <a:gd name="connsiteY5" fmla="*/ 7 h 10000"/>
              <a:gd name="connsiteX0" fmla="*/ 0 w 11007"/>
              <a:gd name="connsiteY0" fmla="*/ 7 h 10000"/>
              <a:gd name="connsiteX1" fmla="*/ 7772 w 11007"/>
              <a:gd name="connsiteY1" fmla="*/ 0 h 10000"/>
              <a:gd name="connsiteX2" fmla="*/ 7924 w 11007"/>
              <a:gd name="connsiteY2" fmla="*/ 9410 h 10000"/>
              <a:gd name="connsiteX3" fmla="*/ 11007 w 11007"/>
              <a:gd name="connsiteY3" fmla="*/ 9994 h 10000"/>
              <a:gd name="connsiteX4" fmla="*/ 23 w 11007"/>
              <a:gd name="connsiteY4" fmla="*/ 10000 h 10000"/>
              <a:gd name="connsiteX5" fmla="*/ 0 w 11007"/>
              <a:gd name="connsiteY5" fmla="*/ 7 h 10000"/>
              <a:gd name="connsiteX0" fmla="*/ 76 w 10988"/>
              <a:gd name="connsiteY0" fmla="*/ 45 h 10000"/>
              <a:gd name="connsiteX1" fmla="*/ 7753 w 10988"/>
              <a:gd name="connsiteY1" fmla="*/ 0 h 10000"/>
              <a:gd name="connsiteX2" fmla="*/ 7905 w 10988"/>
              <a:gd name="connsiteY2" fmla="*/ 9410 h 10000"/>
              <a:gd name="connsiteX3" fmla="*/ 10988 w 10988"/>
              <a:gd name="connsiteY3" fmla="*/ 9994 h 10000"/>
              <a:gd name="connsiteX4" fmla="*/ 4 w 10988"/>
              <a:gd name="connsiteY4" fmla="*/ 10000 h 10000"/>
              <a:gd name="connsiteX5" fmla="*/ 76 w 10988"/>
              <a:gd name="connsiteY5" fmla="*/ 45 h 10000"/>
              <a:gd name="connsiteX0" fmla="*/ 16 w 10988"/>
              <a:gd name="connsiteY0" fmla="*/ 20 h 10000"/>
              <a:gd name="connsiteX1" fmla="*/ 7753 w 10988"/>
              <a:gd name="connsiteY1" fmla="*/ 0 h 10000"/>
              <a:gd name="connsiteX2" fmla="*/ 7905 w 10988"/>
              <a:gd name="connsiteY2" fmla="*/ 9410 h 10000"/>
              <a:gd name="connsiteX3" fmla="*/ 10988 w 10988"/>
              <a:gd name="connsiteY3" fmla="*/ 9994 h 10000"/>
              <a:gd name="connsiteX4" fmla="*/ 4 w 10988"/>
              <a:gd name="connsiteY4" fmla="*/ 10000 h 10000"/>
              <a:gd name="connsiteX5" fmla="*/ 16 w 10988"/>
              <a:gd name="connsiteY5" fmla="*/ 20 h 10000"/>
              <a:gd name="connsiteX0" fmla="*/ 16 w 10988"/>
              <a:gd name="connsiteY0" fmla="*/ 0 h 9980"/>
              <a:gd name="connsiteX1" fmla="*/ 7753 w 10988"/>
              <a:gd name="connsiteY1" fmla="*/ 0 h 9980"/>
              <a:gd name="connsiteX2" fmla="*/ 7905 w 10988"/>
              <a:gd name="connsiteY2" fmla="*/ 9390 h 9980"/>
              <a:gd name="connsiteX3" fmla="*/ 10988 w 10988"/>
              <a:gd name="connsiteY3" fmla="*/ 9974 h 9980"/>
              <a:gd name="connsiteX4" fmla="*/ 4 w 10988"/>
              <a:gd name="connsiteY4" fmla="*/ 9980 h 9980"/>
              <a:gd name="connsiteX5" fmla="*/ 16 w 10988"/>
              <a:gd name="connsiteY5" fmla="*/ 0 h 9980"/>
              <a:gd name="connsiteX0" fmla="*/ 0 w 9985"/>
              <a:gd name="connsiteY0" fmla="*/ 0 h 9994"/>
              <a:gd name="connsiteX1" fmla="*/ 7041 w 9985"/>
              <a:gd name="connsiteY1" fmla="*/ 0 h 9994"/>
              <a:gd name="connsiteX2" fmla="*/ 7179 w 9985"/>
              <a:gd name="connsiteY2" fmla="*/ 9409 h 9994"/>
              <a:gd name="connsiteX3" fmla="*/ 9985 w 9985"/>
              <a:gd name="connsiteY3" fmla="*/ 9994 h 9994"/>
              <a:gd name="connsiteX4" fmla="*/ 11 w 9985"/>
              <a:gd name="connsiteY4" fmla="*/ 9987 h 9994"/>
              <a:gd name="connsiteX5" fmla="*/ 0 w 9985"/>
              <a:gd name="connsiteY5" fmla="*/ 0 h 9994"/>
              <a:gd name="connsiteX0" fmla="*/ 0 w 10000"/>
              <a:gd name="connsiteY0" fmla="*/ 0 h 10000"/>
              <a:gd name="connsiteX1" fmla="*/ 7052 w 10000"/>
              <a:gd name="connsiteY1" fmla="*/ 0 h 10000"/>
              <a:gd name="connsiteX2" fmla="*/ 7190 w 10000"/>
              <a:gd name="connsiteY2" fmla="*/ 9415 h 10000"/>
              <a:gd name="connsiteX3" fmla="*/ 10000 w 10000"/>
              <a:gd name="connsiteY3" fmla="*/ 10000 h 10000"/>
              <a:gd name="connsiteX4" fmla="*/ 11 w 10000"/>
              <a:gd name="connsiteY4" fmla="*/ 9996 h 10000"/>
              <a:gd name="connsiteX5" fmla="*/ 0 w 10000"/>
              <a:gd name="connsiteY5" fmla="*/ 0 h 10000"/>
              <a:gd name="connsiteX0" fmla="*/ 35 w 10035"/>
              <a:gd name="connsiteY0" fmla="*/ 0 h 10009"/>
              <a:gd name="connsiteX1" fmla="*/ 7087 w 10035"/>
              <a:gd name="connsiteY1" fmla="*/ 0 h 10009"/>
              <a:gd name="connsiteX2" fmla="*/ 7225 w 10035"/>
              <a:gd name="connsiteY2" fmla="*/ 9415 h 10009"/>
              <a:gd name="connsiteX3" fmla="*/ 10035 w 10035"/>
              <a:gd name="connsiteY3" fmla="*/ 10000 h 10009"/>
              <a:gd name="connsiteX4" fmla="*/ 3 w 10035"/>
              <a:gd name="connsiteY4" fmla="*/ 10009 h 10009"/>
              <a:gd name="connsiteX5" fmla="*/ 35 w 10035"/>
              <a:gd name="connsiteY5" fmla="*/ 0 h 10009"/>
              <a:gd name="connsiteX0" fmla="*/ 0 w 10000"/>
              <a:gd name="connsiteY0" fmla="*/ 0 h 10000"/>
              <a:gd name="connsiteX1" fmla="*/ 7052 w 10000"/>
              <a:gd name="connsiteY1" fmla="*/ 0 h 10000"/>
              <a:gd name="connsiteX2" fmla="*/ 7190 w 10000"/>
              <a:gd name="connsiteY2" fmla="*/ 9415 h 10000"/>
              <a:gd name="connsiteX3" fmla="*/ 10000 w 10000"/>
              <a:gd name="connsiteY3" fmla="*/ 10000 h 10000"/>
              <a:gd name="connsiteX4" fmla="*/ 66 w 10000"/>
              <a:gd name="connsiteY4" fmla="*/ 9989 h 10000"/>
              <a:gd name="connsiteX5" fmla="*/ 0 w 10000"/>
              <a:gd name="connsiteY5" fmla="*/ 0 h 10000"/>
              <a:gd name="connsiteX0" fmla="*/ 0 w 10000"/>
              <a:gd name="connsiteY0" fmla="*/ 0 h 10002"/>
              <a:gd name="connsiteX1" fmla="*/ 7052 w 10000"/>
              <a:gd name="connsiteY1" fmla="*/ 0 h 10002"/>
              <a:gd name="connsiteX2" fmla="*/ 7190 w 10000"/>
              <a:gd name="connsiteY2" fmla="*/ 9415 h 10002"/>
              <a:gd name="connsiteX3" fmla="*/ 10000 w 10000"/>
              <a:gd name="connsiteY3" fmla="*/ 10000 h 10002"/>
              <a:gd name="connsiteX4" fmla="*/ 23 w 10000"/>
              <a:gd name="connsiteY4" fmla="*/ 10002 h 10002"/>
              <a:gd name="connsiteX5" fmla="*/ 0 w 10000"/>
              <a:gd name="connsiteY5" fmla="*/ 0 h 10002"/>
              <a:gd name="connsiteX0" fmla="*/ 164 w 10164"/>
              <a:gd name="connsiteY0" fmla="*/ 0 h 10000"/>
              <a:gd name="connsiteX1" fmla="*/ 7216 w 10164"/>
              <a:gd name="connsiteY1" fmla="*/ 0 h 10000"/>
              <a:gd name="connsiteX2" fmla="*/ 7354 w 10164"/>
              <a:gd name="connsiteY2" fmla="*/ 9415 h 10000"/>
              <a:gd name="connsiteX3" fmla="*/ 10164 w 10164"/>
              <a:gd name="connsiteY3" fmla="*/ 10000 h 10000"/>
              <a:gd name="connsiteX4" fmla="*/ 2 w 10164"/>
              <a:gd name="connsiteY4" fmla="*/ 9999 h 10000"/>
              <a:gd name="connsiteX5" fmla="*/ 164 w 10164"/>
              <a:gd name="connsiteY5" fmla="*/ 0 h 10000"/>
              <a:gd name="connsiteX0" fmla="*/ 163 w 10163"/>
              <a:gd name="connsiteY0" fmla="*/ 0 h 10000"/>
              <a:gd name="connsiteX1" fmla="*/ 7215 w 10163"/>
              <a:gd name="connsiteY1" fmla="*/ 0 h 10000"/>
              <a:gd name="connsiteX2" fmla="*/ 7353 w 10163"/>
              <a:gd name="connsiteY2" fmla="*/ 9415 h 10000"/>
              <a:gd name="connsiteX3" fmla="*/ 10163 w 10163"/>
              <a:gd name="connsiteY3" fmla="*/ 10000 h 10000"/>
              <a:gd name="connsiteX4" fmla="*/ 1 w 10163"/>
              <a:gd name="connsiteY4" fmla="*/ 9999 h 10000"/>
              <a:gd name="connsiteX5" fmla="*/ 163 w 10163"/>
              <a:gd name="connsiteY5" fmla="*/ 0 h 10000"/>
              <a:gd name="connsiteX0" fmla="*/ 0 w 10174"/>
              <a:gd name="connsiteY0" fmla="*/ 0 h 10000"/>
              <a:gd name="connsiteX1" fmla="*/ 7226 w 10174"/>
              <a:gd name="connsiteY1" fmla="*/ 0 h 10000"/>
              <a:gd name="connsiteX2" fmla="*/ 7364 w 10174"/>
              <a:gd name="connsiteY2" fmla="*/ 9415 h 10000"/>
              <a:gd name="connsiteX3" fmla="*/ 10174 w 10174"/>
              <a:gd name="connsiteY3" fmla="*/ 10000 h 10000"/>
              <a:gd name="connsiteX4" fmla="*/ 12 w 10174"/>
              <a:gd name="connsiteY4" fmla="*/ 9999 h 10000"/>
              <a:gd name="connsiteX5" fmla="*/ 0 w 10174"/>
              <a:gd name="connsiteY5" fmla="*/ 0 h 10000"/>
              <a:gd name="connsiteX0" fmla="*/ 0 w 10174"/>
              <a:gd name="connsiteY0" fmla="*/ 0 h 10000"/>
              <a:gd name="connsiteX1" fmla="*/ 7226 w 10174"/>
              <a:gd name="connsiteY1" fmla="*/ 0 h 10000"/>
              <a:gd name="connsiteX2" fmla="*/ 7364 w 10174"/>
              <a:gd name="connsiteY2" fmla="*/ 9415 h 10000"/>
              <a:gd name="connsiteX3" fmla="*/ 10174 w 10174"/>
              <a:gd name="connsiteY3" fmla="*/ 10000 h 10000"/>
              <a:gd name="connsiteX4" fmla="*/ 12 w 10174"/>
              <a:gd name="connsiteY4" fmla="*/ 9999 h 10000"/>
              <a:gd name="connsiteX5" fmla="*/ 0 w 10174"/>
              <a:gd name="connsiteY5" fmla="*/ 0 h 10000"/>
              <a:gd name="connsiteX0" fmla="*/ 0 w 10174"/>
              <a:gd name="connsiteY0" fmla="*/ 3 h 10003"/>
              <a:gd name="connsiteX1" fmla="*/ 7335 w 10174"/>
              <a:gd name="connsiteY1" fmla="*/ 0 h 10003"/>
              <a:gd name="connsiteX2" fmla="*/ 7364 w 10174"/>
              <a:gd name="connsiteY2" fmla="*/ 9418 h 10003"/>
              <a:gd name="connsiteX3" fmla="*/ 10174 w 10174"/>
              <a:gd name="connsiteY3" fmla="*/ 10003 h 10003"/>
              <a:gd name="connsiteX4" fmla="*/ 12 w 10174"/>
              <a:gd name="connsiteY4" fmla="*/ 10002 h 10003"/>
              <a:gd name="connsiteX5" fmla="*/ 0 w 10174"/>
              <a:gd name="connsiteY5" fmla="*/ 3 h 10003"/>
              <a:gd name="connsiteX0" fmla="*/ 0 w 10174"/>
              <a:gd name="connsiteY0" fmla="*/ 6 h 10006"/>
              <a:gd name="connsiteX1" fmla="*/ 7346 w 10174"/>
              <a:gd name="connsiteY1" fmla="*/ 0 h 10006"/>
              <a:gd name="connsiteX2" fmla="*/ 7364 w 10174"/>
              <a:gd name="connsiteY2" fmla="*/ 9421 h 10006"/>
              <a:gd name="connsiteX3" fmla="*/ 10174 w 10174"/>
              <a:gd name="connsiteY3" fmla="*/ 10006 h 10006"/>
              <a:gd name="connsiteX4" fmla="*/ 12 w 10174"/>
              <a:gd name="connsiteY4" fmla="*/ 10005 h 10006"/>
              <a:gd name="connsiteX5" fmla="*/ 0 w 10174"/>
              <a:gd name="connsiteY5" fmla="*/ 6 h 10006"/>
              <a:gd name="connsiteX0" fmla="*/ 0 w 10174"/>
              <a:gd name="connsiteY0" fmla="*/ 6 h 10006"/>
              <a:gd name="connsiteX1" fmla="*/ 7346 w 10174"/>
              <a:gd name="connsiteY1" fmla="*/ 0 h 10006"/>
              <a:gd name="connsiteX2" fmla="*/ 7364 w 10174"/>
              <a:gd name="connsiteY2" fmla="*/ 9421 h 10006"/>
              <a:gd name="connsiteX3" fmla="*/ 10174 w 10174"/>
              <a:gd name="connsiteY3" fmla="*/ 10006 h 10006"/>
              <a:gd name="connsiteX4" fmla="*/ 12 w 10174"/>
              <a:gd name="connsiteY4" fmla="*/ 10005 h 10006"/>
              <a:gd name="connsiteX5" fmla="*/ 0 w 10174"/>
              <a:gd name="connsiteY5" fmla="*/ 6 h 10006"/>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0 w 9613"/>
              <a:gd name="connsiteY0" fmla="*/ 3 h 10009"/>
              <a:gd name="connsiteX1" fmla="*/ 6785 w 9613"/>
              <a:gd name="connsiteY1" fmla="*/ 0 h 10009"/>
              <a:gd name="connsiteX2" fmla="*/ 6803 w 9613"/>
              <a:gd name="connsiteY2" fmla="*/ 9424 h 10009"/>
              <a:gd name="connsiteX3" fmla="*/ 9613 w 9613"/>
              <a:gd name="connsiteY3" fmla="*/ 10009 h 10009"/>
              <a:gd name="connsiteX4" fmla="*/ 95 w 9613"/>
              <a:gd name="connsiteY4" fmla="*/ 9998 h 10009"/>
              <a:gd name="connsiteX5" fmla="*/ 0 w 9613"/>
              <a:gd name="connsiteY5" fmla="*/ 3 h 10009"/>
              <a:gd name="connsiteX0" fmla="*/ 0 w 10000"/>
              <a:gd name="connsiteY0" fmla="*/ 3 h 10000"/>
              <a:gd name="connsiteX1" fmla="*/ 7058 w 10000"/>
              <a:gd name="connsiteY1" fmla="*/ 0 h 10000"/>
              <a:gd name="connsiteX2" fmla="*/ 7077 w 10000"/>
              <a:gd name="connsiteY2" fmla="*/ 9416 h 10000"/>
              <a:gd name="connsiteX3" fmla="*/ 10000 w 10000"/>
              <a:gd name="connsiteY3" fmla="*/ 10000 h 10000"/>
              <a:gd name="connsiteX4" fmla="*/ 14 w 10000"/>
              <a:gd name="connsiteY4" fmla="*/ 9999 h 10000"/>
              <a:gd name="connsiteX5" fmla="*/ 0 w 10000"/>
              <a:gd name="connsiteY5" fmla="*/ 3 h 10000"/>
              <a:gd name="connsiteX0" fmla="*/ 0 w 10000"/>
              <a:gd name="connsiteY0" fmla="*/ 3 h 10000"/>
              <a:gd name="connsiteX1" fmla="*/ 7058 w 10000"/>
              <a:gd name="connsiteY1" fmla="*/ 0 h 10000"/>
              <a:gd name="connsiteX2" fmla="*/ 7077 w 10000"/>
              <a:gd name="connsiteY2" fmla="*/ 9416 h 10000"/>
              <a:gd name="connsiteX3" fmla="*/ 10000 w 10000"/>
              <a:gd name="connsiteY3" fmla="*/ 10000 h 10000"/>
              <a:gd name="connsiteX4" fmla="*/ 14 w 10000"/>
              <a:gd name="connsiteY4" fmla="*/ 9999 h 10000"/>
              <a:gd name="connsiteX5" fmla="*/ 0 w 10000"/>
              <a:gd name="connsiteY5" fmla="*/ 3 h 10000"/>
              <a:gd name="connsiteX0" fmla="*/ 18 w 10018"/>
              <a:gd name="connsiteY0" fmla="*/ 3 h 10000"/>
              <a:gd name="connsiteX1" fmla="*/ 7076 w 10018"/>
              <a:gd name="connsiteY1" fmla="*/ 0 h 10000"/>
              <a:gd name="connsiteX2" fmla="*/ 7095 w 10018"/>
              <a:gd name="connsiteY2" fmla="*/ 9416 h 10000"/>
              <a:gd name="connsiteX3" fmla="*/ 10018 w 10018"/>
              <a:gd name="connsiteY3" fmla="*/ 10000 h 10000"/>
              <a:gd name="connsiteX4" fmla="*/ 32 w 10018"/>
              <a:gd name="connsiteY4" fmla="*/ 9999 h 10000"/>
              <a:gd name="connsiteX5" fmla="*/ 18 w 10018"/>
              <a:gd name="connsiteY5" fmla="*/ 3 h 10000"/>
              <a:gd name="connsiteX0" fmla="*/ 0 w 10065"/>
              <a:gd name="connsiteY0" fmla="*/ 3 h 10000"/>
              <a:gd name="connsiteX1" fmla="*/ 7123 w 10065"/>
              <a:gd name="connsiteY1" fmla="*/ 0 h 10000"/>
              <a:gd name="connsiteX2" fmla="*/ 7142 w 10065"/>
              <a:gd name="connsiteY2" fmla="*/ 9416 h 10000"/>
              <a:gd name="connsiteX3" fmla="*/ 10065 w 10065"/>
              <a:gd name="connsiteY3" fmla="*/ 10000 h 10000"/>
              <a:gd name="connsiteX4" fmla="*/ 79 w 10065"/>
              <a:gd name="connsiteY4" fmla="*/ 9999 h 10000"/>
              <a:gd name="connsiteX5" fmla="*/ 0 w 10065"/>
              <a:gd name="connsiteY5" fmla="*/ 3 h 10000"/>
              <a:gd name="connsiteX0" fmla="*/ 0 w 10065"/>
              <a:gd name="connsiteY0" fmla="*/ 3 h 10000"/>
              <a:gd name="connsiteX1" fmla="*/ 7123 w 10065"/>
              <a:gd name="connsiteY1" fmla="*/ 0 h 10000"/>
              <a:gd name="connsiteX2" fmla="*/ 7142 w 10065"/>
              <a:gd name="connsiteY2" fmla="*/ 9416 h 10000"/>
              <a:gd name="connsiteX3" fmla="*/ 10065 w 10065"/>
              <a:gd name="connsiteY3" fmla="*/ 10000 h 10000"/>
              <a:gd name="connsiteX4" fmla="*/ 79 w 10065"/>
              <a:gd name="connsiteY4" fmla="*/ 9999 h 10000"/>
              <a:gd name="connsiteX5" fmla="*/ 0 w 10065"/>
              <a:gd name="connsiteY5" fmla="*/ 3 h 1000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0065" h="10000">
                <a:moveTo>
                  <a:pt x="0" y="3"/>
                </a:moveTo>
                <a:lnTo>
                  <a:pt x="7123" y="0"/>
                </a:lnTo>
                <a:cubicBezTo>
                  <a:pt x="7114" y="2528"/>
                  <a:pt x="7133" y="8825"/>
                  <a:pt x="7142" y="9416"/>
                </a:cubicBezTo>
                <a:cubicBezTo>
                  <a:pt x="7117" y="9743"/>
                  <a:pt x="8449" y="10000"/>
                  <a:pt x="10065" y="10000"/>
                </a:cubicBezTo>
                <a:lnTo>
                  <a:pt x="79" y="9999"/>
                </a:lnTo>
                <a:cubicBezTo>
                  <a:pt x="7" y="7401"/>
                  <a:pt x="15" y="1749"/>
                  <a:pt x="0" y="3"/>
                </a:cubicBezTo>
                <a:close/>
              </a:path>
            </a:pathLst>
          </a:custGeom>
          <a:solidFill>
            <a:srgbClr val="65AA00"/>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sz="1050"/>
          </a:p>
        </p:txBody>
      </p:sp>
    </p:spTree>
    <p:extLst>
      <p:ext uri="{BB962C8B-B14F-4D97-AF65-F5344CB8AC3E}">
        <p14:creationId xmlns:p14="http://schemas.microsoft.com/office/powerpoint/2010/main" val="175225253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preserve="1" userDrawn="1">
  <p:cSld name="Systematic Review / Meta-analysis">
    <p:spTree>
      <p:nvGrpSpPr>
        <p:cNvPr id="1" name=""/>
        <p:cNvGrpSpPr/>
        <p:nvPr/>
      </p:nvGrpSpPr>
      <p:grpSpPr>
        <a:xfrm>
          <a:off x="0" y="0"/>
          <a:ext cx="0" cy="0"/>
          <a:chOff x="0" y="0"/>
          <a:chExt cx="0" cy="0"/>
        </a:xfrm>
      </p:grpSpPr>
      <p:sp>
        <p:nvSpPr>
          <p:cNvPr id="16" name="Flowchart: Stored Data 4">
            <a:extLst>
              <a:ext uri="{FF2B5EF4-FFF2-40B4-BE49-F238E27FC236}">
                <a16:creationId xmlns:a16="http://schemas.microsoft.com/office/drawing/2014/main" id="{6750A1AE-34CF-C798-885B-4AD2785F8297}"/>
              </a:ext>
            </a:extLst>
          </p:cNvPr>
          <p:cNvSpPr/>
          <p:nvPr userDrawn="1"/>
        </p:nvSpPr>
        <p:spPr>
          <a:xfrm rot="5400000">
            <a:off x="5284491" y="-4795876"/>
            <a:ext cx="1614236" cy="12214771"/>
          </a:xfrm>
          <a:custGeom>
            <a:avLst/>
            <a:gdLst>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89795 h 103750"/>
              <a:gd name="connsiteX1" fmla="*/ 8293 w 10000"/>
              <a:gd name="connsiteY1" fmla="*/ 0 h 103750"/>
              <a:gd name="connsiteX2" fmla="*/ 8333 w 10000"/>
              <a:gd name="connsiteY2" fmla="*/ 94795 h 103750"/>
              <a:gd name="connsiteX3" fmla="*/ 10000 w 10000"/>
              <a:gd name="connsiteY3" fmla="*/ 99795 h 103750"/>
              <a:gd name="connsiteX4" fmla="*/ 1667 w 10000"/>
              <a:gd name="connsiteY4" fmla="*/ 99795 h 103750"/>
              <a:gd name="connsiteX5" fmla="*/ 0 w 10000"/>
              <a:gd name="connsiteY5" fmla="*/ 94795 h 103750"/>
              <a:gd name="connsiteX6" fmla="*/ 1667 w 10000"/>
              <a:gd name="connsiteY6" fmla="*/ 89795 h 10375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5639 w 10161"/>
              <a:gd name="connsiteY0" fmla="*/ 18392 h 112308"/>
              <a:gd name="connsiteX1" fmla="*/ 8672 w 10161"/>
              <a:gd name="connsiteY1" fmla="*/ 5059 h 112308"/>
              <a:gd name="connsiteX2" fmla="*/ 8494 w 10161"/>
              <a:gd name="connsiteY2" fmla="*/ 103121 h 112308"/>
              <a:gd name="connsiteX3" fmla="*/ 10161 w 10161"/>
              <a:gd name="connsiteY3" fmla="*/ 108121 h 112308"/>
              <a:gd name="connsiteX4" fmla="*/ 1828 w 10161"/>
              <a:gd name="connsiteY4" fmla="*/ 108121 h 112308"/>
              <a:gd name="connsiteX5" fmla="*/ 161 w 10161"/>
              <a:gd name="connsiteY5" fmla="*/ 103121 h 112308"/>
              <a:gd name="connsiteX6" fmla="*/ 5639 w 10161"/>
              <a:gd name="connsiteY6" fmla="*/ 18392 h 112308"/>
              <a:gd name="connsiteX0" fmla="*/ 5639 w 10161"/>
              <a:gd name="connsiteY0" fmla="*/ 48998 h 145481"/>
              <a:gd name="connsiteX1" fmla="*/ 8354 w 10161"/>
              <a:gd name="connsiteY1" fmla="*/ 0 h 145481"/>
              <a:gd name="connsiteX2" fmla="*/ 8494 w 10161"/>
              <a:gd name="connsiteY2" fmla="*/ 133727 h 145481"/>
              <a:gd name="connsiteX3" fmla="*/ 10161 w 10161"/>
              <a:gd name="connsiteY3" fmla="*/ 138727 h 145481"/>
              <a:gd name="connsiteX4" fmla="*/ 1828 w 10161"/>
              <a:gd name="connsiteY4" fmla="*/ 138727 h 145481"/>
              <a:gd name="connsiteX5" fmla="*/ 161 w 10161"/>
              <a:gd name="connsiteY5" fmla="*/ 133727 h 145481"/>
              <a:gd name="connsiteX6" fmla="*/ 5639 w 10161"/>
              <a:gd name="connsiteY6" fmla="*/ 48998 h 145481"/>
              <a:gd name="connsiteX0" fmla="*/ 4738 w 10113"/>
              <a:gd name="connsiteY0" fmla="*/ 13812 h 159292"/>
              <a:gd name="connsiteX1" fmla="*/ 8306 w 10113"/>
              <a:gd name="connsiteY1" fmla="*/ 13811 h 159292"/>
              <a:gd name="connsiteX2" fmla="*/ 8446 w 10113"/>
              <a:gd name="connsiteY2" fmla="*/ 147538 h 159292"/>
              <a:gd name="connsiteX3" fmla="*/ 10113 w 10113"/>
              <a:gd name="connsiteY3" fmla="*/ 152538 h 159292"/>
              <a:gd name="connsiteX4" fmla="*/ 1780 w 10113"/>
              <a:gd name="connsiteY4" fmla="*/ 152538 h 159292"/>
              <a:gd name="connsiteX5" fmla="*/ 113 w 10113"/>
              <a:gd name="connsiteY5" fmla="*/ 147538 h 159292"/>
              <a:gd name="connsiteX6" fmla="*/ 4738 w 10113"/>
              <a:gd name="connsiteY6" fmla="*/ 13812 h 159292"/>
              <a:gd name="connsiteX0" fmla="*/ 4738 w 10113"/>
              <a:gd name="connsiteY0" fmla="*/ 2870 h 148350"/>
              <a:gd name="connsiteX1" fmla="*/ 8306 w 10113"/>
              <a:gd name="connsiteY1" fmla="*/ 2869 h 148350"/>
              <a:gd name="connsiteX2" fmla="*/ 8446 w 10113"/>
              <a:gd name="connsiteY2" fmla="*/ 136596 h 148350"/>
              <a:gd name="connsiteX3" fmla="*/ 10113 w 10113"/>
              <a:gd name="connsiteY3" fmla="*/ 141596 h 148350"/>
              <a:gd name="connsiteX4" fmla="*/ 1780 w 10113"/>
              <a:gd name="connsiteY4" fmla="*/ 141596 h 148350"/>
              <a:gd name="connsiteX5" fmla="*/ 113 w 10113"/>
              <a:gd name="connsiteY5" fmla="*/ 136596 h 148350"/>
              <a:gd name="connsiteX6" fmla="*/ 4738 w 10113"/>
              <a:gd name="connsiteY6" fmla="*/ 2870 h 148350"/>
              <a:gd name="connsiteX0" fmla="*/ 4738 w 10113"/>
              <a:gd name="connsiteY0" fmla="*/ 51 h 145531"/>
              <a:gd name="connsiteX1" fmla="*/ 8306 w 10113"/>
              <a:gd name="connsiteY1" fmla="*/ 50 h 145531"/>
              <a:gd name="connsiteX2" fmla="*/ 8446 w 10113"/>
              <a:gd name="connsiteY2" fmla="*/ 133777 h 145531"/>
              <a:gd name="connsiteX3" fmla="*/ 10113 w 10113"/>
              <a:gd name="connsiteY3" fmla="*/ 138777 h 145531"/>
              <a:gd name="connsiteX4" fmla="*/ 1780 w 10113"/>
              <a:gd name="connsiteY4" fmla="*/ 138777 h 145531"/>
              <a:gd name="connsiteX5" fmla="*/ 113 w 10113"/>
              <a:gd name="connsiteY5" fmla="*/ 133777 h 145531"/>
              <a:gd name="connsiteX6" fmla="*/ 4738 w 10113"/>
              <a:gd name="connsiteY6" fmla="*/ 51 h 145531"/>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674 w 10109"/>
              <a:gd name="connsiteY0" fmla="*/ 170 h 145517"/>
              <a:gd name="connsiteX1" fmla="*/ 8302 w 10109"/>
              <a:gd name="connsiteY1" fmla="*/ 36 h 145517"/>
              <a:gd name="connsiteX2" fmla="*/ 8442 w 10109"/>
              <a:gd name="connsiteY2" fmla="*/ 133763 h 145517"/>
              <a:gd name="connsiteX3" fmla="*/ 10109 w 10109"/>
              <a:gd name="connsiteY3" fmla="*/ 138763 h 145517"/>
              <a:gd name="connsiteX4" fmla="*/ 1776 w 10109"/>
              <a:gd name="connsiteY4" fmla="*/ 138763 h 145517"/>
              <a:gd name="connsiteX5" fmla="*/ 109 w 10109"/>
              <a:gd name="connsiteY5" fmla="*/ 133763 h 145517"/>
              <a:gd name="connsiteX6" fmla="*/ 4674 w 10109"/>
              <a:gd name="connsiteY6" fmla="*/ 170 h 145517"/>
              <a:gd name="connsiteX0" fmla="*/ 3080 w 8515"/>
              <a:gd name="connsiteY0" fmla="*/ 170 h 145517"/>
              <a:gd name="connsiteX1" fmla="*/ 6708 w 8515"/>
              <a:gd name="connsiteY1" fmla="*/ 36 h 145517"/>
              <a:gd name="connsiteX2" fmla="*/ 6848 w 8515"/>
              <a:gd name="connsiteY2" fmla="*/ 133763 h 145517"/>
              <a:gd name="connsiteX3" fmla="*/ 8515 w 8515"/>
              <a:gd name="connsiteY3" fmla="*/ 138763 h 145517"/>
              <a:gd name="connsiteX4" fmla="*/ 182 w 8515"/>
              <a:gd name="connsiteY4" fmla="*/ 138763 h 145517"/>
              <a:gd name="connsiteX5" fmla="*/ 3080 w 8515"/>
              <a:gd name="connsiteY5" fmla="*/ 170 h 145517"/>
              <a:gd name="connsiteX0" fmla="*/ 3617 w 10000"/>
              <a:gd name="connsiteY0" fmla="*/ 12 h 9536"/>
              <a:gd name="connsiteX1" fmla="*/ 7878 w 10000"/>
              <a:gd name="connsiteY1" fmla="*/ 2 h 9536"/>
              <a:gd name="connsiteX2" fmla="*/ 8042 w 10000"/>
              <a:gd name="connsiteY2" fmla="*/ 9192 h 9536"/>
              <a:gd name="connsiteX3" fmla="*/ 10000 w 10000"/>
              <a:gd name="connsiteY3" fmla="*/ 9536 h 9536"/>
              <a:gd name="connsiteX4" fmla="*/ 214 w 10000"/>
              <a:gd name="connsiteY4" fmla="*/ 9536 h 9536"/>
              <a:gd name="connsiteX5" fmla="*/ 3617 w 10000"/>
              <a:gd name="connsiteY5" fmla="*/ 12 h 9536"/>
              <a:gd name="connsiteX0" fmla="*/ 3403 w 9786"/>
              <a:gd name="connsiteY0" fmla="*/ 13 h 10000"/>
              <a:gd name="connsiteX1" fmla="*/ 7664 w 9786"/>
              <a:gd name="connsiteY1" fmla="*/ 2 h 10000"/>
              <a:gd name="connsiteX2" fmla="*/ 7828 w 9786"/>
              <a:gd name="connsiteY2" fmla="*/ 9639 h 10000"/>
              <a:gd name="connsiteX3" fmla="*/ 9786 w 9786"/>
              <a:gd name="connsiteY3" fmla="*/ 10000 h 10000"/>
              <a:gd name="connsiteX4" fmla="*/ 0 w 9786"/>
              <a:gd name="connsiteY4" fmla="*/ 10000 h 10000"/>
              <a:gd name="connsiteX5" fmla="*/ 3403 w 9786"/>
              <a:gd name="connsiteY5" fmla="*/ 13 h 10000"/>
              <a:gd name="connsiteX0" fmla="*/ 494 w 7017"/>
              <a:gd name="connsiteY0" fmla="*/ 743 h 10730"/>
              <a:gd name="connsiteX1" fmla="*/ 4849 w 7017"/>
              <a:gd name="connsiteY1" fmla="*/ 732 h 10730"/>
              <a:gd name="connsiteX2" fmla="*/ 5016 w 7017"/>
              <a:gd name="connsiteY2" fmla="*/ 10369 h 10730"/>
              <a:gd name="connsiteX3" fmla="*/ 7017 w 7017"/>
              <a:gd name="connsiteY3" fmla="*/ 10730 h 10730"/>
              <a:gd name="connsiteX4" fmla="*/ 45 w 7017"/>
              <a:gd name="connsiteY4" fmla="*/ 10709 h 10730"/>
              <a:gd name="connsiteX5" fmla="*/ 494 w 7017"/>
              <a:gd name="connsiteY5" fmla="*/ 743 h 10730"/>
              <a:gd name="connsiteX0" fmla="*/ 521 w 9817"/>
              <a:gd name="connsiteY0" fmla="*/ 692 h 10000"/>
              <a:gd name="connsiteX1" fmla="*/ 6727 w 9817"/>
              <a:gd name="connsiteY1" fmla="*/ 682 h 10000"/>
              <a:gd name="connsiteX2" fmla="*/ 6965 w 9817"/>
              <a:gd name="connsiteY2" fmla="*/ 9664 h 10000"/>
              <a:gd name="connsiteX3" fmla="*/ 9817 w 9817"/>
              <a:gd name="connsiteY3" fmla="*/ 10000 h 10000"/>
              <a:gd name="connsiteX4" fmla="*/ 273 w 9817"/>
              <a:gd name="connsiteY4" fmla="*/ 9980 h 10000"/>
              <a:gd name="connsiteX5" fmla="*/ 521 w 9817"/>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70 w 10039"/>
              <a:gd name="connsiteY0" fmla="*/ 695 h 10015"/>
              <a:gd name="connsiteX1" fmla="*/ 6891 w 10039"/>
              <a:gd name="connsiteY1" fmla="*/ 685 h 10015"/>
              <a:gd name="connsiteX2" fmla="*/ 7134 w 10039"/>
              <a:gd name="connsiteY2" fmla="*/ 9667 h 10015"/>
              <a:gd name="connsiteX3" fmla="*/ 10039 w 10039"/>
              <a:gd name="connsiteY3" fmla="*/ 10003 h 10015"/>
              <a:gd name="connsiteX4" fmla="*/ 217 w 10039"/>
              <a:gd name="connsiteY4" fmla="*/ 10015 h 10015"/>
              <a:gd name="connsiteX5" fmla="*/ 570 w 10039"/>
              <a:gd name="connsiteY5" fmla="*/ 695 h 10015"/>
              <a:gd name="connsiteX0" fmla="*/ 615 w 10084"/>
              <a:gd name="connsiteY0" fmla="*/ 695 h 10015"/>
              <a:gd name="connsiteX1" fmla="*/ 6936 w 10084"/>
              <a:gd name="connsiteY1" fmla="*/ 685 h 10015"/>
              <a:gd name="connsiteX2" fmla="*/ 7179 w 10084"/>
              <a:gd name="connsiteY2" fmla="*/ 9667 h 10015"/>
              <a:gd name="connsiteX3" fmla="*/ 10084 w 10084"/>
              <a:gd name="connsiteY3" fmla="*/ 10003 h 10015"/>
              <a:gd name="connsiteX4" fmla="*/ 262 w 10084"/>
              <a:gd name="connsiteY4" fmla="*/ 10015 h 10015"/>
              <a:gd name="connsiteX5" fmla="*/ 615 w 10084"/>
              <a:gd name="connsiteY5" fmla="*/ 695 h 10015"/>
              <a:gd name="connsiteX0" fmla="*/ 356 w 9825"/>
              <a:gd name="connsiteY0" fmla="*/ 695 h 10015"/>
              <a:gd name="connsiteX1" fmla="*/ 6677 w 9825"/>
              <a:gd name="connsiteY1" fmla="*/ 685 h 10015"/>
              <a:gd name="connsiteX2" fmla="*/ 6920 w 9825"/>
              <a:gd name="connsiteY2" fmla="*/ 9667 h 10015"/>
              <a:gd name="connsiteX3" fmla="*/ 9825 w 9825"/>
              <a:gd name="connsiteY3" fmla="*/ 10003 h 10015"/>
              <a:gd name="connsiteX4" fmla="*/ 3 w 9825"/>
              <a:gd name="connsiteY4" fmla="*/ 10015 h 10015"/>
              <a:gd name="connsiteX5" fmla="*/ 356 w 9825"/>
              <a:gd name="connsiteY5" fmla="*/ 695 h 10015"/>
              <a:gd name="connsiteX0" fmla="*/ 362 w 10000"/>
              <a:gd name="connsiteY0" fmla="*/ 10 h 9316"/>
              <a:gd name="connsiteX1" fmla="*/ 6796 w 10000"/>
              <a:gd name="connsiteY1" fmla="*/ 0 h 9316"/>
              <a:gd name="connsiteX2" fmla="*/ 7043 w 10000"/>
              <a:gd name="connsiteY2" fmla="*/ 8969 h 9316"/>
              <a:gd name="connsiteX3" fmla="*/ 10000 w 10000"/>
              <a:gd name="connsiteY3" fmla="*/ 9304 h 9316"/>
              <a:gd name="connsiteX4" fmla="*/ 3 w 10000"/>
              <a:gd name="connsiteY4" fmla="*/ 9316 h 9316"/>
              <a:gd name="connsiteX5" fmla="*/ 362 w 10000"/>
              <a:gd name="connsiteY5" fmla="*/ 10 h 9316"/>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0 w 9998"/>
              <a:gd name="connsiteY0" fmla="*/ 11 h 10000"/>
              <a:gd name="connsiteX1" fmla="*/ 7099 w 9998"/>
              <a:gd name="connsiteY1" fmla="*/ 0 h 10000"/>
              <a:gd name="connsiteX2" fmla="*/ 7041 w 9998"/>
              <a:gd name="connsiteY2" fmla="*/ 9628 h 10000"/>
              <a:gd name="connsiteX3" fmla="*/ 9998 w 9998"/>
              <a:gd name="connsiteY3" fmla="*/ 9987 h 10000"/>
              <a:gd name="connsiteX4" fmla="*/ 1 w 9998"/>
              <a:gd name="connsiteY4" fmla="*/ 10000 h 10000"/>
              <a:gd name="connsiteX5" fmla="*/ 360 w 9998"/>
              <a:gd name="connsiteY5" fmla="*/ 11 h 10000"/>
              <a:gd name="connsiteX0" fmla="*/ 0 w 9640"/>
              <a:gd name="connsiteY0" fmla="*/ 11 h 10000"/>
              <a:gd name="connsiteX1" fmla="*/ 6740 w 9640"/>
              <a:gd name="connsiteY1" fmla="*/ 0 h 10000"/>
              <a:gd name="connsiteX2" fmla="*/ 6682 w 9640"/>
              <a:gd name="connsiteY2" fmla="*/ 9628 h 10000"/>
              <a:gd name="connsiteX3" fmla="*/ 9640 w 9640"/>
              <a:gd name="connsiteY3" fmla="*/ 9987 h 10000"/>
              <a:gd name="connsiteX4" fmla="*/ 302 w 9640"/>
              <a:gd name="connsiteY4" fmla="*/ 10000 h 10000"/>
              <a:gd name="connsiteX5" fmla="*/ 0 w 964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9991"/>
              <a:gd name="connsiteX1" fmla="*/ 7048 w 10056"/>
              <a:gd name="connsiteY1" fmla="*/ 0 h 9991"/>
              <a:gd name="connsiteX2" fmla="*/ 6988 w 10056"/>
              <a:gd name="connsiteY2" fmla="*/ 9628 h 9991"/>
              <a:gd name="connsiteX3" fmla="*/ 10056 w 10056"/>
              <a:gd name="connsiteY3" fmla="*/ 9987 h 9991"/>
              <a:gd name="connsiteX4" fmla="*/ 129 w 10056"/>
              <a:gd name="connsiteY4" fmla="*/ 9991 h 9991"/>
              <a:gd name="connsiteX5" fmla="*/ 0 w 10056"/>
              <a:gd name="connsiteY5" fmla="*/ 4 h 9991"/>
              <a:gd name="connsiteX0" fmla="*/ 0 w 10000"/>
              <a:gd name="connsiteY0" fmla="*/ 4 h 9996"/>
              <a:gd name="connsiteX1" fmla="*/ 7009 w 10000"/>
              <a:gd name="connsiteY1" fmla="*/ 0 h 9996"/>
              <a:gd name="connsiteX2" fmla="*/ 6949 w 10000"/>
              <a:gd name="connsiteY2" fmla="*/ 9637 h 9996"/>
              <a:gd name="connsiteX3" fmla="*/ 10000 w 10000"/>
              <a:gd name="connsiteY3" fmla="*/ 9996 h 9996"/>
              <a:gd name="connsiteX4" fmla="*/ 128 w 10000"/>
              <a:gd name="connsiteY4" fmla="*/ 9992 h 9996"/>
              <a:gd name="connsiteX5" fmla="*/ 0 w 10000"/>
              <a:gd name="connsiteY5" fmla="*/ 4 h 9996"/>
              <a:gd name="connsiteX0" fmla="*/ 0 w 10000"/>
              <a:gd name="connsiteY0" fmla="*/ 4 h 10000"/>
              <a:gd name="connsiteX1" fmla="*/ 7009 w 10000"/>
              <a:gd name="connsiteY1" fmla="*/ 0 h 10000"/>
              <a:gd name="connsiteX2" fmla="*/ 6949 w 10000"/>
              <a:gd name="connsiteY2" fmla="*/ 9641 h 10000"/>
              <a:gd name="connsiteX3" fmla="*/ 10000 w 10000"/>
              <a:gd name="connsiteY3" fmla="*/ 10000 h 10000"/>
              <a:gd name="connsiteX4" fmla="*/ 128 w 10000"/>
              <a:gd name="connsiteY4" fmla="*/ 9996 h 10000"/>
              <a:gd name="connsiteX5" fmla="*/ 0 w 10000"/>
              <a:gd name="connsiteY5" fmla="*/ 4 h 10000"/>
              <a:gd name="connsiteX0" fmla="*/ 0 w 10000"/>
              <a:gd name="connsiteY0" fmla="*/ 4 h 10000"/>
              <a:gd name="connsiteX1" fmla="*/ 7009 w 10000"/>
              <a:gd name="connsiteY1" fmla="*/ 0 h 10000"/>
              <a:gd name="connsiteX2" fmla="*/ 6949 w 10000"/>
              <a:gd name="connsiteY2" fmla="*/ 9641 h 10000"/>
              <a:gd name="connsiteX3" fmla="*/ 10000 w 10000"/>
              <a:gd name="connsiteY3" fmla="*/ 10000 h 10000"/>
              <a:gd name="connsiteX4" fmla="*/ 128 w 10000"/>
              <a:gd name="connsiteY4" fmla="*/ 9996 h 10000"/>
              <a:gd name="connsiteX5" fmla="*/ 0 w 10000"/>
              <a:gd name="connsiteY5" fmla="*/ 4 h 10000"/>
              <a:gd name="connsiteX0" fmla="*/ 0 w 10000"/>
              <a:gd name="connsiteY0" fmla="*/ 4 h 10000"/>
              <a:gd name="connsiteX1" fmla="*/ 7009 w 10000"/>
              <a:gd name="connsiteY1" fmla="*/ 0 h 10000"/>
              <a:gd name="connsiteX2" fmla="*/ 6949 w 10000"/>
              <a:gd name="connsiteY2" fmla="*/ 9641 h 10000"/>
              <a:gd name="connsiteX3" fmla="*/ 10000 w 10000"/>
              <a:gd name="connsiteY3" fmla="*/ 10000 h 10000"/>
              <a:gd name="connsiteX4" fmla="*/ 128 w 10000"/>
              <a:gd name="connsiteY4" fmla="*/ 9996 h 10000"/>
              <a:gd name="connsiteX5" fmla="*/ 0 w 10000"/>
              <a:gd name="connsiteY5" fmla="*/ 4 h 10000"/>
              <a:gd name="connsiteX0" fmla="*/ 0 w 10000"/>
              <a:gd name="connsiteY0" fmla="*/ 4 h 10004"/>
              <a:gd name="connsiteX1" fmla="*/ 7009 w 10000"/>
              <a:gd name="connsiteY1" fmla="*/ 0 h 10004"/>
              <a:gd name="connsiteX2" fmla="*/ 6949 w 10000"/>
              <a:gd name="connsiteY2" fmla="*/ 9641 h 10004"/>
              <a:gd name="connsiteX3" fmla="*/ 10000 w 10000"/>
              <a:gd name="connsiteY3" fmla="*/ 10000 h 10004"/>
              <a:gd name="connsiteX4" fmla="*/ 128 w 10000"/>
              <a:gd name="connsiteY4" fmla="*/ 10004 h 10004"/>
              <a:gd name="connsiteX5" fmla="*/ 0 w 10000"/>
              <a:gd name="connsiteY5" fmla="*/ 4 h 10004"/>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0000" h="10004">
                <a:moveTo>
                  <a:pt x="0" y="4"/>
                </a:moveTo>
                <a:lnTo>
                  <a:pt x="7009" y="0"/>
                </a:lnTo>
                <a:cubicBezTo>
                  <a:pt x="6847" y="1556"/>
                  <a:pt x="6821" y="9283"/>
                  <a:pt x="6949" y="9641"/>
                </a:cubicBezTo>
                <a:cubicBezTo>
                  <a:pt x="6923" y="9843"/>
                  <a:pt x="8314" y="10000"/>
                  <a:pt x="10000" y="10000"/>
                </a:cubicBezTo>
                <a:lnTo>
                  <a:pt x="128" y="10004"/>
                </a:lnTo>
                <a:cubicBezTo>
                  <a:pt x="97" y="8408"/>
                  <a:pt x="98" y="1073"/>
                  <a:pt x="0" y="4"/>
                </a:cubicBezTo>
                <a:close/>
              </a:path>
            </a:pathLst>
          </a:custGeom>
          <a:solidFill>
            <a:srgbClr val="860050"/>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sz="1050" dirty="0"/>
          </a:p>
        </p:txBody>
      </p:sp>
      <p:sp>
        <p:nvSpPr>
          <p:cNvPr id="5" name="Flowchart: Stored Data 4">
            <a:extLst>
              <a:ext uri="{FF2B5EF4-FFF2-40B4-BE49-F238E27FC236}">
                <a16:creationId xmlns:a16="http://schemas.microsoft.com/office/drawing/2014/main" id="{D150C2D2-09E4-F78B-7FA6-F42DD5FA59F4}"/>
              </a:ext>
            </a:extLst>
          </p:cNvPr>
          <p:cNvSpPr/>
          <p:nvPr userDrawn="1"/>
        </p:nvSpPr>
        <p:spPr>
          <a:xfrm rot="5400000">
            <a:off x="5283465" y="-5325515"/>
            <a:ext cx="1614236" cy="12214770"/>
          </a:xfrm>
          <a:custGeom>
            <a:avLst/>
            <a:gdLst>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89795 h 103750"/>
              <a:gd name="connsiteX1" fmla="*/ 8293 w 10000"/>
              <a:gd name="connsiteY1" fmla="*/ 0 h 103750"/>
              <a:gd name="connsiteX2" fmla="*/ 8333 w 10000"/>
              <a:gd name="connsiteY2" fmla="*/ 94795 h 103750"/>
              <a:gd name="connsiteX3" fmla="*/ 10000 w 10000"/>
              <a:gd name="connsiteY3" fmla="*/ 99795 h 103750"/>
              <a:gd name="connsiteX4" fmla="*/ 1667 w 10000"/>
              <a:gd name="connsiteY4" fmla="*/ 99795 h 103750"/>
              <a:gd name="connsiteX5" fmla="*/ 0 w 10000"/>
              <a:gd name="connsiteY5" fmla="*/ 94795 h 103750"/>
              <a:gd name="connsiteX6" fmla="*/ 1667 w 10000"/>
              <a:gd name="connsiteY6" fmla="*/ 89795 h 10375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5639 w 10161"/>
              <a:gd name="connsiteY0" fmla="*/ 18392 h 112308"/>
              <a:gd name="connsiteX1" fmla="*/ 8672 w 10161"/>
              <a:gd name="connsiteY1" fmla="*/ 5059 h 112308"/>
              <a:gd name="connsiteX2" fmla="*/ 8494 w 10161"/>
              <a:gd name="connsiteY2" fmla="*/ 103121 h 112308"/>
              <a:gd name="connsiteX3" fmla="*/ 10161 w 10161"/>
              <a:gd name="connsiteY3" fmla="*/ 108121 h 112308"/>
              <a:gd name="connsiteX4" fmla="*/ 1828 w 10161"/>
              <a:gd name="connsiteY4" fmla="*/ 108121 h 112308"/>
              <a:gd name="connsiteX5" fmla="*/ 161 w 10161"/>
              <a:gd name="connsiteY5" fmla="*/ 103121 h 112308"/>
              <a:gd name="connsiteX6" fmla="*/ 5639 w 10161"/>
              <a:gd name="connsiteY6" fmla="*/ 18392 h 112308"/>
              <a:gd name="connsiteX0" fmla="*/ 5639 w 10161"/>
              <a:gd name="connsiteY0" fmla="*/ 48998 h 145481"/>
              <a:gd name="connsiteX1" fmla="*/ 8354 w 10161"/>
              <a:gd name="connsiteY1" fmla="*/ 0 h 145481"/>
              <a:gd name="connsiteX2" fmla="*/ 8494 w 10161"/>
              <a:gd name="connsiteY2" fmla="*/ 133727 h 145481"/>
              <a:gd name="connsiteX3" fmla="*/ 10161 w 10161"/>
              <a:gd name="connsiteY3" fmla="*/ 138727 h 145481"/>
              <a:gd name="connsiteX4" fmla="*/ 1828 w 10161"/>
              <a:gd name="connsiteY4" fmla="*/ 138727 h 145481"/>
              <a:gd name="connsiteX5" fmla="*/ 161 w 10161"/>
              <a:gd name="connsiteY5" fmla="*/ 133727 h 145481"/>
              <a:gd name="connsiteX6" fmla="*/ 5639 w 10161"/>
              <a:gd name="connsiteY6" fmla="*/ 48998 h 145481"/>
              <a:gd name="connsiteX0" fmla="*/ 4738 w 10113"/>
              <a:gd name="connsiteY0" fmla="*/ 13812 h 159292"/>
              <a:gd name="connsiteX1" fmla="*/ 8306 w 10113"/>
              <a:gd name="connsiteY1" fmla="*/ 13811 h 159292"/>
              <a:gd name="connsiteX2" fmla="*/ 8446 w 10113"/>
              <a:gd name="connsiteY2" fmla="*/ 147538 h 159292"/>
              <a:gd name="connsiteX3" fmla="*/ 10113 w 10113"/>
              <a:gd name="connsiteY3" fmla="*/ 152538 h 159292"/>
              <a:gd name="connsiteX4" fmla="*/ 1780 w 10113"/>
              <a:gd name="connsiteY4" fmla="*/ 152538 h 159292"/>
              <a:gd name="connsiteX5" fmla="*/ 113 w 10113"/>
              <a:gd name="connsiteY5" fmla="*/ 147538 h 159292"/>
              <a:gd name="connsiteX6" fmla="*/ 4738 w 10113"/>
              <a:gd name="connsiteY6" fmla="*/ 13812 h 159292"/>
              <a:gd name="connsiteX0" fmla="*/ 4738 w 10113"/>
              <a:gd name="connsiteY0" fmla="*/ 2870 h 148350"/>
              <a:gd name="connsiteX1" fmla="*/ 8306 w 10113"/>
              <a:gd name="connsiteY1" fmla="*/ 2869 h 148350"/>
              <a:gd name="connsiteX2" fmla="*/ 8446 w 10113"/>
              <a:gd name="connsiteY2" fmla="*/ 136596 h 148350"/>
              <a:gd name="connsiteX3" fmla="*/ 10113 w 10113"/>
              <a:gd name="connsiteY3" fmla="*/ 141596 h 148350"/>
              <a:gd name="connsiteX4" fmla="*/ 1780 w 10113"/>
              <a:gd name="connsiteY4" fmla="*/ 141596 h 148350"/>
              <a:gd name="connsiteX5" fmla="*/ 113 w 10113"/>
              <a:gd name="connsiteY5" fmla="*/ 136596 h 148350"/>
              <a:gd name="connsiteX6" fmla="*/ 4738 w 10113"/>
              <a:gd name="connsiteY6" fmla="*/ 2870 h 148350"/>
              <a:gd name="connsiteX0" fmla="*/ 4738 w 10113"/>
              <a:gd name="connsiteY0" fmla="*/ 51 h 145531"/>
              <a:gd name="connsiteX1" fmla="*/ 8306 w 10113"/>
              <a:gd name="connsiteY1" fmla="*/ 50 h 145531"/>
              <a:gd name="connsiteX2" fmla="*/ 8446 w 10113"/>
              <a:gd name="connsiteY2" fmla="*/ 133777 h 145531"/>
              <a:gd name="connsiteX3" fmla="*/ 10113 w 10113"/>
              <a:gd name="connsiteY3" fmla="*/ 138777 h 145531"/>
              <a:gd name="connsiteX4" fmla="*/ 1780 w 10113"/>
              <a:gd name="connsiteY4" fmla="*/ 138777 h 145531"/>
              <a:gd name="connsiteX5" fmla="*/ 113 w 10113"/>
              <a:gd name="connsiteY5" fmla="*/ 133777 h 145531"/>
              <a:gd name="connsiteX6" fmla="*/ 4738 w 10113"/>
              <a:gd name="connsiteY6" fmla="*/ 51 h 145531"/>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674 w 10109"/>
              <a:gd name="connsiteY0" fmla="*/ 170 h 145517"/>
              <a:gd name="connsiteX1" fmla="*/ 8302 w 10109"/>
              <a:gd name="connsiteY1" fmla="*/ 36 h 145517"/>
              <a:gd name="connsiteX2" fmla="*/ 8442 w 10109"/>
              <a:gd name="connsiteY2" fmla="*/ 133763 h 145517"/>
              <a:gd name="connsiteX3" fmla="*/ 10109 w 10109"/>
              <a:gd name="connsiteY3" fmla="*/ 138763 h 145517"/>
              <a:gd name="connsiteX4" fmla="*/ 1776 w 10109"/>
              <a:gd name="connsiteY4" fmla="*/ 138763 h 145517"/>
              <a:gd name="connsiteX5" fmla="*/ 109 w 10109"/>
              <a:gd name="connsiteY5" fmla="*/ 133763 h 145517"/>
              <a:gd name="connsiteX6" fmla="*/ 4674 w 10109"/>
              <a:gd name="connsiteY6" fmla="*/ 170 h 145517"/>
              <a:gd name="connsiteX0" fmla="*/ 3080 w 8515"/>
              <a:gd name="connsiteY0" fmla="*/ 170 h 145517"/>
              <a:gd name="connsiteX1" fmla="*/ 6708 w 8515"/>
              <a:gd name="connsiteY1" fmla="*/ 36 h 145517"/>
              <a:gd name="connsiteX2" fmla="*/ 6848 w 8515"/>
              <a:gd name="connsiteY2" fmla="*/ 133763 h 145517"/>
              <a:gd name="connsiteX3" fmla="*/ 8515 w 8515"/>
              <a:gd name="connsiteY3" fmla="*/ 138763 h 145517"/>
              <a:gd name="connsiteX4" fmla="*/ 182 w 8515"/>
              <a:gd name="connsiteY4" fmla="*/ 138763 h 145517"/>
              <a:gd name="connsiteX5" fmla="*/ 3080 w 8515"/>
              <a:gd name="connsiteY5" fmla="*/ 170 h 145517"/>
              <a:gd name="connsiteX0" fmla="*/ 3617 w 10000"/>
              <a:gd name="connsiteY0" fmla="*/ 12 h 9536"/>
              <a:gd name="connsiteX1" fmla="*/ 7878 w 10000"/>
              <a:gd name="connsiteY1" fmla="*/ 2 h 9536"/>
              <a:gd name="connsiteX2" fmla="*/ 8042 w 10000"/>
              <a:gd name="connsiteY2" fmla="*/ 9192 h 9536"/>
              <a:gd name="connsiteX3" fmla="*/ 10000 w 10000"/>
              <a:gd name="connsiteY3" fmla="*/ 9536 h 9536"/>
              <a:gd name="connsiteX4" fmla="*/ 214 w 10000"/>
              <a:gd name="connsiteY4" fmla="*/ 9536 h 9536"/>
              <a:gd name="connsiteX5" fmla="*/ 3617 w 10000"/>
              <a:gd name="connsiteY5" fmla="*/ 12 h 9536"/>
              <a:gd name="connsiteX0" fmla="*/ 3403 w 9786"/>
              <a:gd name="connsiteY0" fmla="*/ 13 h 10000"/>
              <a:gd name="connsiteX1" fmla="*/ 7664 w 9786"/>
              <a:gd name="connsiteY1" fmla="*/ 2 h 10000"/>
              <a:gd name="connsiteX2" fmla="*/ 7828 w 9786"/>
              <a:gd name="connsiteY2" fmla="*/ 9639 h 10000"/>
              <a:gd name="connsiteX3" fmla="*/ 9786 w 9786"/>
              <a:gd name="connsiteY3" fmla="*/ 10000 h 10000"/>
              <a:gd name="connsiteX4" fmla="*/ 0 w 9786"/>
              <a:gd name="connsiteY4" fmla="*/ 10000 h 10000"/>
              <a:gd name="connsiteX5" fmla="*/ 3403 w 9786"/>
              <a:gd name="connsiteY5" fmla="*/ 13 h 10000"/>
              <a:gd name="connsiteX0" fmla="*/ 494 w 7017"/>
              <a:gd name="connsiteY0" fmla="*/ 743 h 10730"/>
              <a:gd name="connsiteX1" fmla="*/ 4849 w 7017"/>
              <a:gd name="connsiteY1" fmla="*/ 732 h 10730"/>
              <a:gd name="connsiteX2" fmla="*/ 5016 w 7017"/>
              <a:gd name="connsiteY2" fmla="*/ 10369 h 10730"/>
              <a:gd name="connsiteX3" fmla="*/ 7017 w 7017"/>
              <a:gd name="connsiteY3" fmla="*/ 10730 h 10730"/>
              <a:gd name="connsiteX4" fmla="*/ 45 w 7017"/>
              <a:gd name="connsiteY4" fmla="*/ 10709 h 10730"/>
              <a:gd name="connsiteX5" fmla="*/ 494 w 7017"/>
              <a:gd name="connsiteY5" fmla="*/ 743 h 10730"/>
              <a:gd name="connsiteX0" fmla="*/ 521 w 9817"/>
              <a:gd name="connsiteY0" fmla="*/ 692 h 10000"/>
              <a:gd name="connsiteX1" fmla="*/ 6727 w 9817"/>
              <a:gd name="connsiteY1" fmla="*/ 682 h 10000"/>
              <a:gd name="connsiteX2" fmla="*/ 6965 w 9817"/>
              <a:gd name="connsiteY2" fmla="*/ 9664 h 10000"/>
              <a:gd name="connsiteX3" fmla="*/ 9817 w 9817"/>
              <a:gd name="connsiteY3" fmla="*/ 10000 h 10000"/>
              <a:gd name="connsiteX4" fmla="*/ 273 w 9817"/>
              <a:gd name="connsiteY4" fmla="*/ 9980 h 10000"/>
              <a:gd name="connsiteX5" fmla="*/ 521 w 9817"/>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70 w 10039"/>
              <a:gd name="connsiteY0" fmla="*/ 695 h 10015"/>
              <a:gd name="connsiteX1" fmla="*/ 6891 w 10039"/>
              <a:gd name="connsiteY1" fmla="*/ 685 h 10015"/>
              <a:gd name="connsiteX2" fmla="*/ 7134 w 10039"/>
              <a:gd name="connsiteY2" fmla="*/ 9667 h 10015"/>
              <a:gd name="connsiteX3" fmla="*/ 10039 w 10039"/>
              <a:gd name="connsiteY3" fmla="*/ 10003 h 10015"/>
              <a:gd name="connsiteX4" fmla="*/ 217 w 10039"/>
              <a:gd name="connsiteY4" fmla="*/ 10015 h 10015"/>
              <a:gd name="connsiteX5" fmla="*/ 570 w 10039"/>
              <a:gd name="connsiteY5" fmla="*/ 695 h 10015"/>
              <a:gd name="connsiteX0" fmla="*/ 615 w 10084"/>
              <a:gd name="connsiteY0" fmla="*/ 695 h 10015"/>
              <a:gd name="connsiteX1" fmla="*/ 6936 w 10084"/>
              <a:gd name="connsiteY1" fmla="*/ 685 h 10015"/>
              <a:gd name="connsiteX2" fmla="*/ 7179 w 10084"/>
              <a:gd name="connsiteY2" fmla="*/ 9667 h 10015"/>
              <a:gd name="connsiteX3" fmla="*/ 10084 w 10084"/>
              <a:gd name="connsiteY3" fmla="*/ 10003 h 10015"/>
              <a:gd name="connsiteX4" fmla="*/ 262 w 10084"/>
              <a:gd name="connsiteY4" fmla="*/ 10015 h 10015"/>
              <a:gd name="connsiteX5" fmla="*/ 615 w 10084"/>
              <a:gd name="connsiteY5" fmla="*/ 695 h 10015"/>
              <a:gd name="connsiteX0" fmla="*/ 356 w 9825"/>
              <a:gd name="connsiteY0" fmla="*/ 695 h 10015"/>
              <a:gd name="connsiteX1" fmla="*/ 6677 w 9825"/>
              <a:gd name="connsiteY1" fmla="*/ 685 h 10015"/>
              <a:gd name="connsiteX2" fmla="*/ 6920 w 9825"/>
              <a:gd name="connsiteY2" fmla="*/ 9667 h 10015"/>
              <a:gd name="connsiteX3" fmla="*/ 9825 w 9825"/>
              <a:gd name="connsiteY3" fmla="*/ 10003 h 10015"/>
              <a:gd name="connsiteX4" fmla="*/ 3 w 9825"/>
              <a:gd name="connsiteY4" fmla="*/ 10015 h 10015"/>
              <a:gd name="connsiteX5" fmla="*/ 356 w 9825"/>
              <a:gd name="connsiteY5" fmla="*/ 695 h 10015"/>
              <a:gd name="connsiteX0" fmla="*/ 362 w 10000"/>
              <a:gd name="connsiteY0" fmla="*/ 10 h 9316"/>
              <a:gd name="connsiteX1" fmla="*/ 6796 w 10000"/>
              <a:gd name="connsiteY1" fmla="*/ 0 h 9316"/>
              <a:gd name="connsiteX2" fmla="*/ 7043 w 10000"/>
              <a:gd name="connsiteY2" fmla="*/ 8969 h 9316"/>
              <a:gd name="connsiteX3" fmla="*/ 10000 w 10000"/>
              <a:gd name="connsiteY3" fmla="*/ 9304 h 9316"/>
              <a:gd name="connsiteX4" fmla="*/ 3 w 10000"/>
              <a:gd name="connsiteY4" fmla="*/ 9316 h 9316"/>
              <a:gd name="connsiteX5" fmla="*/ 362 w 10000"/>
              <a:gd name="connsiteY5" fmla="*/ 10 h 9316"/>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0 w 9998"/>
              <a:gd name="connsiteY0" fmla="*/ 11 h 10000"/>
              <a:gd name="connsiteX1" fmla="*/ 7099 w 9998"/>
              <a:gd name="connsiteY1" fmla="*/ 0 h 10000"/>
              <a:gd name="connsiteX2" fmla="*/ 7041 w 9998"/>
              <a:gd name="connsiteY2" fmla="*/ 9628 h 10000"/>
              <a:gd name="connsiteX3" fmla="*/ 9998 w 9998"/>
              <a:gd name="connsiteY3" fmla="*/ 9987 h 10000"/>
              <a:gd name="connsiteX4" fmla="*/ 1 w 9998"/>
              <a:gd name="connsiteY4" fmla="*/ 10000 h 10000"/>
              <a:gd name="connsiteX5" fmla="*/ 360 w 9998"/>
              <a:gd name="connsiteY5" fmla="*/ 11 h 10000"/>
              <a:gd name="connsiteX0" fmla="*/ 0 w 9640"/>
              <a:gd name="connsiteY0" fmla="*/ 11 h 10000"/>
              <a:gd name="connsiteX1" fmla="*/ 6740 w 9640"/>
              <a:gd name="connsiteY1" fmla="*/ 0 h 10000"/>
              <a:gd name="connsiteX2" fmla="*/ 6682 w 9640"/>
              <a:gd name="connsiteY2" fmla="*/ 9628 h 10000"/>
              <a:gd name="connsiteX3" fmla="*/ 9640 w 9640"/>
              <a:gd name="connsiteY3" fmla="*/ 9987 h 10000"/>
              <a:gd name="connsiteX4" fmla="*/ 302 w 9640"/>
              <a:gd name="connsiteY4" fmla="*/ 10000 h 10000"/>
              <a:gd name="connsiteX5" fmla="*/ 0 w 964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0 h 9996"/>
              <a:gd name="connsiteX1" fmla="*/ 7001 w 10056"/>
              <a:gd name="connsiteY1" fmla="*/ 1 h 9996"/>
              <a:gd name="connsiteX2" fmla="*/ 6988 w 10056"/>
              <a:gd name="connsiteY2" fmla="*/ 9624 h 9996"/>
              <a:gd name="connsiteX3" fmla="*/ 10056 w 10056"/>
              <a:gd name="connsiteY3" fmla="*/ 9983 h 9996"/>
              <a:gd name="connsiteX4" fmla="*/ 62 w 10056"/>
              <a:gd name="connsiteY4" fmla="*/ 9996 h 9996"/>
              <a:gd name="connsiteX5" fmla="*/ 0 w 10056"/>
              <a:gd name="connsiteY5" fmla="*/ 0 h 9996"/>
              <a:gd name="connsiteX0" fmla="*/ 0 w 10000"/>
              <a:gd name="connsiteY0" fmla="*/ 2 h 10002"/>
              <a:gd name="connsiteX1" fmla="*/ 6962 w 10000"/>
              <a:gd name="connsiteY1" fmla="*/ 0 h 10002"/>
              <a:gd name="connsiteX2" fmla="*/ 6949 w 10000"/>
              <a:gd name="connsiteY2" fmla="*/ 9630 h 10002"/>
              <a:gd name="connsiteX3" fmla="*/ 10000 w 10000"/>
              <a:gd name="connsiteY3" fmla="*/ 9989 h 10002"/>
              <a:gd name="connsiteX4" fmla="*/ 62 w 10000"/>
              <a:gd name="connsiteY4" fmla="*/ 10002 h 10002"/>
              <a:gd name="connsiteX5" fmla="*/ 0 w 10000"/>
              <a:gd name="connsiteY5" fmla="*/ 2 h 10002"/>
              <a:gd name="connsiteX0" fmla="*/ 0 w 10000"/>
              <a:gd name="connsiteY0" fmla="*/ 4 h 10004"/>
              <a:gd name="connsiteX1" fmla="*/ 6927 w 10000"/>
              <a:gd name="connsiteY1" fmla="*/ 0 h 10004"/>
              <a:gd name="connsiteX2" fmla="*/ 6949 w 10000"/>
              <a:gd name="connsiteY2" fmla="*/ 9632 h 10004"/>
              <a:gd name="connsiteX3" fmla="*/ 10000 w 10000"/>
              <a:gd name="connsiteY3" fmla="*/ 9991 h 10004"/>
              <a:gd name="connsiteX4" fmla="*/ 62 w 10000"/>
              <a:gd name="connsiteY4" fmla="*/ 10004 h 10004"/>
              <a:gd name="connsiteX5" fmla="*/ 0 w 10000"/>
              <a:gd name="connsiteY5" fmla="*/ 4 h 10004"/>
              <a:gd name="connsiteX0" fmla="*/ 0 w 10000"/>
              <a:gd name="connsiteY0" fmla="*/ 4 h 10004"/>
              <a:gd name="connsiteX1" fmla="*/ 6927 w 10000"/>
              <a:gd name="connsiteY1" fmla="*/ 0 h 10004"/>
              <a:gd name="connsiteX2" fmla="*/ 6949 w 10000"/>
              <a:gd name="connsiteY2" fmla="*/ 9632 h 10004"/>
              <a:gd name="connsiteX3" fmla="*/ 10000 w 10000"/>
              <a:gd name="connsiteY3" fmla="*/ 9991 h 10004"/>
              <a:gd name="connsiteX4" fmla="*/ 62 w 10000"/>
              <a:gd name="connsiteY4" fmla="*/ 10004 h 10004"/>
              <a:gd name="connsiteX5" fmla="*/ 0 w 10000"/>
              <a:gd name="connsiteY5" fmla="*/ 4 h 10004"/>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0000" h="10004">
                <a:moveTo>
                  <a:pt x="0" y="4"/>
                </a:moveTo>
                <a:lnTo>
                  <a:pt x="6927" y="0"/>
                </a:lnTo>
                <a:cubicBezTo>
                  <a:pt x="6894" y="1547"/>
                  <a:pt x="6891" y="9283"/>
                  <a:pt x="6949" y="9632"/>
                </a:cubicBezTo>
                <a:cubicBezTo>
                  <a:pt x="6923" y="9834"/>
                  <a:pt x="8645" y="9997"/>
                  <a:pt x="10000" y="9991"/>
                </a:cubicBezTo>
                <a:lnTo>
                  <a:pt x="62" y="10004"/>
                </a:lnTo>
                <a:cubicBezTo>
                  <a:pt x="31" y="8409"/>
                  <a:pt x="98" y="1072"/>
                  <a:pt x="0" y="4"/>
                </a:cubicBezTo>
                <a:close/>
              </a:path>
            </a:pathLst>
          </a:custGeom>
          <a:solidFill>
            <a:srgbClr val="AA0065"/>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dirty="0"/>
          </a:p>
        </p:txBody>
      </p:sp>
      <p:sp>
        <p:nvSpPr>
          <p:cNvPr id="12" name="Rectangle 11"/>
          <p:cNvSpPr/>
          <p:nvPr userDrawn="1"/>
        </p:nvSpPr>
        <p:spPr>
          <a:xfrm>
            <a:off x="7490690" y="5672093"/>
            <a:ext cx="4702823" cy="421061"/>
          </a:xfrm>
          <a:prstGeom prst="rect">
            <a:avLst/>
          </a:prstGeom>
          <a:solidFill>
            <a:srgbClr val="65AA0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900"/>
          </a:p>
        </p:txBody>
      </p:sp>
      <p:grpSp>
        <p:nvGrpSpPr>
          <p:cNvPr id="13" name="Group 12"/>
          <p:cNvGrpSpPr/>
          <p:nvPr userDrawn="1"/>
        </p:nvGrpSpPr>
        <p:grpSpPr>
          <a:xfrm>
            <a:off x="7637330" y="6112457"/>
            <a:ext cx="4174624" cy="723275"/>
            <a:chOff x="7646796" y="6098813"/>
            <a:chExt cx="4174624" cy="723275"/>
          </a:xfrm>
        </p:grpSpPr>
        <p:pic>
          <p:nvPicPr>
            <p:cNvPr id="14" name="Picture 10" descr="LOGO_IPNA_Blue"/>
            <p:cNvPicPr>
              <a:picLocks noChangeAspect="1" noChangeArrowheads="1"/>
            </p:cNvPicPr>
            <p:nvPr/>
          </p:nvPicPr>
          <p:blipFill>
            <a:blip r:embed="rId2" cstate="print">
              <a:extLst>
                <a:ext uri="{28A0092B-C50C-407E-A947-70E740481C1C}">
                  <a14:useLocalDpi xmlns:a14="http://schemas.microsoft.com/office/drawing/2010/main" val="0"/>
                </a:ext>
              </a:extLst>
            </a:blip>
            <a:srcRect/>
            <a:stretch>
              <a:fillRect/>
            </a:stretch>
          </p:blipFill>
          <p:spPr bwMode="auto">
            <a:xfrm>
              <a:off x="7646796" y="6186597"/>
              <a:ext cx="581637" cy="581637"/>
            </a:xfrm>
            <a:prstGeom prst="rect">
              <a:avLst/>
            </a:prstGeom>
            <a:noFill/>
            <a:extLst>
              <a:ext uri="{909E8E84-426E-40DD-AFC4-6F175D3DCCD1}">
                <a14:hiddenFill xmlns:a14="http://schemas.microsoft.com/office/drawing/2010/main">
                  <a:solidFill>
                    <a:srgbClr val="FFFFFF"/>
                  </a:solidFill>
                </a14:hiddenFill>
              </a:ext>
            </a:extLst>
          </p:spPr>
        </p:pic>
        <p:sp>
          <p:nvSpPr>
            <p:cNvPr id="15" name="Rectangle 12"/>
            <p:cNvSpPr>
              <a:spLocks noChangeArrowheads="1"/>
            </p:cNvSpPr>
            <p:nvPr/>
          </p:nvSpPr>
          <p:spPr bwMode="auto">
            <a:xfrm>
              <a:off x="8208157" y="6098813"/>
              <a:ext cx="3613263" cy="72327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GB" altLang="en-US" b="1" i="0" u="none" strike="noStrike" cap="none" normalizeH="0" baseline="0" dirty="0">
                  <a:ln>
                    <a:noFill/>
                  </a:ln>
                  <a:solidFill>
                    <a:srgbClr val="296DC0"/>
                  </a:solidFill>
                  <a:effectLst/>
                  <a:latin typeface="Arial" panose="020B0604020202020204" pitchFamily="34" charset="0"/>
                  <a:ea typeface="Calibri" panose="020F0502020204030204" pitchFamily="34" charset="0"/>
                  <a:cs typeface="Calibri" panose="020F0502020204030204" pitchFamily="34" charset="0"/>
                </a:rPr>
                <a:t>Pediatric Nephrology</a:t>
              </a:r>
              <a:endParaRPr kumimoji="0" lang="en-GB" altLang="en-US" sz="500" b="0" i="0" u="none" strike="noStrike" cap="none" normalizeH="0" baseline="0" dirty="0">
                <a:ln>
                  <a:noFill/>
                </a:ln>
                <a:solidFill>
                  <a:schemeClr val="tx1"/>
                </a:solidFill>
                <a:effectLst/>
                <a:latin typeface="Arial" panose="020B0604020202020204" pitchFamily="34" charset="0"/>
              </a:endParaRPr>
            </a:p>
            <a:p>
              <a:pPr marL="0" marR="0" lvl="0" indent="0" algn="l" defTabSz="914400" rtl="0" eaLnBrk="0" fontAlgn="base" latinLnBrk="0" hangingPunct="0">
                <a:lnSpc>
                  <a:spcPct val="100000"/>
                </a:lnSpc>
                <a:spcBef>
                  <a:spcPct val="0"/>
                </a:spcBef>
                <a:spcAft>
                  <a:spcPct val="0"/>
                </a:spcAft>
                <a:buClrTx/>
                <a:buSzTx/>
                <a:buFontTx/>
                <a:buNone/>
                <a:tabLst/>
              </a:pPr>
              <a:r>
                <a:rPr kumimoji="0" lang="en-GB" altLang="en-US" sz="11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t>Journal of the </a:t>
              </a:r>
              <a:br>
                <a:rPr kumimoji="0" lang="en-GB" altLang="en-US" sz="11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br>
              <a:r>
                <a:rPr kumimoji="0" lang="en-GB" altLang="en-US" sz="1200" b="0" i="0" u="none" strike="noStrike" cap="none" normalizeH="0" baseline="0" dirty="0">
                  <a:ln>
                    <a:noFill/>
                  </a:ln>
                  <a:solidFill>
                    <a:schemeClr val="tx1"/>
                  </a:solidFill>
                  <a:effectLst/>
                  <a:latin typeface="Arial" panose="020B0604020202020204" pitchFamily="34" charset="0"/>
                  <a:ea typeface="Calibri" panose="020F0502020204030204" pitchFamily="34" charset="0"/>
                  <a:cs typeface="Times New Roman" panose="02020603050405020304" pitchFamily="18" charset="0"/>
                </a:rPr>
                <a:t>International Pediatric Nephrology Association</a:t>
              </a:r>
              <a:endParaRPr kumimoji="0" lang="en-GB" altLang="en-US" sz="1200" b="0" i="0" u="none" strike="noStrike" cap="none" normalizeH="0" baseline="0" dirty="0">
                <a:ln>
                  <a:noFill/>
                </a:ln>
                <a:solidFill>
                  <a:schemeClr val="tx1"/>
                </a:solidFill>
                <a:effectLst/>
                <a:latin typeface="Arial" panose="020B0604020202020204" pitchFamily="34" charset="0"/>
              </a:endParaRPr>
            </a:p>
          </p:txBody>
        </p:sp>
      </p:grpSp>
      <p:sp>
        <p:nvSpPr>
          <p:cNvPr id="37" name="Rectangle 36">
            <a:extLst>
              <a:ext uri="{FF2B5EF4-FFF2-40B4-BE49-F238E27FC236}">
                <a16:creationId xmlns:a16="http://schemas.microsoft.com/office/drawing/2014/main" id="{FB861B61-643E-7D14-D771-2A7BF1205723}"/>
              </a:ext>
            </a:extLst>
          </p:cNvPr>
          <p:cNvSpPr/>
          <p:nvPr userDrawn="1"/>
        </p:nvSpPr>
        <p:spPr>
          <a:xfrm>
            <a:off x="10134600" y="-28393"/>
            <a:ext cx="2068286" cy="1119323"/>
          </a:xfrm>
          <a:prstGeom prst="rect">
            <a:avLst/>
          </a:prstGeom>
          <a:solidFill>
            <a:srgbClr val="003969"/>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19" name="TextBox 18"/>
          <p:cNvSpPr txBox="1"/>
          <p:nvPr/>
        </p:nvSpPr>
        <p:spPr>
          <a:xfrm>
            <a:off x="10626853" y="297104"/>
            <a:ext cx="1441475" cy="419695"/>
          </a:xfrm>
          <a:prstGeom prst="rect">
            <a:avLst/>
          </a:prstGeom>
          <a:noFill/>
        </p:spPr>
        <p:txBody>
          <a:bodyPr wrap="square" rtlCol="0">
            <a:spAutoFit/>
          </a:bodyPr>
          <a:lstStyle/>
          <a:p>
            <a:r>
              <a:rPr lang="en-GB" sz="2400" dirty="0">
                <a:solidFill>
                  <a:schemeClr val="bg1"/>
                </a:solidFill>
              </a:rPr>
              <a:t>Review/</a:t>
            </a:r>
          </a:p>
        </p:txBody>
      </p:sp>
      <p:sp>
        <p:nvSpPr>
          <p:cNvPr id="18" name="TextBox 17"/>
          <p:cNvSpPr txBox="1"/>
          <p:nvPr/>
        </p:nvSpPr>
        <p:spPr>
          <a:xfrm>
            <a:off x="10361243" y="16591"/>
            <a:ext cx="1747805" cy="419695"/>
          </a:xfrm>
          <a:prstGeom prst="rect">
            <a:avLst/>
          </a:prstGeom>
          <a:noFill/>
        </p:spPr>
        <p:txBody>
          <a:bodyPr wrap="square" rtlCol="0">
            <a:spAutoFit/>
          </a:bodyPr>
          <a:lstStyle/>
          <a:p>
            <a:r>
              <a:rPr lang="en-GB" sz="2400" dirty="0">
                <a:solidFill>
                  <a:schemeClr val="bg1"/>
                </a:solidFill>
              </a:rPr>
              <a:t>Systematic</a:t>
            </a:r>
          </a:p>
        </p:txBody>
      </p:sp>
      <p:sp>
        <p:nvSpPr>
          <p:cNvPr id="29" name="Flowchart: Stored Data 4">
            <a:extLst>
              <a:ext uri="{FF2B5EF4-FFF2-40B4-BE49-F238E27FC236}">
                <a16:creationId xmlns:a16="http://schemas.microsoft.com/office/drawing/2014/main" id="{17034CCF-1EDD-D498-AB89-09358AFA3492}"/>
              </a:ext>
            </a:extLst>
          </p:cNvPr>
          <p:cNvSpPr/>
          <p:nvPr userDrawn="1"/>
        </p:nvSpPr>
        <p:spPr>
          <a:xfrm rot="16200000" flipV="1">
            <a:off x="2901409" y="2274353"/>
            <a:ext cx="1684645" cy="7491425"/>
          </a:xfrm>
          <a:custGeom>
            <a:avLst/>
            <a:gdLst>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0 h 10000"/>
              <a:gd name="connsiteX1" fmla="*/ 10000 w 10000"/>
              <a:gd name="connsiteY1" fmla="*/ 0 h 10000"/>
              <a:gd name="connsiteX2" fmla="*/ 8333 w 10000"/>
              <a:gd name="connsiteY2" fmla="*/ 5000 h 10000"/>
              <a:gd name="connsiteX3" fmla="*/ 10000 w 10000"/>
              <a:gd name="connsiteY3" fmla="*/ 10000 h 10000"/>
              <a:gd name="connsiteX4" fmla="*/ 1667 w 10000"/>
              <a:gd name="connsiteY4" fmla="*/ 10000 h 10000"/>
              <a:gd name="connsiteX5" fmla="*/ 0 w 10000"/>
              <a:gd name="connsiteY5" fmla="*/ 5000 h 10000"/>
              <a:gd name="connsiteX6" fmla="*/ 1667 w 10000"/>
              <a:gd name="connsiteY6" fmla="*/ 0 h 10000"/>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38798 h 49391"/>
              <a:gd name="connsiteX1" fmla="*/ 7817 w 10000"/>
              <a:gd name="connsiteY1" fmla="*/ 0 h 49391"/>
              <a:gd name="connsiteX2" fmla="*/ 8333 w 10000"/>
              <a:gd name="connsiteY2" fmla="*/ 43798 h 49391"/>
              <a:gd name="connsiteX3" fmla="*/ 10000 w 10000"/>
              <a:gd name="connsiteY3" fmla="*/ 48798 h 49391"/>
              <a:gd name="connsiteX4" fmla="*/ 1667 w 10000"/>
              <a:gd name="connsiteY4" fmla="*/ 48798 h 49391"/>
              <a:gd name="connsiteX5" fmla="*/ 0 w 10000"/>
              <a:gd name="connsiteY5" fmla="*/ 43798 h 49391"/>
              <a:gd name="connsiteX6" fmla="*/ 1667 w 10000"/>
              <a:gd name="connsiteY6" fmla="*/ 38798 h 49391"/>
              <a:gd name="connsiteX0" fmla="*/ 1667 w 10000"/>
              <a:gd name="connsiteY0" fmla="*/ 89795 h 103750"/>
              <a:gd name="connsiteX1" fmla="*/ 8293 w 10000"/>
              <a:gd name="connsiteY1" fmla="*/ 0 h 103750"/>
              <a:gd name="connsiteX2" fmla="*/ 8333 w 10000"/>
              <a:gd name="connsiteY2" fmla="*/ 94795 h 103750"/>
              <a:gd name="connsiteX3" fmla="*/ 10000 w 10000"/>
              <a:gd name="connsiteY3" fmla="*/ 99795 h 103750"/>
              <a:gd name="connsiteX4" fmla="*/ 1667 w 10000"/>
              <a:gd name="connsiteY4" fmla="*/ 99795 h 103750"/>
              <a:gd name="connsiteX5" fmla="*/ 0 w 10000"/>
              <a:gd name="connsiteY5" fmla="*/ 94795 h 103750"/>
              <a:gd name="connsiteX6" fmla="*/ 1667 w 10000"/>
              <a:gd name="connsiteY6" fmla="*/ 89795 h 10375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87862 h 101680"/>
              <a:gd name="connsiteX1" fmla="*/ 7836 w 10000"/>
              <a:gd name="connsiteY1" fmla="*/ 0 h 101680"/>
              <a:gd name="connsiteX2" fmla="*/ 8333 w 10000"/>
              <a:gd name="connsiteY2" fmla="*/ 92862 h 101680"/>
              <a:gd name="connsiteX3" fmla="*/ 10000 w 10000"/>
              <a:gd name="connsiteY3" fmla="*/ 97862 h 101680"/>
              <a:gd name="connsiteX4" fmla="*/ 1667 w 10000"/>
              <a:gd name="connsiteY4" fmla="*/ 97862 h 101680"/>
              <a:gd name="connsiteX5" fmla="*/ 0 w 10000"/>
              <a:gd name="connsiteY5" fmla="*/ 92862 h 101680"/>
              <a:gd name="connsiteX6" fmla="*/ 1667 w 10000"/>
              <a:gd name="connsiteY6" fmla="*/ 87862 h 101680"/>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1667 w 10000"/>
              <a:gd name="connsiteY0" fmla="*/ 93062 h 107249"/>
              <a:gd name="connsiteX1" fmla="*/ 8511 w 10000"/>
              <a:gd name="connsiteY1" fmla="*/ 0 h 107249"/>
              <a:gd name="connsiteX2" fmla="*/ 8333 w 10000"/>
              <a:gd name="connsiteY2" fmla="*/ 98062 h 107249"/>
              <a:gd name="connsiteX3" fmla="*/ 10000 w 10000"/>
              <a:gd name="connsiteY3" fmla="*/ 103062 h 107249"/>
              <a:gd name="connsiteX4" fmla="*/ 1667 w 10000"/>
              <a:gd name="connsiteY4" fmla="*/ 103062 h 107249"/>
              <a:gd name="connsiteX5" fmla="*/ 0 w 10000"/>
              <a:gd name="connsiteY5" fmla="*/ 98062 h 107249"/>
              <a:gd name="connsiteX6" fmla="*/ 1667 w 10000"/>
              <a:gd name="connsiteY6" fmla="*/ 93062 h 107249"/>
              <a:gd name="connsiteX0" fmla="*/ 5639 w 10161"/>
              <a:gd name="connsiteY0" fmla="*/ 18392 h 112308"/>
              <a:gd name="connsiteX1" fmla="*/ 8672 w 10161"/>
              <a:gd name="connsiteY1" fmla="*/ 5059 h 112308"/>
              <a:gd name="connsiteX2" fmla="*/ 8494 w 10161"/>
              <a:gd name="connsiteY2" fmla="*/ 103121 h 112308"/>
              <a:gd name="connsiteX3" fmla="*/ 10161 w 10161"/>
              <a:gd name="connsiteY3" fmla="*/ 108121 h 112308"/>
              <a:gd name="connsiteX4" fmla="*/ 1828 w 10161"/>
              <a:gd name="connsiteY4" fmla="*/ 108121 h 112308"/>
              <a:gd name="connsiteX5" fmla="*/ 161 w 10161"/>
              <a:gd name="connsiteY5" fmla="*/ 103121 h 112308"/>
              <a:gd name="connsiteX6" fmla="*/ 5639 w 10161"/>
              <a:gd name="connsiteY6" fmla="*/ 18392 h 112308"/>
              <a:gd name="connsiteX0" fmla="*/ 5639 w 10161"/>
              <a:gd name="connsiteY0" fmla="*/ 48998 h 145481"/>
              <a:gd name="connsiteX1" fmla="*/ 8354 w 10161"/>
              <a:gd name="connsiteY1" fmla="*/ 0 h 145481"/>
              <a:gd name="connsiteX2" fmla="*/ 8494 w 10161"/>
              <a:gd name="connsiteY2" fmla="*/ 133727 h 145481"/>
              <a:gd name="connsiteX3" fmla="*/ 10161 w 10161"/>
              <a:gd name="connsiteY3" fmla="*/ 138727 h 145481"/>
              <a:gd name="connsiteX4" fmla="*/ 1828 w 10161"/>
              <a:gd name="connsiteY4" fmla="*/ 138727 h 145481"/>
              <a:gd name="connsiteX5" fmla="*/ 161 w 10161"/>
              <a:gd name="connsiteY5" fmla="*/ 133727 h 145481"/>
              <a:gd name="connsiteX6" fmla="*/ 5639 w 10161"/>
              <a:gd name="connsiteY6" fmla="*/ 48998 h 145481"/>
              <a:gd name="connsiteX0" fmla="*/ 4738 w 10113"/>
              <a:gd name="connsiteY0" fmla="*/ 13812 h 159292"/>
              <a:gd name="connsiteX1" fmla="*/ 8306 w 10113"/>
              <a:gd name="connsiteY1" fmla="*/ 13811 h 159292"/>
              <a:gd name="connsiteX2" fmla="*/ 8446 w 10113"/>
              <a:gd name="connsiteY2" fmla="*/ 147538 h 159292"/>
              <a:gd name="connsiteX3" fmla="*/ 10113 w 10113"/>
              <a:gd name="connsiteY3" fmla="*/ 152538 h 159292"/>
              <a:gd name="connsiteX4" fmla="*/ 1780 w 10113"/>
              <a:gd name="connsiteY4" fmla="*/ 152538 h 159292"/>
              <a:gd name="connsiteX5" fmla="*/ 113 w 10113"/>
              <a:gd name="connsiteY5" fmla="*/ 147538 h 159292"/>
              <a:gd name="connsiteX6" fmla="*/ 4738 w 10113"/>
              <a:gd name="connsiteY6" fmla="*/ 13812 h 159292"/>
              <a:gd name="connsiteX0" fmla="*/ 4738 w 10113"/>
              <a:gd name="connsiteY0" fmla="*/ 2870 h 148350"/>
              <a:gd name="connsiteX1" fmla="*/ 8306 w 10113"/>
              <a:gd name="connsiteY1" fmla="*/ 2869 h 148350"/>
              <a:gd name="connsiteX2" fmla="*/ 8446 w 10113"/>
              <a:gd name="connsiteY2" fmla="*/ 136596 h 148350"/>
              <a:gd name="connsiteX3" fmla="*/ 10113 w 10113"/>
              <a:gd name="connsiteY3" fmla="*/ 141596 h 148350"/>
              <a:gd name="connsiteX4" fmla="*/ 1780 w 10113"/>
              <a:gd name="connsiteY4" fmla="*/ 141596 h 148350"/>
              <a:gd name="connsiteX5" fmla="*/ 113 w 10113"/>
              <a:gd name="connsiteY5" fmla="*/ 136596 h 148350"/>
              <a:gd name="connsiteX6" fmla="*/ 4738 w 10113"/>
              <a:gd name="connsiteY6" fmla="*/ 2870 h 148350"/>
              <a:gd name="connsiteX0" fmla="*/ 4738 w 10113"/>
              <a:gd name="connsiteY0" fmla="*/ 51 h 145531"/>
              <a:gd name="connsiteX1" fmla="*/ 8306 w 10113"/>
              <a:gd name="connsiteY1" fmla="*/ 50 h 145531"/>
              <a:gd name="connsiteX2" fmla="*/ 8446 w 10113"/>
              <a:gd name="connsiteY2" fmla="*/ 133777 h 145531"/>
              <a:gd name="connsiteX3" fmla="*/ 10113 w 10113"/>
              <a:gd name="connsiteY3" fmla="*/ 138777 h 145531"/>
              <a:gd name="connsiteX4" fmla="*/ 1780 w 10113"/>
              <a:gd name="connsiteY4" fmla="*/ 138777 h 145531"/>
              <a:gd name="connsiteX5" fmla="*/ 113 w 10113"/>
              <a:gd name="connsiteY5" fmla="*/ 133777 h 145531"/>
              <a:gd name="connsiteX6" fmla="*/ 4738 w 10113"/>
              <a:gd name="connsiteY6" fmla="*/ 51 h 145531"/>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738 w 10113"/>
              <a:gd name="connsiteY0" fmla="*/ 68 h 145548"/>
              <a:gd name="connsiteX1" fmla="*/ 8306 w 10113"/>
              <a:gd name="connsiteY1" fmla="*/ 67 h 145548"/>
              <a:gd name="connsiteX2" fmla="*/ 8446 w 10113"/>
              <a:gd name="connsiteY2" fmla="*/ 133794 h 145548"/>
              <a:gd name="connsiteX3" fmla="*/ 10113 w 10113"/>
              <a:gd name="connsiteY3" fmla="*/ 138794 h 145548"/>
              <a:gd name="connsiteX4" fmla="*/ 1780 w 10113"/>
              <a:gd name="connsiteY4" fmla="*/ 138794 h 145548"/>
              <a:gd name="connsiteX5" fmla="*/ 113 w 10113"/>
              <a:gd name="connsiteY5" fmla="*/ 133794 h 145548"/>
              <a:gd name="connsiteX6" fmla="*/ 4738 w 10113"/>
              <a:gd name="connsiteY6" fmla="*/ 68 h 145548"/>
              <a:gd name="connsiteX0" fmla="*/ 4674 w 10109"/>
              <a:gd name="connsiteY0" fmla="*/ 170 h 145517"/>
              <a:gd name="connsiteX1" fmla="*/ 8302 w 10109"/>
              <a:gd name="connsiteY1" fmla="*/ 36 h 145517"/>
              <a:gd name="connsiteX2" fmla="*/ 8442 w 10109"/>
              <a:gd name="connsiteY2" fmla="*/ 133763 h 145517"/>
              <a:gd name="connsiteX3" fmla="*/ 10109 w 10109"/>
              <a:gd name="connsiteY3" fmla="*/ 138763 h 145517"/>
              <a:gd name="connsiteX4" fmla="*/ 1776 w 10109"/>
              <a:gd name="connsiteY4" fmla="*/ 138763 h 145517"/>
              <a:gd name="connsiteX5" fmla="*/ 109 w 10109"/>
              <a:gd name="connsiteY5" fmla="*/ 133763 h 145517"/>
              <a:gd name="connsiteX6" fmla="*/ 4674 w 10109"/>
              <a:gd name="connsiteY6" fmla="*/ 170 h 145517"/>
              <a:gd name="connsiteX0" fmla="*/ 3080 w 8515"/>
              <a:gd name="connsiteY0" fmla="*/ 170 h 145517"/>
              <a:gd name="connsiteX1" fmla="*/ 6708 w 8515"/>
              <a:gd name="connsiteY1" fmla="*/ 36 h 145517"/>
              <a:gd name="connsiteX2" fmla="*/ 6848 w 8515"/>
              <a:gd name="connsiteY2" fmla="*/ 133763 h 145517"/>
              <a:gd name="connsiteX3" fmla="*/ 8515 w 8515"/>
              <a:gd name="connsiteY3" fmla="*/ 138763 h 145517"/>
              <a:gd name="connsiteX4" fmla="*/ 182 w 8515"/>
              <a:gd name="connsiteY4" fmla="*/ 138763 h 145517"/>
              <a:gd name="connsiteX5" fmla="*/ 3080 w 8515"/>
              <a:gd name="connsiteY5" fmla="*/ 170 h 145517"/>
              <a:gd name="connsiteX0" fmla="*/ 3617 w 10000"/>
              <a:gd name="connsiteY0" fmla="*/ 12 h 9536"/>
              <a:gd name="connsiteX1" fmla="*/ 7878 w 10000"/>
              <a:gd name="connsiteY1" fmla="*/ 2 h 9536"/>
              <a:gd name="connsiteX2" fmla="*/ 8042 w 10000"/>
              <a:gd name="connsiteY2" fmla="*/ 9192 h 9536"/>
              <a:gd name="connsiteX3" fmla="*/ 10000 w 10000"/>
              <a:gd name="connsiteY3" fmla="*/ 9536 h 9536"/>
              <a:gd name="connsiteX4" fmla="*/ 214 w 10000"/>
              <a:gd name="connsiteY4" fmla="*/ 9536 h 9536"/>
              <a:gd name="connsiteX5" fmla="*/ 3617 w 10000"/>
              <a:gd name="connsiteY5" fmla="*/ 12 h 9536"/>
              <a:gd name="connsiteX0" fmla="*/ 3403 w 9786"/>
              <a:gd name="connsiteY0" fmla="*/ 13 h 10000"/>
              <a:gd name="connsiteX1" fmla="*/ 7664 w 9786"/>
              <a:gd name="connsiteY1" fmla="*/ 2 h 10000"/>
              <a:gd name="connsiteX2" fmla="*/ 7828 w 9786"/>
              <a:gd name="connsiteY2" fmla="*/ 9639 h 10000"/>
              <a:gd name="connsiteX3" fmla="*/ 9786 w 9786"/>
              <a:gd name="connsiteY3" fmla="*/ 10000 h 10000"/>
              <a:gd name="connsiteX4" fmla="*/ 0 w 9786"/>
              <a:gd name="connsiteY4" fmla="*/ 10000 h 10000"/>
              <a:gd name="connsiteX5" fmla="*/ 3403 w 9786"/>
              <a:gd name="connsiteY5" fmla="*/ 13 h 10000"/>
              <a:gd name="connsiteX0" fmla="*/ 494 w 7017"/>
              <a:gd name="connsiteY0" fmla="*/ 743 h 10730"/>
              <a:gd name="connsiteX1" fmla="*/ 4849 w 7017"/>
              <a:gd name="connsiteY1" fmla="*/ 732 h 10730"/>
              <a:gd name="connsiteX2" fmla="*/ 5016 w 7017"/>
              <a:gd name="connsiteY2" fmla="*/ 10369 h 10730"/>
              <a:gd name="connsiteX3" fmla="*/ 7017 w 7017"/>
              <a:gd name="connsiteY3" fmla="*/ 10730 h 10730"/>
              <a:gd name="connsiteX4" fmla="*/ 45 w 7017"/>
              <a:gd name="connsiteY4" fmla="*/ 10709 h 10730"/>
              <a:gd name="connsiteX5" fmla="*/ 494 w 7017"/>
              <a:gd name="connsiteY5" fmla="*/ 743 h 10730"/>
              <a:gd name="connsiteX0" fmla="*/ 521 w 9817"/>
              <a:gd name="connsiteY0" fmla="*/ 692 h 10000"/>
              <a:gd name="connsiteX1" fmla="*/ 6727 w 9817"/>
              <a:gd name="connsiteY1" fmla="*/ 682 h 10000"/>
              <a:gd name="connsiteX2" fmla="*/ 6965 w 9817"/>
              <a:gd name="connsiteY2" fmla="*/ 9664 h 10000"/>
              <a:gd name="connsiteX3" fmla="*/ 9817 w 9817"/>
              <a:gd name="connsiteY3" fmla="*/ 10000 h 10000"/>
              <a:gd name="connsiteX4" fmla="*/ 273 w 9817"/>
              <a:gd name="connsiteY4" fmla="*/ 9980 h 10000"/>
              <a:gd name="connsiteX5" fmla="*/ 521 w 9817"/>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31 w 10000"/>
              <a:gd name="connsiteY0" fmla="*/ 692 h 10000"/>
              <a:gd name="connsiteX1" fmla="*/ 6852 w 10000"/>
              <a:gd name="connsiteY1" fmla="*/ 682 h 10000"/>
              <a:gd name="connsiteX2" fmla="*/ 7095 w 10000"/>
              <a:gd name="connsiteY2" fmla="*/ 9664 h 10000"/>
              <a:gd name="connsiteX3" fmla="*/ 10000 w 10000"/>
              <a:gd name="connsiteY3" fmla="*/ 10000 h 10000"/>
              <a:gd name="connsiteX4" fmla="*/ 278 w 10000"/>
              <a:gd name="connsiteY4" fmla="*/ 9980 h 10000"/>
              <a:gd name="connsiteX5" fmla="*/ 531 w 10000"/>
              <a:gd name="connsiteY5" fmla="*/ 692 h 10000"/>
              <a:gd name="connsiteX0" fmla="*/ 570 w 10039"/>
              <a:gd name="connsiteY0" fmla="*/ 695 h 10015"/>
              <a:gd name="connsiteX1" fmla="*/ 6891 w 10039"/>
              <a:gd name="connsiteY1" fmla="*/ 685 h 10015"/>
              <a:gd name="connsiteX2" fmla="*/ 7134 w 10039"/>
              <a:gd name="connsiteY2" fmla="*/ 9667 h 10015"/>
              <a:gd name="connsiteX3" fmla="*/ 10039 w 10039"/>
              <a:gd name="connsiteY3" fmla="*/ 10003 h 10015"/>
              <a:gd name="connsiteX4" fmla="*/ 217 w 10039"/>
              <a:gd name="connsiteY4" fmla="*/ 10015 h 10015"/>
              <a:gd name="connsiteX5" fmla="*/ 570 w 10039"/>
              <a:gd name="connsiteY5" fmla="*/ 695 h 10015"/>
              <a:gd name="connsiteX0" fmla="*/ 615 w 10084"/>
              <a:gd name="connsiteY0" fmla="*/ 695 h 10015"/>
              <a:gd name="connsiteX1" fmla="*/ 6936 w 10084"/>
              <a:gd name="connsiteY1" fmla="*/ 685 h 10015"/>
              <a:gd name="connsiteX2" fmla="*/ 7179 w 10084"/>
              <a:gd name="connsiteY2" fmla="*/ 9667 h 10015"/>
              <a:gd name="connsiteX3" fmla="*/ 10084 w 10084"/>
              <a:gd name="connsiteY3" fmla="*/ 10003 h 10015"/>
              <a:gd name="connsiteX4" fmla="*/ 262 w 10084"/>
              <a:gd name="connsiteY4" fmla="*/ 10015 h 10015"/>
              <a:gd name="connsiteX5" fmla="*/ 615 w 10084"/>
              <a:gd name="connsiteY5" fmla="*/ 695 h 10015"/>
              <a:gd name="connsiteX0" fmla="*/ 356 w 9825"/>
              <a:gd name="connsiteY0" fmla="*/ 695 h 10015"/>
              <a:gd name="connsiteX1" fmla="*/ 6677 w 9825"/>
              <a:gd name="connsiteY1" fmla="*/ 685 h 10015"/>
              <a:gd name="connsiteX2" fmla="*/ 6920 w 9825"/>
              <a:gd name="connsiteY2" fmla="*/ 9667 h 10015"/>
              <a:gd name="connsiteX3" fmla="*/ 9825 w 9825"/>
              <a:gd name="connsiteY3" fmla="*/ 10003 h 10015"/>
              <a:gd name="connsiteX4" fmla="*/ 3 w 9825"/>
              <a:gd name="connsiteY4" fmla="*/ 10015 h 10015"/>
              <a:gd name="connsiteX5" fmla="*/ 356 w 9825"/>
              <a:gd name="connsiteY5" fmla="*/ 695 h 10015"/>
              <a:gd name="connsiteX0" fmla="*/ 362 w 10000"/>
              <a:gd name="connsiteY0" fmla="*/ 10 h 9316"/>
              <a:gd name="connsiteX1" fmla="*/ 6796 w 10000"/>
              <a:gd name="connsiteY1" fmla="*/ 0 h 9316"/>
              <a:gd name="connsiteX2" fmla="*/ 7043 w 10000"/>
              <a:gd name="connsiteY2" fmla="*/ 8969 h 9316"/>
              <a:gd name="connsiteX3" fmla="*/ 10000 w 10000"/>
              <a:gd name="connsiteY3" fmla="*/ 9304 h 9316"/>
              <a:gd name="connsiteX4" fmla="*/ 3 w 10000"/>
              <a:gd name="connsiteY4" fmla="*/ 9316 h 9316"/>
              <a:gd name="connsiteX5" fmla="*/ 362 w 10000"/>
              <a:gd name="connsiteY5" fmla="*/ 10 h 9316"/>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6796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474"/>
              <a:gd name="connsiteX1" fmla="*/ 7101 w 10000"/>
              <a:gd name="connsiteY1" fmla="*/ 0 h 10474"/>
              <a:gd name="connsiteX2" fmla="*/ 7043 w 10000"/>
              <a:gd name="connsiteY2" fmla="*/ 9628 h 10474"/>
              <a:gd name="connsiteX3" fmla="*/ 10000 w 10000"/>
              <a:gd name="connsiteY3" fmla="*/ 9987 h 10474"/>
              <a:gd name="connsiteX4" fmla="*/ 3 w 10000"/>
              <a:gd name="connsiteY4" fmla="*/ 10000 h 10474"/>
              <a:gd name="connsiteX5" fmla="*/ 362 w 10000"/>
              <a:gd name="connsiteY5" fmla="*/ 11 h 10474"/>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2 w 10000"/>
              <a:gd name="connsiteY0" fmla="*/ 11 h 10000"/>
              <a:gd name="connsiteX1" fmla="*/ 7101 w 10000"/>
              <a:gd name="connsiteY1" fmla="*/ 0 h 10000"/>
              <a:gd name="connsiteX2" fmla="*/ 7043 w 10000"/>
              <a:gd name="connsiteY2" fmla="*/ 9628 h 10000"/>
              <a:gd name="connsiteX3" fmla="*/ 10000 w 10000"/>
              <a:gd name="connsiteY3" fmla="*/ 9987 h 10000"/>
              <a:gd name="connsiteX4" fmla="*/ 3 w 10000"/>
              <a:gd name="connsiteY4" fmla="*/ 10000 h 10000"/>
              <a:gd name="connsiteX5" fmla="*/ 362 w 10000"/>
              <a:gd name="connsiteY5" fmla="*/ 11 h 10000"/>
              <a:gd name="connsiteX0" fmla="*/ 360 w 9998"/>
              <a:gd name="connsiteY0" fmla="*/ 11 h 10000"/>
              <a:gd name="connsiteX1" fmla="*/ 7099 w 9998"/>
              <a:gd name="connsiteY1" fmla="*/ 0 h 10000"/>
              <a:gd name="connsiteX2" fmla="*/ 7041 w 9998"/>
              <a:gd name="connsiteY2" fmla="*/ 9628 h 10000"/>
              <a:gd name="connsiteX3" fmla="*/ 9998 w 9998"/>
              <a:gd name="connsiteY3" fmla="*/ 9987 h 10000"/>
              <a:gd name="connsiteX4" fmla="*/ 1 w 9998"/>
              <a:gd name="connsiteY4" fmla="*/ 10000 h 10000"/>
              <a:gd name="connsiteX5" fmla="*/ 360 w 9998"/>
              <a:gd name="connsiteY5" fmla="*/ 11 h 10000"/>
              <a:gd name="connsiteX0" fmla="*/ 0 w 9640"/>
              <a:gd name="connsiteY0" fmla="*/ 11 h 10000"/>
              <a:gd name="connsiteX1" fmla="*/ 6740 w 9640"/>
              <a:gd name="connsiteY1" fmla="*/ 0 h 10000"/>
              <a:gd name="connsiteX2" fmla="*/ 6682 w 9640"/>
              <a:gd name="connsiteY2" fmla="*/ 9628 h 10000"/>
              <a:gd name="connsiteX3" fmla="*/ 9640 w 9640"/>
              <a:gd name="connsiteY3" fmla="*/ 9987 h 10000"/>
              <a:gd name="connsiteX4" fmla="*/ 302 w 9640"/>
              <a:gd name="connsiteY4" fmla="*/ 10000 h 10000"/>
              <a:gd name="connsiteX5" fmla="*/ 0 w 964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00"/>
              <a:gd name="connsiteY0" fmla="*/ 11 h 10000"/>
              <a:gd name="connsiteX1" fmla="*/ 6992 w 10000"/>
              <a:gd name="connsiteY1" fmla="*/ 0 h 10000"/>
              <a:gd name="connsiteX2" fmla="*/ 6932 w 10000"/>
              <a:gd name="connsiteY2" fmla="*/ 9628 h 10000"/>
              <a:gd name="connsiteX3" fmla="*/ 10000 w 10000"/>
              <a:gd name="connsiteY3" fmla="*/ 9987 h 10000"/>
              <a:gd name="connsiteX4" fmla="*/ 6 w 10000"/>
              <a:gd name="connsiteY4" fmla="*/ 10000 h 10000"/>
              <a:gd name="connsiteX5" fmla="*/ 0 w 10000"/>
              <a:gd name="connsiteY5" fmla="*/ 11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10000"/>
              <a:gd name="connsiteX1" fmla="*/ 7048 w 10056"/>
              <a:gd name="connsiteY1" fmla="*/ 0 h 10000"/>
              <a:gd name="connsiteX2" fmla="*/ 6988 w 10056"/>
              <a:gd name="connsiteY2" fmla="*/ 9628 h 10000"/>
              <a:gd name="connsiteX3" fmla="*/ 10056 w 10056"/>
              <a:gd name="connsiteY3" fmla="*/ 9987 h 10000"/>
              <a:gd name="connsiteX4" fmla="*/ 62 w 10056"/>
              <a:gd name="connsiteY4" fmla="*/ 10000 h 10000"/>
              <a:gd name="connsiteX5" fmla="*/ 0 w 10056"/>
              <a:gd name="connsiteY5" fmla="*/ 4 h 10000"/>
              <a:gd name="connsiteX0" fmla="*/ 0 w 10056"/>
              <a:gd name="connsiteY0" fmla="*/ 4 h 9991"/>
              <a:gd name="connsiteX1" fmla="*/ 7048 w 10056"/>
              <a:gd name="connsiteY1" fmla="*/ 0 h 9991"/>
              <a:gd name="connsiteX2" fmla="*/ 6988 w 10056"/>
              <a:gd name="connsiteY2" fmla="*/ 9628 h 9991"/>
              <a:gd name="connsiteX3" fmla="*/ 10056 w 10056"/>
              <a:gd name="connsiteY3" fmla="*/ 9987 h 9991"/>
              <a:gd name="connsiteX4" fmla="*/ 129 w 10056"/>
              <a:gd name="connsiteY4" fmla="*/ 9991 h 9991"/>
              <a:gd name="connsiteX5" fmla="*/ 0 w 10056"/>
              <a:gd name="connsiteY5" fmla="*/ 4 h 9991"/>
              <a:gd name="connsiteX0" fmla="*/ 0 w 10000"/>
              <a:gd name="connsiteY0" fmla="*/ 0 h 9996"/>
              <a:gd name="connsiteX1" fmla="*/ 6799 w 10000"/>
              <a:gd name="connsiteY1" fmla="*/ 3842 h 9996"/>
              <a:gd name="connsiteX2" fmla="*/ 6949 w 10000"/>
              <a:gd name="connsiteY2" fmla="*/ 9633 h 9996"/>
              <a:gd name="connsiteX3" fmla="*/ 10000 w 10000"/>
              <a:gd name="connsiteY3" fmla="*/ 9992 h 9996"/>
              <a:gd name="connsiteX4" fmla="*/ 128 w 10000"/>
              <a:gd name="connsiteY4" fmla="*/ 9996 h 9996"/>
              <a:gd name="connsiteX5" fmla="*/ 0 w 10000"/>
              <a:gd name="connsiteY5" fmla="*/ 0 h 9996"/>
              <a:gd name="connsiteX0" fmla="*/ 0 w 9895"/>
              <a:gd name="connsiteY0" fmla="*/ 11 h 6156"/>
              <a:gd name="connsiteX1" fmla="*/ 6694 w 9895"/>
              <a:gd name="connsiteY1" fmla="*/ 0 h 6156"/>
              <a:gd name="connsiteX2" fmla="*/ 6844 w 9895"/>
              <a:gd name="connsiteY2" fmla="*/ 5793 h 6156"/>
              <a:gd name="connsiteX3" fmla="*/ 9895 w 9895"/>
              <a:gd name="connsiteY3" fmla="*/ 6152 h 6156"/>
              <a:gd name="connsiteX4" fmla="*/ 23 w 9895"/>
              <a:gd name="connsiteY4" fmla="*/ 6156 h 6156"/>
              <a:gd name="connsiteX5" fmla="*/ 0 w 9895"/>
              <a:gd name="connsiteY5" fmla="*/ 11 h 6156"/>
              <a:gd name="connsiteX0" fmla="*/ 0 w 11007"/>
              <a:gd name="connsiteY0" fmla="*/ 7 h 10000"/>
              <a:gd name="connsiteX1" fmla="*/ 7772 w 11007"/>
              <a:gd name="connsiteY1" fmla="*/ 0 h 10000"/>
              <a:gd name="connsiteX2" fmla="*/ 7924 w 11007"/>
              <a:gd name="connsiteY2" fmla="*/ 9410 h 10000"/>
              <a:gd name="connsiteX3" fmla="*/ 11007 w 11007"/>
              <a:gd name="connsiteY3" fmla="*/ 9994 h 10000"/>
              <a:gd name="connsiteX4" fmla="*/ 1030 w 11007"/>
              <a:gd name="connsiteY4" fmla="*/ 10000 h 10000"/>
              <a:gd name="connsiteX5" fmla="*/ 0 w 11007"/>
              <a:gd name="connsiteY5" fmla="*/ 7 h 10000"/>
              <a:gd name="connsiteX0" fmla="*/ 0 w 11007"/>
              <a:gd name="connsiteY0" fmla="*/ 7 h 10000"/>
              <a:gd name="connsiteX1" fmla="*/ 7772 w 11007"/>
              <a:gd name="connsiteY1" fmla="*/ 0 h 10000"/>
              <a:gd name="connsiteX2" fmla="*/ 7924 w 11007"/>
              <a:gd name="connsiteY2" fmla="*/ 9410 h 10000"/>
              <a:gd name="connsiteX3" fmla="*/ 11007 w 11007"/>
              <a:gd name="connsiteY3" fmla="*/ 9994 h 10000"/>
              <a:gd name="connsiteX4" fmla="*/ 23 w 11007"/>
              <a:gd name="connsiteY4" fmla="*/ 10000 h 10000"/>
              <a:gd name="connsiteX5" fmla="*/ 0 w 11007"/>
              <a:gd name="connsiteY5" fmla="*/ 7 h 10000"/>
              <a:gd name="connsiteX0" fmla="*/ 76 w 10988"/>
              <a:gd name="connsiteY0" fmla="*/ 45 h 10000"/>
              <a:gd name="connsiteX1" fmla="*/ 7753 w 10988"/>
              <a:gd name="connsiteY1" fmla="*/ 0 h 10000"/>
              <a:gd name="connsiteX2" fmla="*/ 7905 w 10988"/>
              <a:gd name="connsiteY2" fmla="*/ 9410 h 10000"/>
              <a:gd name="connsiteX3" fmla="*/ 10988 w 10988"/>
              <a:gd name="connsiteY3" fmla="*/ 9994 h 10000"/>
              <a:gd name="connsiteX4" fmla="*/ 4 w 10988"/>
              <a:gd name="connsiteY4" fmla="*/ 10000 h 10000"/>
              <a:gd name="connsiteX5" fmla="*/ 76 w 10988"/>
              <a:gd name="connsiteY5" fmla="*/ 45 h 10000"/>
              <a:gd name="connsiteX0" fmla="*/ 16 w 10988"/>
              <a:gd name="connsiteY0" fmla="*/ 20 h 10000"/>
              <a:gd name="connsiteX1" fmla="*/ 7753 w 10988"/>
              <a:gd name="connsiteY1" fmla="*/ 0 h 10000"/>
              <a:gd name="connsiteX2" fmla="*/ 7905 w 10988"/>
              <a:gd name="connsiteY2" fmla="*/ 9410 h 10000"/>
              <a:gd name="connsiteX3" fmla="*/ 10988 w 10988"/>
              <a:gd name="connsiteY3" fmla="*/ 9994 h 10000"/>
              <a:gd name="connsiteX4" fmla="*/ 4 w 10988"/>
              <a:gd name="connsiteY4" fmla="*/ 10000 h 10000"/>
              <a:gd name="connsiteX5" fmla="*/ 16 w 10988"/>
              <a:gd name="connsiteY5" fmla="*/ 20 h 10000"/>
              <a:gd name="connsiteX0" fmla="*/ 16 w 10988"/>
              <a:gd name="connsiteY0" fmla="*/ 0 h 9980"/>
              <a:gd name="connsiteX1" fmla="*/ 7753 w 10988"/>
              <a:gd name="connsiteY1" fmla="*/ 0 h 9980"/>
              <a:gd name="connsiteX2" fmla="*/ 7905 w 10988"/>
              <a:gd name="connsiteY2" fmla="*/ 9390 h 9980"/>
              <a:gd name="connsiteX3" fmla="*/ 10988 w 10988"/>
              <a:gd name="connsiteY3" fmla="*/ 9974 h 9980"/>
              <a:gd name="connsiteX4" fmla="*/ 4 w 10988"/>
              <a:gd name="connsiteY4" fmla="*/ 9980 h 9980"/>
              <a:gd name="connsiteX5" fmla="*/ 16 w 10988"/>
              <a:gd name="connsiteY5" fmla="*/ 0 h 9980"/>
              <a:gd name="connsiteX0" fmla="*/ 0 w 9985"/>
              <a:gd name="connsiteY0" fmla="*/ 0 h 9994"/>
              <a:gd name="connsiteX1" fmla="*/ 7041 w 9985"/>
              <a:gd name="connsiteY1" fmla="*/ 0 h 9994"/>
              <a:gd name="connsiteX2" fmla="*/ 7179 w 9985"/>
              <a:gd name="connsiteY2" fmla="*/ 9409 h 9994"/>
              <a:gd name="connsiteX3" fmla="*/ 9985 w 9985"/>
              <a:gd name="connsiteY3" fmla="*/ 9994 h 9994"/>
              <a:gd name="connsiteX4" fmla="*/ 11 w 9985"/>
              <a:gd name="connsiteY4" fmla="*/ 9987 h 9994"/>
              <a:gd name="connsiteX5" fmla="*/ 0 w 9985"/>
              <a:gd name="connsiteY5" fmla="*/ 0 h 9994"/>
              <a:gd name="connsiteX0" fmla="*/ 0 w 10000"/>
              <a:gd name="connsiteY0" fmla="*/ 0 h 10000"/>
              <a:gd name="connsiteX1" fmla="*/ 7052 w 10000"/>
              <a:gd name="connsiteY1" fmla="*/ 0 h 10000"/>
              <a:gd name="connsiteX2" fmla="*/ 7190 w 10000"/>
              <a:gd name="connsiteY2" fmla="*/ 9415 h 10000"/>
              <a:gd name="connsiteX3" fmla="*/ 10000 w 10000"/>
              <a:gd name="connsiteY3" fmla="*/ 10000 h 10000"/>
              <a:gd name="connsiteX4" fmla="*/ 11 w 10000"/>
              <a:gd name="connsiteY4" fmla="*/ 9996 h 10000"/>
              <a:gd name="connsiteX5" fmla="*/ 0 w 10000"/>
              <a:gd name="connsiteY5" fmla="*/ 0 h 10000"/>
              <a:gd name="connsiteX0" fmla="*/ 35 w 10035"/>
              <a:gd name="connsiteY0" fmla="*/ 0 h 10009"/>
              <a:gd name="connsiteX1" fmla="*/ 7087 w 10035"/>
              <a:gd name="connsiteY1" fmla="*/ 0 h 10009"/>
              <a:gd name="connsiteX2" fmla="*/ 7225 w 10035"/>
              <a:gd name="connsiteY2" fmla="*/ 9415 h 10009"/>
              <a:gd name="connsiteX3" fmla="*/ 10035 w 10035"/>
              <a:gd name="connsiteY3" fmla="*/ 10000 h 10009"/>
              <a:gd name="connsiteX4" fmla="*/ 3 w 10035"/>
              <a:gd name="connsiteY4" fmla="*/ 10009 h 10009"/>
              <a:gd name="connsiteX5" fmla="*/ 35 w 10035"/>
              <a:gd name="connsiteY5" fmla="*/ 0 h 10009"/>
              <a:gd name="connsiteX0" fmla="*/ 0 w 10000"/>
              <a:gd name="connsiteY0" fmla="*/ 0 h 10000"/>
              <a:gd name="connsiteX1" fmla="*/ 7052 w 10000"/>
              <a:gd name="connsiteY1" fmla="*/ 0 h 10000"/>
              <a:gd name="connsiteX2" fmla="*/ 7190 w 10000"/>
              <a:gd name="connsiteY2" fmla="*/ 9415 h 10000"/>
              <a:gd name="connsiteX3" fmla="*/ 10000 w 10000"/>
              <a:gd name="connsiteY3" fmla="*/ 10000 h 10000"/>
              <a:gd name="connsiteX4" fmla="*/ 66 w 10000"/>
              <a:gd name="connsiteY4" fmla="*/ 9989 h 10000"/>
              <a:gd name="connsiteX5" fmla="*/ 0 w 10000"/>
              <a:gd name="connsiteY5" fmla="*/ 0 h 10000"/>
              <a:gd name="connsiteX0" fmla="*/ 0 w 10000"/>
              <a:gd name="connsiteY0" fmla="*/ 0 h 10002"/>
              <a:gd name="connsiteX1" fmla="*/ 7052 w 10000"/>
              <a:gd name="connsiteY1" fmla="*/ 0 h 10002"/>
              <a:gd name="connsiteX2" fmla="*/ 7190 w 10000"/>
              <a:gd name="connsiteY2" fmla="*/ 9415 h 10002"/>
              <a:gd name="connsiteX3" fmla="*/ 10000 w 10000"/>
              <a:gd name="connsiteY3" fmla="*/ 10000 h 10002"/>
              <a:gd name="connsiteX4" fmla="*/ 23 w 10000"/>
              <a:gd name="connsiteY4" fmla="*/ 10002 h 10002"/>
              <a:gd name="connsiteX5" fmla="*/ 0 w 10000"/>
              <a:gd name="connsiteY5" fmla="*/ 0 h 10002"/>
              <a:gd name="connsiteX0" fmla="*/ 164 w 10164"/>
              <a:gd name="connsiteY0" fmla="*/ 0 h 10000"/>
              <a:gd name="connsiteX1" fmla="*/ 7216 w 10164"/>
              <a:gd name="connsiteY1" fmla="*/ 0 h 10000"/>
              <a:gd name="connsiteX2" fmla="*/ 7354 w 10164"/>
              <a:gd name="connsiteY2" fmla="*/ 9415 h 10000"/>
              <a:gd name="connsiteX3" fmla="*/ 10164 w 10164"/>
              <a:gd name="connsiteY3" fmla="*/ 10000 h 10000"/>
              <a:gd name="connsiteX4" fmla="*/ 2 w 10164"/>
              <a:gd name="connsiteY4" fmla="*/ 9999 h 10000"/>
              <a:gd name="connsiteX5" fmla="*/ 164 w 10164"/>
              <a:gd name="connsiteY5" fmla="*/ 0 h 10000"/>
              <a:gd name="connsiteX0" fmla="*/ 163 w 10163"/>
              <a:gd name="connsiteY0" fmla="*/ 0 h 10000"/>
              <a:gd name="connsiteX1" fmla="*/ 7215 w 10163"/>
              <a:gd name="connsiteY1" fmla="*/ 0 h 10000"/>
              <a:gd name="connsiteX2" fmla="*/ 7353 w 10163"/>
              <a:gd name="connsiteY2" fmla="*/ 9415 h 10000"/>
              <a:gd name="connsiteX3" fmla="*/ 10163 w 10163"/>
              <a:gd name="connsiteY3" fmla="*/ 10000 h 10000"/>
              <a:gd name="connsiteX4" fmla="*/ 1 w 10163"/>
              <a:gd name="connsiteY4" fmla="*/ 9999 h 10000"/>
              <a:gd name="connsiteX5" fmla="*/ 163 w 10163"/>
              <a:gd name="connsiteY5" fmla="*/ 0 h 10000"/>
              <a:gd name="connsiteX0" fmla="*/ 0 w 10174"/>
              <a:gd name="connsiteY0" fmla="*/ 0 h 10000"/>
              <a:gd name="connsiteX1" fmla="*/ 7226 w 10174"/>
              <a:gd name="connsiteY1" fmla="*/ 0 h 10000"/>
              <a:gd name="connsiteX2" fmla="*/ 7364 w 10174"/>
              <a:gd name="connsiteY2" fmla="*/ 9415 h 10000"/>
              <a:gd name="connsiteX3" fmla="*/ 10174 w 10174"/>
              <a:gd name="connsiteY3" fmla="*/ 10000 h 10000"/>
              <a:gd name="connsiteX4" fmla="*/ 12 w 10174"/>
              <a:gd name="connsiteY4" fmla="*/ 9999 h 10000"/>
              <a:gd name="connsiteX5" fmla="*/ 0 w 10174"/>
              <a:gd name="connsiteY5" fmla="*/ 0 h 10000"/>
              <a:gd name="connsiteX0" fmla="*/ 0 w 10174"/>
              <a:gd name="connsiteY0" fmla="*/ 0 h 10000"/>
              <a:gd name="connsiteX1" fmla="*/ 7226 w 10174"/>
              <a:gd name="connsiteY1" fmla="*/ 0 h 10000"/>
              <a:gd name="connsiteX2" fmla="*/ 7364 w 10174"/>
              <a:gd name="connsiteY2" fmla="*/ 9415 h 10000"/>
              <a:gd name="connsiteX3" fmla="*/ 10174 w 10174"/>
              <a:gd name="connsiteY3" fmla="*/ 10000 h 10000"/>
              <a:gd name="connsiteX4" fmla="*/ 12 w 10174"/>
              <a:gd name="connsiteY4" fmla="*/ 9999 h 10000"/>
              <a:gd name="connsiteX5" fmla="*/ 0 w 10174"/>
              <a:gd name="connsiteY5" fmla="*/ 0 h 10000"/>
              <a:gd name="connsiteX0" fmla="*/ 0 w 10174"/>
              <a:gd name="connsiteY0" fmla="*/ 3 h 10003"/>
              <a:gd name="connsiteX1" fmla="*/ 7335 w 10174"/>
              <a:gd name="connsiteY1" fmla="*/ 0 h 10003"/>
              <a:gd name="connsiteX2" fmla="*/ 7364 w 10174"/>
              <a:gd name="connsiteY2" fmla="*/ 9418 h 10003"/>
              <a:gd name="connsiteX3" fmla="*/ 10174 w 10174"/>
              <a:gd name="connsiteY3" fmla="*/ 10003 h 10003"/>
              <a:gd name="connsiteX4" fmla="*/ 12 w 10174"/>
              <a:gd name="connsiteY4" fmla="*/ 10002 h 10003"/>
              <a:gd name="connsiteX5" fmla="*/ 0 w 10174"/>
              <a:gd name="connsiteY5" fmla="*/ 3 h 10003"/>
              <a:gd name="connsiteX0" fmla="*/ 0 w 10174"/>
              <a:gd name="connsiteY0" fmla="*/ 6 h 10006"/>
              <a:gd name="connsiteX1" fmla="*/ 7346 w 10174"/>
              <a:gd name="connsiteY1" fmla="*/ 0 h 10006"/>
              <a:gd name="connsiteX2" fmla="*/ 7364 w 10174"/>
              <a:gd name="connsiteY2" fmla="*/ 9421 h 10006"/>
              <a:gd name="connsiteX3" fmla="*/ 10174 w 10174"/>
              <a:gd name="connsiteY3" fmla="*/ 10006 h 10006"/>
              <a:gd name="connsiteX4" fmla="*/ 12 w 10174"/>
              <a:gd name="connsiteY4" fmla="*/ 10005 h 10006"/>
              <a:gd name="connsiteX5" fmla="*/ 0 w 10174"/>
              <a:gd name="connsiteY5" fmla="*/ 6 h 10006"/>
              <a:gd name="connsiteX0" fmla="*/ 0 w 10174"/>
              <a:gd name="connsiteY0" fmla="*/ 6 h 10006"/>
              <a:gd name="connsiteX1" fmla="*/ 7346 w 10174"/>
              <a:gd name="connsiteY1" fmla="*/ 0 h 10006"/>
              <a:gd name="connsiteX2" fmla="*/ 7364 w 10174"/>
              <a:gd name="connsiteY2" fmla="*/ 9421 h 10006"/>
              <a:gd name="connsiteX3" fmla="*/ 10174 w 10174"/>
              <a:gd name="connsiteY3" fmla="*/ 10006 h 10006"/>
              <a:gd name="connsiteX4" fmla="*/ 12 w 10174"/>
              <a:gd name="connsiteY4" fmla="*/ 10005 h 10006"/>
              <a:gd name="connsiteX5" fmla="*/ 0 w 10174"/>
              <a:gd name="connsiteY5" fmla="*/ 6 h 10006"/>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0 w 10174"/>
              <a:gd name="connsiteY0" fmla="*/ 9 h 10009"/>
              <a:gd name="connsiteX1" fmla="*/ 7346 w 10174"/>
              <a:gd name="connsiteY1" fmla="*/ 0 h 10009"/>
              <a:gd name="connsiteX2" fmla="*/ 7364 w 10174"/>
              <a:gd name="connsiteY2" fmla="*/ 9424 h 10009"/>
              <a:gd name="connsiteX3" fmla="*/ 10174 w 10174"/>
              <a:gd name="connsiteY3" fmla="*/ 10009 h 10009"/>
              <a:gd name="connsiteX4" fmla="*/ 12 w 10174"/>
              <a:gd name="connsiteY4" fmla="*/ 10008 h 10009"/>
              <a:gd name="connsiteX5" fmla="*/ 0 w 10174"/>
              <a:gd name="connsiteY5" fmla="*/ 9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550 w 10163"/>
              <a:gd name="connsiteY0" fmla="*/ 3 h 10009"/>
              <a:gd name="connsiteX1" fmla="*/ 7335 w 10163"/>
              <a:gd name="connsiteY1" fmla="*/ 0 h 10009"/>
              <a:gd name="connsiteX2" fmla="*/ 7353 w 10163"/>
              <a:gd name="connsiteY2" fmla="*/ 9424 h 10009"/>
              <a:gd name="connsiteX3" fmla="*/ 10163 w 10163"/>
              <a:gd name="connsiteY3" fmla="*/ 10009 h 10009"/>
              <a:gd name="connsiteX4" fmla="*/ 1 w 10163"/>
              <a:gd name="connsiteY4" fmla="*/ 10008 h 10009"/>
              <a:gd name="connsiteX5" fmla="*/ 550 w 10163"/>
              <a:gd name="connsiteY5" fmla="*/ 3 h 10009"/>
              <a:gd name="connsiteX0" fmla="*/ 0 w 9613"/>
              <a:gd name="connsiteY0" fmla="*/ 3 h 10009"/>
              <a:gd name="connsiteX1" fmla="*/ 6785 w 9613"/>
              <a:gd name="connsiteY1" fmla="*/ 0 h 10009"/>
              <a:gd name="connsiteX2" fmla="*/ 6803 w 9613"/>
              <a:gd name="connsiteY2" fmla="*/ 9424 h 10009"/>
              <a:gd name="connsiteX3" fmla="*/ 9613 w 9613"/>
              <a:gd name="connsiteY3" fmla="*/ 10009 h 10009"/>
              <a:gd name="connsiteX4" fmla="*/ 95 w 9613"/>
              <a:gd name="connsiteY4" fmla="*/ 9998 h 10009"/>
              <a:gd name="connsiteX5" fmla="*/ 0 w 9613"/>
              <a:gd name="connsiteY5" fmla="*/ 3 h 10009"/>
              <a:gd name="connsiteX0" fmla="*/ 0 w 10000"/>
              <a:gd name="connsiteY0" fmla="*/ 3 h 10000"/>
              <a:gd name="connsiteX1" fmla="*/ 7058 w 10000"/>
              <a:gd name="connsiteY1" fmla="*/ 0 h 10000"/>
              <a:gd name="connsiteX2" fmla="*/ 7077 w 10000"/>
              <a:gd name="connsiteY2" fmla="*/ 9416 h 10000"/>
              <a:gd name="connsiteX3" fmla="*/ 10000 w 10000"/>
              <a:gd name="connsiteY3" fmla="*/ 10000 h 10000"/>
              <a:gd name="connsiteX4" fmla="*/ 14 w 10000"/>
              <a:gd name="connsiteY4" fmla="*/ 9999 h 10000"/>
              <a:gd name="connsiteX5" fmla="*/ 0 w 10000"/>
              <a:gd name="connsiteY5" fmla="*/ 3 h 1000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10000" h="10000">
                <a:moveTo>
                  <a:pt x="0" y="3"/>
                </a:moveTo>
                <a:lnTo>
                  <a:pt x="7058" y="0"/>
                </a:lnTo>
                <a:cubicBezTo>
                  <a:pt x="7049" y="2528"/>
                  <a:pt x="7068" y="8825"/>
                  <a:pt x="7077" y="9416"/>
                </a:cubicBezTo>
                <a:cubicBezTo>
                  <a:pt x="7052" y="9743"/>
                  <a:pt x="8384" y="10000"/>
                  <a:pt x="10000" y="10000"/>
                </a:cubicBezTo>
                <a:lnTo>
                  <a:pt x="14" y="9999"/>
                </a:lnTo>
                <a:cubicBezTo>
                  <a:pt x="7" y="7401"/>
                  <a:pt x="15" y="1749"/>
                  <a:pt x="0" y="3"/>
                </a:cubicBezTo>
                <a:close/>
              </a:path>
            </a:pathLst>
          </a:custGeom>
          <a:solidFill>
            <a:srgbClr val="AA0065"/>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2" name="TextBox 1">
            <a:extLst>
              <a:ext uri="{FF2B5EF4-FFF2-40B4-BE49-F238E27FC236}">
                <a16:creationId xmlns:a16="http://schemas.microsoft.com/office/drawing/2014/main" id="{4FAD86AC-4C87-1793-B8DA-143F6DFB4B75}"/>
              </a:ext>
            </a:extLst>
          </p:cNvPr>
          <p:cNvSpPr txBox="1"/>
          <p:nvPr userDrawn="1"/>
        </p:nvSpPr>
        <p:spPr>
          <a:xfrm>
            <a:off x="10246589" y="585744"/>
            <a:ext cx="2225725" cy="419695"/>
          </a:xfrm>
          <a:prstGeom prst="rect">
            <a:avLst/>
          </a:prstGeom>
          <a:noFill/>
        </p:spPr>
        <p:txBody>
          <a:bodyPr wrap="square" rtlCol="0">
            <a:spAutoFit/>
          </a:bodyPr>
          <a:lstStyle/>
          <a:p>
            <a:r>
              <a:rPr lang="en-GB" sz="2400" dirty="0">
                <a:solidFill>
                  <a:schemeClr val="bg1"/>
                </a:solidFill>
              </a:rPr>
              <a:t>Meta-analysis</a:t>
            </a:r>
          </a:p>
        </p:txBody>
      </p:sp>
    </p:spTree>
    <p:extLst>
      <p:ext uri="{BB962C8B-B14F-4D97-AF65-F5344CB8AC3E}">
        <p14:creationId xmlns:p14="http://schemas.microsoft.com/office/powerpoint/2010/main" val="2059782281"/>
      </p:ext>
    </p:extLst>
  </p:cSld>
  <p:clrMapOvr>
    <a:masterClrMapping/>
  </p:clrMapOvr>
</p:sldLayout>
</file>

<file path=ppt/slideMasters/_rels/slideMaster1.xml.rels><?xml version="1.0" encoding="UTF-8" standalone="yes"?>
<Relationships xmlns="http://schemas.openxmlformats.org/package/2006/relationships"><Relationship Id="rId3" Type="http://schemas.openxmlformats.org/officeDocument/2006/relationships/slideLayout" Target="../slideLayouts/slideLayout3.xml"/><Relationship Id="rId2" Type="http://schemas.openxmlformats.org/officeDocument/2006/relationships/slideLayout" Target="../slideLayouts/slideLayout2.xml"/><Relationship Id="rId1" Type="http://schemas.openxmlformats.org/officeDocument/2006/relationships/slideLayout" Target="../slideLayouts/slideLayout1.xml"/><Relationship Id="rId5" Type="http://schemas.openxmlformats.org/officeDocument/2006/relationships/theme" Target="../theme/theme1.xml"/><Relationship Id="rId4" Type="http://schemas.openxmlformats.org/officeDocument/2006/relationships/slideLayout" Target="../slideLayouts/slideLayout4.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endParaRPr lang="en-GB"/>
          </a:p>
        </p:txBody>
      </p:sp>
      <p:sp>
        <p:nvSpPr>
          <p:cNvPr id="3" name="Text Placeholder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4" name="Date Placeholder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0F14BA06-560F-4272-BD1D-D3D251BC0A82}" type="datetimeFigureOut">
              <a:rPr lang="en-GB" smtClean="0"/>
              <a:t>13/08/2024</a:t>
            </a:fld>
            <a:endParaRPr lang="en-GB"/>
          </a:p>
        </p:txBody>
      </p:sp>
      <p:sp>
        <p:nvSpPr>
          <p:cNvPr id="5" name="Footer Placeholder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GB"/>
          </a:p>
        </p:txBody>
      </p:sp>
      <p:sp>
        <p:nvSpPr>
          <p:cNvPr id="6" name="Slide Number Placeholder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A22DF36B-8F18-4F81-92A8-26E2BC629512}" type="slidenum">
              <a:rPr lang="en-GB" smtClean="0"/>
              <a:t>‹#›</a:t>
            </a:fld>
            <a:endParaRPr lang="en-GB"/>
          </a:p>
        </p:txBody>
      </p:sp>
    </p:spTree>
    <p:extLst>
      <p:ext uri="{BB962C8B-B14F-4D97-AF65-F5344CB8AC3E}">
        <p14:creationId xmlns:p14="http://schemas.microsoft.com/office/powerpoint/2010/main" val="690031264"/>
      </p:ext>
    </p:extLst>
  </p:cSld>
  <p:clrMap bg1="lt1" tx1="dk1" bg2="lt2" tx2="dk2" accent1="accent1" accent2="accent2" accent3="accent3" accent4="accent4" accent5="accent5" accent6="accent6" hlink="hlink" folHlink="folHlink"/>
  <p:sldLayoutIdLst>
    <p:sldLayoutId id="2147483649" r:id="rId1"/>
    <p:sldLayoutId id="2147483653" r:id="rId2"/>
    <p:sldLayoutId id="2147483652" r:id="rId3"/>
    <p:sldLayoutId id="2147483654" r:id="rId4"/>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image" Target="../media/image2.png"/><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4" name="Title 1"/>
          <p:cNvSpPr txBox="1">
            <a:spLocks/>
          </p:cNvSpPr>
          <p:nvPr/>
        </p:nvSpPr>
        <p:spPr>
          <a:xfrm>
            <a:off x="0" y="0"/>
            <a:ext cx="10233660" cy="1085673"/>
          </a:xfrm>
          <a:prstGeom prst="rect">
            <a:avLst/>
          </a:prstGeom>
          <a:noFill/>
        </p:spPr>
        <p:txBody>
          <a:bodyPr vert="horz" lIns="91440" tIns="45720" rIns="91440" bIns="45720" rtlCol="0" anchor="ctr">
            <a:normAutofit/>
          </a:bodyPr>
          <a:lstStyle>
            <a:lvl1pPr algn="ctr" defTabSz="914400" rtl="0" eaLnBrk="1" latinLnBrk="0" hangingPunct="1">
              <a:lnSpc>
                <a:spcPct val="90000"/>
              </a:lnSpc>
              <a:spcBef>
                <a:spcPct val="0"/>
              </a:spcBef>
              <a:buNone/>
              <a:defRPr sz="6000" kern="1200">
                <a:solidFill>
                  <a:schemeClr val="tx1"/>
                </a:solidFill>
                <a:latin typeface="+mj-lt"/>
                <a:ea typeface="+mj-ea"/>
                <a:cs typeface="+mj-cs"/>
              </a:defRPr>
            </a:lvl1pPr>
          </a:lstStyle>
          <a:p>
            <a:pPr marL="216000" algn="l"/>
            <a:r>
              <a:rPr lang="en-GB" sz="2800" b="1" dirty="0">
                <a:solidFill>
                  <a:schemeClr val="bg1"/>
                </a:solidFill>
              </a:rPr>
              <a:t>Efficacy and safety of fenoldopam for the treatment of hypertensive crises in children with kidney disease: a retrospective study</a:t>
            </a:r>
          </a:p>
        </p:txBody>
      </p:sp>
      <p:sp>
        <p:nvSpPr>
          <p:cNvPr id="3" name="TextBox 2">
            <a:extLst>
              <a:ext uri="{FF2B5EF4-FFF2-40B4-BE49-F238E27FC236}">
                <a16:creationId xmlns:a16="http://schemas.microsoft.com/office/drawing/2014/main" id="{228B6892-1648-DF62-E831-66BF54B0FEA3}"/>
              </a:ext>
            </a:extLst>
          </p:cNvPr>
          <p:cNvSpPr txBox="1"/>
          <p:nvPr/>
        </p:nvSpPr>
        <p:spPr>
          <a:xfrm>
            <a:off x="254830" y="1096385"/>
            <a:ext cx="11744337" cy="541046"/>
          </a:xfrm>
          <a:prstGeom prst="rect">
            <a:avLst/>
          </a:prstGeom>
          <a:noFill/>
        </p:spPr>
        <p:txBody>
          <a:bodyPr wrap="square" rtlCol="0">
            <a:spAutoFit/>
          </a:bodyPr>
          <a:lstStyle/>
          <a:p>
            <a:pPr algn="just">
              <a:lnSpc>
                <a:spcPct val="80000"/>
              </a:lnSpc>
            </a:pPr>
            <a:r>
              <a:rPr lang="en-GB" sz="1800" b="1" dirty="0">
                <a:solidFill>
                  <a:schemeClr val="bg1"/>
                </a:solidFill>
              </a:rPr>
              <a:t>HYPOTHESIS</a:t>
            </a:r>
            <a:r>
              <a:rPr lang="en-GB" sz="1800" dirty="0">
                <a:solidFill>
                  <a:schemeClr val="bg1"/>
                </a:solidFill>
              </a:rPr>
              <a:t>: </a:t>
            </a:r>
            <a:r>
              <a:rPr lang="en-US" sz="1800" dirty="0">
                <a:solidFill>
                  <a:schemeClr val="bg1"/>
                </a:solidFill>
              </a:rPr>
              <a:t>assess the efficacy and safety of fenoldopam in the management of hypertensive urgencies and emergencies of children affected by acute or chronic kidney disease in a monocentric cohort of children.</a:t>
            </a:r>
            <a:r>
              <a:rPr lang="it-IT" sz="1800" dirty="0">
                <a:solidFill>
                  <a:schemeClr val="bg1"/>
                </a:solidFill>
              </a:rPr>
              <a:t> </a:t>
            </a:r>
            <a:endParaRPr lang="en-GB" sz="1800" dirty="0">
              <a:solidFill>
                <a:schemeClr val="bg1"/>
              </a:solidFill>
            </a:endParaRPr>
          </a:p>
        </p:txBody>
      </p:sp>
      <p:sp>
        <p:nvSpPr>
          <p:cNvPr id="5" name="TextBox 4">
            <a:extLst>
              <a:ext uri="{FF2B5EF4-FFF2-40B4-BE49-F238E27FC236}">
                <a16:creationId xmlns:a16="http://schemas.microsoft.com/office/drawing/2014/main" id="{A80C6002-7C3F-D901-2E37-E725207AAA1E}"/>
              </a:ext>
            </a:extLst>
          </p:cNvPr>
          <p:cNvSpPr txBox="1"/>
          <p:nvPr/>
        </p:nvSpPr>
        <p:spPr>
          <a:xfrm>
            <a:off x="7650039" y="5686867"/>
            <a:ext cx="4108032" cy="400110"/>
          </a:xfrm>
          <a:prstGeom prst="rect">
            <a:avLst/>
          </a:prstGeom>
          <a:noFill/>
        </p:spPr>
        <p:txBody>
          <a:bodyPr wrap="square" rtlCol="0">
            <a:spAutoFit/>
          </a:bodyPr>
          <a:lstStyle/>
          <a:p>
            <a:r>
              <a:rPr lang="en-GB" sz="2000" b="1" dirty="0" err="1">
                <a:solidFill>
                  <a:schemeClr val="bg1"/>
                </a:solidFill>
                <a:latin typeface="+mj-lt"/>
              </a:rPr>
              <a:t>Bertazza</a:t>
            </a:r>
            <a:r>
              <a:rPr lang="en-GB" sz="2000" b="1" dirty="0">
                <a:solidFill>
                  <a:schemeClr val="bg1"/>
                </a:solidFill>
                <a:latin typeface="+mj-lt"/>
              </a:rPr>
              <a:t> Partigiani et al. 2024</a:t>
            </a:r>
            <a:endParaRPr lang="en-GB" sz="1400" b="1" dirty="0">
              <a:solidFill>
                <a:schemeClr val="bg1"/>
              </a:solidFill>
              <a:latin typeface="+mj-lt"/>
            </a:endParaRPr>
          </a:p>
        </p:txBody>
      </p:sp>
      <p:sp>
        <p:nvSpPr>
          <p:cNvPr id="6" name="TextBox 5">
            <a:extLst>
              <a:ext uri="{FF2B5EF4-FFF2-40B4-BE49-F238E27FC236}">
                <a16:creationId xmlns:a16="http://schemas.microsoft.com/office/drawing/2014/main" id="{A7D8B74F-E6D1-9E52-9D66-BB2127F9D94A}"/>
              </a:ext>
            </a:extLst>
          </p:cNvPr>
          <p:cNvSpPr txBox="1"/>
          <p:nvPr/>
        </p:nvSpPr>
        <p:spPr>
          <a:xfrm>
            <a:off x="115919" y="5716915"/>
            <a:ext cx="7361951" cy="1200329"/>
          </a:xfrm>
          <a:prstGeom prst="rect">
            <a:avLst/>
          </a:prstGeom>
          <a:noFill/>
        </p:spPr>
        <p:txBody>
          <a:bodyPr wrap="square" rtlCol="0">
            <a:spAutoFit/>
          </a:bodyPr>
          <a:lstStyle/>
          <a:p>
            <a:pPr algn="just">
              <a:lnSpc>
                <a:spcPct val="90000"/>
              </a:lnSpc>
              <a:spcAft>
                <a:spcPts val="600"/>
              </a:spcAft>
            </a:pPr>
            <a:r>
              <a:rPr lang="en-GB" sz="1600" b="1" dirty="0">
                <a:solidFill>
                  <a:schemeClr val="bg1"/>
                </a:solidFill>
              </a:rPr>
              <a:t>CONCLUSION</a:t>
            </a:r>
            <a:r>
              <a:rPr lang="en-GB" sz="1600" dirty="0">
                <a:solidFill>
                  <a:schemeClr val="bg1"/>
                </a:solidFill>
              </a:rPr>
              <a:t>: </a:t>
            </a:r>
            <a:r>
              <a:rPr lang="en-US" sz="1600" dirty="0">
                <a:solidFill>
                  <a:schemeClr val="bg1"/>
                </a:solidFill>
              </a:rPr>
              <a:t>Fenoldopam seems effective and safe for treatment of hypertensive crises in children with kidney disease, with low incidence of hypotension and other side effects, but initial dose should not exceed 0.2 mcg/kg/min in the first 8 hours. Strict BP monitoring is required to identify a possible excessive drop pressure in the first hours of infusion.</a:t>
            </a:r>
            <a:endParaRPr lang="it-IT" sz="1600" dirty="0">
              <a:solidFill>
                <a:schemeClr val="bg1"/>
              </a:solidFill>
            </a:endParaRPr>
          </a:p>
        </p:txBody>
      </p:sp>
      <p:sp>
        <p:nvSpPr>
          <p:cNvPr id="52" name="TextBox 59">
            <a:extLst>
              <a:ext uri="{FF2B5EF4-FFF2-40B4-BE49-F238E27FC236}">
                <a16:creationId xmlns:a16="http://schemas.microsoft.com/office/drawing/2014/main" id="{D67A3490-914C-B0B2-4DBB-16E10CB5D2B7}"/>
              </a:ext>
            </a:extLst>
          </p:cNvPr>
          <p:cNvSpPr txBox="1"/>
          <p:nvPr/>
        </p:nvSpPr>
        <p:spPr>
          <a:xfrm>
            <a:off x="140891" y="4280840"/>
            <a:ext cx="2362043" cy="954107"/>
          </a:xfrm>
          <a:prstGeom prst="rect">
            <a:avLst/>
          </a:prstGeom>
          <a:noFill/>
        </p:spPr>
        <p:txBody>
          <a:bodyPr wrap="square" rtlCol="0">
            <a:spAutoFit/>
          </a:bodyPr>
          <a:lstStyle/>
          <a:p>
            <a:r>
              <a:rPr lang="en-US" sz="1400" b="1" dirty="0">
                <a:solidFill>
                  <a:srgbClr val="AA0065"/>
                </a:solidFill>
              </a:rPr>
              <a:t>-74 pediatric patients with hypertensive crisis </a:t>
            </a:r>
          </a:p>
          <a:p>
            <a:r>
              <a:rPr lang="en-US" sz="1400" b="1" dirty="0">
                <a:solidFill>
                  <a:srgbClr val="296DC0"/>
                </a:solidFill>
              </a:rPr>
              <a:t>-102 fenoldopam infusions</a:t>
            </a:r>
          </a:p>
          <a:p>
            <a:endParaRPr lang="en-GB" sz="1400" dirty="0">
              <a:solidFill>
                <a:srgbClr val="AA0065"/>
              </a:solidFill>
            </a:endParaRPr>
          </a:p>
        </p:txBody>
      </p:sp>
      <p:sp>
        <p:nvSpPr>
          <p:cNvPr id="53" name="Freeform: Shape 46">
            <a:extLst>
              <a:ext uri="{FF2B5EF4-FFF2-40B4-BE49-F238E27FC236}">
                <a16:creationId xmlns:a16="http://schemas.microsoft.com/office/drawing/2014/main" id="{AF7AE4F2-CCDB-4E23-092D-799278FE29D3}"/>
              </a:ext>
            </a:extLst>
          </p:cNvPr>
          <p:cNvSpPr/>
          <p:nvPr/>
        </p:nvSpPr>
        <p:spPr>
          <a:xfrm>
            <a:off x="1094776" y="3429000"/>
            <a:ext cx="386084" cy="800172"/>
          </a:xfrm>
          <a:custGeom>
            <a:avLst/>
            <a:gdLst>
              <a:gd name="connsiteX0" fmla="*/ 427832 w 855663"/>
              <a:gd name="connsiteY0" fmla="*/ 350043 h 1750218"/>
              <a:gd name="connsiteX1" fmla="*/ 556181 w 855663"/>
              <a:gd name="connsiteY1" fmla="*/ 365601 h 1750218"/>
              <a:gd name="connsiteX2" fmla="*/ 719535 w 855663"/>
              <a:gd name="connsiteY2" fmla="*/ 451168 h 1750218"/>
              <a:gd name="connsiteX3" fmla="*/ 742872 w 855663"/>
              <a:gd name="connsiteY3" fmla="*/ 493950 h 1750218"/>
              <a:gd name="connsiteX4" fmla="*/ 851774 w 855663"/>
              <a:gd name="connsiteY4" fmla="*/ 956786 h 1750218"/>
              <a:gd name="connsiteX5" fmla="*/ 855663 w 855663"/>
              <a:gd name="connsiteY5" fmla="*/ 976232 h 1750218"/>
              <a:gd name="connsiteX6" fmla="*/ 777876 w 855663"/>
              <a:gd name="connsiteY6" fmla="*/ 1054020 h 1750218"/>
              <a:gd name="connsiteX7" fmla="*/ 703977 w 855663"/>
              <a:gd name="connsiteY7" fmla="*/ 995680 h 1750218"/>
              <a:gd name="connsiteX8" fmla="*/ 622301 w 855663"/>
              <a:gd name="connsiteY8" fmla="*/ 657304 h 1750218"/>
              <a:gd name="connsiteX9" fmla="*/ 622301 w 855663"/>
              <a:gd name="connsiteY9" fmla="*/ 1750218 h 1750218"/>
              <a:gd name="connsiteX10" fmla="*/ 466726 w 855663"/>
              <a:gd name="connsiteY10" fmla="*/ 1750218 h 1750218"/>
              <a:gd name="connsiteX11" fmla="*/ 466726 w 855663"/>
              <a:gd name="connsiteY11" fmla="*/ 1050131 h 1750218"/>
              <a:gd name="connsiteX12" fmla="*/ 388938 w 855663"/>
              <a:gd name="connsiteY12" fmla="*/ 1050131 h 1750218"/>
              <a:gd name="connsiteX13" fmla="*/ 388938 w 855663"/>
              <a:gd name="connsiteY13" fmla="*/ 1750218 h 1750218"/>
              <a:gd name="connsiteX14" fmla="*/ 233363 w 855663"/>
              <a:gd name="connsiteY14" fmla="*/ 1750218 h 1750218"/>
              <a:gd name="connsiteX15" fmla="*/ 233363 w 855663"/>
              <a:gd name="connsiteY15" fmla="*/ 661193 h 1750218"/>
              <a:gd name="connsiteX16" fmla="*/ 151686 w 855663"/>
              <a:gd name="connsiteY16" fmla="*/ 999569 h 1750218"/>
              <a:gd name="connsiteX17" fmla="*/ 77788 w 855663"/>
              <a:gd name="connsiteY17" fmla="*/ 1057910 h 1750218"/>
              <a:gd name="connsiteX18" fmla="*/ 0 w 855663"/>
              <a:gd name="connsiteY18" fmla="*/ 980123 h 1750218"/>
              <a:gd name="connsiteX19" fmla="*/ 3889 w 855663"/>
              <a:gd name="connsiteY19" fmla="*/ 960675 h 1750218"/>
              <a:gd name="connsiteX20" fmla="*/ 112792 w 855663"/>
              <a:gd name="connsiteY20" fmla="*/ 497840 h 1750218"/>
              <a:gd name="connsiteX21" fmla="*/ 136129 w 855663"/>
              <a:gd name="connsiteY21" fmla="*/ 455057 h 1750218"/>
              <a:gd name="connsiteX22" fmla="*/ 299482 w 855663"/>
              <a:gd name="connsiteY22" fmla="*/ 369490 h 1750218"/>
              <a:gd name="connsiteX23" fmla="*/ 427832 w 855663"/>
              <a:gd name="connsiteY23" fmla="*/ 350043 h 1750218"/>
              <a:gd name="connsiteX24" fmla="*/ 427831 w 855663"/>
              <a:gd name="connsiteY24" fmla="*/ 0 h 1750218"/>
              <a:gd name="connsiteX25" fmla="*/ 583406 w 855663"/>
              <a:gd name="connsiteY25" fmla="*/ 155575 h 1750218"/>
              <a:gd name="connsiteX26" fmla="*/ 427831 w 855663"/>
              <a:gd name="connsiteY26" fmla="*/ 311150 h 1750218"/>
              <a:gd name="connsiteX27" fmla="*/ 272256 w 855663"/>
              <a:gd name="connsiteY27" fmla="*/ 155575 h 1750218"/>
              <a:gd name="connsiteX28" fmla="*/ 427831 w 855663"/>
              <a:gd name="connsiteY28" fmla="*/ 0 h 175021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Lst>
            <a:rect l="l" t="t" r="r" b="b"/>
            <a:pathLst>
              <a:path w="855663" h="1750218">
                <a:moveTo>
                  <a:pt x="427832" y="350043"/>
                </a:moveTo>
                <a:cubicBezTo>
                  <a:pt x="470615" y="350043"/>
                  <a:pt x="513398" y="357821"/>
                  <a:pt x="556181" y="365601"/>
                </a:cubicBezTo>
                <a:cubicBezTo>
                  <a:pt x="618412" y="385047"/>
                  <a:pt x="672862" y="412273"/>
                  <a:pt x="719535" y="451168"/>
                </a:cubicBezTo>
                <a:cubicBezTo>
                  <a:pt x="731203" y="462835"/>
                  <a:pt x="738983" y="478392"/>
                  <a:pt x="742872" y="493950"/>
                </a:cubicBezTo>
                <a:lnTo>
                  <a:pt x="851774" y="956786"/>
                </a:lnTo>
                <a:cubicBezTo>
                  <a:pt x="851774" y="960675"/>
                  <a:pt x="855663" y="968454"/>
                  <a:pt x="855663" y="976232"/>
                </a:cubicBezTo>
                <a:cubicBezTo>
                  <a:pt x="855663" y="1019016"/>
                  <a:pt x="820659" y="1054020"/>
                  <a:pt x="777876" y="1054020"/>
                </a:cubicBezTo>
                <a:cubicBezTo>
                  <a:pt x="742872" y="1054020"/>
                  <a:pt x="711757" y="1026795"/>
                  <a:pt x="703977" y="995680"/>
                </a:cubicBezTo>
                <a:lnTo>
                  <a:pt x="622301" y="657304"/>
                </a:lnTo>
                <a:lnTo>
                  <a:pt x="622301" y="1750218"/>
                </a:lnTo>
                <a:lnTo>
                  <a:pt x="466726" y="1750218"/>
                </a:lnTo>
                <a:lnTo>
                  <a:pt x="466726" y="1050131"/>
                </a:lnTo>
                <a:lnTo>
                  <a:pt x="388938" y="1050131"/>
                </a:lnTo>
                <a:lnTo>
                  <a:pt x="388938" y="1750218"/>
                </a:lnTo>
                <a:lnTo>
                  <a:pt x="233363" y="1750218"/>
                </a:lnTo>
                <a:lnTo>
                  <a:pt x="233363" y="661193"/>
                </a:lnTo>
                <a:lnTo>
                  <a:pt x="151686" y="999569"/>
                </a:lnTo>
                <a:cubicBezTo>
                  <a:pt x="143907" y="1030684"/>
                  <a:pt x="112792" y="1057910"/>
                  <a:pt x="77788" y="1057910"/>
                </a:cubicBezTo>
                <a:cubicBezTo>
                  <a:pt x="35004" y="1057910"/>
                  <a:pt x="0" y="1022905"/>
                  <a:pt x="0" y="980123"/>
                </a:cubicBezTo>
                <a:cubicBezTo>
                  <a:pt x="0" y="972343"/>
                  <a:pt x="3889" y="964564"/>
                  <a:pt x="3889" y="960675"/>
                </a:cubicBezTo>
                <a:lnTo>
                  <a:pt x="112792" y="497840"/>
                </a:lnTo>
                <a:cubicBezTo>
                  <a:pt x="116682" y="482281"/>
                  <a:pt x="124460" y="466725"/>
                  <a:pt x="136129" y="455057"/>
                </a:cubicBezTo>
                <a:cubicBezTo>
                  <a:pt x="182801" y="416162"/>
                  <a:pt x="237252" y="385047"/>
                  <a:pt x="299482" y="369490"/>
                </a:cubicBezTo>
                <a:cubicBezTo>
                  <a:pt x="342265" y="357821"/>
                  <a:pt x="385049" y="350043"/>
                  <a:pt x="427832" y="350043"/>
                </a:cubicBezTo>
                <a:close/>
                <a:moveTo>
                  <a:pt x="427831" y="0"/>
                </a:moveTo>
                <a:cubicBezTo>
                  <a:pt x="513753" y="0"/>
                  <a:pt x="583406" y="69653"/>
                  <a:pt x="583406" y="155575"/>
                </a:cubicBezTo>
                <a:cubicBezTo>
                  <a:pt x="583406" y="241496"/>
                  <a:pt x="513753" y="311150"/>
                  <a:pt x="427831" y="311150"/>
                </a:cubicBezTo>
                <a:cubicBezTo>
                  <a:pt x="341910" y="311150"/>
                  <a:pt x="272256" y="241496"/>
                  <a:pt x="272256" y="155575"/>
                </a:cubicBezTo>
                <a:cubicBezTo>
                  <a:pt x="272256" y="69653"/>
                  <a:pt x="341910" y="0"/>
                  <a:pt x="427831" y="0"/>
                </a:cubicBezTo>
                <a:close/>
              </a:path>
            </a:pathLst>
          </a:custGeom>
          <a:solidFill>
            <a:srgbClr val="296DC0"/>
          </a:solidFill>
          <a:ln w="15081" cap="flat">
            <a:noFill/>
            <a:prstDash val="solid"/>
            <a:miter/>
          </a:ln>
        </p:spPr>
        <p:txBody>
          <a:bodyPr wrap="square" rtlCol="0" anchor="ctr">
            <a:noAutofit/>
          </a:bodyPr>
          <a:lstStyle/>
          <a:p>
            <a:r>
              <a:rPr lang="en-US" sz="1600" dirty="0"/>
              <a:t>       </a:t>
            </a:r>
          </a:p>
        </p:txBody>
      </p:sp>
      <p:sp>
        <p:nvSpPr>
          <p:cNvPr id="54" name="Freeform: Shape 46">
            <a:extLst>
              <a:ext uri="{FF2B5EF4-FFF2-40B4-BE49-F238E27FC236}">
                <a16:creationId xmlns:a16="http://schemas.microsoft.com/office/drawing/2014/main" id="{93AA897E-B200-ABFA-9242-016FD0F184DF}"/>
              </a:ext>
            </a:extLst>
          </p:cNvPr>
          <p:cNvSpPr/>
          <p:nvPr/>
        </p:nvSpPr>
        <p:spPr>
          <a:xfrm>
            <a:off x="644385" y="3434081"/>
            <a:ext cx="386084" cy="800172"/>
          </a:xfrm>
          <a:custGeom>
            <a:avLst/>
            <a:gdLst>
              <a:gd name="connsiteX0" fmla="*/ 427832 w 855663"/>
              <a:gd name="connsiteY0" fmla="*/ 350043 h 1750218"/>
              <a:gd name="connsiteX1" fmla="*/ 556181 w 855663"/>
              <a:gd name="connsiteY1" fmla="*/ 365601 h 1750218"/>
              <a:gd name="connsiteX2" fmla="*/ 719535 w 855663"/>
              <a:gd name="connsiteY2" fmla="*/ 451168 h 1750218"/>
              <a:gd name="connsiteX3" fmla="*/ 742872 w 855663"/>
              <a:gd name="connsiteY3" fmla="*/ 493950 h 1750218"/>
              <a:gd name="connsiteX4" fmla="*/ 851774 w 855663"/>
              <a:gd name="connsiteY4" fmla="*/ 956786 h 1750218"/>
              <a:gd name="connsiteX5" fmla="*/ 855663 w 855663"/>
              <a:gd name="connsiteY5" fmla="*/ 976232 h 1750218"/>
              <a:gd name="connsiteX6" fmla="*/ 777876 w 855663"/>
              <a:gd name="connsiteY6" fmla="*/ 1054020 h 1750218"/>
              <a:gd name="connsiteX7" fmla="*/ 703977 w 855663"/>
              <a:gd name="connsiteY7" fmla="*/ 995680 h 1750218"/>
              <a:gd name="connsiteX8" fmla="*/ 622301 w 855663"/>
              <a:gd name="connsiteY8" fmla="*/ 657304 h 1750218"/>
              <a:gd name="connsiteX9" fmla="*/ 622301 w 855663"/>
              <a:gd name="connsiteY9" fmla="*/ 1750218 h 1750218"/>
              <a:gd name="connsiteX10" fmla="*/ 466726 w 855663"/>
              <a:gd name="connsiteY10" fmla="*/ 1750218 h 1750218"/>
              <a:gd name="connsiteX11" fmla="*/ 466726 w 855663"/>
              <a:gd name="connsiteY11" fmla="*/ 1050131 h 1750218"/>
              <a:gd name="connsiteX12" fmla="*/ 388938 w 855663"/>
              <a:gd name="connsiteY12" fmla="*/ 1050131 h 1750218"/>
              <a:gd name="connsiteX13" fmla="*/ 388938 w 855663"/>
              <a:gd name="connsiteY13" fmla="*/ 1750218 h 1750218"/>
              <a:gd name="connsiteX14" fmla="*/ 233363 w 855663"/>
              <a:gd name="connsiteY14" fmla="*/ 1750218 h 1750218"/>
              <a:gd name="connsiteX15" fmla="*/ 233363 w 855663"/>
              <a:gd name="connsiteY15" fmla="*/ 661193 h 1750218"/>
              <a:gd name="connsiteX16" fmla="*/ 151686 w 855663"/>
              <a:gd name="connsiteY16" fmla="*/ 999569 h 1750218"/>
              <a:gd name="connsiteX17" fmla="*/ 77788 w 855663"/>
              <a:gd name="connsiteY17" fmla="*/ 1057910 h 1750218"/>
              <a:gd name="connsiteX18" fmla="*/ 0 w 855663"/>
              <a:gd name="connsiteY18" fmla="*/ 980123 h 1750218"/>
              <a:gd name="connsiteX19" fmla="*/ 3889 w 855663"/>
              <a:gd name="connsiteY19" fmla="*/ 960675 h 1750218"/>
              <a:gd name="connsiteX20" fmla="*/ 112792 w 855663"/>
              <a:gd name="connsiteY20" fmla="*/ 497840 h 1750218"/>
              <a:gd name="connsiteX21" fmla="*/ 136129 w 855663"/>
              <a:gd name="connsiteY21" fmla="*/ 455057 h 1750218"/>
              <a:gd name="connsiteX22" fmla="*/ 299482 w 855663"/>
              <a:gd name="connsiteY22" fmla="*/ 369490 h 1750218"/>
              <a:gd name="connsiteX23" fmla="*/ 427832 w 855663"/>
              <a:gd name="connsiteY23" fmla="*/ 350043 h 1750218"/>
              <a:gd name="connsiteX24" fmla="*/ 427831 w 855663"/>
              <a:gd name="connsiteY24" fmla="*/ 0 h 1750218"/>
              <a:gd name="connsiteX25" fmla="*/ 583406 w 855663"/>
              <a:gd name="connsiteY25" fmla="*/ 155575 h 1750218"/>
              <a:gd name="connsiteX26" fmla="*/ 427831 w 855663"/>
              <a:gd name="connsiteY26" fmla="*/ 311150 h 1750218"/>
              <a:gd name="connsiteX27" fmla="*/ 272256 w 855663"/>
              <a:gd name="connsiteY27" fmla="*/ 155575 h 1750218"/>
              <a:gd name="connsiteX28" fmla="*/ 427831 w 855663"/>
              <a:gd name="connsiteY28" fmla="*/ 0 h 175021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 ang="0">
                <a:pos x="connsiteX18" y="connsiteY18"/>
              </a:cxn>
              <a:cxn ang="0">
                <a:pos x="connsiteX19" y="connsiteY19"/>
              </a:cxn>
              <a:cxn ang="0">
                <a:pos x="connsiteX20" y="connsiteY20"/>
              </a:cxn>
              <a:cxn ang="0">
                <a:pos x="connsiteX21" y="connsiteY21"/>
              </a:cxn>
              <a:cxn ang="0">
                <a:pos x="connsiteX22" y="connsiteY22"/>
              </a:cxn>
              <a:cxn ang="0">
                <a:pos x="connsiteX23" y="connsiteY23"/>
              </a:cxn>
              <a:cxn ang="0">
                <a:pos x="connsiteX24" y="connsiteY24"/>
              </a:cxn>
              <a:cxn ang="0">
                <a:pos x="connsiteX25" y="connsiteY25"/>
              </a:cxn>
              <a:cxn ang="0">
                <a:pos x="connsiteX26" y="connsiteY26"/>
              </a:cxn>
              <a:cxn ang="0">
                <a:pos x="connsiteX27" y="connsiteY27"/>
              </a:cxn>
              <a:cxn ang="0">
                <a:pos x="connsiteX28" y="connsiteY28"/>
              </a:cxn>
            </a:cxnLst>
            <a:rect l="l" t="t" r="r" b="b"/>
            <a:pathLst>
              <a:path w="855663" h="1750218">
                <a:moveTo>
                  <a:pt x="427832" y="350043"/>
                </a:moveTo>
                <a:cubicBezTo>
                  <a:pt x="470615" y="350043"/>
                  <a:pt x="513398" y="357821"/>
                  <a:pt x="556181" y="365601"/>
                </a:cubicBezTo>
                <a:cubicBezTo>
                  <a:pt x="618412" y="385047"/>
                  <a:pt x="672862" y="412273"/>
                  <a:pt x="719535" y="451168"/>
                </a:cubicBezTo>
                <a:cubicBezTo>
                  <a:pt x="731203" y="462835"/>
                  <a:pt x="738983" y="478392"/>
                  <a:pt x="742872" y="493950"/>
                </a:cubicBezTo>
                <a:lnTo>
                  <a:pt x="851774" y="956786"/>
                </a:lnTo>
                <a:cubicBezTo>
                  <a:pt x="851774" y="960675"/>
                  <a:pt x="855663" y="968454"/>
                  <a:pt x="855663" y="976232"/>
                </a:cubicBezTo>
                <a:cubicBezTo>
                  <a:pt x="855663" y="1019016"/>
                  <a:pt x="820659" y="1054020"/>
                  <a:pt x="777876" y="1054020"/>
                </a:cubicBezTo>
                <a:cubicBezTo>
                  <a:pt x="742872" y="1054020"/>
                  <a:pt x="711757" y="1026795"/>
                  <a:pt x="703977" y="995680"/>
                </a:cubicBezTo>
                <a:lnTo>
                  <a:pt x="622301" y="657304"/>
                </a:lnTo>
                <a:lnTo>
                  <a:pt x="622301" y="1750218"/>
                </a:lnTo>
                <a:lnTo>
                  <a:pt x="466726" y="1750218"/>
                </a:lnTo>
                <a:lnTo>
                  <a:pt x="466726" y="1050131"/>
                </a:lnTo>
                <a:lnTo>
                  <a:pt x="388938" y="1050131"/>
                </a:lnTo>
                <a:lnTo>
                  <a:pt x="388938" y="1750218"/>
                </a:lnTo>
                <a:lnTo>
                  <a:pt x="233363" y="1750218"/>
                </a:lnTo>
                <a:lnTo>
                  <a:pt x="233363" y="661193"/>
                </a:lnTo>
                <a:lnTo>
                  <a:pt x="151686" y="999569"/>
                </a:lnTo>
                <a:cubicBezTo>
                  <a:pt x="143907" y="1030684"/>
                  <a:pt x="112792" y="1057910"/>
                  <a:pt x="77788" y="1057910"/>
                </a:cubicBezTo>
                <a:cubicBezTo>
                  <a:pt x="35004" y="1057910"/>
                  <a:pt x="0" y="1022905"/>
                  <a:pt x="0" y="980123"/>
                </a:cubicBezTo>
                <a:cubicBezTo>
                  <a:pt x="0" y="972343"/>
                  <a:pt x="3889" y="964564"/>
                  <a:pt x="3889" y="960675"/>
                </a:cubicBezTo>
                <a:lnTo>
                  <a:pt x="112792" y="497840"/>
                </a:lnTo>
                <a:cubicBezTo>
                  <a:pt x="116682" y="482281"/>
                  <a:pt x="124460" y="466725"/>
                  <a:pt x="136129" y="455057"/>
                </a:cubicBezTo>
                <a:cubicBezTo>
                  <a:pt x="182801" y="416162"/>
                  <a:pt x="237252" y="385047"/>
                  <a:pt x="299482" y="369490"/>
                </a:cubicBezTo>
                <a:cubicBezTo>
                  <a:pt x="342265" y="357821"/>
                  <a:pt x="385049" y="350043"/>
                  <a:pt x="427832" y="350043"/>
                </a:cubicBezTo>
                <a:close/>
                <a:moveTo>
                  <a:pt x="427831" y="0"/>
                </a:moveTo>
                <a:cubicBezTo>
                  <a:pt x="513753" y="0"/>
                  <a:pt x="583406" y="69653"/>
                  <a:pt x="583406" y="155575"/>
                </a:cubicBezTo>
                <a:cubicBezTo>
                  <a:pt x="583406" y="241496"/>
                  <a:pt x="513753" y="311150"/>
                  <a:pt x="427831" y="311150"/>
                </a:cubicBezTo>
                <a:cubicBezTo>
                  <a:pt x="341910" y="311150"/>
                  <a:pt x="272256" y="241496"/>
                  <a:pt x="272256" y="155575"/>
                </a:cubicBezTo>
                <a:cubicBezTo>
                  <a:pt x="272256" y="69653"/>
                  <a:pt x="341910" y="0"/>
                  <a:pt x="427831" y="0"/>
                </a:cubicBezTo>
                <a:close/>
              </a:path>
            </a:pathLst>
          </a:custGeom>
          <a:solidFill>
            <a:srgbClr val="AA0065"/>
          </a:solidFill>
          <a:ln w="15081" cap="flat">
            <a:noFill/>
            <a:prstDash val="solid"/>
            <a:miter/>
          </a:ln>
        </p:spPr>
        <p:txBody>
          <a:bodyPr wrap="square" rtlCol="0" anchor="ctr">
            <a:noAutofit/>
          </a:bodyPr>
          <a:lstStyle/>
          <a:p>
            <a:r>
              <a:rPr lang="en-US" dirty="0"/>
              <a:t>           </a:t>
            </a:r>
          </a:p>
        </p:txBody>
      </p:sp>
      <p:sp>
        <p:nvSpPr>
          <p:cNvPr id="55" name="Shape">
            <a:extLst>
              <a:ext uri="{FF2B5EF4-FFF2-40B4-BE49-F238E27FC236}">
                <a16:creationId xmlns:a16="http://schemas.microsoft.com/office/drawing/2014/main" id="{5417EED7-DD80-3B81-054A-E2E54A5BBDA2}"/>
              </a:ext>
            </a:extLst>
          </p:cNvPr>
          <p:cNvSpPr/>
          <p:nvPr/>
        </p:nvSpPr>
        <p:spPr>
          <a:xfrm>
            <a:off x="2337003" y="3105862"/>
            <a:ext cx="2212925" cy="2423784"/>
          </a:xfrm>
          <a:custGeom>
            <a:avLst/>
            <a:gdLst/>
            <a:ahLst/>
            <a:cxnLst>
              <a:cxn ang="0">
                <a:pos x="wd2" y="hd2"/>
              </a:cxn>
              <a:cxn ang="5400000">
                <a:pos x="wd2" y="hd2"/>
              </a:cxn>
              <a:cxn ang="10800000">
                <a:pos x="wd2" y="hd2"/>
              </a:cxn>
              <a:cxn ang="16200000">
                <a:pos x="wd2" y="hd2"/>
              </a:cxn>
            </a:cxnLst>
            <a:rect l="0" t="0" r="r" b="b"/>
            <a:pathLst>
              <a:path w="21600" h="21494" extrusionOk="0">
                <a:moveTo>
                  <a:pt x="21600" y="15519"/>
                </a:moveTo>
                <a:lnTo>
                  <a:pt x="21600" y="5968"/>
                </a:lnTo>
                <a:cubicBezTo>
                  <a:pt x="21600" y="5543"/>
                  <a:pt x="21341" y="5147"/>
                  <a:pt x="20923" y="4935"/>
                </a:cubicBezTo>
                <a:lnTo>
                  <a:pt x="11481" y="159"/>
                </a:lnTo>
                <a:cubicBezTo>
                  <a:pt x="11063" y="-53"/>
                  <a:pt x="10545" y="-53"/>
                  <a:pt x="10119" y="159"/>
                </a:cubicBezTo>
                <a:lnTo>
                  <a:pt x="677" y="4935"/>
                </a:lnTo>
                <a:cubicBezTo>
                  <a:pt x="259" y="5147"/>
                  <a:pt x="0" y="5543"/>
                  <a:pt x="0" y="5968"/>
                </a:cubicBezTo>
                <a:lnTo>
                  <a:pt x="0" y="15526"/>
                </a:lnTo>
                <a:cubicBezTo>
                  <a:pt x="0" y="15951"/>
                  <a:pt x="259" y="16347"/>
                  <a:pt x="677" y="16559"/>
                </a:cubicBezTo>
                <a:lnTo>
                  <a:pt x="10119" y="21335"/>
                </a:lnTo>
                <a:cubicBezTo>
                  <a:pt x="10537" y="21547"/>
                  <a:pt x="11055" y="21547"/>
                  <a:pt x="11481" y="21335"/>
                </a:cubicBezTo>
                <a:lnTo>
                  <a:pt x="20923" y="16559"/>
                </a:lnTo>
                <a:cubicBezTo>
                  <a:pt x="21341" y="16339"/>
                  <a:pt x="21600" y="15944"/>
                  <a:pt x="21600" y="15519"/>
                </a:cubicBezTo>
                <a:close/>
              </a:path>
            </a:pathLst>
          </a:custGeom>
          <a:solidFill>
            <a:srgbClr val="296DC0"/>
          </a:solidFill>
          <a:ln w="12700">
            <a:miter lim="400000"/>
          </a:ln>
        </p:spPr>
        <p:txBody>
          <a:bodyPr lIns="28575" tIns="28575" rIns="28575" bIns="28575" anchor="ctr"/>
          <a:lstStyle/>
          <a:p>
            <a:pPr>
              <a:defRPr sz="3000">
                <a:solidFill>
                  <a:srgbClr val="FFFFFF"/>
                </a:solidFill>
              </a:defRPr>
            </a:pPr>
            <a:endParaRPr lang="it-IT" sz="2000" dirty="0">
              <a:solidFill>
                <a:srgbClr val="296DC0"/>
              </a:solidFill>
              <a:highlight>
                <a:srgbClr val="296DC0"/>
              </a:highlight>
            </a:endParaRPr>
          </a:p>
        </p:txBody>
      </p:sp>
      <p:sp>
        <p:nvSpPr>
          <p:cNvPr id="56" name="Shape">
            <a:extLst>
              <a:ext uri="{FF2B5EF4-FFF2-40B4-BE49-F238E27FC236}">
                <a16:creationId xmlns:a16="http://schemas.microsoft.com/office/drawing/2014/main" id="{2B4382C1-F4DE-AED6-F083-3F4A857F2994}"/>
              </a:ext>
            </a:extLst>
          </p:cNvPr>
          <p:cNvSpPr/>
          <p:nvPr/>
        </p:nvSpPr>
        <p:spPr>
          <a:xfrm>
            <a:off x="1281659" y="1795100"/>
            <a:ext cx="1725744" cy="1728994"/>
          </a:xfrm>
          <a:custGeom>
            <a:avLst/>
            <a:gdLst/>
            <a:ahLst/>
            <a:cxnLst>
              <a:cxn ang="0">
                <a:pos x="wd2" y="hd2"/>
              </a:cxn>
              <a:cxn ang="5400000">
                <a:pos x="wd2" y="hd2"/>
              </a:cxn>
              <a:cxn ang="10800000">
                <a:pos x="wd2" y="hd2"/>
              </a:cxn>
              <a:cxn ang="16200000">
                <a:pos x="wd2" y="hd2"/>
              </a:cxn>
            </a:cxnLst>
            <a:rect l="0" t="0" r="r" b="b"/>
            <a:pathLst>
              <a:path w="21600" h="21494" extrusionOk="0">
                <a:moveTo>
                  <a:pt x="0" y="5968"/>
                </a:moveTo>
                <a:lnTo>
                  <a:pt x="0" y="15526"/>
                </a:lnTo>
                <a:cubicBezTo>
                  <a:pt x="0" y="15951"/>
                  <a:pt x="259" y="16347"/>
                  <a:pt x="677" y="16559"/>
                </a:cubicBezTo>
                <a:lnTo>
                  <a:pt x="10119" y="21335"/>
                </a:lnTo>
                <a:cubicBezTo>
                  <a:pt x="10537" y="21547"/>
                  <a:pt x="11055" y="21547"/>
                  <a:pt x="11481" y="21335"/>
                </a:cubicBezTo>
                <a:lnTo>
                  <a:pt x="20923" y="16559"/>
                </a:lnTo>
                <a:cubicBezTo>
                  <a:pt x="21341" y="16347"/>
                  <a:pt x="21600" y="15951"/>
                  <a:pt x="21600" y="15526"/>
                </a:cubicBezTo>
                <a:lnTo>
                  <a:pt x="21600" y="5968"/>
                </a:lnTo>
                <a:cubicBezTo>
                  <a:pt x="21600" y="5543"/>
                  <a:pt x="21341" y="5147"/>
                  <a:pt x="20923" y="4935"/>
                </a:cubicBezTo>
                <a:lnTo>
                  <a:pt x="11481" y="159"/>
                </a:lnTo>
                <a:cubicBezTo>
                  <a:pt x="11063" y="-53"/>
                  <a:pt x="10545" y="-53"/>
                  <a:pt x="10119" y="159"/>
                </a:cubicBezTo>
                <a:lnTo>
                  <a:pt x="677" y="4935"/>
                </a:lnTo>
                <a:cubicBezTo>
                  <a:pt x="259" y="5147"/>
                  <a:pt x="0" y="5543"/>
                  <a:pt x="0" y="5968"/>
                </a:cubicBezTo>
                <a:close/>
              </a:path>
            </a:pathLst>
          </a:custGeom>
          <a:solidFill>
            <a:srgbClr val="AA0065"/>
          </a:solidFill>
          <a:ln w="12700">
            <a:miter lim="400000"/>
          </a:ln>
        </p:spPr>
        <p:txBody>
          <a:bodyPr lIns="28575" tIns="28575" rIns="28575" bIns="28575" anchor="ctr"/>
          <a:lstStyle/>
          <a:p>
            <a:pPr>
              <a:defRPr sz="3000">
                <a:solidFill>
                  <a:srgbClr val="FFFFFF"/>
                </a:solidFill>
              </a:defRPr>
            </a:pPr>
            <a:endParaRPr sz="2000"/>
          </a:p>
        </p:txBody>
      </p:sp>
      <p:sp>
        <p:nvSpPr>
          <p:cNvPr id="57" name="TextBox 30">
            <a:extLst>
              <a:ext uri="{FF2B5EF4-FFF2-40B4-BE49-F238E27FC236}">
                <a16:creationId xmlns:a16="http://schemas.microsoft.com/office/drawing/2014/main" id="{164694D6-0896-451E-CC99-1B57E32CD93B}"/>
              </a:ext>
            </a:extLst>
          </p:cNvPr>
          <p:cNvSpPr txBox="1"/>
          <p:nvPr/>
        </p:nvSpPr>
        <p:spPr>
          <a:xfrm>
            <a:off x="2523319" y="3412942"/>
            <a:ext cx="1806718" cy="307777"/>
          </a:xfrm>
          <a:prstGeom prst="rect">
            <a:avLst/>
          </a:prstGeom>
          <a:noFill/>
        </p:spPr>
        <p:txBody>
          <a:bodyPr wrap="square" rtlCol="0">
            <a:spAutoFit/>
          </a:bodyPr>
          <a:lstStyle/>
          <a:p>
            <a:pPr algn="ctr"/>
            <a:r>
              <a:rPr lang="en-GB" sz="1400" b="1" dirty="0" err="1">
                <a:solidFill>
                  <a:schemeClr val="bg1"/>
                </a:solidFill>
              </a:rPr>
              <a:t>Effecriveness</a:t>
            </a:r>
            <a:endParaRPr lang="en-GB" sz="1400" b="1" dirty="0">
              <a:solidFill>
                <a:schemeClr val="bg1"/>
              </a:solidFill>
            </a:endParaRPr>
          </a:p>
        </p:txBody>
      </p:sp>
      <p:sp>
        <p:nvSpPr>
          <p:cNvPr id="58" name="CasellaDiTesto 22">
            <a:extLst>
              <a:ext uri="{FF2B5EF4-FFF2-40B4-BE49-F238E27FC236}">
                <a16:creationId xmlns:a16="http://schemas.microsoft.com/office/drawing/2014/main" id="{0312D88C-77FA-A1E3-3D30-3429D2A5A059}"/>
              </a:ext>
            </a:extLst>
          </p:cNvPr>
          <p:cNvSpPr txBox="1"/>
          <p:nvPr/>
        </p:nvSpPr>
        <p:spPr>
          <a:xfrm>
            <a:off x="2337002" y="3694739"/>
            <a:ext cx="2212926" cy="1384995"/>
          </a:xfrm>
          <a:prstGeom prst="rect">
            <a:avLst/>
          </a:prstGeom>
          <a:noFill/>
        </p:spPr>
        <p:txBody>
          <a:bodyPr wrap="square">
            <a:spAutoFit/>
          </a:bodyPr>
          <a:lstStyle/>
          <a:p>
            <a:pPr algn="ctr"/>
            <a:r>
              <a:rPr lang="en-US" sz="1400" dirty="0">
                <a:solidFill>
                  <a:schemeClr val="bg1"/>
                </a:solidFill>
              </a:rPr>
              <a:t>Reduction of blood pressure (BP) after 8 hours was </a:t>
            </a:r>
            <a:r>
              <a:rPr lang="en-US" sz="1400" dirty="0" err="1">
                <a:solidFill>
                  <a:schemeClr val="bg1"/>
                </a:solidFill>
              </a:rPr>
              <a:t>idenfied</a:t>
            </a:r>
            <a:r>
              <a:rPr lang="en-US" sz="1400" dirty="0">
                <a:solidFill>
                  <a:schemeClr val="bg1"/>
                </a:solidFill>
              </a:rPr>
              <a:t> in all cases, MAP normalized in 23% of cases after 24 hours and 36% after 48 hours. </a:t>
            </a:r>
            <a:endParaRPr lang="en-US" sz="1400" noProof="1">
              <a:solidFill>
                <a:schemeClr val="bg1"/>
              </a:solidFill>
            </a:endParaRPr>
          </a:p>
        </p:txBody>
      </p:sp>
      <p:sp>
        <p:nvSpPr>
          <p:cNvPr id="59" name="TextBox 30">
            <a:extLst>
              <a:ext uri="{FF2B5EF4-FFF2-40B4-BE49-F238E27FC236}">
                <a16:creationId xmlns:a16="http://schemas.microsoft.com/office/drawing/2014/main" id="{86DCA83B-73C0-BE36-DAFE-74E940C01401}"/>
              </a:ext>
            </a:extLst>
          </p:cNvPr>
          <p:cNvSpPr txBox="1"/>
          <p:nvPr/>
        </p:nvSpPr>
        <p:spPr>
          <a:xfrm>
            <a:off x="1247234" y="1953569"/>
            <a:ext cx="1806718" cy="307777"/>
          </a:xfrm>
          <a:prstGeom prst="rect">
            <a:avLst/>
          </a:prstGeom>
          <a:noFill/>
        </p:spPr>
        <p:txBody>
          <a:bodyPr wrap="square" rtlCol="0">
            <a:spAutoFit/>
          </a:bodyPr>
          <a:lstStyle/>
          <a:p>
            <a:pPr algn="ctr"/>
            <a:r>
              <a:rPr lang="en-GB" sz="1400" b="1" dirty="0">
                <a:solidFill>
                  <a:schemeClr val="bg1"/>
                </a:solidFill>
              </a:rPr>
              <a:t>Over response</a:t>
            </a:r>
          </a:p>
        </p:txBody>
      </p:sp>
      <p:sp>
        <p:nvSpPr>
          <p:cNvPr id="60" name="TextBox 28">
            <a:extLst>
              <a:ext uri="{FF2B5EF4-FFF2-40B4-BE49-F238E27FC236}">
                <a16:creationId xmlns:a16="http://schemas.microsoft.com/office/drawing/2014/main" id="{23B0F746-3806-550A-0899-B8A61152285C}"/>
              </a:ext>
            </a:extLst>
          </p:cNvPr>
          <p:cNvSpPr txBox="1"/>
          <p:nvPr/>
        </p:nvSpPr>
        <p:spPr>
          <a:xfrm>
            <a:off x="1366818" y="2248356"/>
            <a:ext cx="1567550" cy="1200329"/>
          </a:xfrm>
          <a:prstGeom prst="rect">
            <a:avLst/>
          </a:prstGeom>
          <a:noFill/>
        </p:spPr>
        <p:txBody>
          <a:bodyPr wrap="square" lIns="0" rIns="0" rtlCol="0" anchor="t">
            <a:spAutoFit/>
          </a:bodyPr>
          <a:lstStyle/>
          <a:p>
            <a:pPr algn="ctr"/>
            <a:r>
              <a:rPr lang="en-US" sz="1200" dirty="0">
                <a:solidFill>
                  <a:schemeClr val="bg1"/>
                </a:solidFill>
              </a:rPr>
              <a:t>87% of patients the reduction of the initial mean arterial pressure (MAP) was higher than 25% of calculated drop pressure.</a:t>
            </a:r>
            <a:endParaRPr lang="en-US" sz="1400" b="1" noProof="1">
              <a:solidFill>
                <a:srgbClr val="296DC0"/>
              </a:solidFill>
            </a:endParaRPr>
          </a:p>
        </p:txBody>
      </p:sp>
      <p:sp>
        <p:nvSpPr>
          <p:cNvPr id="61" name="Rectangle 3">
            <a:extLst>
              <a:ext uri="{FF2B5EF4-FFF2-40B4-BE49-F238E27FC236}">
                <a16:creationId xmlns:a16="http://schemas.microsoft.com/office/drawing/2014/main" id="{8A9908C4-CB33-4C11-0773-3D17D313BD5F}"/>
              </a:ext>
            </a:extLst>
          </p:cNvPr>
          <p:cNvSpPr/>
          <p:nvPr/>
        </p:nvSpPr>
        <p:spPr>
          <a:xfrm>
            <a:off x="4540574" y="1820051"/>
            <a:ext cx="3872136" cy="1352541"/>
          </a:xfrm>
          <a:prstGeom prst="rect">
            <a:avLst/>
          </a:prstGeom>
          <a:solidFill>
            <a:srgbClr val="65AA00"/>
          </a:solidFill>
          <a:ln w="41275">
            <a:solidFill>
              <a:schemeClr val="accent6"/>
            </a:solidFill>
            <a:round/>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lnSpc>
                <a:spcPct val="115000"/>
              </a:lnSpc>
            </a:pPr>
            <a:r>
              <a:rPr lang="en-US" sz="1200" dirty="0">
                <a:solidFill>
                  <a:schemeClr val="bg1"/>
                </a:solidFill>
              </a:rPr>
              <a:t>MAP reduction not exceeding the 25% of calculated drop pressure received a lower median fenoldopam dose (0.2 mcg/kg/min vs 0.4 mcg/kg/min; p=0.002). In fact, not exceeding 0.2 mcg/kg/min at 8 hours was associated with an acceptable reduction of MAP in 38%, while higher doses decrease MAP exceeding 25% in 91% of patients (p&lt;0.001).</a:t>
            </a:r>
            <a:endParaRPr lang="it-IT" sz="1200" dirty="0">
              <a:solidFill>
                <a:schemeClr val="bg1"/>
              </a:solidFill>
            </a:endParaRPr>
          </a:p>
        </p:txBody>
      </p:sp>
      <p:sp>
        <p:nvSpPr>
          <p:cNvPr id="62" name="Rectangle 55">
            <a:extLst>
              <a:ext uri="{FF2B5EF4-FFF2-40B4-BE49-F238E27FC236}">
                <a16:creationId xmlns:a16="http://schemas.microsoft.com/office/drawing/2014/main" id="{16EBC0B3-814B-2E25-73C2-42CC604EF7A1}"/>
              </a:ext>
            </a:extLst>
          </p:cNvPr>
          <p:cNvSpPr/>
          <p:nvPr/>
        </p:nvSpPr>
        <p:spPr>
          <a:xfrm>
            <a:off x="8522933" y="4915917"/>
            <a:ext cx="3320928" cy="651786"/>
          </a:xfrm>
          <a:prstGeom prst="rect">
            <a:avLst/>
          </a:prstGeom>
          <a:solidFill>
            <a:srgbClr val="C00000"/>
          </a:solidFill>
          <a:ln w="41275">
            <a:noFill/>
            <a:round/>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lnSpc>
                <a:spcPct val="115000"/>
              </a:lnSpc>
            </a:pPr>
            <a:r>
              <a:rPr lang="en-US" sz="1200" dirty="0">
                <a:solidFill>
                  <a:schemeClr val="bg1"/>
                </a:solidFill>
              </a:rPr>
              <a:t>The occurrence of hypotension was 7%, while hypokalemia was observed in 13% of cases. </a:t>
            </a:r>
            <a:endParaRPr lang="it-IT" sz="1200" dirty="0">
              <a:solidFill>
                <a:schemeClr val="bg1"/>
              </a:solidFill>
            </a:endParaRPr>
          </a:p>
        </p:txBody>
      </p:sp>
      <p:grpSp>
        <p:nvGrpSpPr>
          <p:cNvPr id="63" name="Group 15">
            <a:extLst>
              <a:ext uri="{FF2B5EF4-FFF2-40B4-BE49-F238E27FC236}">
                <a16:creationId xmlns:a16="http://schemas.microsoft.com/office/drawing/2014/main" id="{C8A72BA1-2E3B-890E-F36D-56D135DB67A2}"/>
              </a:ext>
            </a:extLst>
          </p:cNvPr>
          <p:cNvGrpSpPr/>
          <p:nvPr/>
        </p:nvGrpSpPr>
        <p:grpSpPr>
          <a:xfrm>
            <a:off x="3134241" y="1620688"/>
            <a:ext cx="510599" cy="1301323"/>
            <a:chOff x="6835411" y="809625"/>
            <a:chExt cx="1198208" cy="3464101"/>
          </a:xfrm>
        </p:grpSpPr>
        <p:grpSp>
          <p:nvGrpSpPr>
            <p:cNvPr id="64" name="Group 10">
              <a:extLst>
                <a:ext uri="{FF2B5EF4-FFF2-40B4-BE49-F238E27FC236}">
                  <a16:creationId xmlns:a16="http://schemas.microsoft.com/office/drawing/2014/main" id="{28681611-678B-3B40-6CBA-28545D49041B}"/>
                </a:ext>
              </a:extLst>
            </p:cNvPr>
            <p:cNvGrpSpPr/>
            <p:nvPr/>
          </p:nvGrpSpPr>
          <p:grpSpPr>
            <a:xfrm>
              <a:off x="6835411" y="809625"/>
              <a:ext cx="1198208" cy="3464101"/>
              <a:chOff x="6835411" y="809625"/>
              <a:chExt cx="1198208" cy="3464101"/>
            </a:xfrm>
          </p:grpSpPr>
          <p:sp>
            <p:nvSpPr>
              <p:cNvPr id="66" name="Shape">
                <a:extLst>
                  <a:ext uri="{FF2B5EF4-FFF2-40B4-BE49-F238E27FC236}">
                    <a16:creationId xmlns:a16="http://schemas.microsoft.com/office/drawing/2014/main" id="{C184F34B-90C0-2BD7-3894-23719CC70767}"/>
                  </a:ext>
                </a:extLst>
              </p:cNvPr>
              <p:cNvSpPr/>
              <p:nvPr/>
            </p:nvSpPr>
            <p:spPr>
              <a:xfrm>
                <a:off x="7102006" y="2265179"/>
                <a:ext cx="665019" cy="634130"/>
              </a:xfrm>
              <a:custGeom>
                <a:avLst/>
                <a:gdLst/>
                <a:ahLst/>
                <a:cxnLst>
                  <a:cxn ang="0">
                    <a:pos x="wd2" y="hd2"/>
                  </a:cxn>
                  <a:cxn ang="5400000">
                    <a:pos x="wd2" y="hd2"/>
                  </a:cxn>
                  <a:cxn ang="10800000">
                    <a:pos x="wd2" y="hd2"/>
                  </a:cxn>
                  <a:cxn ang="16200000">
                    <a:pos x="wd2" y="hd2"/>
                  </a:cxn>
                </a:cxnLst>
                <a:rect l="0" t="0" r="r" b="b"/>
                <a:pathLst>
                  <a:path w="21600" h="21600" extrusionOk="0">
                    <a:moveTo>
                      <a:pt x="0" y="19269"/>
                    </a:moveTo>
                    <a:cubicBezTo>
                      <a:pt x="0" y="20568"/>
                      <a:pt x="4839" y="21600"/>
                      <a:pt x="10800" y="21600"/>
                    </a:cubicBezTo>
                    <a:cubicBezTo>
                      <a:pt x="16761" y="21600"/>
                      <a:pt x="21600" y="20548"/>
                      <a:pt x="21600" y="19269"/>
                    </a:cubicBezTo>
                    <a:cubicBezTo>
                      <a:pt x="21600" y="19248"/>
                      <a:pt x="21600" y="19228"/>
                      <a:pt x="21600" y="19207"/>
                    </a:cubicBezTo>
                    <a:lnTo>
                      <a:pt x="21246" y="14421"/>
                    </a:lnTo>
                    <a:cubicBezTo>
                      <a:pt x="21246" y="14132"/>
                      <a:pt x="20990" y="13843"/>
                      <a:pt x="20518" y="13595"/>
                    </a:cubicBezTo>
                    <a:lnTo>
                      <a:pt x="19731" y="1939"/>
                    </a:lnTo>
                    <a:cubicBezTo>
                      <a:pt x="19731" y="866"/>
                      <a:pt x="15738" y="0"/>
                      <a:pt x="10800" y="0"/>
                    </a:cubicBezTo>
                    <a:cubicBezTo>
                      <a:pt x="5862" y="0"/>
                      <a:pt x="1869" y="866"/>
                      <a:pt x="1869" y="1939"/>
                    </a:cubicBezTo>
                    <a:lnTo>
                      <a:pt x="1161" y="13554"/>
                    </a:lnTo>
                    <a:cubicBezTo>
                      <a:pt x="649" y="13822"/>
                      <a:pt x="354" y="14111"/>
                      <a:pt x="354" y="14421"/>
                    </a:cubicBezTo>
                    <a:lnTo>
                      <a:pt x="0" y="19207"/>
                    </a:lnTo>
                    <a:cubicBezTo>
                      <a:pt x="0" y="19228"/>
                      <a:pt x="0" y="19248"/>
                      <a:pt x="0" y="19269"/>
                    </a:cubicBezTo>
                    <a:close/>
                  </a:path>
                </a:pathLst>
              </a:custGeom>
              <a:solidFill>
                <a:srgbClr val="000000"/>
              </a:solidFill>
              <a:ln w="12700">
                <a:miter lim="400000"/>
              </a:ln>
            </p:spPr>
            <p:txBody>
              <a:bodyPr lIns="28575" tIns="28575" rIns="28575" bIns="28575" anchor="ctr"/>
              <a:lstStyle/>
              <a:p>
                <a:pPr>
                  <a:defRPr sz="3000">
                    <a:solidFill>
                      <a:srgbClr val="FFFFFF"/>
                    </a:solidFill>
                  </a:defRPr>
                </a:pPr>
                <a:endParaRPr sz="2250"/>
              </a:p>
            </p:txBody>
          </p:sp>
          <p:sp>
            <p:nvSpPr>
              <p:cNvPr id="67" name="Shape">
                <a:extLst>
                  <a:ext uri="{FF2B5EF4-FFF2-40B4-BE49-F238E27FC236}">
                    <a16:creationId xmlns:a16="http://schemas.microsoft.com/office/drawing/2014/main" id="{506C9A8D-A53A-D9BD-00E5-DB224095B549}"/>
                  </a:ext>
                </a:extLst>
              </p:cNvPr>
              <p:cNvSpPr/>
              <p:nvPr/>
            </p:nvSpPr>
            <p:spPr>
              <a:xfrm>
                <a:off x="6835411" y="2773936"/>
                <a:ext cx="1198208" cy="1499790"/>
              </a:xfrm>
              <a:custGeom>
                <a:avLst/>
                <a:gdLst/>
                <a:ahLst/>
                <a:cxnLst>
                  <a:cxn ang="0">
                    <a:pos x="wd2" y="hd2"/>
                  </a:cxn>
                  <a:cxn ang="5400000">
                    <a:pos x="wd2" y="hd2"/>
                  </a:cxn>
                  <a:cxn ang="10800000">
                    <a:pos x="wd2" y="hd2"/>
                  </a:cxn>
                  <a:cxn ang="16200000">
                    <a:pos x="wd2" y="hd2"/>
                  </a:cxn>
                </a:cxnLst>
                <a:rect l="0" t="0" r="r" b="b"/>
                <a:pathLst>
                  <a:path w="21441" h="21361" extrusionOk="0">
                    <a:moveTo>
                      <a:pt x="0" y="12827"/>
                    </a:moveTo>
                    <a:cubicBezTo>
                      <a:pt x="0" y="17390"/>
                      <a:pt x="4509" y="21126"/>
                      <a:pt x="10177" y="21350"/>
                    </a:cubicBezTo>
                    <a:cubicBezTo>
                      <a:pt x="16398" y="21600"/>
                      <a:pt x="21600" y="17554"/>
                      <a:pt x="21437" y="12603"/>
                    </a:cubicBezTo>
                    <a:cubicBezTo>
                      <a:pt x="21372" y="10541"/>
                      <a:pt x="20386" y="8661"/>
                      <a:pt x="18793" y="7220"/>
                    </a:cubicBezTo>
                    <a:cubicBezTo>
                      <a:pt x="16961" y="5555"/>
                      <a:pt x="15888" y="3442"/>
                      <a:pt x="15682" y="1225"/>
                    </a:cubicBezTo>
                    <a:lnTo>
                      <a:pt x="15650" y="811"/>
                    </a:lnTo>
                    <a:cubicBezTo>
                      <a:pt x="15650" y="362"/>
                      <a:pt x="13450" y="0"/>
                      <a:pt x="10730" y="0"/>
                    </a:cubicBezTo>
                    <a:cubicBezTo>
                      <a:pt x="8009" y="0"/>
                      <a:pt x="5809" y="362"/>
                      <a:pt x="5809" y="811"/>
                    </a:cubicBezTo>
                    <a:lnTo>
                      <a:pt x="5777" y="1208"/>
                    </a:lnTo>
                    <a:cubicBezTo>
                      <a:pt x="5603" y="3442"/>
                      <a:pt x="4476" y="5555"/>
                      <a:pt x="2634" y="7246"/>
                    </a:cubicBezTo>
                    <a:cubicBezTo>
                      <a:pt x="986" y="8738"/>
                      <a:pt x="0" y="10688"/>
                      <a:pt x="0" y="12827"/>
                    </a:cubicBezTo>
                    <a:close/>
                  </a:path>
                </a:pathLst>
              </a:custGeom>
              <a:solidFill>
                <a:schemeClr val="accent4"/>
              </a:solidFill>
              <a:ln w="12700">
                <a:miter lim="400000"/>
              </a:ln>
            </p:spPr>
            <p:txBody>
              <a:bodyPr lIns="28575" tIns="28575" rIns="28575" bIns="28575" anchor="ctr"/>
              <a:lstStyle/>
              <a:p>
                <a:pPr>
                  <a:defRPr sz="3000">
                    <a:solidFill>
                      <a:srgbClr val="FFFFFF"/>
                    </a:solidFill>
                  </a:defRPr>
                </a:pPr>
                <a:endParaRPr sz="2250"/>
              </a:p>
            </p:txBody>
          </p:sp>
          <p:sp>
            <p:nvSpPr>
              <p:cNvPr id="68" name="Shape">
                <a:extLst>
                  <a:ext uri="{FF2B5EF4-FFF2-40B4-BE49-F238E27FC236}">
                    <a16:creationId xmlns:a16="http://schemas.microsoft.com/office/drawing/2014/main" id="{6669A05B-6CC5-2193-C6C9-56B437E978DB}"/>
                  </a:ext>
                </a:extLst>
              </p:cNvPr>
              <p:cNvSpPr/>
              <p:nvPr/>
            </p:nvSpPr>
            <p:spPr>
              <a:xfrm>
                <a:off x="7151460" y="2725483"/>
                <a:ext cx="566110" cy="957353"/>
              </a:xfrm>
              <a:custGeom>
                <a:avLst/>
                <a:gdLst/>
                <a:ahLst/>
                <a:cxnLst>
                  <a:cxn ang="0">
                    <a:pos x="wd2" y="hd2"/>
                  </a:cxn>
                  <a:cxn ang="5400000">
                    <a:pos x="wd2" y="hd2"/>
                  </a:cxn>
                  <a:cxn ang="10800000">
                    <a:pos x="wd2" y="hd2"/>
                  </a:cxn>
                  <a:cxn ang="16200000">
                    <a:pos x="wd2" y="hd2"/>
                  </a:cxn>
                </a:cxnLst>
                <a:rect l="0" t="0" r="r" b="b"/>
                <a:pathLst>
                  <a:path w="21319" h="21555" extrusionOk="0">
                    <a:moveTo>
                      <a:pt x="3749" y="21545"/>
                    </a:moveTo>
                    <a:cubicBezTo>
                      <a:pt x="4707" y="21600"/>
                      <a:pt x="5551" y="21409"/>
                      <a:pt x="6190" y="21000"/>
                    </a:cubicBezTo>
                    <a:cubicBezTo>
                      <a:pt x="6920" y="20523"/>
                      <a:pt x="7399" y="19773"/>
                      <a:pt x="7558" y="18750"/>
                    </a:cubicBezTo>
                    <a:cubicBezTo>
                      <a:pt x="7581" y="18573"/>
                      <a:pt x="7604" y="18382"/>
                      <a:pt x="7627" y="18177"/>
                    </a:cubicBezTo>
                    <a:cubicBezTo>
                      <a:pt x="8585" y="18164"/>
                      <a:pt x="9588" y="18164"/>
                      <a:pt x="10592" y="18164"/>
                    </a:cubicBezTo>
                    <a:cubicBezTo>
                      <a:pt x="10592" y="18164"/>
                      <a:pt x="10615" y="18164"/>
                      <a:pt x="10615" y="18164"/>
                    </a:cubicBezTo>
                    <a:lnTo>
                      <a:pt x="10683" y="18164"/>
                    </a:lnTo>
                    <a:cubicBezTo>
                      <a:pt x="10683" y="18164"/>
                      <a:pt x="10706" y="18164"/>
                      <a:pt x="10706" y="18164"/>
                    </a:cubicBezTo>
                    <a:cubicBezTo>
                      <a:pt x="11710" y="18164"/>
                      <a:pt x="12713" y="18164"/>
                      <a:pt x="13671" y="18177"/>
                    </a:cubicBezTo>
                    <a:cubicBezTo>
                      <a:pt x="13694" y="18382"/>
                      <a:pt x="13717" y="18573"/>
                      <a:pt x="13740" y="18750"/>
                    </a:cubicBezTo>
                    <a:cubicBezTo>
                      <a:pt x="13922" y="19773"/>
                      <a:pt x="14378" y="20523"/>
                      <a:pt x="15108" y="21000"/>
                    </a:cubicBezTo>
                    <a:cubicBezTo>
                      <a:pt x="15747" y="21409"/>
                      <a:pt x="16591" y="21600"/>
                      <a:pt x="17549" y="21545"/>
                    </a:cubicBezTo>
                    <a:cubicBezTo>
                      <a:pt x="19487" y="21436"/>
                      <a:pt x="21449" y="20305"/>
                      <a:pt x="21312" y="19405"/>
                    </a:cubicBezTo>
                    <a:cubicBezTo>
                      <a:pt x="21107" y="18177"/>
                      <a:pt x="18073" y="17891"/>
                      <a:pt x="14264" y="17823"/>
                    </a:cubicBezTo>
                    <a:cubicBezTo>
                      <a:pt x="13831" y="12614"/>
                      <a:pt x="15724" y="164"/>
                      <a:pt x="15747" y="27"/>
                    </a:cubicBezTo>
                    <a:lnTo>
                      <a:pt x="15131" y="0"/>
                    </a:lnTo>
                    <a:cubicBezTo>
                      <a:pt x="15108" y="136"/>
                      <a:pt x="13238" y="12545"/>
                      <a:pt x="13648" y="17823"/>
                    </a:cubicBezTo>
                    <a:cubicBezTo>
                      <a:pt x="12690" y="17809"/>
                      <a:pt x="11687" y="17809"/>
                      <a:pt x="10683" y="17809"/>
                    </a:cubicBezTo>
                    <a:lnTo>
                      <a:pt x="10615" y="17809"/>
                    </a:lnTo>
                    <a:cubicBezTo>
                      <a:pt x="10615" y="17809"/>
                      <a:pt x="10592" y="17809"/>
                      <a:pt x="10592" y="17809"/>
                    </a:cubicBezTo>
                    <a:cubicBezTo>
                      <a:pt x="9588" y="17809"/>
                      <a:pt x="8608" y="17809"/>
                      <a:pt x="7672" y="17823"/>
                    </a:cubicBezTo>
                    <a:cubicBezTo>
                      <a:pt x="8106" y="12545"/>
                      <a:pt x="6213" y="136"/>
                      <a:pt x="6190" y="0"/>
                    </a:cubicBezTo>
                    <a:lnTo>
                      <a:pt x="5574" y="27"/>
                    </a:lnTo>
                    <a:cubicBezTo>
                      <a:pt x="5597" y="164"/>
                      <a:pt x="7490" y="12614"/>
                      <a:pt x="7057" y="17823"/>
                    </a:cubicBezTo>
                    <a:cubicBezTo>
                      <a:pt x="3225" y="17891"/>
                      <a:pt x="191" y="18164"/>
                      <a:pt x="9" y="19405"/>
                    </a:cubicBezTo>
                    <a:cubicBezTo>
                      <a:pt x="-151" y="20305"/>
                      <a:pt x="1833" y="21436"/>
                      <a:pt x="3749" y="21545"/>
                    </a:cubicBezTo>
                    <a:close/>
                    <a:moveTo>
                      <a:pt x="20742" y="19445"/>
                    </a:moveTo>
                    <a:cubicBezTo>
                      <a:pt x="20833" y="20086"/>
                      <a:pt x="19259" y="21082"/>
                      <a:pt x="17549" y="21191"/>
                    </a:cubicBezTo>
                    <a:cubicBezTo>
                      <a:pt x="17457" y="21191"/>
                      <a:pt x="17366" y="21205"/>
                      <a:pt x="17275" y="21205"/>
                    </a:cubicBezTo>
                    <a:cubicBezTo>
                      <a:pt x="15701" y="21205"/>
                      <a:pt x="14697" y="20332"/>
                      <a:pt x="14401" y="18736"/>
                    </a:cubicBezTo>
                    <a:cubicBezTo>
                      <a:pt x="14378" y="18573"/>
                      <a:pt x="14355" y="18395"/>
                      <a:pt x="14332" y="18218"/>
                    </a:cubicBezTo>
                    <a:cubicBezTo>
                      <a:pt x="17754" y="18259"/>
                      <a:pt x="20582" y="18505"/>
                      <a:pt x="20742" y="19445"/>
                    </a:cubicBezTo>
                    <a:close/>
                    <a:moveTo>
                      <a:pt x="625" y="19445"/>
                    </a:moveTo>
                    <a:cubicBezTo>
                      <a:pt x="784" y="18505"/>
                      <a:pt x="3590" y="18273"/>
                      <a:pt x="7034" y="18205"/>
                    </a:cubicBezTo>
                    <a:cubicBezTo>
                      <a:pt x="7011" y="18395"/>
                      <a:pt x="6988" y="18559"/>
                      <a:pt x="6965" y="18723"/>
                    </a:cubicBezTo>
                    <a:cubicBezTo>
                      <a:pt x="6692" y="20318"/>
                      <a:pt x="5665" y="21191"/>
                      <a:pt x="4091" y="21191"/>
                    </a:cubicBezTo>
                    <a:cubicBezTo>
                      <a:pt x="4000" y="21191"/>
                      <a:pt x="3909" y="21191"/>
                      <a:pt x="3818" y="21177"/>
                    </a:cubicBezTo>
                    <a:cubicBezTo>
                      <a:pt x="2107" y="21082"/>
                      <a:pt x="510" y="20086"/>
                      <a:pt x="625" y="19445"/>
                    </a:cubicBezTo>
                    <a:close/>
                  </a:path>
                </a:pathLst>
              </a:custGeom>
              <a:solidFill>
                <a:srgbClr val="000000"/>
              </a:solidFill>
              <a:ln w="12700">
                <a:miter lim="400000"/>
              </a:ln>
            </p:spPr>
            <p:txBody>
              <a:bodyPr lIns="28575" tIns="28575" rIns="28575" bIns="28575" anchor="ctr"/>
              <a:lstStyle/>
              <a:p>
                <a:pPr>
                  <a:defRPr sz="3000">
                    <a:solidFill>
                      <a:srgbClr val="FFFFFF"/>
                    </a:solidFill>
                  </a:defRPr>
                </a:pPr>
                <a:endParaRPr sz="2250"/>
              </a:p>
            </p:txBody>
          </p:sp>
          <p:sp>
            <p:nvSpPr>
              <p:cNvPr id="69" name="Rectangle">
                <a:extLst>
                  <a:ext uri="{FF2B5EF4-FFF2-40B4-BE49-F238E27FC236}">
                    <a16:creationId xmlns:a16="http://schemas.microsoft.com/office/drawing/2014/main" id="{9236C360-EF87-700D-A1C1-8DA2AEC69339}"/>
                  </a:ext>
                </a:extLst>
              </p:cNvPr>
              <p:cNvSpPr/>
              <p:nvPr/>
            </p:nvSpPr>
            <p:spPr>
              <a:xfrm>
                <a:off x="7396661" y="809625"/>
                <a:ext cx="75708" cy="1611816"/>
              </a:xfrm>
              <a:prstGeom prst="rect">
                <a:avLst/>
              </a:prstGeom>
              <a:solidFill>
                <a:srgbClr val="000000"/>
              </a:solidFill>
              <a:ln w="12700">
                <a:miter lim="400000"/>
              </a:ln>
            </p:spPr>
            <p:txBody>
              <a:bodyPr lIns="28575" tIns="28575" rIns="28575" bIns="28575" anchor="ctr"/>
              <a:lstStyle/>
              <a:p>
                <a:pPr>
                  <a:defRPr sz="3000">
                    <a:solidFill>
                      <a:srgbClr val="FFFFFF"/>
                    </a:solidFill>
                  </a:defRPr>
                </a:pPr>
                <a:endParaRPr sz="2250"/>
              </a:p>
            </p:txBody>
          </p:sp>
        </p:grpSp>
        <p:sp>
          <p:nvSpPr>
            <p:cNvPr id="65" name="Oval 13">
              <a:extLst>
                <a:ext uri="{FF2B5EF4-FFF2-40B4-BE49-F238E27FC236}">
                  <a16:creationId xmlns:a16="http://schemas.microsoft.com/office/drawing/2014/main" id="{468AAA81-96E3-8153-8F34-62CEF5EC29BC}"/>
                </a:ext>
              </a:extLst>
            </p:cNvPr>
            <p:cNvSpPr/>
            <p:nvPr/>
          </p:nvSpPr>
          <p:spPr>
            <a:xfrm rot="19483492">
              <a:off x="7487771" y="3907606"/>
              <a:ext cx="371475" cy="171450"/>
            </a:xfrm>
            <a:prstGeom prst="ellipse">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350"/>
            </a:p>
          </p:txBody>
        </p:sp>
      </p:grpSp>
      <p:pic>
        <p:nvPicPr>
          <p:cNvPr id="71" name="image2.png" descr="Grafico">
            <a:extLst>
              <a:ext uri="{FF2B5EF4-FFF2-40B4-BE49-F238E27FC236}">
                <a16:creationId xmlns:a16="http://schemas.microsoft.com/office/drawing/2014/main" id="{49008D74-B91A-CFE3-0119-B9C40872A1F4}"/>
              </a:ext>
            </a:extLst>
          </p:cNvPr>
          <p:cNvPicPr/>
          <p:nvPr/>
        </p:nvPicPr>
        <p:blipFill>
          <a:blip r:embed="rId2"/>
          <a:srcRect/>
          <a:stretch>
            <a:fillRect/>
          </a:stretch>
        </p:blipFill>
        <p:spPr>
          <a:xfrm>
            <a:off x="4540574" y="3150793"/>
            <a:ext cx="3786531" cy="2333921"/>
          </a:xfrm>
          <a:prstGeom prst="rect">
            <a:avLst/>
          </a:prstGeom>
          <a:ln/>
        </p:spPr>
      </p:pic>
      <p:pic>
        <p:nvPicPr>
          <p:cNvPr id="72" name="Immagine 3" descr="Immagine che contiene testo, schermata, diagramma, schermo&#10;&#10;Descrizione generata automaticamente">
            <a:extLst>
              <a:ext uri="{FF2B5EF4-FFF2-40B4-BE49-F238E27FC236}">
                <a16:creationId xmlns:a16="http://schemas.microsoft.com/office/drawing/2014/main" id="{A6CB698C-6657-C128-956F-1ABD1C9F623C}"/>
              </a:ext>
            </a:extLst>
          </p:cNvPr>
          <p:cNvPicPr>
            <a:picLocks noChangeAspect="1"/>
          </p:cNvPicPr>
          <p:nvPr/>
        </p:nvPicPr>
        <p:blipFill rotWithShape="1">
          <a:blip r:embed="rId3" cstate="print">
            <a:extLst>
              <a:ext uri="{28A0092B-C50C-407E-A947-70E740481C1C}">
                <a14:useLocalDpi xmlns:a14="http://schemas.microsoft.com/office/drawing/2010/main" val="0"/>
              </a:ext>
            </a:extLst>
          </a:blip>
          <a:srcRect t="4273" r="5434" b="6944"/>
          <a:stretch/>
        </p:blipFill>
        <p:spPr>
          <a:xfrm>
            <a:off x="8746545" y="1712038"/>
            <a:ext cx="2873704" cy="2697994"/>
          </a:xfrm>
          <a:prstGeom prst="rect">
            <a:avLst/>
          </a:prstGeom>
        </p:spPr>
      </p:pic>
      <p:sp>
        <p:nvSpPr>
          <p:cNvPr id="70" name="Shape">
            <a:extLst>
              <a:ext uri="{FF2B5EF4-FFF2-40B4-BE49-F238E27FC236}">
                <a16:creationId xmlns:a16="http://schemas.microsoft.com/office/drawing/2014/main" id="{B94A5461-8020-8EFA-3A8A-A61940F1EFA8}"/>
              </a:ext>
            </a:extLst>
          </p:cNvPr>
          <p:cNvSpPr/>
          <p:nvPr/>
        </p:nvSpPr>
        <p:spPr>
          <a:xfrm>
            <a:off x="9842124" y="4311782"/>
            <a:ext cx="747867" cy="631540"/>
          </a:xfrm>
          <a:custGeom>
            <a:avLst/>
            <a:gdLst/>
            <a:ahLst/>
            <a:cxnLst>
              <a:cxn ang="0">
                <a:pos x="wd2" y="hd2"/>
              </a:cxn>
              <a:cxn ang="5400000">
                <a:pos x="wd2" y="hd2"/>
              </a:cxn>
              <a:cxn ang="10800000">
                <a:pos x="wd2" y="hd2"/>
              </a:cxn>
              <a:cxn ang="16200000">
                <a:pos x="wd2" y="hd2"/>
              </a:cxn>
            </a:cxnLst>
            <a:rect l="0" t="0" r="r" b="b"/>
            <a:pathLst>
              <a:path w="20189" h="21055" extrusionOk="0">
                <a:moveTo>
                  <a:pt x="10106" y="21055"/>
                </a:moveTo>
                <a:lnTo>
                  <a:pt x="2833" y="21055"/>
                </a:lnTo>
                <a:cubicBezTo>
                  <a:pt x="656" y="21055"/>
                  <a:pt x="-706" y="18335"/>
                  <a:pt x="382" y="16166"/>
                </a:cubicBezTo>
                <a:lnTo>
                  <a:pt x="4015" y="8899"/>
                </a:lnTo>
                <a:lnTo>
                  <a:pt x="7647" y="1633"/>
                </a:lnTo>
                <a:cubicBezTo>
                  <a:pt x="8736" y="-545"/>
                  <a:pt x="11452" y="-545"/>
                  <a:pt x="12541" y="1633"/>
                </a:cubicBezTo>
                <a:lnTo>
                  <a:pt x="16173" y="8899"/>
                </a:lnTo>
                <a:lnTo>
                  <a:pt x="19806" y="16166"/>
                </a:lnTo>
                <a:cubicBezTo>
                  <a:pt x="20894" y="18344"/>
                  <a:pt x="19532" y="21055"/>
                  <a:pt x="17355" y="21055"/>
                </a:cubicBezTo>
                <a:lnTo>
                  <a:pt x="10106" y="21055"/>
                </a:lnTo>
                <a:close/>
              </a:path>
            </a:pathLst>
          </a:custGeom>
          <a:solidFill>
            <a:srgbClr val="C00000"/>
          </a:solidFill>
          <a:ln w="12700">
            <a:miter lim="400000"/>
          </a:ln>
        </p:spPr>
        <p:txBody>
          <a:bodyPr lIns="38100" tIns="38100" rIns="38100" bIns="38100" anchor="ctr"/>
          <a:lstStyle/>
          <a:p>
            <a:pPr algn="ctr">
              <a:defRPr sz="3000">
                <a:solidFill>
                  <a:srgbClr val="FFFFFF"/>
                </a:solidFill>
              </a:defRPr>
            </a:pPr>
            <a:r>
              <a:rPr lang="it-IT" sz="3600" b="1" dirty="0">
                <a:latin typeface="ADLaM Display" panose="020F0502020204030204" pitchFamily="34" charset="0"/>
                <a:cs typeface="ADLaM Display" panose="020F0502020204030204" pitchFamily="34" charset="0"/>
              </a:rPr>
              <a:t>!</a:t>
            </a:r>
            <a:endParaRPr b="1" dirty="0">
              <a:latin typeface="ADLaM Display" panose="020F0502020204030204" pitchFamily="34" charset="0"/>
              <a:cs typeface="ADLaM Display" panose="020F0502020204030204" pitchFamily="34" charset="0"/>
            </a:endParaRPr>
          </a:p>
        </p:txBody>
      </p:sp>
    </p:spTree>
    <p:extLst>
      <p:ext uri="{BB962C8B-B14F-4D97-AF65-F5344CB8AC3E}">
        <p14:creationId xmlns:p14="http://schemas.microsoft.com/office/powerpoint/2010/main" val="2867428870"/>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PedNeph_VisualAbstract_Template_NoText.potx" id="{B1C48F58-D1E0-4C98-814B-D3979964E517}" vid="{3276ECFE-687C-499A-B544-1DE21692DD62}"/>
    </a:ext>
  </a:extLst>
</a:theme>
</file>

<file path=docProps/app.xml><?xml version="1.0" encoding="utf-8"?>
<Properties xmlns="http://schemas.openxmlformats.org/officeDocument/2006/extended-properties" xmlns:vt="http://schemas.openxmlformats.org/officeDocument/2006/docPropsVTypes">
  <Template/>
  <TotalTime>3112</TotalTime>
  <Words>295</Words>
  <Application>Microsoft Office PowerPoint</Application>
  <PresentationFormat>Widescreen</PresentationFormat>
  <Paragraphs>15</Paragraphs>
  <Slides>1</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vt:i4>
      </vt:variant>
    </vt:vector>
  </HeadingPairs>
  <TitlesOfParts>
    <vt:vector size="6" baseType="lpstr">
      <vt:lpstr>ADLaM Display</vt:lpstr>
      <vt:lpstr>Arial</vt:lpstr>
      <vt:lpstr>Calibri</vt:lpstr>
      <vt:lpstr>Calibri Light</vt:lpstr>
      <vt:lpstr>Office Theme</vt:lpstr>
      <vt:lpstr>PowerPoint Presentation</vt:lpstr>
    </vt:vector>
  </TitlesOfParts>
  <Company>University College London</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DRAFT IDEAS  initially using a combination of    monochromatic and triadic colours</dc:title>
  <dc:creator>Joseph Laycock</dc:creator>
  <cp:lastModifiedBy>Laycock, Joseph</cp:lastModifiedBy>
  <cp:revision>61</cp:revision>
  <dcterms:created xsi:type="dcterms:W3CDTF">2019-06-13T12:30:18Z</dcterms:created>
  <dcterms:modified xsi:type="dcterms:W3CDTF">2024-08-13T10:31:25Z</dcterms:modified>
</cp:coreProperties>
</file>